
<file path=[Content_Types].xml><?xml version="1.0" encoding="utf-8"?>
<Types xmlns="http://schemas.openxmlformats.org/package/2006/content-types">
  <Default Extension="bin" ContentType="application/vnd.openxmlformats-officedocument.oleObject"/>
  <Default Extension="emf" ContentType="image/x-emf"/>
  <Default Extension="gif" ContentType="image/gif"/>
  <Default Extension="jpe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441" r:id="rId2"/>
    <p:sldId id="431" r:id="rId3"/>
    <p:sldId id="442" r:id="rId4"/>
    <p:sldId id="430" r:id="rId5"/>
    <p:sldId id="440" r:id="rId6"/>
    <p:sldId id="443" r:id="rId7"/>
    <p:sldId id="445" r:id="rId8"/>
    <p:sldId id="444" r:id="rId9"/>
    <p:sldId id="446"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D7B26C5-4107-4FEC-AEDC-1716B250A1EF}" styleName="浅色样式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073A0DAA-6AF3-43AB-8588-CEC1D06C72B9}" styleName="中度样式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0505E3EF-67EA-436B-97B2-0124C06EBD24}" styleName="中度样式 4 - 强调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125" d="100"/>
          <a:sy n="125" d="100"/>
        </p:scale>
        <p:origin x="1157"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411FA55-6056-46DB-AC6F-AAE8990E5FBA}" type="datetimeFigureOut">
              <a:rPr lang="zh-CN" altLang="en-US" smtClean="0"/>
              <a:t>2024/1/15</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54C82FB-55CB-4E6E-BDF3-2124ECE4AF74}" type="slidenum">
              <a:rPr lang="zh-CN" altLang="en-US" smtClean="0"/>
              <a:t>‹#›</a:t>
            </a:fld>
            <a:endParaRPr lang="zh-CN" altLang="en-US"/>
          </a:p>
        </p:txBody>
      </p:sp>
    </p:spTree>
    <p:extLst>
      <p:ext uri="{BB962C8B-B14F-4D97-AF65-F5344CB8AC3E}">
        <p14:creationId xmlns:p14="http://schemas.microsoft.com/office/powerpoint/2010/main" val="9730772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37365833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22394888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22928181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28686016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25213546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10173435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34917067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152224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2799985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17137194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C6360DFA-0135-4BE6-9C05-E8FF968AD06A}" type="datetimeFigureOut">
              <a:rPr lang="zh-CN" altLang="en-US" smtClean="0"/>
              <a:t>2024/1/1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12885610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6360DFA-0135-4BE6-9C05-E8FF968AD06A}" type="datetimeFigureOut">
              <a:rPr lang="zh-CN" altLang="en-US" smtClean="0"/>
              <a:t>2024/1/15</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0800A91-C16D-4DBD-A9FE-736A3ED7139C}" type="slidenum">
              <a:rPr lang="zh-CN" altLang="en-US" smtClean="0"/>
              <a:t>‹#›</a:t>
            </a:fld>
            <a:endParaRPr lang="zh-CN" altLang="en-US"/>
          </a:p>
        </p:txBody>
      </p:sp>
    </p:spTree>
    <p:extLst>
      <p:ext uri="{BB962C8B-B14F-4D97-AF65-F5344CB8AC3E}">
        <p14:creationId xmlns:p14="http://schemas.microsoft.com/office/powerpoint/2010/main" val="17514700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6.emf"/><Relationship Id="rId18" Type="http://schemas.openxmlformats.org/officeDocument/2006/relationships/oleObject" Target="../embeddings/oleObject7.bin"/><Relationship Id="rId3" Type="http://schemas.openxmlformats.org/officeDocument/2006/relationships/image" Target="../media/image1.emf"/><Relationship Id="rId7" Type="http://schemas.openxmlformats.org/officeDocument/2006/relationships/image" Target="../media/image3.emf"/><Relationship Id="rId12" Type="http://schemas.openxmlformats.org/officeDocument/2006/relationships/oleObject" Target="../embeddings/oleObject6.bin"/><Relationship Id="rId17" Type="http://schemas.openxmlformats.org/officeDocument/2006/relationships/image" Target="../media/image10.tiff"/><Relationship Id="rId2" Type="http://schemas.openxmlformats.org/officeDocument/2006/relationships/oleObject" Target="../embeddings/oleObject1.bin"/><Relationship Id="rId16" Type="http://schemas.openxmlformats.org/officeDocument/2006/relationships/image" Target="../media/image9.tiff"/><Relationship Id="rId1" Type="http://schemas.openxmlformats.org/officeDocument/2006/relationships/slideLayout" Target="../slideLayouts/slideLayout7.xml"/><Relationship Id="rId6" Type="http://schemas.openxmlformats.org/officeDocument/2006/relationships/oleObject" Target="../embeddings/oleObject3.bin"/><Relationship Id="rId11" Type="http://schemas.openxmlformats.org/officeDocument/2006/relationships/image" Target="../media/image5.emf"/><Relationship Id="rId5" Type="http://schemas.openxmlformats.org/officeDocument/2006/relationships/image" Target="../media/image2.emf"/><Relationship Id="rId15" Type="http://schemas.openxmlformats.org/officeDocument/2006/relationships/image" Target="../media/image8.tiff"/><Relationship Id="rId10" Type="http://schemas.openxmlformats.org/officeDocument/2006/relationships/oleObject" Target="../embeddings/oleObject5.bin"/><Relationship Id="rId19" Type="http://schemas.openxmlformats.org/officeDocument/2006/relationships/image" Target="../media/image11.emf"/><Relationship Id="rId4" Type="http://schemas.openxmlformats.org/officeDocument/2006/relationships/oleObject" Target="../embeddings/oleObject2.bin"/><Relationship Id="rId9" Type="http://schemas.openxmlformats.org/officeDocument/2006/relationships/image" Target="../media/image4.emf"/><Relationship Id="rId14" Type="http://schemas.openxmlformats.org/officeDocument/2006/relationships/image" Target="../media/image7.tiff"/></Relationships>
</file>

<file path=ppt/slides/_rels/slide2.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oleObject" Target="../embeddings/oleObject8.bin"/><Relationship Id="rId1" Type="http://schemas.openxmlformats.org/officeDocument/2006/relationships/slideLayout" Target="../slideLayouts/slideLayout2.xml"/><Relationship Id="rId5" Type="http://schemas.openxmlformats.org/officeDocument/2006/relationships/image" Target="../media/image13.emf"/><Relationship Id="rId4" Type="http://schemas.openxmlformats.org/officeDocument/2006/relationships/oleObject" Target="../embeddings/oleObject9.bin"/></Relationships>
</file>

<file path=ppt/slides/_rels/slide3.xml.rels><?xml version="1.0" encoding="UTF-8" standalone="yes"?>
<Relationships xmlns="http://schemas.openxmlformats.org/package/2006/relationships"><Relationship Id="rId8" Type="http://schemas.openxmlformats.org/officeDocument/2006/relationships/image" Target="../media/image20.gif"/><Relationship Id="rId3" Type="http://schemas.openxmlformats.org/officeDocument/2006/relationships/image" Target="../media/image15.gif"/><Relationship Id="rId7" Type="http://schemas.openxmlformats.org/officeDocument/2006/relationships/image" Target="../media/image19.gif"/><Relationship Id="rId2" Type="http://schemas.openxmlformats.org/officeDocument/2006/relationships/image" Target="../media/image14.gif"/><Relationship Id="rId1" Type="http://schemas.openxmlformats.org/officeDocument/2006/relationships/slideLayout" Target="../slideLayouts/slideLayout7.xml"/><Relationship Id="rId6" Type="http://schemas.openxmlformats.org/officeDocument/2006/relationships/image" Target="../media/image18.gif"/><Relationship Id="rId11" Type="http://schemas.openxmlformats.org/officeDocument/2006/relationships/image" Target="../media/image22.emf"/><Relationship Id="rId5" Type="http://schemas.openxmlformats.org/officeDocument/2006/relationships/image" Target="../media/image17.gif"/><Relationship Id="rId10" Type="http://schemas.openxmlformats.org/officeDocument/2006/relationships/oleObject" Target="../embeddings/oleObject10.bin"/><Relationship Id="rId4" Type="http://schemas.openxmlformats.org/officeDocument/2006/relationships/image" Target="../media/image16.gif"/><Relationship Id="rId9" Type="http://schemas.openxmlformats.org/officeDocument/2006/relationships/image" Target="../media/image21.tiff"/></Relationships>
</file>

<file path=ppt/slides/_rels/slide4.xml.rels><?xml version="1.0" encoding="UTF-8" standalone="yes"?>
<Relationships xmlns="http://schemas.openxmlformats.org/package/2006/relationships"><Relationship Id="rId8" Type="http://schemas.openxmlformats.org/officeDocument/2006/relationships/image" Target="../media/image26.emf"/><Relationship Id="rId13" Type="http://schemas.openxmlformats.org/officeDocument/2006/relationships/image" Target="../media/image29.tiff"/><Relationship Id="rId3" Type="http://schemas.openxmlformats.org/officeDocument/2006/relationships/image" Target="../media/image23.emf"/><Relationship Id="rId7" Type="http://schemas.openxmlformats.org/officeDocument/2006/relationships/oleObject" Target="../embeddings/oleObject12.bin"/><Relationship Id="rId12" Type="http://schemas.openxmlformats.org/officeDocument/2006/relationships/image" Target="../media/image28.emf"/><Relationship Id="rId2" Type="http://schemas.openxmlformats.org/officeDocument/2006/relationships/oleObject" Target="../embeddings/oleObject11.bin"/><Relationship Id="rId1" Type="http://schemas.openxmlformats.org/officeDocument/2006/relationships/slideLayout" Target="../slideLayouts/slideLayout2.xml"/><Relationship Id="rId6" Type="http://schemas.openxmlformats.org/officeDocument/2006/relationships/image" Target="../media/image25.png"/><Relationship Id="rId11" Type="http://schemas.openxmlformats.org/officeDocument/2006/relationships/oleObject" Target="../embeddings/oleObject14.bin"/><Relationship Id="rId5" Type="http://schemas.microsoft.com/office/2007/relationships/hdphoto" Target="../media/hdphoto1.wdp"/><Relationship Id="rId15" Type="http://schemas.openxmlformats.org/officeDocument/2006/relationships/image" Target="../media/image31.tiff"/><Relationship Id="rId10" Type="http://schemas.openxmlformats.org/officeDocument/2006/relationships/image" Target="../media/image27.emf"/><Relationship Id="rId4" Type="http://schemas.openxmlformats.org/officeDocument/2006/relationships/image" Target="../media/image24.png"/><Relationship Id="rId9" Type="http://schemas.openxmlformats.org/officeDocument/2006/relationships/oleObject" Target="../embeddings/oleObject13.bin"/><Relationship Id="rId14" Type="http://schemas.openxmlformats.org/officeDocument/2006/relationships/image" Target="../media/image30.tif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7.bin"/><Relationship Id="rId13" Type="http://schemas.openxmlformats.org/officeDocument/2006/relationships/image" Target="../media/image39.tiff"/><Relationship Id="rId3" Type="http://schemas.openxmlformats.org/officeDocument/2006/relationships/image" Target="../media/image32.emf"/><Relationship Id="rId7" Type="http://schemas.openxmlformats.org/officeDocument/2006/relationships/image" Target="../media/image35.emf"/><Relationship Id="rId12" Type="http://schemas.openxmlformats.org/officeDocument/2006/relationships/image" Target="../media/image38.tiff"/><Relationship Id="rId2" Type="http://schemas.openxmlformats.org/officeDocument/2006/relationships/oleObject" Target="../embeddings/oleObject15.bin"/><Relationship Id="rId1" Type="http://schemas.openxmlformats.org/officeDocument/2006/relationships/slideLayout" Target="../slideLayouts/slideLayout2.xml"/><Relationship Id="rId6" Type="http://schemas.openxmlformats.org/officeDocument/2006/relationships/oleObject" Target="../embeddings/oleObject16.bin"/><Relationship Id="rId11" Type="http://schemas.openxmlformats.org/officeDocument/2006/relationships/image" Target="../media/image37.emf"/><Relationship Id="rId5" Type="http://schemas.openxmlformats.org/officeDocument/2006/relationships/image" Target="../media/image34.tif"/><Relationship Id="rId10" Type="http://schemas.openxmlformats.org/officeDocument/2006/relationships/oleObject" Target="../embeddings/oleObject18.bin"/><Relationship Id="rId4" Type="http://schemas.openxmlformats.org/officeDocument/2006/relationships/image" Target="../media/image33.tif"/><Relationship Id="rId9" Type="http://schemas.openxmlformats.org/officeDocument/2006/relationships/image" Target="../media/image36.emf"/><Relationship Id="rId14" Type="http://schemas.openxmlformats.org/officeDocument/2006/relationships/image" Target="../media/image40.tif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组合 17">
            <a:extLst>
              <a:ext uri="{FF2B5EF4-FFF2-40B4-BE49-F238E27FC236}">
                <a16:creationId xmlns:a16="http://schemas.microsoft.com/office/drawing/2014/main" id="{06D7880D-D59D-6E1F-A359-17CC2155550C}"/>
              </a:ext>
            </a:extLst>
          </p:cNvPr>
          <p:cNvGrpSpPr/>
          <p:nvPr/>
        </p:nvGrpSpPr>
        <p:grpSpPr>
          <a:xfrm>
            <a:off x="225425" y="60791"/>
            <a:ext cx="6265863" cy="2466509"/>
            <a:chOff x="198190" y="561078"/>
            <a:chExt cx="6265863" cy="2466509"/>
          </a:xfrm>
        </p:grpSpPr>
        <p:graphicFrame>
          <p:nvGraphicFramePr>
            <p:cNvPr id="3" name="对象 2">
              <a:extLst>
                <a:ext uri="{FF2B5EF4-FFF2-40B4-BE49-F238E27FC236}">
                  <a16:creationId xmlns:a16="http://schemas.microsoft.com/office/drawing/2014/main" id="{82E7DC9F-B607-CAE6-AD81-AF5DDA92A92E}"/>
                </a:ext>
              </a:extLst>
            </p:cNvPr>
            <p:cNvGraphicFramePr>
              <a:graphicFrameLocks noChangeAspect="1"/>
            </p:cNvGraphicFramePr>
            <p:nvPr>
              <p:extLst>
                <p:ext uri="{D42A27DB-BD31-4B8C-83A1-F6EECF244321}">
                  <p14:modId xmlns:p14="http://schemas.microsoft.com/office/powerpoint/2010/main" val="3237295243"/>
                </p:ext>
              </p:extLst>
            </p:nvPr>
          </p:nvGraphicFramePr>
          <p:xfrm>
            <a:off x="198190" y="671737"/>
            <a:ext cx="1557338" cy="2327275"/>
          </p:xfrm>
          <a:graphic>
            <a:graphicData uri="http://schemas.openxmlformats.org/presentationml/2006/ole">
              <mc:AlternateContent xmlns:mc="http://schemas.openxmlformats.org/markup-compatibility/2006">
                <mc:Choice xmlns:v="urn:schemas-microsoft-com:vml" Requires="v">
                  <p:oleObj name="Prism 9" r:id="rId2" imgW="2229197" imgH="3334324" progId="Prism9.Document">
                    <p:embed/>
                  </p:oleObj>
                </mc:Choice>
                <mc:Fallback>
                  <p:oleObj name="Prism 9" r:id="rId2" imgW="2229197" imgH="3334324" progId="Prism9.Document">
                    <p:embed/>
                    <p:pic>
                      <p:nvPicPr>
                        <p:cNvPr id="3" name="对象 2">
                          <a:extLst>
                            <a:ext uri="{FF2B5EF4-FFF2-40B4-BE49-F238E27FC236}">
                              <a16:creationId xmlns:a16="http://schemas.microsoft.com/office/drawing/2014/main" id="{82E7DC9F-B607-CAE6-AD81-AF5DDA92A92E}"/>
                            </a:ext>
                          </a:extLst>
                        </p:cNvPr>
                        <p:cNvPicPr/>
                        <p:nvPr/>
                      </p:nvPicPr>
                      <p:blipFill>
                        <a:blip r:embed="rId3"/>
                        <a:stretch>
                          <a:fillRect/>
                        </a:stretch>
                      </p:blipFill>
                      <p:spPr>
                        <a:xfrm>
                          <a:off x="198190" y="671737"/>
                          <a:ext cx="1557338" cy="2327275"/>
                        </a:xfrm>
                        <a:prstGeom prst="rect">
                          <a:avLst/>
                        </a:prstGeom>
                      </p:spPr>
                    </p:pic>
                  </p:oleObj>
                </mc:Fallback>
              </mc:AlternateContent>
            </a:graphicData>
          </a:graphic>
        </p:graphicFrame>
        <p:graphicFrame>
          <p:nvGraphicFramePr>
            <p:cNvPr id="5" name="对象 4">
              <a:extLst>
                <a:ext uri="{FF2B5EF4-FFF2-40B4-BE49-F238E27FC236}">
                  <a16:creationId xmlns:a16="http://schemas.microsoft.com/office/drawing/2014/main" id="{643C74B6-323B-2FD9-235D-196273908883}"/>
                </a:ext>
              </a:extLst>
            </p:cNvPr>
            <p:cNvGraphicFramePr>
              <a:graphicFrameLocks noChangeAspect="1"/>
            </p:cNvGraphicFramePr>
            <p:nvPr>
              <p:extLst>
                <p:ext uri="{D42A27DB-BD31-4B8C-83A1-F6EECF244321}">
                  <p14:modId xmlns:p14="http://schemas.microsoft.com/office/powerpoint/2010/main" val="2569462732"/>
                </p:ext>
              </p:extLst>
            </p:nvPr>
          </p:nvGraphicFramePr>
          <p:xfrm>
            <a:off x="1898403" y="676500"/>
            <a:ext cx="1519237" cy="2281237"/>
          </p:xfrm>
          <a:graphic>
            <a:graphicData uri="http://schemas.openxmlformats.org/presentationml/2006/ole">
              <mc:AlternateContent xmlns:mc="http://schemas.openxmlformats.org/markup-compatibility/2006">
                <mc:Choice xmlns:v="urn:schemas-microsoft-com:vml" Requires="v">
                  <p:oleObj name="Prism 9" r:id="rId4" imgW="2218758" imgH="3334324" progId="Prism9.Document">
                    <p:embed/>
                  </p:oleObj>
                </mc:Choice>
                <mc:Fallback>
                  <p:oleObj name="Prism 9" r:id="rId4" imgW="2218758" imgH="3334324" progId="Prism9.Document">
                    <p:embed/>
                    <p:pic>
                      <p:nvPicPr>
                        <p:cNvPr id="5" name="对象 4">
                          <a:extLst>
                            <a:ext uri="{FF2B5EF4-FFF2-40B4-BE49-F238E27FC236}">
                              <a16:creationId xmlns:a16="http://schemas.microsoft.com/office/drawing/2014/main" id="{643C74B6-323B-2FD9-235D-196273908883}"/>
                            </a:ext>
                          </a:extLst>
                        </p:cNvPr>
                        <p:cNvPicPr/>
                        <p:nvPr/>
                      </p:nvPicPr>
                      <p:blipFill>
                        <a:blip r:embed="rId5"/>
                        <a:stretch>
                          <a:fillRect/>
                        </a:stretch>
                      </p:blipFill>
                      <p:spPr>
                        <a:xfrm>
                          <a:off x="1898403" y="676500"/>
                          <a:ext cx="1519237" cy="2281237"/>
                        </a:xfrm>
                        <a:prstGeom prst="rect">
                          <a:avLst/>
                        </a:prstGeom>
                      </p:spPr>
                    </p:pic>
                  </p:oleObj>
                </mc:Fallback>
              </mc:AlternateContent>
            </a:graphicData>
          </a:graphic>
        </p:graphicFrame>
        <p:graphicFrame>
          <p:nvGraphicFramePr>
            <p:cNvPr id="6" name="对象 5">
              <a:extLst>
                <a:ext uri="{FF2B5EF4-FFF2-40B4-BE49-F238E27FC236}">
                  <a16:creationId xmlns:a16="http://schemas.microsoft.com/office/drawing/2014/main" id="{A50B973F-13E8-1191-840C-7EB03EC7730B}"/>
                </a:ext>
              </a:extLst>
            </p:cNvPr>
            <p:cNvGraphicFramePr>
              <a:graphicFrameLocks noChangeAspect="1"/>
            </p:cNvGraphicFramePr>
            <p:nvPr>
              <p:extLst>
                <p:ext uri="{D42A27DB-BD31-4B8C-83A1-F6EECF244321}">
                  <p14:modId xmlns:p14="http://schemas.microsoft.com/office/powerpoint/2010/main" val="3251929747"/>
                </p:ext>
              </p:extLst>
            </p:nvPr>
          </p:nvGraphicFramePr>
          <p:xfrm>
            <a:off x="3425578" y="678087"/>
            <a:ext cx="1454150" cy="2281238"/>
          </p:xfrm>
          <a:graphic>
            <a:graphicData uri="http://schemas.openxmlformats.org/presentationml/2006/ole">
              <mc:AlternateContent xmlns:mc="http://schemas.openxmlformats.org/markup-compatibility/2006">
                <mc:Choice xmlns:v="urn:schemas-microsoft-com:vml" Requires="v">
                  <p:oleObj name="Prism 9" r:id="rId6" imgW="2122650" imgH="3334324" progId="Prism9.Document">
                    <p:embed/>
                  </p:oleObj>
                </mc:Choice>
                <mc:Fallback>
                  <p:oleObj name="Prism 9" r:id="rId6" imgW="2122650" imgH="3334324" progId="Prism9.Document">
                    <p:embed/>
                    <p:pic>
                      <p:nvPicPr>
                        <p:cNvPr id="6" name="对象 5">
                          <a:extLst>
                            <a:ext uri="{FF2B5EF4-FFF2-40B4-BE49-F238E27FC236}">
                              <a16:creationId xmlns:a16="http://schemas.microsoft.com/office/drawing/2014/main" id="{A50B973F-13E8-1191-840C-7EB03EC7730B}"/>
                            </a:ext>
                          </a:extLst>
                        </p:cNvPr>
                        <p:cNvPicPr/>
                        <p:nvPr/>
                      </p:nvPicPr>
                      <p:blipFill>
                        <a:blip r:embed="rId7"/>
                        <a:stretch>
                          <a:fillRect/>
                        </a:stretch>
                      </p:blipFill>
                      <p:spPr>
                        <a:xfrm>
                          <a:off x="3425578" y="678087"/>
                          <a:ext cx="1454150" cy="2281238"/>
                        </a:xfrm>
                        <a:prstGeom prst="rect">
                          <a:avLst/>
                        </a:prstGeom>
                      </p:spPr>
                    </p:pic>
                  </p:oleObj>
                </mc:Fallback>
              </mc:AlternateContent>
            </a:graphicData>
          </a:graphic>
        </p:graphicFrame>
        <p:graphicFrame>
          <p:nvGraphicFramePr>
            <p:cNvPr id="7" name="对象 6">
              <a:extLst>
                <a:ext uri="{FF2B5EF4-FFF2-40B4-BE49-F238E27FC236}">
                  <a16:creationId xmlns:a16="http://schemas.microsoft.com/office/drawing/2014/main" id="{B00A620F-A12B-00D1-17B5-70A859F46AFA}"/>
                </a:ext>
              </a:extLst>
            </p:cNvPr>
            <p:cNvGraphicFramePr>
              <a:graphicFrameLocks noChangeAspect="1"/>
            </p:cNvGraphicFramePr>
            <p:nvPr>
              <p:extLst>
                <p:ext uri="{D42A27DB-BD31-4B8C-83A1-F6EECF244321}">
                  <p14:modId xmlns:p14="http://schemas.microsoft.com/office/powerpoint/2010/main" val="2533415820"/>
                </p:ext>
              </p:extLst>
            </p:nvPr>
          </p:nvGraphicFramePr>
          <p:xfrm>
            <a:off x="4987678" y="700312"/>
            <a:ext cx="1476375" cy="2327275"/>
          </p:xfrm>
          <a:graphic>
            <a:graphicData uri="http://schemas.openxmlformats.org/presentationml/2006/ole">
              <mc:AlternateContent xmlns:mc="http://schemas.openxmlformats.org/markup-compatibility/2006">
                <mc:Choice xmlns:v="urn:schemas-microsoft-com:vml" Requires="v">
                  <p:oleObj name="Prism 9" r:id="rId8" imgW="2168365" imgH="3414956" progId="Prism9.Document">
                    <p:embed/>
                  </p:oleObj>
                </mc:Choice>
                <mc:Fallback>
                  <p:oleObj name="Prism 9" r:id="rId8" imgW="2168365" imgH="3414956" progId="Prism9.Document">
                    <p:embed/>
                    <p:pic>
                      <p:nvPicPr>
                        <p:cNvPr id="7" name="对象 6">
                          <a:extLst>
                            <a:ext uri="{FF2B5EF4-FFF2-40B4-BE49-F238E27FC236}">
                              <a16:creationId xmlns:a16="http://schemas.microsoft.com/office/drawing/2014/main" id="{B00A620F-A12B-00D1-17B5-70A859F46AFA}"/>
                            </a:ext>
                          </a:extLst>
                        </p:cNvPr>
                        <p:cNvPicPr/>
                        <p:nvPr/>
                      </p:nvPicPr>
                      <p:blipFill>
                        <a:blip r:embed="rId9"/>
                        <a:stretch>
                          <a:fillRect/>
                        </a:stretch>
                      </p:blipFill>
                      <p:spPr>
                        <a:xfrm>
                          <a:off x="4987678" y="700312"/>
                          <a:ext cx="1476375" cy="2327275"/>
                        </a:xfrm>
                        <a:prstGeom prst="rect">
                          <a:avLst/>
                        </a:prstGeom>
                      </p:spPr>
                    </p:pic>
                  </p:oleObj>
                </mc:Fallback>
              </mc:AlternateContent>
            </a:graphicData>
          </a:graphic>
        </p:graphicFrame>
        <p:sp>
          <p:nvSpPr>
            <p:cNvPr id="8" name="文本框 7">
              <a:extLst>
                <a:ext uri="{FF2B5EF4-FFF2-40B4-BE49-F238E27FC236}">
                  <a16:creationId xmlns:a16="http://schemas.microsoft.com/office/drawing/2014/main" id="{D4BE9470-B470-3C86-C63E-55E3503CC22E}"/>
                </a:ext>
              </a:extLst>
            </p:cNvPr>
            <p:cNvSpPr txBox="1"/>
            <p:nvPr/>
          </p:nvSpPr>
          <p:spPr>
            <a:xfrm>
              <a:off x="260436" y="561078"/>
              <a:ext cx="40940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B73D51EE-DBCB-5D51-DB51-BBA330E22D5C}"/>
                </a:ext>
              </a:extLst>
            </p:cNvPr>
            <p:cNvSpPr txBox="1"/>
            <p:nvPr/>
          </p:nvSpPr>
          <p:spPr>
            <a:xfrm>
              <a:off x="1820421" y="561078"/>
              <a:ext cx="40940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D88597C9-83C0-57A7-DC1E-CDD5F0CD196C}"/>
                </a:ext>
              </a:extLst>
            </p:cNvPr>
            <p:cNvSpPr txBox="1"/>
            <p:nvPr/>
          </p:nvSpPr>
          <p:spPr>
            <a:xfrm>
              <a:off x="3429000" y="561078"/>
              <a:ext cx="40940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c</a:t>
              </a:r>
              <a:endParaRPr lang="zh-CN" altLang="en-US" sz="1200" b="1"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6A232417-EB39-0502-9F82-C340759D18A4}"/>
                </a:ext>
              </a:extLst>
            </p:cNvPr>
            <p:cNvSpPr txBox="1"/>
            <p:nvPr/>
          </p:nvSpPr>
          <p:spPr>
            <a:xfrm>
              <a:off x="4943393" y="561078"/>
              <a:ext cx="40940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d</a:t>
              </a:r>
              <a:endParaRPr lang="zh-CN" altLang="en-US" sz="1200" b="1" dirty="0">
                <a:latin typeface="Arial" panose="020B0604020202020204" pitchFamily="34" charset="0"/>
                <a:cs typeface="Arial" panose="020B0604020202020204" pitchFamily="34" charset="0"/>
              </a:endParaRPr>
            </a:p>
          </p:txBody>
        </p:sp>
      </p:grpSp>
      <p:sp>
        <p:nvSpPr>
          <p:cNvPr id="12" name="文本框 11">
            <a:extLst>
              <a:ext uri="{FF2B5EF4-FFF2-40B4-BE49-F238E27FC236}">
                <a16:creationId xmlns:a16="http://schemas.microsoft.com/office/drawing/2014/main" id="{057E4ED8-6567-ED0C-1E75-AFFC15254B99}"/>
              </a:ext>
            </a:extLst>
          </p:cNvPr>
          <p:cNvSpPr txBox="1"/>
          <p:nvPr/>
        </p:nvSpPr>
        <p:spPr>
          <a:xfrm>
            <a:off x="190530" y="7882098"/>
            <a:ext cx="6508690" cy="253916"/>
          </a:xfrm>
          <a:prstGeom prst="rect">
            <a:avLst/>
          </a:prstGeom>
          <a:noFill/>
        </p:spPr>
        <p:txBody>
          <a:bodyPr wrap="square">
            <a:spAutoFit/>
          </a:bodyPr>
          <a:lstStyle/>
          <a:p>
            <a:pPr algn="ct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Fig. </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S</a:t>
            </a: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1</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 S</a:t>
            </a: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hortened lifespan and accumul</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ated fatty acid in </a:t>
            </a:r>
            <a:r>
              <a:rPr lang="en-US" altLang="zh-CN" sz="1050" b="1" i="1" dirty="0">
                <a:latin typeface="Times New Roman" panose="02020603050405020304" pitchFamily="18" charset="0"/>
                <a:ea typeface="宋体" panose="02010600030101010101" pitchFamily="2" charset="-122"/>
                <a:cs typeface="宋体" panose="02010600030101010101" pitchFamily="2" charset="-122"/>
              </a:rPr>
              <a:t>dAcsl</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 RNAi</a:t>
            </a:r>
            <a:endParaRPr lang="zh-CN" altLang="zh-CN" sz="1050" kern="100" dirty="0">
              <a:effectLst/>
              <a:latin typeface="Times New Roman" panose="02020603050405020304" pitchFamily="18" charset="0"/>
              <a:ea typeface="宋体" panose="02010600030101010101" pitchFamily="2" charset="-122"/>
            </a:endParaRPr>
          </a:p>
        </p:txBody>
      </p:sp>
      <p:sp>
        <p:nvSpPr>
          <p:cNvPr id="14" name="文本框 13">
            <a:extLst>
              <a:ext uri="{FF2B5EF4-FFF2-40B4-BE49-F238E27FC236}">
                <a16:creationId xmlns:a16="http://schemas.microsoft.com/office/drawing/2014/main" id="{0051BF7C-C2B7-6F4C-FD7D-E4CBC7F73342}"/>
              </a:ext>
            </a:extLst>
          </p:cNvPr>
          <p:cNvSpPr txBox="1"/>
          <p:nvPr/>
        </p:nvSpPr>
        <p:spPr>
          <a:xfrm>
            <a:off x="155545" y="8093953"/>
            <a:ext cx="6543675" cy="1708160"/>
          </a:xfrm>
          <a:prstGeom prst="rect">
            <a:avLst/>
          </a:prstGeom>
          <a:noFill/>
        </p:spPr>
        <p:txBody>
          <a:bodyPr wrap="square">
            <a:spAutoFit/>
          </a:bodyPr>
          <a:lstStyle/>
          <a:p>
            <a:pPr algn="just"/>
            <a:r>
              <a:rPr lang="en-US" altLang="zh-CN" sz="1050" dirty="0">
                <a:solidFill>
                  <a:srgbClr val="000000"/>
                </a:solidFill>
                <a:latin typeface="Times New Roman" panose="02020603050405020304" pitchFamily="18" charset="0"/>
                <a:ea typeface="等线" panose="02010600030101010101" pitchFamily="2" charset="-122"/>
              </a:rPr>
              <a:t>(a, b, c and d) </a:t>
            </a:r>
            <a:r>
              <a:rPr lang="en-US" altLang="zh-CN" sz="1050" dirty="0">
                <a:solidFill>
                  <a:srgbClr val="000000"/>
                </a:solidFill>
                <a:effectLst/>
                <a:latin typeface="Times New Roman" panose="02020603050405020304" pitchFamily="18" charset="0"/>
                <a:ea typeface="宋体" panose="02010600030101010101" pitchFamily="2" charset="-122"/>
                <a:cs typeface="+mn-cs"/>
              </a:rPr>
              <a:t>Quantified </a:t>
            </a:r>
            <a:r>
              <a:rPr lang="en-US" altLang="zh-CN" sz="1050" kern="1200" dirty="0">
                <a:solidFill>
                  <a:srgbClr val="000000"/>
                </a:solidFill>
                <a:effectLst/>
                <a:latin typeface="Times New Roman" panose="02020603050405020304" pitchFamily="18" charset="0"/>
                <a:ea typeface="等线" panose="02010600030101010101" pitchFamily="2" charset="-122"/>
                <a:cs typeface="宋体" panose="02010600030101010101" pitchFamily="2" charset="-122"/>
              </a:rPr>
              <a:t>levels of </a:t>
            </a:r>
            <a:r>
              <a:rPr lang="en-US" altLang="zh-CN" sz="1050" dirty="0">
                <a:solidFill>
                  <a:srgbClr val="000000"/>
                </a:solidFill>
                <a:latin typeface="Times New Roman" panose="02020603050405020304" pitchFamily="18" charset="0"/>
                <a:ea typeface="等线" panose="02010600030101010101" pitchFamily="2" charset="-122"/>
                <a:cs typeface="宋体" panose="02010600030101010101" pitchFamily="2" charset="-122"/>
              </a:rPr>
              <a:t>fatty acids </a:t>
            </a:r>
            <a:r>
              <a:rPr lang="en-US" altLang="zh-CN" sz="1050" kern="1200" dirty="0">
                <a:solidFill>
                  <a:srgbClr val="000000"/>
                </a:solidFill>
                <a:effectLst/>
                <a:latin typeface="Times New Roman" panose="02020603050405020304" pitchFamily="18" charset="0"/>
                <a:ea typeface="等线" panose="02010600030101010101" pitchFamily="2" charset="-122"/>
                <a:cs typeface="宋体" panose="02010600030101010101" pitchFamily="2" charset="-122"/>
              </a:rPr>
              <a:t>(a) Palmitic acid,  (b) Palmitoleic acid, (c) Oleic acid and (d) Linoleic acid.</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e and f) (e) Neutral lipid accumulation phenotype in the gut appears after feed palmitoleic acid </a:t>
            </a:r>
            <a:r>
              <a:rPr lang="en-US" altLang="zh-CN" sz="1050" dirty="0">
                <a:solidFill>
                  <a:srgbClr val="000000"/>
                </a:solidFill>
                <a:latin typeface="Times New Roman" panose="02020603050405020304" pitchFamily="18" charset="0"/>
                <a:ea typeface="等线" panose="02010600030101010101" pitchFamily="2" charset="-122"/>
                <a:cs typeface="宋体" panose="02010600030101010101" pitchFamily="2" charset="-122"/>
              </a:rPr>
              <a:t>(po)</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in the background of </a:t>
            </a:r>
            <a:r>
              <a:rPr kumimoji="0" lang="en-US" altLang="zh-CN" sz="1050" b="0" i="1" u="none" strike="noStrike" kern="1200" cap="none" spc="0" normalizeH="0" baseline="0" noProof="0" dirty="0" err="1">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dAcsl</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RNAi. Green fluorescence is BODIPY-labeled lipid droplets. (f) Statistical analysis results showed that there was no significant difference in green fluorescence between the </a:t>
            </a:r>
            <a:r>
              <a:rPr kumimoji="0" lang="en-US" altLang="zh-CN" sz="1050" b="0" i="1"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cg </a:t>
            </a:r>
            <a:r>
              <a:rPr kumimoji="0" lang="en-US" altLang="zh-CN" sz="1050" b="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gt;</a:t>
            </a:r>
            <a:r>
              <a:rPr kumimoji="0" lang="en-US" altLang="zh-CN" sz="1050" b="0" i="1"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a:t>
            </a:r>
            <a:r>
              <a:rPr kumimoji="0" lang="en-US" altLang="zh-CN" sz="1050" b="0" i="1" u="none" strike="noStrike" kern="1200" cap="none" spc="0" normalizeH="0" baseline="0" noProof="0" dirty="0" err="1">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dAcsl</a:t>
            </a:r>
            <a:r>
              <a:rPr kumimoji="0" lang="en-US" altLang="zh-CN" sz="1050" b="0" i="1"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RNAi </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and </a:t>
            </a:r>
            <a:r>
              <a:rPr kumimoji="0" lang="en-US" altLang="zh-CN" sz="1050" b="0" i="1"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cg </a:t>
            </a:r>
            <a:r>
              <a:rPr kumimoji="0" lang="en-US" altLang="zh-CN" sz="1050" b="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gt;</a:t>
            </a:r>
            <a:r>
              <a:rPr kumimoji="0" lang="en-US" altLang="zh-CN" sz="1050" b="0" i="1"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a:t>
            </a:r>
            <a:r>
              <a:rPr kumimoji="0" lang="en-US" altLang="zh-CN" sz="1050" b="0" i="1" u="none" strike="noStrike" kern="1200" cap="none" spc="0" normalizeH="0" baseline="0" noProof="0" dirty="0" err="1">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dAcsl</a:t>
            </a:r>
            <a:r>
              <a:rPr kumimoji="0" lang="en-US" altLang="zh-CN" sz="1050" b="0" i="1"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RNAi</a:t>
            </a:r>
            <a:r>
              <a:rPr lang="en-US" altLang="zh-CN" sz="1050" dirty="0">
                <a:solidFill>
                  <a:srgbClr val="000000"/>
                </a:solidFill>
                <a:latin typeface="Times New Roman" panose="02020603050405020304" pitchFamily="18" charset="0"/>
                <a:ea typeface="等线" panose="02010600030101010101" pitchFamily="2" charset="-122"/>
                <a:cs typeface="宋体" panose="02010600030101010101" pitchFamily="2" charset="-122"/>
              </a:rPr>
              <a:t> </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po) (n </a:t>
            </a:r>
            <a:r>
              <a:rPr kumimoji="0" lang="zh-CN" altLang="en-US"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 10). Numbers in the figure represent p values, ns mean no significant difference, scale bar = 20 </a:t>
            </a:r>
            <a:r>
              <a:rPr kumimoji="0" lang="el-GR"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μ</a:t>
            </a:r>
            <a:r>
              <a:rPr kumimoji="0" lang="en-US" altLang="zh-CN" sz="1050" b="0" i="0" u="none" strike="noStrike" kern="1200" cap="none" spc="0" normalizeH="0" baseline="0" noProof="0" dirty="0">
                <a:ln>
                  <a:noFill/>
                </a:ln>
                <a:solidFill>
                  <a:srgbClr val="000000"/>
                </a:solidFill>
                <a:effectLst/>
                <a:uLnTx/>
                <a:uFillTx/>
                <a:latin typeface="Times New Roman" panose="02020603050405020304" pitchFamily="18" charset="0"/>
                <a:ea typeface="等线" panose="02010600030101010101" pitchFamily="2" charset="-122"/>
                <a:cs typeface="宋体" panose="02010600030101010101" pitchFamily="2" charset="-122"/>
              </a:rPr>
              <a:t>m.</a:t>
            </a:r>
            <a:r>
              <a:rPr kumimoji="0" lang="en-US" altLang="zh-CN" sz="1050" b="0" i="0" u="none" strike="noStrike" cap="none" spc="0" normalizeH="0" baseline="0" noProof="0" dirty="0">
                <a:ln>
                  <a:noFill/>
                </a:ln>
                <a:solidFill>
                  <a:srgbClr val="000000"/>
                </a:solidFill>
                <a:uLnTx/>
                <a:uFillTx/>
                <a:latin typeface="Times New Roman" panose="02020603050405020304" pitchFamily="18" charset="0"/>
                <a:ea typeface="等线" panose="02010600030101010101" pitchFamily="2" charset="-122"/>
                <a:cs typeface="宋体" panose="02010600030101010101" pitchFamily="2" charset="-122"/>
              </a:rPr>
              <a:t> </a:t>
            </a:r>
            <a:r>
              <a:rPr lang="en-US" altLang="zh-CN" sz="1050" dirty="0">
                <a:solidFill>
                  <a:srgbClr val="000000"/>
                </a:solidFill>
                <a:latin typeface="Times New Roman" panose="02020603050405020304" pitchFamily="18" charset="0"/>
                <a:ea typeface="等线" panose="02010600030101010101" pitchFamily="2" charset="-122"/>
                <a:cs typeface="宋体" panose="02010600030101010101" pitchFamily="2" charset="-122"/>
              </a:rPr>
              <a:t>(g and h) Kaplan-Meier survival analysis indicates that lifespan was significantly reduced (</a:t>
            </a:r>
            <a:r>
              <a:rPr lang="en-US" altLang="zh-CN" sz="1050" i="1" dirty="0">
                <a:solidFill>
                  <a:srgbClr val="000000"/>
                </a:solidFill>
                <a:latin typeface="Times New Roman" panose="02020603050405020304" pitchFamily="18" charset="0"/>
                <a:ea typeface="等线" panose="02010600030101010101" pitchFamily="2" charset="-122"/>
                <a:cs typeface="宋体" panose="02010600030101010101" pitchFamily="2" charset="-122"/>
              </a:rPr>
              <a:t>P </a:t>
            </a:r>
            <a:r>
              <a:rPr lang="en-US" altLang="zh-CN" sz="1050" dirty="0">
                <a:solidFill>
                  <a:srgbClr val="000000"/>
                </a:solidFill>
                <a:latin typeface="Times New Roman" panose="02020603050405020304" pitchFamily="18" charset="0"/>
                <a:ea typeface="等线" panose="02010600030101010101" pitchFamily="2" charset="-122"/>
                <a:cs typeface="宋体" panose="02010600030101010101" pitchFamily="2" charset="-122"/>
              </a:rPr>
              <a:t>&lt; 0.001) in </a:t>
            </a:r>
            <a:r>
              <a:rPr lang="en-US" altLang="zh-CN" sz="1050" i="1" dirty="0">
                <a:solidFill>
                  <a:srgbClr val="000000"/>
                </a:solidFill>
                <a:latin typeface="Times New Roman" panose="02020603050405020304" pitchFamily="18" charset="0"/>
                <a:ea typeface="等线" panose="02010600030101010101" pitchFamily="2" charset="-122"/>
                <a:cs typeface="宋体" panose="02010600030101010101" pitchFamily="2" charset="-122"/>
              </a:rPr>
              <a:t>dAcsl</a:t>
            </a:r>
            <a:r>
              <a:rPr lang="en-US" altLang="zh-CN" sz="1050" dirty="0">
                <a:solidFill>
                  <a:srgbClr val="000000"/>
                </a:solidFill>
                <a:latin typeface="Times New Roman" panose="02020603050405020304" pitchFamily="18" charset="0"/>
                <a:ea typeface="等线" panose="02010600030101010101" pitchFamily="2" charset="-122"/>
                <a:cs typeface="宋体" panose="02010600030101010101" pitchFamily="2" charset="-122"/>
              </a:rPr>
              <a:t> knock-down male (g) and female (h) relative to control group. A total of about 100 flies were included at the start of the survival analysis for each group, where the survival curve represents the percentage of surviving flies in each group at each time point. Number of surviving flies was recorded with two-day intervals. P-value from the Log-rank (Mantel-Cox) test was indicated.</a:t>
            </a:r>
            <a:endParaRPr lang="zh-CN" altLang="zh-CN" sz="1050" dirty="0">
              <a:effectLst/>
              <a:latin typeface="宋体" panose="02010600030101010101" pitchFamily="2" charset="-122"/>
              <a:ea typeface="宋体" panose="02010600030101010101" pitchFamily="2" charset="-122"/>
              <a:cs typeface="宋体" panose="02010600030101010101" pitchFamily="2" charset="-122"/>
            </a:endParaRPr>
          </a:p>
        </p:txBody>
      </p:sp>
      <p:grpSp>
        <p:nvGrpSpPr>
          <p:cNvPr id="34" name="组合 33">
            <a:extLst>
              <a:ext uri="{FF2B5EF4-FFF2-40B4-BE49-F238E27FC236}">
                <a16:creationId xmlns:a16="http://schemas.microsoft.com/office/drawing/2014/main" id="{3C6280B3-DB2B-3A72-CED5-BF021BEB92FE}"/>
              </a:ext>
            </a:extLst>
          </p:cNvPr>
          <p:cNvGrpSpPr/>
          <p:nvPr/>
        </p:nvGrpSpPr>
        <p:grpSpPr>
          <a:xfrm>
            <a:off x="366670" y="5941834"/>
            <a:ext cx="6245268" cy="1954391"/>
            <a:chOff x="366670" y="4706301"/>
            <a:chExt cx="6245268" cy="1954391"/>
          </a:xfrm>
        </p:grpSpPr>
        <p:grpSp>
          <p:nvGrpSpPr>
            <p:cNvPr id="33" name="组合 32">
              <a:extLst>
                <a:ext uri="{FF2B5EF4-FFF2-40B4-BE49-F238E27FC236}">
                  <a16:creationId xmlns:a16="http://schemas.microsoft.com/office/drawing/2014/main" id="{FA3CC5D8-DAF8-962F-2DD2-7090DF2FD397}"/>
                </a:ext>
              </a:extLst>
            </p:cNvPr>
            <p:cNvGrpSpPr/>
            <p:nvPr/>
          </p:nvGrpSpPr>
          <p:grpSpPr>
            <a:xfrm>
              <a:off x="373063" y="4737100"/>
              <a:ext cx="6238875" cy="1923592"/>
              <a:chOff x="373063" y="4737100"/>
              <a:chExt cx="6238875" cy="1923592"/>
            </a:xfrm>
          </p:grpSpPr>
          <p:graphicFrame>
            <p:nvGraphicFramePr>
              <p:cNvPr id="2" name="对象 1">
                <a:extLst>
                  <a:ext uri="{FF2B5EF4-FFF2-40B4-BE49-F238E27FC236}">
                    <a16:creationId xmlns:a16="http://schemas.microsoft.com/office/drawing/2014/main" id="{2D3C94AC-F952-83DA-537A-BD482C7F4411}"/>
                  </a:ext>
                </a:extLst>
              </p:cNvPr>
              <p:cNvGraphicFramePr>
                <a:graphicFrameLocks noChangeAspect="1"/>
              </p:cNvGraphicFramePr>
              <p:nvPr>
                <p:extLst>
                  <p:ext uri="{D42A27DB-BD31-4B8C-83A1-F6EECF244321}">
                    <p14:modId xmlns:p14="http://schemas.microsoft.com/office/powerpoint/2010/main" val="215603294"/>
                  </p:ext>
                </p:extLst>
              </p:nvPr>
            </p:nvGraphicFramePr>
            <p:xfrm>
              <a:off x="373063" y="4737100"/>
              <a:ext cx="3148012" cy="1898650"/>
            </p:xfrm>
            <a:graphic>
              <a:graphicData uri="http://schemas.openxmlformats.org/presentationml/2006/ole">
                <mc:AlternateContent xmlns:mc="http://schemas.openxmlformats.org/markup-compatibility/2006">
                  <mc:Choice xmlns:v="urn:schemas-microsoft-com:vml" Requires="v">
                    <p:oleObj name="Prism 9" r:id="rId10" imgW="4443276" imgH="2678834" progId="Prism9.Document">
                      <p:embed/>
                    </p:oleObj>
                  </mc:Choice>
                  <mc:Fallback>
                    <p:oleObj name="Prism 9" r:id="rId10" imgW="4443276" imgH="2678834" progId="Prism9.Document">
                      <p:embed/>
                      <p:pic>
                        <p:nvPicPr>
                          <p:cNvPr id="2" name="对象 1">
                            <a:extLst>
                              <a:ext uri="{FF2B5EF4-FFF2-40B4-BE49-F238E27FC236}">
                                <a16:creationId xmlns:a16="http://schemas.microsoft.com/office/drawing/2014/main" id="{2D3C94AC-F952-83DA-537A-BD482C7F4411}"/>
                              </a:ext>
                            </a:extLst>
                          </p:cNvPr>
                          <p:cNvPicPr/>
                          <p:nvPr/>
                        </p:nvPicPr>
                        <p:blipFill>
                          <a:blip r:embed="rId11"/>
                          <a:stretch>
                            <a:fillRect/>
                          </a:stretch>
                        </p:blipFill>
                        <p:spPr>
                          <a:xfrm>
                            <a:off x="373063" y="4737100"/>
                            <a:ext cx="3148012" cy="1898650"/>
                          </a:xfrm>
                          <a:prstGeom prst="rect">
                            <a:avLst/>
                          </a:prstGeom>
                        </p:spPr>
                      </p:pic>
                    </p:oleObj>
                  </mc:Fallback>
                </mc:AlternateContent>
              </a:graphicData>
            </a:graphic>
          </p:graphicFrame>
          <p:graphicFrame>
            <p:nvGraphicFramePr>
              <p:cNvPr id="4" name="对象 3">
                <a:extLst>
                  <a:ext uri="{FF2B5EF4-FFF2-40B4-BE49-F238E27FC236}">
                    <a16:creationId xmlns:a16="http://schemas.microsoft.com/office/drawing/2014/main" id="{BF70E5EC-3648-C935-E1CD-FA0C7708FFAB}"/>
                  </a:ext>
                </a:extLst>
              </p:cNvPr>
              <p:cNvGraphicFramePr>
                <a:graphicFrameLocks noChangeAspect="1"/>
              </p:cNvGraphicFramePr>
              <p:nvPr>
                <p:extLst>
                  <p:ext uri="{D42A27DB-BD31-4B8C-83A1-F6EECF244321}">
                    <p14:modId xmlns:p14="http://schemas.microsoft.com/office/powerpoint/2010/main" val="747780285"/>
                  </p:ext>
                </p:extLst>
              </p:nvPr>
            </p:nvGraphicFramePr>
            <p:xfrm>
              <a:off x="3460750" y="4774742"/>
              <a:ext cx="3151188" cy="1885950"/>
            </p:xfrm>
            <a:graphic>
              <a:graphicData uri="http://schemas.openxmlformats.org/presentationml/2006/ole">
                <mc:AlternateContent xmlns:mc="http://schemas.openxmlformats.org/markup-compatibility/2006">
                  <mc:Choice xmlns:v="urn:schemas-microsoft-com:vml" Requires="v">
                    <p:oleObj name="Prism 9" r:id="rId12" imgW="4510587" imgH="2701872" progId="Prism9.Document">
                      <p:embed/>
                    </p:oleObj>
                  </mc:Choice>
                  <mc:Fallback>
                    <p:oleObj name="Prism 9" r:id="rId12" imgW="4510587" imgH="2701872" progId="Prism9.Document">
                      <p:embed/>
                      <p:pic>
                        <p:nvPicPr>
                          <p:cNvPr id="4" name="对象 3">
                            <a:extLst>
                              <a:ext uri="{FF2B5EF4-FFF2-40B4-BE49-F238E27FC236}">
                                <a16:creationId xmlns:a16="http://schemas.microsoft.com/office/drawing/2014/main" id="{BF70E5EC-3648-C935-E1CD-FA0C7708FFAB}"/>
                              </a:ext>
                            </a:extLst>
                          </p:cNvPr>
                          <p:cNvPicPr/>
                          <p:nvPr/>
                        </p:nvPicPr>
                        <p:blipFill>
                          <a:blip r:embed="rId13"/>
                          <a:stretch>
                            <a:fillRect/>
                          </a:stretch>
                        </p:blipFill>
                        <p:spPr>
                          <a:xfrm>
                            <a:off x="3460750" y="4774742"/>
                            <a:ext cx="3151188" cy="1885950"/>
                          </a:xfrm>
                          <a:prstGeom prst="rect">
                            <a:avLst/>
                          </a:prstGeom>
                        </p:spPr>
                      </p:pic>
                    </p:oleObj>
                  </mc:Fallback>
                </mc:AlternateContent>
              </a:graphicData>
            </a:graphic>
          </p:graphicFrame>
        </p:grpSp>
        <p:sp>
          <p:nvSpPr>
            <p:cNvPr id="13" name="文本框 12">
              <a:extLst>
                <a:ext uri="{FF2B5EF4-FFF2-40B4-BE49-F238E27FC236}">
                  <a16:creationId xmlns:a16="http://schemas.microsoft.com/office/drawing/2014/main" id="{11B15E27-8EC7-A536-960F-89117B7A9568}"/>
                </a:ext>
              </a:extLst>
            </p:cNvPr>
            <p:cNvSpPr txBox="1"/>
            <p:nvPr/>
          </p:nvSpPr>
          <p:spPr>
            <a:xfrm>
              <a:off x="366670" y="4706301"/>
              <a:ext cx="40940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g</a:t>
              </a:r>
              <a:endParaRPr lang="zh-CN" altLang="en-US" sz="1200" b="1" dirty="0">
                <a:latin typeface="Arial" panose="020B0604020202020204" pitchFamily="34" charset="0"/>
                <a:cs typeface="Arial" panose="020B0604020202020204" pitchFamily="34" charset="0"/>
              </a:endParaRPr>
            </a:p>
          </p:txBody>
        </p:sp>
        <p:sp>
          <p:nvSpPr>
            <p:cNvPr id="15" name="文本框 14">
              <a:extLst>
                <a:ext uri="{FF2B5EF4-FFF2-40B4-BE49-F238E27FC236}">
                  <a16:creationId xmlns:a16="http://schemas.microsoft.com/office/drawing/2014/main" id="{68049C72-761B-234B-5E43-37C49CCB3659}"/>
                </a:ext>
              </a:extLst>
            </p:cNvPr>
            <p:cNvSpPr txBox="1"/>
            <p:nvPr/>
          </p:nvSpPr>
          <p:spPr>
            <a:xfrm>
              <a:off x="3386313" y="4706301"/>
              <a:ext cx="40940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h</a:t>
              </a:r>
              <a:endParaRPr lang="zh-CN" altLang="en-US" sz="1200" b="1" dirty="0">
                <a:latin typeface="Arial" panose="020B0604020202020204" pitchFamily="34" charset="0"/>
                <a:cs typeface="Arial" panose="020B0604020202020204" pitchFamily="34" charset="0"/>
              </a:endParaRPr>
            </a:p>
          </p:txBody>
        </p:sp>
      </p:grpSp>
      <p:grpSp>
        <p:nvGrpSpPr>
          <p:cNvPr id="32" name="组合 31">
            <a:extLst>
              <a:ext uri="{FF2B5EF4-FFF2-40B4-BE49-F238E27FC236}">
                <a16:creationId xmlns:a16="http://schemas.microsoft.com/office/drawing/2014/main" id="{AE9F2270-D574-BFEA-71F9-FBB355CE304A}"/>
              </a:ext>
            </a:extLst>
          </p:cNvPr>
          <p:cNvGrpSpPr/>
          <p:nvPr/>
        </p:nvGrpSpPr>
        <p:grpSpPr>
          <a:xfrm>
            <a:off x="605662" y="2511531"/>
            <a:ext cx="5791963" cy="3287788"/>
            <a:chOff x="-104801" y="553660"/>
            <a:chExt cx="9530166" cy="5534274"/>
          </a:xfrm>
        </p:grpSpPr>
        <p:sp>
          <p:nvSpPr>
            <p:cNvPr id="17" name="文本框 16">
              <a:extLst>
                <a:ext uri="{FF2B5EF4-FFF2-40B4-BE49-F238E27FC236}">
                  <a16:creationId xmlns:a16="http://schemas.microsoft.com/office/drawing/2014/main" id="{383517F8-53D5-BD50-E810-AF4C7AEDAD39}"/>
                </a:ext>
              </a:extLst>
            </p:cNvPr>
            <p:cNvSpPr txBox="1"/>
            <p:nvPr/>
          </p:nvSpPr>
          <p:spPr>
            <a:xfrm>
              <a:off x="3881337" y="556926"/>
              <a:ext cx="3869666" cy="388555"/>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gt; white RNAi </a:t>
              </a:r>
              <a:r>
                <a:rPr lang="en-US" altLang="zh-CN" sz="900" b="1" dirty="0">
                  <a:latin typeface="Arial" panose="020B0604020202020204" pitchFamily="34" charset="0"/>
                  <a:cs typeface="Arial" panose="020B0604020202020204" pitchFamily="34" charset="0"/>
                </a:rPr>
                <a:t>(po)</a:t>
              </a:r>
              <a:endParaRPr lang="zh-CN" altLang="en-US" sz="900" b="1" dirty="0">
                <a:latin typeface="Arial" panose="020B0604020202020204" pitchFamily="34" charset="0"/>
                <a:cs typeface="Arial" panose="020B0604020202020204" pitchFamily="34" charset="0"/>
              </a:endParaRPr>
            </a:p>
          </p:txBody>
        </p:sp>
        <p:sp>
          <p:nvSpPr>
            <p:cNvPr id="19" name="文本框 18">
              <a:extLst>
                <a:ext uri="{FF2B5EF4-FFF2-40B4-BE49-F238E27FC236}">
                  <a16:creationId xmlns:a16="http://schemas.microsoft.com/office/drawing/2014/main" id="{26192B20-75D1-89E3-B9BE-CA88EDF4B001}"/>
                </a:ext>
              </a:extLst>
            </p:cNvPr>
            <p:cNvSpPr txBox="1"/>
            <p:nvPr/>
          </p:nvSpPr>
          <p:spPr>
            <a:xfrm>
              <a:off x="419482" y="3385228"/>
              <a:ext cx="2894573" cy="388555"/>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RNAi</a:t>
              </a:r>
              <a:endParaRPr lang="zh-CN" altLang="en-US" sz="900" b="1" i="1" dirty="0">
                <a:latin typeface="Arial" panose="020B0604020202020204" pitchFamily="34" charset="0"/>
                <a:cs typeface="Arial" panose="020B0604020202020204" pitchFamily="34" charset="0"/>
              </a:endParaRPr>
            </a:p>
          </p:txBody>
        </p:sp>
        <p:pic>
          <p:nvPicPr>
            <p:cNvPr id="20" name="图片 19">
              <a:extLst>
                <a:ext uri="{FF2B5EF4-FFF2-40B4-BE49-F238E27FC236}">
                  <a16:creationId xmlns:a16="http://schemas.microsoft.com/office/drawing/2014/main" id="{0518CECD-8240-90A8-100E-04FC7F193D4E}"/>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3343277" y="929813"/>
              <a:ext cx="3334922" cy="2321404"/>
            </a:xfrm>
            <a:prstGeom prst="rect">
              <a:avLst/>
            </a:prstGeom>
          </p:spPr>
        </p:pic>
        <p:sp>
          <p:nvSpPr>
            <p:cNvPr id="21" name="文本框 20">
              <a:extLst>
                <a:ext uri="{FF2B5EF4-FFF2-40B4-BE49-F238E27FC236}">
                  <a16:creationId xmlns:a16="http://schemas.microsoft.com/office/drawing/2014/main" id="{BFCC157D-4E51-28EC-0EB6-AAE05C777B9E}"/>
                </a:ext>
              </a:extLst>
            </p:cNvPr>
            <p:cNvSpPr txBox="1"/>
            <p:nvPr/>
          </p:nvSpPr>
          <p:spPr>
            <a:xfrm>
              <a:off x="3921836" y="3394330"/>
              <a:ext cx="2271577" cy="388555"/>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RNAi </a:t>
              </a:r>
              <a:r>
                <a:rPr lang="en-US" altLang="zh-CN" sz="900" b="1" dirty="0">
                  <a:latin typeface="Arial" panose="020B0604020202020204" pitchFamily="34" charset="0"/>
                  <a:cs typeface="Arial" panose="020B0604020202020204" pitchFamily="34" charset="0"/>
                </a:rPr>
                <a:t>(po)</a:t>
              </a:r>
              <a:endParaRPr lang="zh-CN" altLang="en-US" sz="900" b="1" dirty="0">
                <a:latin typeface="Arial" panose="020B0604020202020204" pitchFamily="34" charset="0"/>
                <a:cs typeface="Arial" panose="020B0604020202020204" pitchFamily="34" charset="0"/>
              </a:endParaRPr>
            </a:p>
          </p:txBody>
        </p:sp>
        <p:pic>
          <p:nvPicPr>
            <p:cNvPr id="22" name="图片 21">
              <a:extLst>
                <a:ext uri="{FF2B5EF4-FFF2-40B4-BE49-F238E27FC236}">
                  <a16:creationId xmlns:a16="http://schemas.microsoft.com/office/drawing/2014/main" id="{AA9A21FE-B809-EA52-FFD9-A51B60C061D9}"/>
                </a:ext>
              </a:extLst>
            </p:cNvPr>
            <p:cNvPicPr>
              <a:picLocks noChangeAspect="1"/>
            </p:cNvPicPr>
            <p:nvPr/>
          </p:nvPicPr>
          <p:blipFill rotWithShape="1">
            <a:blip r:embed="rId15">
              <a:extLst>
                <a:ext uri="{28A0092B-C50C-407E-A947-70E740481C1C}">
                  <a14:useLocalDpi xmlns:a14="http://schemas.microsoft.com/office/drawing/2010/main" val="0"/>
                </a:ext>
              </a:extLst>
            </a:blip>
            <a:srcRect t="7099"/>
            <a:stretch/>
          </p:blipFill>
          <p:spPr>
            <a:xfrm>
              <a:off x="-104801" y="3757784"/>
              <a:ext cx="3334922" cy="2321406"/>
            </a:xfrm>
            <a:prstGeom prst="rect">
              <a:avLst/>
            </a:prstGeom>
          </p:spPr>
        </p:pic>
        <p:pic>
          <p:nvPicPr>
            <p:cNvPr id="23" name="图片 22">
              <a:extLst>
                <a:ext uri="{FF2B5EF4-FFF2-40B4-BE49-F238E27FC236}">
                  <a16:creationId xmlns:a16="http://schemas.microsoft.com/office/drawing/2014/main" id="{2FED11F6-D393-9CFB-9D7D-F06E7C83757F}"/>
                </a:ext>
              </a:extLst>
            </p:cNvPr>
            <p:cNvPicPr>
              <a:picLocks noChangeAspect="1"/>
            </p:cNvPicPr>
            <p:nvPr/>
          </p:nvPicPr>
          <p:blipFill rotWithShape="1">
            <a:blip r:embed="rId16">
              <a:extLst>
                <a:ext uri="{28A0092B-C50C-407E-A947-70E740481C1C}">
                  <a14:useLocalDpi xmlns:a14="http://schemas.microsoft.com/office/drawing/2010/main" val="0"/>
                </a:ext>
              </a:extLst>
            </a:blip>
            <a:srcRect b="7099"/>
            <a:stretch/>
          </p:blipFill>
          <p:spPr>
            <a:xfrm>
              <a:off x="3343277" y="3766529"/>
              <a:ext cx="3334922" cy="2321405"/>
            </a:xfrm>
            <a:prstGeom prst="rect">
              <a:avLst/>
            </a:prstGeom>
          </p:spPr>
        </p:pic>
        <p:grpSp>
          <p:nvGrpSpPr>
            <p:cNvPr id="24" name="组合 23">
              <a:extLst>
                <a:ext uri="{FF2B5EF4-FFF2-40B4-BE49-F238E27FC236}">
                  <a16:creationId xmlns:a16="http://schemas.microsoft.com/office/drawing/2014/main" id="{FDB50717-F158-F997-774E-0F4C1CD0E23B}"/>
                </a:ext>
              </a:extLst>
            </p:cNvPr>
            <p:cNvGrpSpPr/>
            <p:nvPr/>
          </p:nvGrpSpPr>
          <p:grpSpPr>
            <a:xfrm>
              <a:off x="-104801" y="937219"/>
              <a:ext cx="3334922" cy="2316209"/>
              <a:chOff x="21271" y="916330"/>
              <a:chExt cx="3808962" cy="2853976"/>
            </a:xfrm>
          </p:grpSpPr>
          <p:pic>
            <p:nvPicPr>
              <p:cNvPr id="25" name="图片 24">
                <a:extLst>
                  <a:ext uri="{FF2B5EF4-FFF2-40B4-BE49-F238E27FC236}">
                    <a16:creationId xmlns:a16="http://schemas.microsoft.com/office/drawing/2014/main" id="{FA582117-D1F8-DB38-56C0-7360EF127AF2}"/>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21271" y="916330"/>
                <a:ext cx="3808962" cy="2853976"/>
              </a:xfrm>
              <a:prstGeom prst="rect">
                <a:avLst/>
              </a:prstGeom>
            </p:spPr>
          </p:pic>
          <p:sp>
            <p:nvSpPr>
              <p:cNvPr id="26" name="文本框 25">
                <a:extLst>
                  <a:ext uri="{FF2B5EF4-FFF2-40B4-BE49-F238E27FC236}">
                    <a16:creationId xmlns:a16="http://schemas.microsoft.com/office/drawing/2014/main" id="{02C25CFB-C9B5-4E37-2A34-FC04FD15F45A}"/>
                  </a:ext>
                </a:extLst>
              </p:cNvPr>
              <p:cNvSpPr txBox="1"/>
              <p:nvPr/>
            </p:nvSpPr>
            <p:spPr>
              <a:xfrm>
                <a:off x="196950" y="3216791"/>
                <a:ext cx="1033898" cy="478768"/>
              </a:xfrm>
              <a:prstGeom prst="rect">
                <a:avLst/>
              </a:prstGeom>
              <a:noFill/>
            </p:spPr>
            <p:txBody>
              <a:bodyPr wrap="none" rtlCol="0">
                <a:spAutoFit/>
              </a:bodyPr>
              <a:lstStyle/>
              <a:p>
                <a:r>
                  <a:rPr lang="en-US" altLang="zh-CN" sz="900" b="1" dirty="0">
                    <a:solidFill>
                      <a:srgbClr val="07B10F"/>
                    </a:solidFill>
                  </a:rPr>
                  <a:t>BODIPY</a:t>
                </a:r>
                <a:endParaRPr lang="zh-CN" altLang="en-US" sz="1000" b="1" dirty="0">
                  <a:solidFill>
                    <a:srgbClr val="07B10F"/>
                  </a:solidFill>
                </a:endParaRPr>
              </a:p>
            </p:txBody>
          </p:sp>
        </p:grpSp>
        <p:sp>
          <p:nvSpPr>
            <p:cNvPr id="30" name="文本框 29">
              <a:extLst>
                <a:ext uri="{FF2B5EF4-FFF2-40B4-BE49-F238E27FC236}">
                  <a16:creationId xmlns:a16="http://schemas.microsoft.com/office/drawing/2014/main" id="{40392F99-405D-C308-D995-AC0A24679EFD}"/>
                </a:ext>
              </a:extLst>
            </p:cNvPr>
            <p:cNvSpPr txBox="1"/>
            <p:nvPr/>
          </p:nvSpPr>
          <p:spPr>
            <a:xfrm>
              <a:off x="410744" y="553660"/>
              <a:ext cx="3077632" cy="388555"/>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a:latin typeface="Arial" panose="020B0604020202020204" pitchFamily="34" charset="0"/>
                  <a:cs typeface="Arial" panose="020B0604020202020204" pitchFamily="34" charset="0"/>
                </a:rPr>
                <a:t>white RNAi</a:t>
              </a:r>
              <a:endParaRPr lang="zh-CN" altLang="en-US" sz="900" b="1" i="1" dirty="0">
                <a:latin typeface="Arial" panose="020B0604020202020204" pitchFamily="34" charset="0"/>
                <a:cs typeface="Arial" panose="020B0604020202020204" pitchFamily="34" charset="0"/>
              </a:endParaRPr>
            </a:p>
          </p:txBody>
        </p:sp>
        <p:graphicFrame>
          <p:nvGraphicFramePr>
            <p:cNvPr id="31" name="对象 30">
              <a:extLst>
                <a:ext uri="{FF2B5EF4-FFF2-40B4-BE49-F238E27FC236}">
                  <a16:creationId xmlns:a16="http://schemas.microsoft.com/office/drawing/2014/main" id="{52FFDC96-BA9F-B726-023E-B6DE89FFE2B8}"/>
                </a:ext>
              </a:extLst>
            </p:cNvPr>
            <p:cNvGraphicFramePr>
              <a:graphicFrameLocks noChangeAspect="1"/>
            </p:cNvGraphicFramePr>
            <p:nvPr>
              <p:extLst>
                <p:ext uri="{D42A27DB-BD31-4B8C-83A1-F6EECF244321}">
                  <p14:modId xmlns:p14="http://schemas.microsoft.com/office/powerpoint/2010/main" val="2445613433"/>
                </p:ext>
              </p:extLst>
            </p:nvPr>
          </p:nvGraphicFramePr>
          <p:xfrm>
            <a:off x="6779317" y="1488755"/>
            <a:ext cx="2646048" cy="3920133"/>
          </p:xfrm>
          <a:graphic>
            <a:graphicData uri="http://schemas.openxmlformats.org/presentationml/2006/ole">
              <mc:AlternateContent xmlns:mc="http://schemas.openxmlformats.org/markup-compatibility/2006">
                <mc:Choice xmlns:v="urn:schemas-microsoft-com:vml" Requires="v">
                  <p:oleObj name="Prism 9" r:id="rId18" imgW="2209399" imgH="3271691" progId="Prism9.Document">
                    <p:embed/>
                  </p:oleObj>
                </mc:Choice>
                <mc:Fallback>
                  <p:oleObj name="Prism 9" r:id="rId18" imgW="2209399" imgH="3271691" progId="Prism9.Document">
                    <p:embed/>
                    <p:pic>
                      <p:nvPicPr>
                        <p:cNvPr id="11" name="对象 10">
                          <a:extLst>
                            <a:ext uri="{FF2B5EF4-FFF2-40B4-BE49-F238E27FC236}">
                              <a16:creationId xmlns:a16="http://schemas.microsoft.com/office/drawing/2014/main" id="{4A1BF3BB-4F1E-EA8B-FC09-2E99662E184A}"/>
                            </a:ext>
                          </a:extLst>
                        </p:cNvPr>
                        <p:cNvPicPr/>
                        <p:nvPr/>
                      </p:nvPicPr>
                      <p:blipFill>
                        <a:blip r:embed="rId19"/>
                        <a:stretch>
                          <a:fillRect/>
                        </a:stretch>
                      </p:blipFill>
                      <p:spPr>
                        <a:xfrm>
                          <a:off x="6779317" y="1488755"/>
                          <a:ext cx="2646048" cy="3920133"/>
                        </a:xfrm>
                        <a:prstGeom prst="rect">
                          <a:avLst/>
                        </a:prstGeom>
                      </p:spPr>
                    </p:pic>
                  </p:oleObj>
                </mc:Fallback>
              </mc:AlternateContent>
            </a:graphicData>
          </a:graphic>
        </p:graphicFrame>
      </p:grpSp>
      <p:sp>
        <p:nvSpPr>
          <p:cNvPr id="38" name="文本框 37">
            <a:extLst>
              <a:ext uri="{FF2B5EF4-FFF2-40B4-BE49-F238E27FC236}">
                <a16:creationId xmlns:a16="http://schemas.microsoft.com/office/drawing/2014/main" id="{9B25D171-0DFD-EA87-6549-86814F09D778}"/>
              </a:ext>
            </a:extLst>
          </p:cNvPr>
          <p:cNvSpPr txBox="1"/>
          <p:nvPr/>
        </p:nvSpPr>
        <p:spPr>
          <a:xfrm>
            <a:off x="288053" y="2355272"/>
            <a:ext cx="3429000" cy="276999"/>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zh-CN" sz="1200" b="1" dirty="0">
                <a:solidFill>
                  <a:prstClr val="black"/>
                </a:solidFill>
                <a:latin typeface="Arial" panose="020B0604020202020204" pitchFamily="34" charset="0"/>
                <a:ea typeface="等线" panose="02010600030101010101" pitchFamily="2" charset="-122"/>
                <a:cs typeface="Arial" panose="020B0604020202020204" pitchFamily="34" charset="0"/>
              </a:rPr>
              <a:t>e</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0" name="文本框 39">
            <a:extLst>
              <a:ext uri="{FF2B5EF4-FFF2-40B4-BE49-F238E27FC236}">
                <a16:creationId xmlns:a16="http://schemas.microsoft.com/office/drawing/2014/main" id="{DE279AC3-998A-AB02-B627-B210DA082917}"/>
              </a:ext>
            </a:extLst>
          </p:cNvPr>
          <p:cNvSpPr txBox="1"/>
          <p:nvPr/>
        </p:nvSpPr>
        <p:spPr>
          <a:xfrm>
            <a:off x="4767263" y="2920192"/>
            <a:ext cx="3429000" cy="461665"/>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zh-CN" sz="1200" b="1" dirty="0">
                <a:solidFill>
                  <a:prstClr val="black"/>
                </a:solidFill>
                <a:latin typeface="Arial" panose="020B0604020202020204" pitchFamily="34" charset="0"/>
                <a:ea typeface="等线" panose="02010600030101010101" pitchFamily="2" charset="-122"/>
                <a:cs typeface="Arial" panose="020B0604020202020204" pitchFamily="34" charset="0"/>
              </a:rPr>
              <a:t>f</a:t>
            </a:r>
            <a:endPar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cxnSp>
        <p:nvCxnSpPr>
          <p:cNvPr id="44" name="直接连接符 43">
            <a:extLst>
              <a:ext uri="{FF2B5EF4-FFF2-40B4-BE49-F238E27FC236}">
                <a16:creationId xmlns:a16="http://schemas.microsoft.com/office/drawing/2014/main" id="{B8F04BBE-4010-C1E6-F7A5-A38CE113E4A4}"/>
              </a:ext>
            </a:extLst>
          </p:cNvPr>
          <p:cNvCxnSpPr>
            <a:cxnSpLocks/>
          </p:cNvCxnSpPr>
          <p:nvPr/>
        </p:nvCxnSpPr>
        <p:spPr>
          <a:xfrm>
            <a:off x="4396168" y="5667937"/>
            <a:ext cx="12730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104383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灯片编号占位符 3">
            <a:extLst>
              <a:ext uri="{FF2B5EF4-FFF2-40B4-BE49-F238E27FC236}">
                <a16:creationId xmlns:a16="http://schemas.microsoft.com/office/drawing/2014/main" id="{1D6E75A8-5C7A-7B8F-4504-62D744E5ECB0}"/>
              </a:ext>
            </a:extLst>
          </p:cNvPr>
          <p:cNvSpPr>
            <a:spLocks noGrp="1"/>
          </p:cNvSpPr>
          <p:nvPr>
            <p:ph type="sldNum" sz="quarter" idx="12"/>
          </p:nvPr>
        </p:nvSpPr>
        <p:spPr/>
        <p:txBody>
          <a:bodyPr/>
          <a:lstStyle/>
          <a:p>
            <a:fld id="{275691A4-F8EC-44F0-99FB-679044126F45}" type="slidenum">
              <a:rPr lang="zh-CN" altLang="en-US" smtClean="0"/>
              <a:t>2</a:t>
            </a:fld>
            <a:endParaRPr lang="zh-CN" altLang="en-US"/>
          </a:p>
        </p:txBody>
      </p:sp>
      <p:graphicFrame>
        <p:nvGraphicFramePr>
          <p:cNvPr id="5" name="对象 4">
            <a:extLst>
              <a:ext uri="{FF2B5EF4-FFF2-40B4-BE49-F238E27FC236}">
                <a16:creationId xmlns:a16="http://schemas.microsoft.com/office/drawing/2014/main" id="{47C136B6-08F1-B4D9-DA78-4ECC34097455}"/>
              </a:ext>
            </a:extLst>
          </p:cNvPr>
          <p:cNvGraphicFramePr>
            <a:graphicFrameLocks noChangeAspect="1"/>
          </p:cNvGraphicFramePr>
          <p:nvPr>
            <p:extLst>
              <p:ext uri="{D42A27DB-BD31-4B8C-83A1-F6EECF244321}">
                <p14:modId xmlns:p14="http://schemas.microsoft.com/office/powerpoint/2010/main" val="4290894721"/>
              </p:ext>
            </p:extLst>
          </p:nvPr>
        </p:nvGraphicFramePr>
        <p:xfrm>
          <a:off x="1092200" y="792163"/>
          <a:ext cx="4916488" cy="2525712"/>
        </p:xfrm>
        <a:graphic>
          <a:graphicData uri="http://schemas.openxmlformats.org/presentationml/2006/ole">
            <mc:AlternateContent xmlns:mc="http://schemas.openxmlformats.org/markup-compatibility/2006">
              <mc:Choice xmlns:v="urn:schemas-microsoft-com:vml" Requires="v">
                <p:oleObj name="Prism 9" r:id="rId2" imgW="8528757" imgH="4374973" progId="Prism9.Document">
                  <p:embed/>
                </p:oleObj>
              </mc:Choice>
              <mc:Fallback>
                <p:oleObj name="Prism 9" r:id="rId2" imgW="8528757" imgH="4374973" progId="Prism9.Document">
                  <p:embed/>
                  <p:pic>
                    <p:nvPicPr>
                      <p:cNvPr id="5" name="对象 4">
                        <a:extLst>
                          <a:ext uri="{FF2B5EF4-FFF2-40B4-BE49-F238E27FC236}">
                            <a16:creationId xmlns:a16="http://schemas.microsoft.com/office/drawing/2014/main" id="{47C136B6-08F1-B4D9-DA78-4ECC34097455}"/>
                          </a:ext>
                        </a:extLst>
                      </p:cNvPr>
                      <p:cNvPicPr/>
                      <p:nvPr/>
                    </p:nvPicPr>
                    <p:blipFill>
                      <a:blip r:embed="rId3"/>
                      <a:stretch>
                        <a:fillRect/>
                      </a:stretch>
                    </p:blipFill>
                    <p:spPr>
                      <a:xfrm>
                        <a:off x="1092200" y="792163"/>
                        <a:ext cx="4916488" cy="2525712"/>
                      </a:xfrm>
                      <a:prstGeom prst="rect">
                        <a:avLst/>
                      </a:prstGeom>
                    </p:spPr>
                  </p:pic>
                </p:oleObj>
              </mc:Fallback>
            </mc:AlternateContent>
          </a:graphicData>
        </a:graphic>
      </p:graphicFrame>
      <p:graphicFrame>
        <p:nvGraphicFramePr>
          <p:cNvPr id="2" name="对象 1">
            <a:extLst>
              <a:ext uri="{FF2B5EF4-FFF2-40B4-BE49-F238E27FC236}">
                <a16:creationId xmlns:a16="http://schemas.microsoft.com/office/drawing/2014/main" id="{92EE972A-A9EB-D033-B654-54C5D45FD5BF}"/>
              </a:ext>
            </a:extLst>
          </p:cNvPr>
          <p:cNvGraphicFramePr>
            <a:graphicFrameLocks noChangeAspect="1"/>
          </p:cNvGraphicFramePr>
          <p:nvPr>
            <p:extLst>
              <p:ext uri="{D42A27DB-BD31-4B8C-83A1-F6EECF244321}">
                <p14:modId xmlns:p14="http://schemas.microsoft.com/office/powerpoint/2010/main" val="4161231154"/>
              </p:ext>
            </p:extLst>
          </p:nvPr>
        </p:nvGraphicFramePr>
        <p:xfrm>
          <a:off x="976313" y="3979863"/>
          <a:ext cx="5443537" cy="2649537"/>
        </p:xfrm>
        <a:graphic>
          <a:graphicData uri="http://schemas.openxmlformats.org/presentationml/2006/ole">
            <mc:AlternateContent xmlns:mc="http://schemas.openxmlformats.org/markup-compatibility/2006">
              <mc:Choice xmlns:v="urn:schemas-microsoft-com:vml" Requires="v">
                <p:oleObj name="Prism 9" r:id="rId4" imgW="8505720" imgH="4128040" progId="Prism9.Document">
                  <p:embed/>
                </p:oleObj>
              </mc:Choice>
              <mc:Fallback>
                <p:oleObj name="Prism 9" r:id="rId4" imgW="8505720" imgH="4128040" progId="Prism9.Document">
                  <p:embed/>
                  <p:pic>
                    <p:nvPicPr>
                      <p:cNvPr id="2" name="对象 1">
                        <a:extLst>
                          <a:ext uri="{FF2B5EF4-FFF2-40B4-BE49-F238E27FC236}">
                            <a16:creationId xmlns:a16="http://schemas.microsoft.com/office/drawing/2014/main" id="{92EE972A-A9EB-D033-B654-54C5D45FD5BF}"/>
                          </a:ext>
                        </a:extLst>
                      </p:cNvPr>
                      <p:cNvPicPr/>
                      <p:nvPr/>
                    </p:nvPicPr>
                    <p:blipFill>
                      <a:blip r:embed="rId5"/>
                      <a:stretch>
                        <a:fillRect/>
                      </a:stretch>
                    </p:blipFill>
                    <p:spPr>
                      <a:xfrm>
                        <a:off x="976313" y="3979863"/>
                        <a:ext cx="5443537" cy="2649537"/>
                      </a:xfrm>
                      <a:prstGeom prst="rect">
                        <a:avLst/>
                      </a:prstGeom>
                    </p:spPr>
                  </p:pic>
                </p:oleObj>
              </mc:Fallback>
            </mc:AlternateContent>
          </a:graphicData>
        </a:graphic>
      </p:graphicFrame>
      <p:sp>
        <p:nvSpPr>
          <p:cNvPr id="3" name="文本框 2">
            <a:extLst>
              <a:ext uri="{FF2B5EF4-FFF2-40B4-BE49-F238E27FC236}">
                <a16:creationId xmlns:a16="http://schemas.microsoft.com/office/drawing/2014/main" id="{CDD32BE4-8309-3446-2616-CC25199607A0}"/>
              </a:ext>
            </a:extLst>
          </p:cNvPr>
          <p:cNvSpPr txBox="1"/>
          <p:nvPr/>
        </p:nvSpPr>
        <p:spPr>
          <a:xfrm>
            <a:off x="440970" y="345522"/>
            <a:ext cx="440970"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AB021CE6-9C51-608A-2DA9-AC84E9F8248F}"/>
              </a:ext>
            </a:extLst>
          </p:cNvPr>
          <p:cNvSpPr txBox="1"/>
          <p:nvPr/>
        </p:nvSpPr>
        <p:spPr>
          <a:xfrm>
            <a:off x="360362" y="3573234"/>
            <a:ext cx="440970"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E554AB8B-A950-46DB-702C-C7D700ECFC4A}"/>
              </a:ext>
            </a:extLst>
          </p:cNvPr>
          <p:cNvSpPr txBox="1"/>
          <p:nvPr/>
        </p:nvSpPr>
        <p:spPr>
          <a:xfrm>
            <a:off x="495702" y="7100716"/>
            <a:ext cx="5850703" cy="253916"/>
          </a:xfrm>
          <a:prstGeom prst="rect">
            <a:avLst/>
          </a:prstGeom>
          <a:noFill/>
        </p:spPr>
        <p:txBody>
          <a:bodyPr wrap="square">
            <a:spAutoFit/>
          </a:bodyPr>
          <a:lstStyle/>
          <a:p>
            <a:pPr algn="ct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Fig. S2</a:t>
            </a:r>
            <a:r>
              <a:rPr lang="en-US" altLang="zh-CN" sz="1050" b="1" kern="100" dirty="0">
                <a:effectLst/>
                <a:latin typeface="Times New Roman" panose="02020603050405020304" pitchFamily="18" charset="0"/>
                <a:ea typeface="宋体" panose="02010600030101010101" pitchFamily="2" charset="-122"/>
              </a:rPr>
              <a:t>. Changes in the content of DAG and TAG with different chain lengths in the hemolymph</a:t>
            </a:r>
            <a:endParaRPr lang="zh-CN" altLang="zh-CN" sz="1050" b="1" kern="100" dirty="0">
              <a:effectLst/>
              <a:latin typeface="Times New Roman" panose="02020603050405020304" pitchFamily="18" charset="0"/>
              <a:ea typeface="宋体" panose="02010600030101010101" pitchFamily="2" charset="-122"/>
            </a:endParaRPr>
          </a:p>
        </p:txBody>
      </p:sp>
      <p:sp>
        <p:nvSpPr>
          <p:cNvPr id="8" name="文本框 7">
            <a:extLst>
              <a:ext uri="{FF2B5EF4-FFF2-40B4-BE49-F238E27FC236}">
                <a16:creationId xmlns:a16="http://schemas.microsoft.com/office/drawing/2014/main" id="{47E814A7-487F-E22B-B379-1F65E531283E}"/>
              </a:ext>
            </a:extLst>
          </p:cNvPr>
          <p:cNvSpPr txBox="1"/>
          <p:nvPr/>
        </p:nvSpPr>
        <p:spPr>
          <a:xfrm>
            <a:off x="325220" y="7516214"/>
            <a:ext cx="6207559" cy="577081"/>
          </a:xfrm>
          <a:prstGeom prst="rect">
            <a:avLst/>
          </a:prstGeom>
          <a:noFill/>
        </p:spPr>
        <p:txBody>
          <a:bodyPr wrap="square">
            <a:spAutoFit/>
          </a:bodyPr>
          <a:lstStyle/>
          <a:p>
            <a:pPr algn="just"/>
            <a:r>
              <a:rPr lang="en-US" altLang="zh-CN" sz="1050" kern="100" dirty="0">
                <a:effectLst/>
                <a:latin typeface="Times New Roman" panose="02020603050405020304" pitchFamily="18" charset="0"/>
                <a:ea typeface="宋体" panose="02010600030101010101" pitchFamily="2" charset="-122"/>
              </a:rPr>
              <a:t>(a) Changes in the content of DAGs with different chain lengths in </a:t>
            </a:r>
            <a:r>
              <a:rPr lang="en-US" altLang="zh-CN" sz="1050" i="1" kern="100" dirty="0">
                <a:effectLst/>
                <a:latin typeface="Times New Roman" panose="02020603050405020304" pitchFamily="18" charset="0"/>
                <a:ea typeface="宋体" panose="02010600030101010101" pitchFamily="2" charset="-122"/>
              </a:rPr>
              <a:t>dAcsl</a:t>
            </a:r>
            <a:r>
              <a:rPr lang="en-US" altLang="zh-CN" sz="1050" kern="100" dirty="0">
                <a:effectLst/>
                <a:latin typeface="Times New Roman" panose="02020603050405020304" pitchFamily="18" charset="0"/>
                <a:ea typeface="宋体" panose="02010600030101010101" pitchFamily="2" charset="-122"/>
              </a:rPr>
              <a:t> RNAi hemolymph and control group (</a:t>
            </a:r>
            <a:r>
              <a:rPr lang="en-US" altLang="zh-CN" sz="1050" i="1" kern="100" dirty="0">
                <a:effectLst/>
                <a:latin typeface="Times New Roman" panose="02020603050405020304" pitchFamily="18" charset="0"/>
                <a:ea typeface="宋体" panose="02010600030101010101" pitchFamily="2" charset="-122"/>
              </a:rPr>
              <a:t>n</a:t>
            </a:r>
            <a:r>
              <a:rPr lang="en-US" altLang="zh-CN" sz="1050" kern="100" dirty="0">
                <a:effectLst/>
                <a:latin typeface="Times New Roman" panose="02020603050405020304" pitchFamily="18" charset="0"/>
                <a:ea typeface="宋体" panose="02010600030101010101" pitchFamily="2" charset="-122"/>
              </a:rPr>
              <a:t> = 4). Numbers in the figure represent </a:t>
            </a:r>
            <a:r>
              <a:rPr lang="en-US" altLang="zh-CN" sz="1050" i="1" kern="100" dirty="0">
                <a:effectLst/>
                <a:latin typeface="Times New Roman" panose="02020603050405020304" pitchFamily="18" charset="0"/>
                <a:ea typeface="宋体" panose="02010600030101010101" pitchFamily="2" charset="-122"/>
              </a:rPr>
              <a:t>P</a:t>
            </a:r>
            <a:r>
              <a:rPr lang="en-US" altLang="zh-CN" sz="1050" kern="100" dirty="0">
                <a:effectLst/>
                <a:latin typeface="Times New Roman" panose="02020603050405020304" pitchFamily="18" charset="0"/>
                <a:ea typeface="宋体" panose="02010600030101010101" pitchFamily="2" charset="-122"/>
              </a:rPr>
              <a:t> values. (b) Changes in the content of TAGs with different chain lengths in </a:t>
            </a:r>
            <a:r>
              <a:rPr lang="en-US" altLang="zh-CN" sz="1050" i="1" kern="100" dirty="0">
                <a:effectLst/>
                <a:latin typeface="Times New Roman" panose="02020603050405020304" pitchFamily="18" charset="0"/>
                <a:ea typeface="宋体" panose="02010600030101010101" pitchFamily="2" charset="-122"/>
              </a:rPr>
              <a:t>dAcsl</a:t>
            </a:r>
            <a:r>
              <a:rPr lang="en-US" altLang="zh-CN" sz="1050" kern="100" dirty="0">
                <a:effectLst/>
                <a:latin typeface="Times New Roman" panose="02020603050405020304" pitchFamily="18" charset="0"/>
                <a:ea typeface="宋体" panose="02010600030101010101" pitchFamily="2" charset="-122"/>
              </a:rPr>
              <a:t> RNAi hemolymph and control group (n = 4). Numbers in the figure represent </a:t>
            </a:r>
            <a:r>
              <a:rPr lang="en-US" altLang="zh-CN" sz="1050" i="1" kern="100" dirty="0">
                <a:effectLst/>
                <a:latin typeface="Times New Roman" panose="02020603050405020304" pitchFamily="18" charset="0"/>
                <a:ea typeface="宋体" panose="02010600030101010101" pitchFamily="2" charset="-122"/>
              </a:rPr>
              <a:t>P</a:t>
            </a:r>
            <a:r>
              <a:rPr lang="en-US" altLang="zh-CN" sz="1050" kern="100" dirty="0">
                <a:effectLst/>
                <a:latin typeface="Times New Roman" panose="02020603050405020304" pitchFamily="18" charset="0"/>
                <a:ea typeface="宋体" panose="02010600030101010101" pitchFamily="2" charset="-122"/>
              </a:rPr>
              <a:t> values.</a:t>
            </a:r>
            <a:endParaRPr lang="zh-CN" altLang="zh-CN" sz="1050" kern="100" dirty="0">
              <a:effectLst/>
              <a:latin typeface="Times New Roman" panose="02020603050405020304" pitchFamily="18" charset="0"/>
              <a:ea typeface="宋体" panose="02010600030101010101" pitchFamily="2" charset="-122"/>
            </a:endParaRPr>
          </a:p>
        </p:txBody>
      </p:sp>
    </p:spTree>
    <p:extLst>
      <p:ext uri="{BB962C8B-B14F-4D97-AF65-F5344CB8AC3E}">
        <p14:creationId xmlns:p14="http://schemas.microsoft.com/office/powerpoint/2010/main" val="6650867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784173A8-DC87-BB7E-FE63-6C59F5843B7A}"/>
              </a:ext>
            </a:extLst>
          </p:cNvPr>
          <p:cNvGrpSpPr/>
          <p:nvPr/>
        </p:nvGrpSpPr>
        <p:grpSpPr>
          <a:xfrm>
            <a:off x="1278111" y="491245"/>
            <a:ext cx="3679253" cy="2788777"/>
            <a:chOff x="1224031" y="612881"/>
            <a:chExt cx="4257039" cy="3280363"/>
          </a:xfrm>
        </p:grpSpPr>
        <p:cxnSp>
          <p:nvCxnSpPr>
            <p:cNvPr id="3" name="直接连接符 2">
              <a:extLst>
                <a:ext uri="{FF2B5EF4-FFF2-40B4-BE49-F238E27FC236}">
                  <a16:creationId xmlns:a16="http://schemas.microsoft.com/office/drawing/2014/main" id="{0C649481-5205-D0FB-3913-47CC79544F1E}"/>
                </a:ext>
              </a:extLst>
            </p:cNvPr>
            <p:cNvCxnSpPr>
              <a:cxnSpLocks/>
            </p:cNvCxnSpPr>
            <p:nvPr/>
          </p:nvCxnSpPr>
          <p:spPr>
            <a:xfrm>
              <a:off x="1838320" y="612881"/>
              <a:ext cx="12730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 name="直接连接符 3">
              <a:extLst>
                <a:ext uri="{FF2B5EF4-FFF2-40B4-BE49-F238E27FC236}">
                  <a16:creationId xmlns:a16="http://schemas.microsoft.com/office/drawing/2014/main" id="{71D66F44-D07A-9F19-B636-7A8FA1E03C00}"/>
                </a:ext>
              </a:extLst>
            </p:cNvPr>
            <p:cNvCxnSpPr>
              <a:cxnSpLocks/>
            </p:cNvCxnSpPr>
            <p:nvPr/>
          </p:nvCxnSpPr>
          <p:spPr>
            <a:xfrm>
              <a:off x="1990720" y="765281"/>
              <a:ext cx="12730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5" name="组合 4">
              <a:extLst>
                <a:ext uri="{FF2B5EF4-FFF2-40B4-BE49-F238E27FC236}">
                  <a16:creationId xmlns:a16="http://schemas.microsoft.com/office/drawing/2014/main" id="{414782BB-4914-F236-E173-4C2BF66628AA}"/>
                </a:ext>
              </a:extLst>
            </p:cNvPr>
            <p:cNvGrpSpPr/>
            <p:nvPr/>
          </p:nvGrpSpPr>
          <p:grpSpPr>
            <a:xfrm>
              <a:off x="1224031" y="892754"/>
              <a:ext cx="274434" cy="2740823"/>
              <a:chOff x="767174" y="3784355"/>
              <a:chExt cx="274434" cy="2740823"/>
            </a:xfrm>
          </p:grpSpPr>
          <p:sp>
            <p:nvSpPr>
              <p:cNvPr id="32" name="文本框 31">
                <a:extLst>
                  <a:ext uri="{FF2B5EF4-FFF2-40B4-BE49-F238E27FC236}">
                    <a16:creationId xmlns:a16="http://schemas.microsoft.com/office/drawing/2014/main" id="{BDBB0159-9673-FD62-59A4-8EE628667362}"/>
                  </a:ext>
                </a:extLst>
              </p:cNvPr>
              <p:cNvSpPr txBox="1"/>
              <p:nvPr/>
            </p:nvSpPr>
            <p:spPr>
              <a:xfrm rot="16200000">
                <a:off x="228680" y="4330201"/>
                <a:ext cx="1358773" cy="267082"/>
              </a:xfrm>
              <a:prstGeom prst="rect">
                <a:avLst/>
              </a:prstGeom>
              <a:noFill/>
            </p:spPr>
            <p:txBody>
              <a:bodyPr wrap="square" rtlCol="0">
                <a:spAutoFit/>
              </a:bodyPr>
              <a:lstStyle/>
              <a:p>
                <a:r>
                  <a:rPr lang="en-US" altLang="zh-CN" sz="900" b="1" i="1" dirty="0">
                    <a:latin typeface="Arial" panose="020B0604020202020204" pitchFamily="34" charset="0"/>
                    <a:cs typeface="Arial" panose="020B0604020202020204" pitchFamily="34" charset="0"/>
                  </a:rPr>
                  <a:t>cg &gt; white RNAi</a:t>
                </a:r>
                <a:endParaRPr lang="zh-CN" altLang="en-US" sz="900" b="1" i="1" dirty="0">
                  <a:latin typeface="Arial" panose="020B0604020202020204" pitchFamily="34" charset="0"/>
                  <a:cs typeface="Arial" panose="020B0604020202020204" pitchFamily="34" charset="0"/>
                </a:endParaRPr>
              </a:p>
            </p:txBody>
          </p:sp>
          <p:sp>
            <p:nvSpPr>
              <p:cNvPr id="33" name="文本框 32">
                <a:extLst>
                  <a:ext uri="{FF2B5EF4-FFF2-40B4-BE49-F238E27FC236}">
                    <a16:creationId xmlns:a16="http://schemas.microsoft.com/office/drawing/2014/main" id="{E41CBA8A-3223-42C8-B504-AE91607546CD}"/>
                  </a:ext>
                </a:extLst>
              </p:cNvPr>
              <p:cNvSpPr txBox="1"/>
              <p:nvPr/>
            </p:nvSpPr>
            <p:spPr>
              <a:xfrm rot="16200000">
                <a:off x="186473" y="5677396"/>
                <a:ext cx="1428483" cy="267082"/>
              </a:xfrm>
              <a:prstGeom prst="rect">
                <a:avLst/>
              </a:prstGeom>
              <a:noFill/>
            </p:spPr>
            <p:txBody>
              <a:bodyPr wrap="square" rtlCol="0">
                <a:spAutoFit/>
              </a:bodyPr>
              <a:lstStyle/>
              <a:p>
                <a:r>
                  <a:rPr lang="en-US" altLang="zh-CN" sz="900" b="1" i="1" dirty="0">
                    <a:latin typeface="Arial" panose="020B0604020202020204" pitchFamily="34" charset="0"/>
                    <a:cs typeface="Arial" panose="020B0604020202020204" pitchFamily="34" charset="0"/>
                  </a:rPr>
                  <a:t>cg &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RNAi</a:t>
                </a:r>
                <a:endParaRPr lang="zh-CN" altLang="en-US" sz="900" b="1" i="1" dirty="0">
                  <a:latin typeface="Arial" panose="020B0604020202020204" pitchFamily="34" charset="0"/>
                  <a:cs typeface="Arial" panose="020B0604020202020204" pitchFamily="34" charset="0"/>
                </a:endParaRPr>
              </a:p>
            </p:txBody>
          </p:sp>
        </p:grpSp>
        <p:grpSp>
          <p:nvGrpSpPr>
            <p:cNvPr id="6" name="组合 5">
              <a:extLst>
                <a:ext uri="{FF2B5EF4-FFF2-40B4-BE49-F238E27FC236}">
                  <a16:creationId xmlns:a16="http://schemas.microsoft.com/office/drawing/2014/main" id="{86E19A6B-2FD8-49D7-D27A-13AEAD2F97E4}"/>
                </a:ext>
              </a:extLst>
            </p:cNvPr>
            <p:cNvGrpSpPr/>
            <p:nvPr/>
          </p:nvGrpSpPr>
          <p:grpSpPr>
            <a:xfrm>
              <a:off x="1454047" y="2378179"/>
              <a:ext cx="2077767" cy="1502999"/>
              <a:chOff x="1679597" y="4288201"/>
              <a:chExt cx="1730424" cy="1281733"/>
            </a:xfrm>
          </p:grpSpPr>
          <p:pic>
            <p:nvPicPr>
              <p:cNvPr id="29" name="图片 28">
                <a:extLst>
                  <a:ext uri="{FF2B5EF4-FFF2-40B4-BE49-F238E27FC236}">
                    <a16:creationId xmlns:a16="http://schemas.microsoft.com/office/drawing/2014/main" id="{8B00D661-E1A1-28C5-C0B9-CD12C89D9D0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79597" y="4288201"/>
                <a:ext cx="1730424" cy="1281733"/>
              </a:xfrm>
              <a:prstGeom prst="rect">
                <a:avLst/>
              </a:prstGeom>
            </p:spPr>
          </p:pic>
          <p:sp>
            <p:nvSpPr>
              <p:cNvPr id="30" name="任意多边形: 形状 29">
                <a:extLst>
                  <a:ext uri="{FF2B5EF4-FFF2-40B4-BE49-F238E27FC236}">
                    <a16:creationId xmlns:a16="http://schemas.microsoft.com/office/drawing/2014/main" id="{0436F8E6-7BD3-79B3-316C-4DF2BE74BF4A}"/>
                  </a:ext>
                </a:extLst>
              </p:cNvPr>
              <p:cNvSpPr/>
              <p:nvPr/>
            </p:nvSpPr>
            <p:spPr>
              <a:xfrm>
                <a:off x="2272037" y="4815634"/>
                <a:ext cx="568999" cy="660283"/>
              </a:xfrm>
              <a:custGeom>
                <a:avLst/>
                <a:gdLst>
                  <a:gd name="connsiteX0" fmla="*/ 452967 w 753533"/>
                  <a:gd name="connsiteY0" fmla="*/ 165100 h 818506"/>
                  <a:gd name="connsiteX1" fmla="*/ 461433 w 753533"/>
                  <a:gd name="connsiteY1" fmla="*/ 143934 h 818506"/>
                  <a:gd name="connsiteX2" fmla="*/ 465667 w 753533"/>
                  <a:gd name="connsiteY2" fmla="*/ 127000 h 818506"/>
                  <a:gd name="connsiteX3" fmla="*/ 482600 w 753533"/>
                  <a:gd name="connsiteY3" fmla="*/ 105834 h 818506"/>
                  <a:gd name="connsiteX4" fmla="*/ 499533 w 753533"/>
                  <a:gd name="connsiteY4" fmla="*/ 71967 h 818506"/>
                  <a:gd name="connsiteX5" fmla="*/ 537633 w 753533"/>
                  <a:gd name="connsiteY5" fmla="*/ 42334 h 818506"/>
                  <a:gd name="connsiteX6" fmla="*/ 550333 w 753533"/>
                  <a:gd name="connsiteY6" fmla="*/ 33867 h 818506"/>
                  <a:gd name="connsiteX7" fmla="*/ 584200 w 753533"/>
                  <a:gd name="connsiteY7" fmla="*/ 16934 h 818506"/>
                  <a:gd name="connsiteX8" fmla="*/ 596900 w 753533"/>
                  <a:gd name="connsiteY8" fmla="*/ 8467 h 818506"/>
                  <a:gd name="connsiteX9" fmla="*/ 630767 w 753533"/>
                  <a:gd name="connsiteY9" fmla="*/ 0 h 818506"/>
                  <a:gd name="connsiteX10" fmla="*/ 711200 w 753533"/>
                  <a:gd name="connsiteY10" fmla="*/ 4234 h 818506"/>
                  <a:gd name="connsiteX11" fmla="*/ 723900 w 753533"/>
                  <a:gd name="connsiteY11" fmla="*/ 12700 h 818506"/>
                  <a:gd name="connsiteX12" fmla="*/ 736600 w 753533"/>
                  <a:gd name="connsiteY12" fmla="*/ 25400 h 818506"/>
                  <a:gd name="connsiteX13" fmla="*/ 749300 w 753533"/>
                  <a:gd name="connsiteY13" fmla="*/ 55034 h 818506"/>
                  <a:gd name="connsiteX14" fmla="*/ 753533 w 753533"/>
                  <a:gd name="connsiteY14" fmla="*/ 80434 h 818506"/>
                  <a:gd name="connsiteX15" fmla="*/ 749300 w 753533"/>
                  <a:gd name="connsiteY15" fmla="*/ 254000 h 818506"/>
                  <a:gd name="connsiteX16" fmla="*/ 740833 w 753533"/>
                  <a:gd name="connsiteY16" fmla="*/ 300567 h 818506"/>
                  <a:gd name="connsiteX17" fmla="*/ 736600 w 753533"/>
                  <a:gd name="connsiteY17" fmla="*/ 338667 h 818506"/>
                  <a:gd name="connsiteX18" fmla="*/ 732367 w 753533"/>
                  <a:gd name="connsiteY18" fmla="*/ 419100 h 818506"/>
                  <a:gd name="connsiteX19" fmla="*/ 728133 w 753533"/>
                  <a:gd name="connsiteY19" fmla="*/ 440267 h 818506"/>
                  <a:gd name="connsiteX20" fmla="*/ 711200 w 753533"/>
                  <a:gd name="connsiteY20" fmla="*/ 584200 h 818506"/>
                  <a:gd name="connsiteX21" fmla="*/ 702733 w 753533"/>
                  <a:gd name="connsiteY21" fmla="*/ 609600 h 818506"/>
                  <a:gd name="connsiteX22" fmla="*/ 685800 w 753533"/>
                  <a:gd name="connsiteY22" fmla="*/ 622300 h 818506"/>
                  <a:gd name="connsiteX23" fmla="*/ 668867 w 753533"/>
                  <a:gd name="connsiteY23" fmla="*/ 647700 h 818506"/>
                  <a:gd name="connsiteX24" fmla="*/ 618067 w 753533"/>
                  <a:gd name="connsiteY24" fmla="*/ 694267 h 818506"/>
                  <a:gd name="connsiteX25" fmla="*/ 605367 w 753533"/>
                  <a:gd name="connsiteY25" fmla="*/ 702734 h 818506"/>
                  <a:gd name="connsiteX26" fmla="*/ 592667 w 753533"/>
                  <a:gd name="connsiteY26" fmla="*/ 715434 h 818506"/>
                  <a:gd name="connsiteX27" fmla="*/ 579967 w 753533"/>
                  <a:gd name="connsiteY27" fmla="*/ 723900 h 818506"/>
                  <a:gd name="connsiteX28" fmla="*/ 558800 w 753533"/>
                  <a:gd name="connsiteY28" fmla="*/ 740834 h 818506"/>
                  <a:gd name="connsiteX29" fmla="*/ 529167 w 753533"/>
                  <a:gd name="connsiteY29" fmla="*/ 757767 h 818506"/>
                  <a:gd name="connsiteX30" fmla="*/ 508000 w 753533"/>
                  <a:gd name="connsiteY30" fmla="*/ 774700 h 818506"/>
                  <a:gd name="connsiteX31" fmla="*/ 474133 w 753533"/>
                  <a:gd name="connsiteY31" fmla="*/ 787400 h 818506"/>
                  <a:gd name="connsiteX32" fmla="*/ 457200 w 753533"/>
                  <a:gd name="connsiteY32" fmla="*/ 795867 h 818506"/>
                  <a:gd name="connsiteX33" fmla="*/ 436033 w 753533"/>
                  <a:gd name="connsiteY33" fmla="*/ 800100 h 818506"/>
                  <a:gd name="connsiteX34" fmla="*/ 376767 w 753533"/>
                  <a:gd name="connsiteY34" fmla="*/ 808567 h 818506"/>
                  <a:gd name="connsiteX35" fmla="*/ 254000 w 753533"/>
                  <a:gd name="connsiteY35" fmla="*/ 817034 h 818506"/>
                  <a:gd name="connsiteX36" fmla="*/ 127000 w 753533"/>
                  <a:gd name="connsiteY36" fmla="*/ 808567 h 818506"/>
                  <a:gd name="connsiteX37" fmla="*/ 110067 w 753533"/>
                  <a:gd name="connsiteY37" fmla="*/ 800100 h 818506"/>
                  <a:gd name="connsiteX38" fmla="*/ 97367 w 753533"/>
                  <a:gd name="connsiteY38" fmla="*/ 791634 h 818506"/>
                  <a:gd name="connsiteX39" fmla="*/ 71967 w 753533"/>
                  <a:gd name="connsiteY39" fmla="*/ 749300 h 818506"/>
                  <a:gd name="connsiteX40" fmla="*/ 55033 w 753533"/>
                  <a:gd name="connsiteY40" fmla="*/ 711200 h 818506"/>
                  <a:gd name="connsiteX41" fmla="*/ 25400 w 753533"/>
                  <a:gd name="connsiteY41" fmla="*/ 681567 h 818506"/>
                  <a:gd name="connsiteX42" fmla="*/ 4233 w 753533"/>
                  <a:gd name="connsiteY42" fmla="*/ 626534 h 818506"/>
                  <a:gd name="connsiteX43" fmla="*/ 0 w 753533"/>
                  <a:gd name="connsiteY43" fmla="*/ 613834 h 818506"/>
                  <a:gd name="connsiteX44" fmla="*/ 4233 w 753533"/>
                  <a:gd name="connsiteY44" fmla="*/ 508000 h 818506"/>
                  <a:gd name="connsiteX45" fmla="*/ 16933 w 753533"/>
                  <a:gd name="connsiteY45" fmla="*/ 491067 h 818506"/>
                  <a:gd name="connsiteX46" fmla="*/ 42333 w 753533"/>
                  <a:gd name="connsiteY46" fmla="*/ 465667 h 818506"/>
                  <a:gd name="connsiteX47" fmla="*/ 50800 w 753533"/>
                  <a:gd name="connsiteY47" fmla="*/ 452967 h 818506"/>
                  <a:gd name="connsiteX48" fmla="*/ 76200 w 753533"/>
                  <a:gd name="connsiteY48" fmla="*/ 431800 h 818506"/>
                  <a:gd name="connsiteX49" fmla="*/ 84667 w 753533"/>
                  <a:gd name="connsiteY49" fmla="*/ 419100 h 818506"/>
                  <a:gd name="connsiteX50" fmla="*/ 105833 w 753533"/>
                  <a:gd name="connsiteY50" fmla="*/ 406400 h 818506"/>
                  <a:gd name="connsiteX51" fmla="*/ 135467 w 753533"/>
                  <a:gd name="connsiteY51" fmla="*/ 381000 h 818506"/>
                  <a:gd name="connsiteX52" fmla="*/ 152400 w 753533"/>
                  <a:gd name="connsiteY52" fmla="*/ 372534 h 818506"/>
                  <a:gd name="connsiteX53" fmla="*/ 169333 w 753533"/>
                  <a:gd name="connsiteY53" fmla="*/ 359834 h 818506"/>
                  <a:gd name="connsiteX54" fmla="*/ 203200 w 753533"/>
                  <a:gd name="connsiteY54" fmla="*/ 351367 h 818506"/>
                  <a:gd name="connsiteX55" fmla="*/ 237067 w 753533"/>
                  <a:gd name="connsiteY55" fmla="*/ 338667 h 818506"/>
                  <a:gd name="connsiteX56" fmla="*/ 279400 w 753533"/>
                  <a:gd name="connsiteY56" fmla="*/ 325967 h 818506"/>
                  <a:gd name="connsiteX57" fmla="*/ 330200 w 753533"/>
                  <a:gd name="connsiteY57" fmla="*/ 296334 h 818506"/>
                  <a:gd name="connsiteX58" fmla="*/ 355600 w 753533"/>
                  <a:gd name="connsiteY58" fmla="*/ 279400 h 818506"/>
                  <a:gd name="connsiteX59" fmla="*/ 381000 w 753533"/>
                  <a:gd name="connsiteY59" fmla="*/ 262467 h 818506"/>
                  <a:gd name="connsiteX60" fmla="*/ 393700 w 753533"/>
                  <a:gd name="connsiteY60" fmla="*/ 254000 h 818506"/>
                  <a:gd name="connsiteX61" fmla="*/ 406400 w 753533"/>
                  <a:gd name="connsiteY61" fmla="*/ 241300 h 818506"/>
                  <a:gd name="connsiteX62" fmla="*/ 444500 w 753533"/>
                  <a:gd name="connsiteY62" fmla="*/ 215900 h 818506"/>
                  <a:gd name="connsiteX63" fmla="*/ 461433 w 753533"/>
                  <a:gd name="connsiteY63" fmla="*/ 190500 h 818506"/>
                  <a:gd name="connsiteX64" fmla="*/ 482600 w 753533"/>
                  <a:gd name="connsiteY64" fmla="*/ 165100 h 818506"/>
                  <a:gd name="connsiteX65" fmla="*/ 499533 w 753533"/>
                  <a:gd name="connsiteY65" fmla="*/ 131234 h 818506"/>
                  <a:gd name="connsiteX66" fmla="*/ 503767 w 753533"/>
                  <a:gd name="connsiteY66" fmla="*/ 110067 h 818506"/>
                  <a:gd name="connsiteX67" fmla="*/ 512233 w 753533"/>
                  <a:gd name="connsiteY67" fmla="*/ 97367 h 818506"/>
                  <a:gd name="connsiteX68" fmla="*/ 524933 w 753533"/>
                  <a:gd name="connsiteY68" fmla="*/ 84667 h 818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Lst>
                <a:rect l="l" t="t" r="r" b="b"/>
                <a:pathLst>
                  <a:path w="753533" h="818506">
                    <a:moveTo>
                      <a:pt x="452967" y="165100"/>
                    </a:moveTo>
                    <a:cubicBezTo>
                      <a:pt x="455789" y="158045"/>
                      <a:pt x="459030" y="151143"/>
                      <a:pt x="461433" y="143934"/>
                    </a:cubicBezTo>
                    <a:cubicBezTo>
                      <a:pt x="463273" y="138414"/>
                      <a:pt x="462841" y="132086"/>
                      <a:pt x="465667" y="127000"/>
                    </a:cubicBezTo>
                    <a:cubicBezTo>
                      <a:pt x="470055" y="119102"/>
                      <a:pt x="477951" y="113582"/>
                      <a:pt x="482600" y="105834"/>
                    </a:cubicBezTo>
                    <a:cubicBezTo>
                      <a:pt x="496515" y="82643"/>
                      <a:pt x="484470" y="89182"/>
                      <a:pt x="499533" y="71967"/>
                    </a:cubicBezTo>
                    <a:cubicBezTo>
                      <a:pt x="523866" y="44157"/>
                      <a:pt x="512595" y="56642"/>
                      <a:pt x="537633" y="42334"/>
                    </a:cubicBezTo>
                    <a:cubicBezTo>
                      <a:pt x="542051" y="39810"/>
                      <a:pt x="545866" y="36303"/>
                      <a:pt x="550333" y="33867"/>
                    </a:cubicBezTo>
                    <a:cubicBezTo>
                      <a:pt x="561413" y="27823"/>
                      <a:pt x="573698" y="23935"/>
                      <a:pt x="584200" y="16934"/>
                    </a:cubicBezTo>
                    <a:cubicBezTo>
                      <a:pt x="588433" y="14112"/>
                      <a:pt x="592349" y="10742"/>
                      <a:pt x="596900" y="8467"/>
                    </a:cubicBezTo>
                    <a:cubicBezTo>
                      <a:pt x="605576" y="4129"/>
                      <a:pt x="622721" y="1609"/>
                      <a:pt x="630767" y="0"/>
                    </a:cubicBezTo>
                    <a:cubicBezTo>
                      <a:pt x="657578" y="1411"/>
                      <a:pt x="684598" y="606"/>
                      <a:pt x="711200" y="4234"/>
                    </a:cubicBezTo>
                    <a:cubicBezTo>
                      <a:pt x="716241" y="4921"/>
                      <a:pt x="719991" y="9443"/>
                      <a:pt x="723900" y="12700"/>
                    </a:cubicBezTo>
                    <a:cubicBezTo>
                      <a:pt x="728499" y="16533"/>
                      <a:pt x="733120" y="20528"/>
                      <a:pt x="736600" y="25400"/>
                    </a:cubicBezTo>
                    <a:cubicBezTo>
                      <a:pt x="740776" y="31246"/>
                      <a:pt x="747517" y="47009"/>
                      <a:pt x="749300" y="55034"/>
                    </a:cubicBezTo>
                    <a:cubicBezTo>
                      <a:pt x="751162" y="63413"/>
                      <a:pt x="752122" y="71967"/>
                      <a:pt x="753533" y="80434"/>
                    </a:cubicBezTo>
                    <a:cubicBezTo>
                      <a:pt x="752122" y="138289"/>
                      <a:pt x="752633" y="196224"/>
                      <a:pt x="749300" y="254000"/>
                    </a:cubicBezTo>
                    <a:cubicBezTo>
                      <a:pt x="748391" y="269751"/>
                      <a:pt x="743173" y="284965"/>
                      <a:pt x="740833" y="300567"/>
                    </a:cubicBezTo>
                    <a:cubicBezTo>
                      <a:pt x="738937" y="313204"/>
                      <a:pt x="738011" y="325967"/>
                      <a:pt x="736600" y="338667"/>
                    </a:cubicBezTo>
                    <a:cubicBezTo>
                      <a:pt x="735189" y="365478"/>
                      <a:pt x="734597" y="392345"/>
                      <a:pt x="732367" y="419100"/>
                    </a:cubicBezTo>
                    <a:cubicBezTo>
                      <a:pt x="731769" y="426271"/>
                      <a:pt x="728665" y="433091"/>
                      <a:pt x="728133" y="440267"/>
                    </a:cubicBezTo>
                    <a:cubicBezTo>
                      <a:pt x="722470" y="516714"/>
                      <a:pt x="731795" y="522417"/>
                      <a:pt x="711200" y="584200"/>
                    </a:cubicBezTo>
                    <a:cubicBezTo>
                      <a:pt x="708378" y="592667"/>
                      <a:pt x="707684" y="602174"/>
                      <a:pt x="702733" y="609600"/>
                    </a:cubicBezTo>
                    <a:cubicBezTo>
                      <a:pt x="698819" y="615471"/>
                      <a:pt x="690487" y="617027"/>
                      <a:pt x="685800" y="622300"/>
                    </a:cubicBezTo>
                    <a:cubicBezTo>
                      <a:pt x="679040" y="629905"/>
                      <a:pt x="675489" y="639974"/>
                      <a:pt x="668867" y="647700"/>
                    </a:cubicBezTo>
                    <a:cubicBezTo>
                      <a:pt x="649633" y="670139"/>
                      <a:pt x="639100" y="679243"/>
                      <a:pt x="618067" y="694267"/>
                    </a:cubicBezTo>
                    <a:cubicBezTo>
                      <a:pt x="613927" y="697224"/>
                      <a:pt x="609276" y="699477"/>
                      <a:pt x="605367" y="702734"/>
                    </a:cubicBezTo>
                    <a:cubicBezTo>
                      <a:pt x="600768" y="706567"/>
                      <a:pt x="597266" y="711601"/>
                      <a:pt x="592667" y="715434"/>
                    </a:cubicBezTo>
                    <a:cubicBezTo>
                      <a:pt x="588758" y="718691"/>
                      <a:pt x="584037" y="720847"/>
                      <a:pt x="579967" y="723900"/>
                    </a:cubicBezTo>
                    <a:cubicBezTo>
                      <a:pt x="572738" y="729321"/>
                      <a:pt x="566029" y="735413"/>
                      <a:pt x="558800" y="740834"/>
                    </a:cubicBezTo>
                    <a:cubicBezTo>
                      <a:pt x="524174" y="766803"/>
                      <a:pt x="571334" y="729656"/>
                      <a:pt x="529167" y="757767"/>
                    </a:cubicBezTo>
                    <a:cubicBezTo>
                      <a:pt x="521649" y="762779"/>
                      <a:pt x="515748" y="770051"/>
                      <a:pt x="508000" y="774700"/>
                    </a:cubicBezTo>
                    <a:cubicBezTo>
                      <a:pt x="493374" y="783475"/>
                      <a:pt x="487768" y="781556"/>
                      <a:pt x="474133" y="787400"/>
                    </a:cubicBezTo>
                    <a:cubicBezTo>
                      <a:pt x="468333" y="789886"/>
                      <a:pt x="463187" y="793871"/>
                      <a:pt x="457200" y="795867"/>
                    </a:cubicBezTo>
                    <a:cubicBezTo>
                      <a:pt x="450374" y="798142"/>
                      <a:pt x="443140" y="798978"/>
                      <a:pt x="436033" y="800100"/>
                    </a:cubicBezTo>
                    <a:cubicBezTo>
                      <a:pt x="416321" y="803212"/>
                      <a:pt x="396451" y="805287"/>
                      <a:pt x="376767" y="808567"/>
                    </a:cubicBezTo>
                    <a:cubicBezTo>
                      <a:pt x="319323" y="818140"/>
                      <a:pt x="359942" y="812427"/>
                      <a:pt x="254000" y="817034"/>
                    </a:cubicBezTo>
                    <a:cubicBezTo>
                      <a:pt x="236840" y="816398"/>
                      <a:pt x="163979" y="824415"/>
                      <a:pt x="127000" y="808567"/>
                    </a:cubicBezTo>
                    <a:cubicBezTo>
                      <a:pt x="121200" y="806081"/>
                      <a:pt x="115546" y="803231"/>
                      <a:pt x="110067" y="800100"/>
                    </a:cubicBezTo>
                    <a:cubicBezTo>
                      <a:pt x="105650" y="797576"/>
                      <a:pt x="101600" y="794456"/>
                      <a:pt x="97367" y="791634"/>
                    </a:cubicBezTo>
                    <a:cubicBezTo>
                      <a:pt x="85322" y="773567"/>
                      <a:pt x="79780" y="767532"/>
                      <a:pt x="71967" y="749300"/>
                    </a:cubicBezTo>
                    <a:cubicBezTo>
                      <a:pt x="64773" y="732513"/>
                      <a:pt x="69658" y="730212"/>
                      <a:pt x="55033" y="711200"/>
                    </a:cubicBezTo>
                    <a:cubicBezTo>
                      <a:pt x="46516" y="700128"/>
                      <a:pt x="31647" y="694061"/>
                      <a:pt x="25400" y="681567"/>
                    </a:cubicBezTo>
                    <a:cubicBezTo>
                      <a:pt x="10946" y="652661"/>
                      <a:pt x="18928" y="670619"/>
                      <a:pt x="4233" y="626534"/>
                    </a:cubicBezTo>
                    <a:lnTo>
                      <a:pt x="0" y="613834"/>
                    </a:lnTo>
                    <a:cubicBezTo>
                      <a:pt x="1411" y="578556"/>
                      <a:pt x="-591" y="542975"/>
                      <a:pt x="4233" y="508000"/>
                    </a:cubicBezTo>
                    <a:cubicBezTo>
                      <a:pt x="5197" y="501011"/>
                      <a:pt x="12213" y="496311"/>
                      <a:pt x="16933" y="491067"/>
                    </a:cubicBezTo>
                    <a:cubicBezTo>
                      <a:pt x="24943" y="482167"/>
                      <a:pt x="35691" y="475630"/>
                      <a:pt x="42333" y="465667"/>
                    </a:cubicBezTo>
                    <a:cubicBezTo>
                      <a:pt x="45155" y="461434"/>
                      <a:pt x="47202" y="456565"/>
                      <a:pt x="50800" y="452967"/>
                    </a:cubicBezTo>
                    <a:cubicBezTo>
                      <a:pt x="84100" y="419667"/>
                      <a:pt x="41524" y="473411"/>
                      <a:pt x="76200" y="431800"/>
                    </a:cubicBezTo>
                    <a:cubicBezTo>
                      <a:pt x="79457" y="427891"/>
                      <a:pt x="80804" y="422411"/>
                      <a:pt x="84667" y="419100"/>
                    </a:cubicBezTo>
                    <a:cubicBezTo>
                      <a:pt x="90914" y="413745"/>
                      <a:pt x="99251" y="411337"/>
                      <a:pt x="105833" y="406400"/>
                    </a:cubicBezTo>
                    <a:cubicBezTo>
                      <a:pt x="140461" y="380429"/>
                      <a:pt x="93781" y="407053"/>
                      <a:pt x="135467" y="381000"/>
                    </a:cubicBezTo>
                    <a:cubicBezTo>
                      <a:pt x="140818" y="377656"/>
                      <a:pt x="147049" y="375879"/>
                      <a:pt x="152400" y="372534"/>
                    </a:cubicBezTo>
                    <a:cubicBezTo>
                      <a:pt x="158383" y="368795"/>
                      <a:pt x="162820" y="362548"/>
                      <a:pt x="169333" y="359834"/>
                    </a:cubicBezTo>
                    <a:cubicBezTo>
                      <a:pt x="180074" y="355358"/>
                      <a:pt x="203200" y="351367"/>
                      <a:pt x="203200" y="351367"/>
                    </a:cubicBezTo>
                    <a:cubicBezTo>
                      <a:pt x="231591" y="337171"/>
                      <a:pt x="208245" y="347314"/>
                      <a:pt x="237067" y="338667"/>
                    </a:cubicBezTo>
                    <a:cubicBezTo>
                      <a:pt x="288606" y="323205"/>
                      <a:pt x="240367" y="335725"/>
                      <a:pt x="279400" y="325967"/>
                    </a:cubicBezTo>
                    <a:cubicBezTo>
                      <a:pt x="331662" y="299837"/>
                      <a:pt x="296415" y="319985"/>
                      <a:pt x="330200" y="296334"/>
                    </a:cubicBezTo>
                    <a:cubicBezTo>
                      <a:pt x="338536" y="290498"/>
                      <a:pt x="348405" y="286595"/>
                      <a:pt x="355600" y="279400"/>
                    </a:cubicBezTo>
                    <a:cubicBezTo>
                      <a:pt x="371455" y="263545"/>
                      <a:pt x="362620" y="268593"/>
                      <a:pt x="381000" y="262467"/>
                    </a:cubicBezTo>
                    <a:cubicBezTo>
                      <a:pt x="385233" y="259645"/>
                      <a:pt x="389791" y="257257"/>
                      <a:pt x="393700" y="254000"/>
                    </a:cubicBezTo>
                    <a:cubicBezTo>
                      <a:pt x="398299" y="250167"/>
                      <a:pt x="401528" y="244780"/>
                      <a:pt x="406400" y="241300"/>
                    </a:cubicBezTo>
                    <a:cubicBezTo>
                      <a:pt x="430636" y="223989"/>
                      <a:pt x="419520" y="243656"/>
                      <a:pt x="444500" y="215900"/>
                    </a:cubicBezTo>
                    <a:cubicBezTo>
                      <a:pt x="451307" y="208336"/>
                      <a:pt x="454919" y="198317"/>
                      <a:pt x="461433" y="190500"/>
                    </a:cubicBezTo>
                    <a:lnTo>
                      <a:pt x="482600" y="165100"/>
                    </a:lnTo>
                    <a:cubicBezTo>
                      <a:pt x="495536" y="113354"/>
                      <a:pt x="474863" y="186738"/>
                      <a:pt x="499533" y="131234"/>
                    </a:cubicBezTo>
                    <a:cubicBezTo>
                      <a:pt x="502455" y="124659"/>
                      <a:pt x="501241" y="116804"/>
                      <a:pt x="503767" y="110067"/>
                    </a:cubicBezTo>
                    <a:cubicBezTo>
                      <a:pt x="505553" y="105303"/>
                      <a:pt x="508636" y="100965"/>
                      <a:pt x="512233" y="97367"/>
                    </a:cubicBezTo>
                    <a:cubicBezTo>
                      <a:pt x="526107" y="83492"/>
                      <a:pt x="524933" y="95271"/>
                      <a:pt x="524933" y="84667"/>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cxnSp>
            <p:nvCxnSpPr>
              <p:cNvPr id="31" name="直接箭头连接符 30">
                <a:extLst>
                  <a:ext uri="{FF2B5EF4-FFF2-40B4-BE49-F238E27FC236}">
                    <a16:creationId xmlns:a16="http://schemas.microsoft.com/office/drawing/2014/main" id="{A5E6A9BD-DAFA-BC2F-9312-97F6B95C7888}"/>
                  </a:ext>
                </a:extLst>
              </p:cNvPr>
              <p:cNvCxnSpPr>
                <a:cxnSpLocks/>
              </p:cNvCxnSpPr>
              <p:nvPr/>
            </p:nvCxnSpPr>
            <p:spPr>
              <a:xfrm flipH="1">
                <a:off x="2638822" y="5083013"/>
                <a:ext cx="110692" cy="86221"/>
              </a:xfrm>
              <a:prstGeom prst="straightConnector1">
                <a:avLst/>
              </a:prstGeom>
              <a:ln w="19050">
                <a:solidFill>
                  <a:srgbClr val="FFFF00"/>
                </a:solidFill>
                <a:tailEnd type="triangle"/>
              </a:ln>
            </p:spPr>
            <p:style>
              <a:lnRef idx="1">
                <a:schemeClr val="accent2"/>
              </a:lnRef>
              <a:fillRef idx="0">
                <a:schemeClr val="accent2"/>
              </a:fillRef>
              <a:effectRef idx="0">
                <a:schemeClr val="accent2"/>
              </a:effectRef>
              <a:fontRef idx="minor">
                <a:schemeClr val="tx1"/>
              </a:fontRef>
            </p:style>
          </p:cxnSp>
        </p:grpSp>
        <p:grpSp>
          <p:nvGrpSpPr>
            <p:cNvPr id="7" name="组合 6">
              <a:extLst>
                <a:ext uri="{FF2B5EF4-FFF2-40B4-BE49-F238E27FC236}">
                  <a16:creationId xmlns:a16="http://schemas.microsoft.com/office/drawing/2014/main" id="{BADC0035-1806-E22D-EEDB-C467C6AD5E9A}"/>
                </a:ext>
              </a:extLst>
            </p:cNvPr>
            <p:cNvGrpSpPr/>
            <p:nvPr/>
          </p:nvGrpSpPr>
          <p:grpSpPr>
            <a:xfrm>
              <a:off x="3568082" y="2385927"/>
              <a:ext cx="1912988" cy="1495251"/>
              <a:chOff x="3461800" y="4279351"/>
              <a:chExt cx="1712088" cy="1290583"/>
            </a:xfrm>
          </p:grpSpPr>
          <p:pic>
            <p:nvPicPr>
              <p:cNvPr id="24" name="图片 23">
                <a:extLst>
                  <a:ext uri="{FF2B5EF4-FFF2-40B4-BE49-F238E27FC236}">
                    <a16:creationId xmlns:a16="http://schemas.microsoft.com/office/drawing/2014/main" id="{C2C25E45-B841-4864-38A4-C07646164CD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61800" y="4279351"/>
                <a:ext cx="1712088" cy="1290583"/>
              </a:xfrm>
              <a:prstGeom prst="rect">
                <a:avLst/>
              </a:prstGeom>
            </p:spPr>
          </p:pic>
          <p:sp>
            <p:nvSpPr>
              <p:cNvPr id="25" name="任意多边形: 形状 24">
                <a:extLst>
                  <a:ext uri="{FF2B5EF4-FFF2-40B4-BE49-F238E27FC236}">
                    <a16:creationId xmlns:a16="http://schemas.microsoft.com/office/drawing/2014/main" id="{67749E0A-5225-A1A5-CF54-141759D6B1A5}"/>
                  </a:ext>
                </a:extLst>
              </p:cNvPr>
              <p:cNvSpPr/>
              <p:nvPr/>
            </p:nvSpPr>
            <p:spPr>
              <a:xfrm>
                <a:off x="3565951" y="4289235"/>
                <a:ext cx="1138630" cy="879999"/>
              </a:xfrm>
              <a:custGeom>
                <a:avLst/>
                <a:gdLst>
                  <a:gd name="connsiteX0" fmla="*/ 317578 w 1477511"/>
                  <a:gd name="connsiteY0" fmla="*/ 254000 h 1138950"/>
                  <a:gd name="connsiteX1" fmla="*/ 351444 w 1477511"/>
                  <a:gd name="connsiteY1" fmla="*/ 249767 h 1138950"/>
                  <a:gd name="connsiteX2" fmla="*/ 381078 w 1477511"/>
                  <a:gd name="connsiteY2" fmla="*/ 241300 h 1138950"/>
                  <a:gd name="connsiteX3" fmla="*/ 410711 w 1477511"/>
                  <a:gd name="connsiteY3" fmla="*/ 237067 h 1138950"/>
                  <a:gd name="connsiteX4" fmla="*/ 584278 w 1477511"/>
                  <a:gd name="connsiteY4" fmla="*/ 232834 h 1138950"/>
                  <a:gd name="connsiteX5" fmla="*/ 668944 w 1477511"/>
                  <a:gd name="connsiteY5" fmla="*/ 245534 h 1138950"/>
                  <a:gd name="connsiteX6" fmla="*/ 694344 w 1477511"/>
                  <a:gd name="connsiteY6" fmla="*/ 258234 h 1138950"/>
                  <a:gd name="connsiteX7" fmla="*/ 707044 w 1477511"/>
                  <a:gd name="connsiteY7" fmla="*/ 262467 h 1138950"/>
                  <a:gd name="connsiteX8" fmla="*/ 723978 w 1477511"/>
                  <a:gd name="connsiteY8" fmla="*/ 237067 h 1138950"/>
                  <a:gd name="connsiteX9" fmla="*/ 736678 w 1477511"/>
                  <a:gd name="connsiteY9" fmla="*/ 211667 h 1138950"/>
                  <a:gd name="connsiteX10" fmla="*/ 757844 w 1477511"/>
                  <a:gd name="connsiteY10" fmla="*/ 182034 h 1138950"/>
                  <a:gd name="connsiteX11" fmla="*/ 774778 w 1477511"/>
                  <a:gd name="connsiteY11" fmla="*/ 152400 h 1138950"/>
                  <a:gd name="connsiteX12" fmla="*/ 779011 w 1477511"/>
                  <a:gd name="connsiteY12" fmla="*/ 135467 h 1138950"/>
                  <a:gd name="connsiteX13" fmla="*/ 787478 w 1477511"/>
                  <a:gd name="connsiteY13" fmla="*/ 122767 h 1138950"/>
                  <a:gd name="connsiteX14" fmla="*/ 834044 w 1477511"/>
                  <a:gd name="connsiteY14" fmla="*/ 76200 h 1138950"/>
                  <a:gd name="connsiteX15" fmla="*/ 884844 w 1477511"/>
                  <a:gd name="connsiteY15" fmla="*/ 67734 h 1138950"/>
                  <a:gd name="connsiteX16" fmla="*/ 922944 w 1477511"/>
                  <a:gd name="connsiteY16" fmla="*/ 46567 h 1138950"/>
                  <a:gd name="connsiteX17" fmla="*/ 939878 w 1477511"/>
                  <a:gd name="connsiteY17" fmla="*/ 42334 h 1138950"/>
                  <a:gd name="connsiteX18" fmla="*/ 965278 w 1477511"/>
                  <a:gd name="connsiteY18" fmla="*/ 25400 h 1138950"/>
                  <a:gd name="connsiteX19" fmla="*/ 977978 w 1477511"/>
                  <a:gd name="connsiteY19" fmla="*/ 16934 h 1138950"/>
                  <a:gd name="connsiteX20" fmla="*/ 1011844 w 1477511"/>
                  <a:gd name="connsiteY20" fmla="*/ 0 h 1138950"/>
                  <a:gd name="connsiteX21" fmla="*/ 1155778 w 1477511"/>
                  <a:gd name="connsiteY21" fmla="*/ 4234 h 1138950"/>
                  <a:gd name="connsiteX22" fmla="*/ 1198111 w 1477511"/>
                  <a:gd name="connsiteY22" fmla="*/ 21167 h 1138950"/>
                  <a:gd name="connsiteX23" fmla="*/ 1215044 w 1477511"/>
                  <a:gd name="connsiteY23" fmla="*/ 33867 h 1138950"/>
                  <a:gd name="connsiteX24" fmla="*/ 1231978 w 1477511"/>
                  <a:gd name="connsiteY24" fmla="*/ 42334 h 1138950"/>
                  <a:gd name="connsiteX25" fmla="*/ 1270078 w 1477511"/>
                  <a:gd name="connsiteY25" fmla="*/ 80434 h 1138950"/>
                  <a:gd name="connsiteX26" fmla="*/ 1282778 w 1477511"/>
                  <a:gd name="connsiteY26" fmla="*/ 93134 h 1138950"/>
                  <a:gd name="connsiteX27" fmla="*/ 1295478 w 1477511"/>
                  <a:gd name="connsiteY27" fmla="*/ 101600 h 1138950"/>
                  <a:gd name="connsiteX28" fmla="*/ 1320878 w 1477511"/>
                  <a:gd name="connsiteY28" fmla="*/ 131234 h 1138950"/>
                  <a:gd name="connsiteX29" fmla="*/ 1337811 w 1477511"/>
                  <a:gd name="connsiteY29" fmla="*/ 152400 h 1138950"/>
                  <a:gd name="connsiteX30" fmla="*/ 1342044 w 1477511"/>
                  <a:gd name="connsiteY30" fmla="*/ 169334 h 1138950"/>
                  <a:gd name="connsiteX31" fmla="*/ 1350511 w 1477511"/>
                  <a:gd name="connsiteY31" fmla="*/ 182034 h 1138950"/>
                  <a:gd name="connsiteX32" fmla="*/ 1358978 w 1477511"/>
                  <a:gd name="connsiteY32" fmla="*/ 198967 h 1138950"/>
                  <a:gd name="connsiteX33" fmla="*/ 1367444 w 1477511"/>
                  <a:gd name="connsiteY33" fmla="*/ 279400 h 1138950"/>
                  <a:gd name="connsiteX34" fmla="*/ 1371678 w 1477511"/>
                  <a:gd name="connsiteY34" fmla="*/ 300567 h 1138950"/>
                  <a:gd name="connsiteX35" fmla="*/ 1367444 w 1477511"/>
                  <a:gd name="connsiteY35" fmla="*/ 402167 h 1138950"/>
                  <a:gd name="connsiteX36" fmla="*/ 1354744 w 1477511"/>
                  <a:gd name="connsiteY36" fmla="*/ 419100 h 1138950"/>
                  <a:gd name="connsiteX37" fmla="*/ 1346278 w 1477511"/>
                  <a:gd name="connsiteY37" fmla="*/ 436034 h 1138950"/>
                  <a:gd name="connsiteX38" fmla="*/ 1303944 w 1477511"/>
                  <a:gd name="connsiteY38" fmla="*/ 474134 h 1138950"/>
                  <a:gd name="connsiteX39" fmla="*/ 1320878 w 1477511"/>
                  <a:gd name="connsiteY39" fmla="*/ 482600 h 1138950"/>
                  <a:gd name="connsiteX40" fmla="*/ 1375911 w 1477511"/>
                  <a:gd name="connsiteY40" fmla="*/ 499534 h 1138950"/>
                  <a:gd name="connsiteX41" fmla="*/ 1435178 w 1477511"/>
                  <a:gd name="connsiteY41" fmla="*/ 596900 h 1138950"/>
                  <a:gd name="connsiteX42" fmla="*/ 1443644 w 1477511"/>
                  <a:gd name="connsiteY42" fmla="*/ 613834 h 1138950"/>
                  <a:gd name="connsiteX43" fmla="*/ 1452111 w 1477511"/>
                  <a:gd name="connsiteY43" fmla="*/ 647700 h 1138950"/>
                  <a:gd name="connsiteX44" fmla="*/ 1460578 w 1477511"/>
                  <a:gd name="connsiteY44" fmla="*/ 677334 h 1138950"/>
                  <a:gd name="connsiteX45" fmla="*/ 1464811 w 1477511"/>
                  <a:gd name="connsiteY45" fmla="*/ 711200 h 1138950"/>
                  <a:gd name="connsiteX46" fmla="*/ 1477511 w 1477511"/>
                  <a:gd name="connsiteY46" fmla="*/ 757767 h 1138950"/>
                  <a:gd name="connsiteX47" fmla="*/ 1469044 w 1477511"/>
                  <a:gd name="connsiteY47" fmla="*/ 863600 h 1138950"/>
                  <a:gd name="connsiteX48" fmla="*/ 1422478 w 1477511"/>
                  <a:gd name="connsiteY48" fmla="*/ 931334 h 1138950"/>
                  <a:gd name="connsiteX49" fmla="*/ 1380144 w 1477511"/>
                  <a:gd name="connsiteY49" fmla="*/ 973667 h 1138950"/>
                  <a:gd name="connsiteX50" fmla="*/ 1367444 w 1477511"/>
                  <a:gd name="connsiteY50" fmla="*/ 986367 h 1138950"/>
                  <a:gd name="connsiteX51" fmla="*/ 1333578 w 1477511"/>
                  <a:gd name="connsiteY51" fmla="*/ 1003300 h 1138950"/>
                  <a:gd name="connsiteX52" fmla="*/ 1316644 w 1477511"/>
                  <a:gd name="connsiteY52" fmla="*/ 1016000 h 1138950"/>
                  <a:gd name="connsiteX53" fmla="*/ 1291244 w 1477511"/>
                  <a:gd name="connsiteY53" fmla="*/ 1028700 h 1138950"/>
                  <a:gd name="connsiteX54" fmla="*/ 1274311 w 1477511"/>
                  <a:gd name="connsiteY54" fmla="*/ 1041400 h 1138950"/>
                  <a:gd name="connsiteX55" fmla="*/ 1236211 w 1477511"/>
                  <a:gd name="connsiteY55" fmla="*/ 1058334 h 1138950"/>
                  <a:gd name="connsiteX56" fmla="*/ 1215044 w 1477511"/>
                  <a:gd name="connsiteY56" fmla="*/ 1071034 h 1138950"/>
                  <a:gd name="connsiteX57" fmla="*/ 1193878 w 1477511"/>
                  <a:gd name="connsiteY57" fmla="*/ 1079500 h 1138950"/>
                  <a:gd name="connsiteX58" fmla="*/ 1176944 w 1477511"/>
                  <a:gd name="connsiteY58" fmla="*/ 1087967 h 1138950"/>
                  <a:gd name="connsiteX59" fmla="*/ 1147311 w 1477511"/>
                  <a:gd name="connsiteY59" fmla="*/ 1104900 h 1138950"/>
                  <a:gd name="connsiteX60" fmla="*/ 1121911 w 1477511"/>
                  <a:gd name="connsiteY60" fmla="*/ 1113367 h 1138950"/>
                  <a:gd name="connsiteX61" fmla="*/ 1109211 w 1477511"/>
                  <a:gd name="connsiteY61" fmla="*/ 1121834 h 1138950"/>
                  <a:gd name="connsiteX62" fmla="*/ 1083811 w 1477511"/>
                  <a:gd name="connsiteY62" fmla="*/ 1126067 h 1138950"/>
                  <a:gd name="connsiteX63" fmla="*/ 1062644 w 1477511"/>
                  <a:gd name="connsiteY63" fmla="*/ 1134534 h 1138950"/>
                  <a:gd name="connsiteX64" fmla="*/ 965278 w 1477511"/>
                  <a:gd name="connsiteY64" fmla="*/ 1121834 h 1138950"/>
                  <a:gd name="connsiteX65" fmla="*/ 948344 w 1477511"/>
                  <a:gd name="connsiteY65" fmla="*/ 1109134 h 1138950"/>
                  <a:gd name="connsiteX66" fmla="*/ 935644 w 1477511"/>
                  <a:gd name="connsiteY66" fmla="*/ 1092200 h 1138950"/>
                  <a:gd name="connsiteX67" fmla="*/ 918711 w 1477511"/>
                  <a:gd name="connsiteY67" fmla="*/ 1083734 h 1138950"/>
                  <a:gd name="connsiteX68" fmla="*/ 893311 w 1477511"/>
                  <a:gd name="connsiteY68" fmla="*/ 1066800 h 1138950"/>
                  <a:gd name="connsiteX69" fmla="*/ 876378 w 1477511"/>
                  <a:gd name="connsiteY69" fmla="*/ 1032934 h 1138950"/>
                  <a:gd name="connsiteX70" fmla="*/ 867911 w 1477511"/>
                  <a:gd name="connsiteY70" fmla="*/ 1016000 h 1138950"/>
                  <a:gd name="connsiteX71" fmla="*/ 859444 w 1477511"/>
                  <a:gd name="connsiteY71" fmla="*/ 990600 h 1138950"/>
                  <a:gd name="connsiteX72" fmla="*/ 829811 w 1477511"/>
                  <a:gd name="connsiteY72" fmla="*/ 960967 h 1138950"/>
                  <a:gd name="connsiteX73" fmla="*/ 812878 w 1477511"/>
                  <a:gd name="connsiteY73" fmla="*/ 948267 h 1138950"/>
                  <a:gd name="connsiteX74" fmla="*/ 800178 w 1477511"/>
                  <a:gd name="connsiteY74" fmla="*/ 939800 h 1138950"/>
                  <a:gd name="connsiteX75" fmla="*/ 787478 w 1477511"/>
                  <a:gd name="connsiteY75" fmla="*/ 927100 h 1138950"/>
                  <a:gd name="connsiteX76" fmla="*/ 770544 w 1477511"/>
                  <a:gd name="connsiteY76" fmla="*/ 918634 h 1138950"/>
                  <a:gd name="connsiteX77" fmla="*/ 749378 w 1477511"/>
                  <a:gd name="connsiteY77" fmla="*/ 905934 h 1138950"/>
                  <a:gd name="connsiteX78" fmla="*/ 732444 w 1477511"/>
                  <a:gd name="connsiteY78" fmla="*/ 901700 h 1138950"/>
                  <a:gd name="connsiteX79" fmla="*/ 694344 w 1477511"/>
                  <a:gd name="connsiteY79" fmla="*/ 893234 h 1138950"/>
                  <a:gd name="connsiteX80" fmla="*/ 673178 w 1477511"/>
                  <a:gd name="connsiteY80" fmla="*/ 884767 h 1138950"/>
                  <a:gd name="connsiteX81" fmla="*/ 660478 w 1477511"/>
                  <a:gd name="connsiteY81" fmla="*/ 880534 h 1138950"/>
                  <a:gd name="connsiteX82" fmla="*/ 643544 w 1477511"/>
                  <a:gd name="connsiteY82" fmla="*/ 867834 h 1138950"/>
                  <a:gd name="connsiteX83" fmla="*/ 613911 w 1477511"/>
                  <a:gd name="connsiteY83" fmla="*/ 855134 h 1138950"/>
                  <a:gd name="connsiteX84" fmla="*/ 596978 w 1477511"/>
                  <a:gd name="connsiteY84" fmla="*/ 842434 h 1138950"/>
                  <a:gd name="connsiteX85" fmla="*/ 580044 w 1477511"/>
                  <a:gd name="connsiteY85" fmla="*/ 833967 h 1138950"/>
                  <a:gd name="connsiteX86" fmla="*/ 563111 w 1477511"/>
                  <a:gd name="connsiteY86" fmla="*/ 821267 h 1138950"/>
                  <a:gd name="connsiteX87" fmla="*/ 525011 w 1477511"/>
                  <a:gd name="connsiteY87" fmla="*/ 800100 h 1138950"/>
                  <a:gd name="connsiteX88" fmla="*/ 474211 w 1477511"/>
                  <a:gd name="connsiteY88" fmla="*/ 787400 h 1138950"/>
                  <a:gd name="connsiteX89" fmla="*/ 414944 w 1477511"/>
                  <a:gd name="connsiteY89" fmla="*/ 770467 h 1138950"/>
                  <a:gd name="connsiteX90" fmla="*/ 364144 w 1477511"/>
                  <a:gd name="connsiteY90" fmla="*/ 753534 h 1138950"/>
                  <a:gd name="connsiteX91" fmla="*/ 304878 w 1477511"/>
                  <a:gd name="connsiteY91" fmla="*/ 732367 h 1138950"/>
                  <a:gd name="connsiteX92" fmla="*/ 279478 w 1477511"/>
                  <a:gd name="connsiteY92" fmla="*/ 728134 h 1138950"/>
                  <a:gd name="connsiteX93" fmla="*/ 228678 w 1477511"/>
                  <a:gd name="connsiteY93" fmla="*/ 702734 h 1138950"/>
                  <a:gd name="connsiteX94" fmla="*/ 211744 w 1477511"/>
                  <a:gd name="connsiteY94" fmla="*/ 694267 h 1138950"/>
                  <a:gd name="connsiteX95" fmla="*/ 165178 w 1477511"/>
                  <a:gd name="connsiteY95" fmla="*/ 664634 h 1138950"/>
                  <a:gd name="connsiteX96" fmla="*/ 148244 w 1477511"/>
                  <a:gd name="connsiteY96" fmla="*/ 647700 h 1138950"/>
                  <a:gd name="connsiteX97" fmla="*/ 135544 w 1477511"/>
                  <a:gd name="connsiteY97" fmla="*/ 639234 h 1138950"/>
                  <a:gd name="connsiteX98" fmla="*/ 101678 w 1477511"/>
                  <a:gd name="connsiteY98" fmla="*/ 605367 h 1138950"/>
                  <a:gd name="connsiteX99" fmla="*/ 80511 w 1477511"/>
                  <a:gd name="connsiteY99" fmla="*/ 592667 h 1138950"/>
                  <a:gd name="connsiteX100" fmla="*/ 67811 w 1477511"/>
                  <a:gd name="connsiteY100" fmla="*/ 584200 h 1138950"/>
                  <a:gd name="connsiteX101" fmla="*/ 42411 w 1477511"/>
                  <a:gd name="connsiteY101" fmla="*/ 558800 h 1138950"/>
                  <a:gd name="connsiteX102" fmla="*/ 21244 w 1477511"/>
                  <a:gd name="connsiteY102" fmla="*/ 529167 h 1138950"/>
                  <a:gd name="connsiteX103" fmla="*/ 4311 w 1477511"/>
                  <a:gd name="connsiteY103" fmla="*/ 499534 h 1138950"/>
                  <a:gd name="connsiteX104" fmla="*/ 78 w 1477511"/>
                  <a:gd name="connsiteY104" fmla="*/ 482600 h 1138950"/>
                  <a:gd name="connsiteX105" fmla="*/ 17011 w 1477511"/>
                  <a:gd name="connsiteY105" fmla="*/ 448734 h 1138950"/>
                  <a:gd name="connsiteX106" fmla="*/ 25478 w 1477511"/>
                  <a:gd name="connsiteY106" fmla="*/ 427567 h 1138950"/>
                  <a:gd name="connsiteX107" fmla="*/ 33944 w 1477511"/>
                  <a:gd name="connsiteY107" fmla="*/ 410634 h 1138950"/>
                  <a:gd name="connsiteX108" fmla="*/ 38178 w 1477511"/>
                  <a:gd name="connsiteY108" fmla="*/ 397934 h 1138950"/>
                  <a:gd name="connsiteX109" fmla="*/ 55111 w 1477511"/>
                  <a:gd name="connsiteY109" fmla="*/ 364067 h 1138950"/>
                  <a:gd name="connsiteX110" fmla="*/ 67811 w 1477511"/>
                  <a:gd name="connsiteY110" fmla="*/ 355600 h 1138950"/>
                  <a:gd name="connsiteX111" fmla="*/ 97444 w 1477511"/>
                  <a:gd name="connsiteY111" fmla="*/ 330200 h 1138950"/>
                  <a:gd name="connsiteX112" fmla="*/ 114378 w 1477511"/>
                  <a:gd name="connsiteY112" fmla="*/ 317500 h 1138950"/>
                  <a:gd name="connsiteX113" fmla="*/ 139778 w 1477511"/>
                  <a:gd name="connsiteY113" fmla="*/ 309034 h 1138950"/>
                  <a:gd name="connsiteX114" fmla="*/ 152478 w 1477511"/>
                  <a:gd name="connsiteY114" fmla="*/ 304800 h 1138950"/>
                  <a:gd name="connsiteX115" fmla="*/ 165178 w 1477511"/>
                  <a:gd name="connsiteY115" fmla="*/ 300567 h 1138950"/>
                  <a:gd name="connsiteX116" fmla="*/ 211744 w 1477511"/>
                  <a:gd name="connsiteY116" fmla="*/ 283634 h 1138950"/>
                  <a:gd name="connsiteX117" fmla="*/ 254078 w 1477511"/>
                  <a:gd name="connsiteY117" fmla="*/ 279400 h 1138950"/>
                  <a:gd name="connsiteX118" fmla="*/ 317578 w 1477511"/>
                  <a:gd name="connsiteY118" fmla="*/ 254000 h 11389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Lst>
                <a:rect l="l" t="t" r="r" b="b"/>
                <a:pathLst>
                  <a:path w="1477511" h="1138950">
                    <a:moveTo>
                      <a:pt x="317578" y="254000"/>
                    </a:moveTo>
                    <a:cubicBezTo>
                      <a:pt x="333806" y="249061"/>
                      <a:pt x="340222" y="251637"/>
                      <a:pt x="351444" y="249767"/>
                    </a:cubicBezTo>
                    <a:cubicBezTo>
                      <a:pt x="414586" y="239244"/>
                      <a:pt x="330739" y="251368"/>
                      <a:pt x="381078" y="241300"/>
                    </a:cubicBezTo>
                    <a:cubicBezTo>
                      <a:pt x="390862" y="239343"/>
                      <a:pt x="400742" y="237482"/>
                      <a:pt x="410711" y="237067"/>
                    </a:cubicBezTo>
                    <a:cubicBezTo>
                      <a:pt x="468534" y="234658"/>
                      <a:pt x="526422" y="234245"/>
                      <a:pt x="584278" y="232834"/>
                    </a:cubicBezTo>
                    <a:cubicBezTo>
                      <a:pt x="612500" y="237067"/>
                      <a:pt x="641137" y="239117"/>
                      <a:pt x="668944" y="245534"/>
                    </a:cubicBezTo>
                    <a:cubicBezTo>
                      <a:pt x="678168" y="247663"/>
                      <a:pt x="685694" y="254390"/>
                      <a:pt x="694344" y="258234"/>
                    </a:cubicBezTo>
                    <a:cubicBezTo>
                      <a:pt x="698422" y="260046"/>
                      <a:pt x="702811" y="261056"/>
                      <a:pt x="707044" y="262467"/>
                    </a:cubicBezTo>
                    <a:cubicBezTo>
                      <a:pt x="712689" y="254000"/>
                      <a:pt x="719427" y="246169"/>
                      <a:pt x="723978" y="237067"/>
                    </a:cubicBezTo>
                    <a:cubicBezTo>
                      <a:pt x="728211" y="228600"/>
                      <a:pt x="731717" y="219729"/>
                      <a:pt x="736678" y="211667"/>
                    </a:cubicBezTo>
                    <a:cubicBezTo>
                      <a:pt x="743040" y="201329"/>
                      <a:pt x="750789" y="191912"/>
                      <a:pt x="757844" y="182034"/>
                    </a:cubicBezTo>
                    <a:cubicBezTo>
                      <a:pt x="770797" y="143182"/>
                      <a:pt x="749143" y="203671"/>
                      <a:pt x="774778" y="152400"/>
                    </a:cubicBezTo>
                    <a:cubicBezTo>
                      <a:pt x="777380" y="147196"/>
                      <a:pt x="776719" y="140815"/>
                      <a:pt x="779011" y="135467"/>
                    </a:cubicBezTo>
                    <a:cubicBezTo>
                      <a:pt x="781015" y="130790"/>
                      <a:pt x="784485" y="126882"/>
                      <a:pt x="787478" y="122767"/>
                    </a:cubicBezTo>
                    <a:cubicBezTo>
                      <a:pt x="804814" y="98930"/>
                      <a:pt x="808358" y="86474"/>
                      <a:pt x="834044" y="76200"/>
                    </a:cubicBezTo>
                    <a:cubicBezTo>
                      <a:pt x="840921" y="73449"/>
                      <a:pt x="881472" y="68216"/>
                      <a:pt x="884844" y="67734"/>
                    </a:cubicBezTo>
                    <a:cubicBezTo>
                      <a:pt x="919971" y="56023"/>
                      <a:pt x="864703" y="75686"/>
                      <a:pt x="922944" y="46567"/>
                    </a:cubicBezTo>
                    <a:cubicBezTo>
                      <a:pt x="928148" y="43965"/>
                      <a:pt x="934233" y="43745"/>
                      <a:pt x="939878" y="42334"/>
                    </a:cubicBezTo>
                    <a:lnTo>
                      <a:pt x="965278" y="25400"/>
                    </a:lnTo>
                    <a:cubicBezTo>
                      <a:pt x="969511" y="22578"/>
                      <a:pt x="973151" y="18543"/>
                      <a:pt x="977978" y="16934"/>
                    </a:cubicBezTo>
                    <a:cubicBezTo>
                      <a:pt x="998484" y="10098"/>
                      <a:pt x="986852" y="14996"/>
                      <a:pt x="1011844" y="0"/>
                    </a:cubicBezTo>
                    <a:cubicBezTo>
                      <a:pt x="1059822" y="1411"/>
                      <a:pt x="1107914" y="644"/>
                      <a:pt x="1155778" y="4234"/>
                    </a:cubicBezTo>
                    <a:cubicBezTo>
                      <a:pt x="1164417" y="4882"/>
                      <a:pt x="1189281" y="15648"/>
                      <a:pt x="1198111" y="21167"/>
                    </a:cubicBezTo>
                    <a:cubicBezTo>
                      <a:pt x="1204094" y="24906"/>
                      <a:pt x="1209061" y="30128"/>
                      <a:pt x="1215044" y="33867"/>
                    </a:cubicBezTo>
                    <a:cubicBezTo>
                      <a:pt x="1220396" y="37212"/>
                      <a:pt x="1227050" y="38392"/>
                      <a:pt x="1231978" y="42334"/>
                    </a:cubicBezTo>
                    <a:lnTo>
                      <a:pt x="1270078" y="80434"/>
                    </a:lnTo>
                    <a:cubicBezTo>
                      <a:pt x="1274311" y="84667"/>
                      <a:pt x="1277797" y="89813"/>
                      <a:pt x="1282778" y="93134"/>
                    </a:cubicBezTo>
                    <a:lnTo>
                      <a:pt x="1295478" y="101600"/>
                    </a:lnTo>
                    <a:cubicBezTo>
                      <a:pt x="1312732" y="127483"/>
                      <a:pt x="1293506" y="100440"/>
                      <a:pt x="1320878" y="131234"/>
                    </a:cubicBezTo>
                    <a:cubicBezTo>
                      <a:pt x="1326881" y="137987"/>
                      <a:pt x="1332167" y="145345"/>
                      <a:pt x="1337811" y="152400"/>
                    </a:cubicBezTo>
                    <a:cubicBezTo>
                      <a:pt x="1339222" y="158045"/>
                      <a:pt x="1339752" y="163986"/>
                      <a:pt x="1342044" y="169334"/>
                    </a:cubicBezTo>
                    <a:cubicBezTo>
                      <a:pt x="1344048" y="174011"/>
                      <a:pt x="1347987" y="177617"/>
                      <a:pt x="1350511" y="182034"/>
                    </a:cubicBezTo>
                    <a:cubicBezTo>
                      <a:pt x="1353642" y="187513"/>
                      <a:pt x="1356156" y="193323"/>
                      <a:pt x="1358978" y="198967"/>
                    </a:cubicBezTo>
                    <a:cubicBezTo>
                      <a:pt x="1361424" y="225878"/>
                      <a:pt x="1363334" y="252684"/>
                      <a:pt x="1367444" y="279400"/>
                    </a:cubicBezTo>
                    <a:cubicBezTo>
                      <a:pt x="1368538" y="286512"/>
                      <a:pt x="1370267" y="293511"/>
                      <a:pt x="1371678" y="300567"/>
                    </a:cubicBezTo>
                    <a:cubicBezTo>
                      <a:pt x="1370267" y="334434"/>
                      <a:pt x="1372238" y="368612"/>
                      <a:pt x="1367444" y="402167"/>
                    </a:cubicBezTo>
                    <a:cubicBezTo>
                      <a:pt x="1366446" y="409152"/>
                      <a:pt x="1358483" y="413117"/>
                      <a:pt x="1354744" y="419100"/>
                    </a:cubicBezTo>
                    <a:cubicBezTo>
                      <a:pt x="1351399" y="424452"/>
                      <a:pt x="1350220" y="431106"/>
                      <a:pt x="1346278" y="436034"/>
                    </a:cubicBezTo>
                    <a:cubicBezTo>
                      <a:pt x="1331084" y="455027"/>
                      <a:pt x="1321503" y="460965"/>
                      <a:pt x="1303944" y="474134"/>
                    </a:cubicBezTo>
                    <a:cubicBezTo>
                      <a:pt x="1309589" y="476956"/>
                      <a:pt x="1314810" y="480866"/>
                      <a:pt x="1320878" y="482600"/>
                    </a:cubicBezTo>
                    <a:cubicBezTo>
                      <a:pt x="1336045" y="486933"/>
                      <a:pt x="1362606" y="484899"/>
                      <a:pt x="1375911" y="499534"/>
                    </a:cubicBezTo>
                    <a:cubicBezTo>
                      <a:pt x="1410189" y="537241"/>
                      <a:pt x="1410587" y="547718"/>
                      <a:pt x="1435178" y="596900"/>
                    </a:cubicBezTo>
                    <a:cubicBezTo>
                      <a:pt x="1438000" y="602545"/>
                      <a:pt x="1442113" y="607712"/>
                      <a:pt x="1443644" y="613834"/>
                    </a:cubicBezTo>
                    <a:cubicBezTo>
                      <a:pt x="1446466" y="625123"/>
                      <a:pt x="1448432" y="636661"/>
                      <a:pt x="1452111" y="647700"/>
                    </a:cubicBezTo>
                    <a:cubicBezTo>
                      <a:pt x="1458184" y="665920"/>
                      <a:pt x="1455262" y="656071"/>
                      <a:pt x="1460578" y="677334"/>
                    </a:cubicBezTo>
                    <a:cubicBezTo>
                      <a:pt x="1461989" y="688623"/>
                      <a:pt x="1462714" y="700018"/>
                      <a:pt x="1464811" y="711200"/>
                    </a:cubicBezTo>
                    <a:cubicBezTo>
                      <a:pt x="1468903" y="733022"/>
                      <a:pt x="1471691" y="740307"/>
                      <a:pt x="1477511" y="757767"/>
                    </a:cubicBezTo>
                    <a:cubicBezTo>
                      <a:pt x="1474689" y="793045"/>
                      <a:pt x="1477627" y="829266"/>
                      <a:pt x="1469044" y="863600"/>
                    </a:cubicBezTo>
                    <a:cubicBezTo>
                      <a:pt x="1466687" y="873030"/>
                      <a:pt x="1435127" y="917781"/>
                      <a:pt x="1422478" y="931334"/>
                    </a:cubicBezTo>
                    <a:cubicBezTo>
                      <a:pt x="1408861" y="945923"/>
                      <a:pt x="1394255" y="959556"/>
                      <a:pt x="1380144" y="973667"/>
                    </a:cubicBezTo>
                    <a:cubicBezTo>
                      <a:pt x="1375911" y="977900"/>
                      <a:pt x="1372799" y="983690"/>
                      <a:pt x="1367444" y="986367"/>
                    </a:cubicBezTo>
                    <a:cubicBezTo>
                      <a:pt x="1356155" y="992011"/>
                      <a:pt x="1343675" y="995728"/>
                      <a:pt x="1333578" y="1003300"/>
                    </a:cubicBezTo>
                    <a:cubicBezTo>
                      <a:pt x="1327933" y="1007533"/>
                      <a:pt x="1322694" y="1012370"/>
                      <a:pt x="1316644" y="1016000"/>
                    </a:cubicBezTo>
                    <a:cubicBezTo>
                      <a:pt x="1308527" y="1020870"/>
                      <a:pt x="1299361" y="1023830"/>
                      <a:pt x="1291244" y="1028700"/>
                    </a:cubicBezTo>
                    <a:cubicBezTo>
                      <a:pt x="1285194" y="1032330"/>
                      <a:pt x="1280294" y="1037661"/>
                      <a:pt x="1274311" y="1041400"/>
                    </a:cubicBezTo>
                    <a:cubicBezTo>
                      <a:pt x="1256355" y="1052623"/>
                      <a:pt x="1256284" y="1048298"/>
                      <a:pt x="1236211" y="1058334"/>
                    </a:cubicBezTo>
                    <a:cubicBezTo>
                      <a:pt x="1228851" y="1062014"/>
                      <a:pt x="1222404" y="1067354"/>
                      <a:pt x="1215044" y="1071034"/>
                    </a:cubicBezTo>
                    <a:cubicBezTo>
                      <a:pt x="1208247" y="1074432"/>
                      <a:pt x="1200822" y="1076414"/>
                      <a:pt x="1193878" y="1079500"/>
                    </a:cubicBezTo>
                    <a:cubicBezTo>
                      <a:pt x="1188111" y="1082063"/>
                      <a:pt x="1182423" y="1084836"/>
                      <a:pt x="1176944" y="1087967"/>
                    </a:cubicBezTo>
                    <a:cubicBezTo>
                      <a:pt x="1159121" y="1098152"/>
                      <a:pt x="1168637" y="1096370"/>
                      <a:pt x="1147311" y="1104900"/>
                    </a:cubicBezTo>
                    <a:cubicBezTo>
                      <a:pt x="1139025" y="1108215"/>
                      <a:pt x="1130066" y="1109742"/>
                      <a:pt x="1121911" y="1113367"/>
                    </a:cubicBezTo>
                    <a:cubicBezTo>
                      <a:pt x="1117262" y="1115433"/>
                      <a:pt x="1114038" y="1120225"/>
                      <a:pt x="1109211" y="1121834"/>
                    </a:cubicBezTo>
                    <a:cubicBezTo>
                      <a:pt x="1101068" y="1124548"/>
                      <a:pt x="1092278" y="1124656"/>
                      <a:pt x="1083811" y="1126067"/>
                    </a:cubicBezTo>
                    <a:cubicBezTo>
                      <a:pt x="1076755" y="1128889"/>
                      <a:pt x="1069923" y="1132350"/>
                      <a:pt x="1062644" y="1134534"/>
                    </a:cubicBezTo>
                    <a:cubicBezTo>
                      <a:pt x="1024904" y="1145856"/>
                      <a:pt x="1016172" y="1133144"/>
                      <a:pt x="965278" y="1121834"/>
                    </a:cubicBezTo>
                    <a:cubicBezTo>
                      <a:pt x="959633" y="1117601"/>
                      <a:pt x="953333" y="1114123"/>
                      <a:pt x="948344" y="1109134"/>
                    </a:cubicBezTo>
                    <a:cubicBezTo>
                      <a:pt x="943355" y="1104145"/>
                      <a:pt x="941001" y="1096792"/>
                      <a:pt x="935644" y="1092200"/>
                    </a:cubicBezTo>
                    <a:cubicBezTo>
                      <a:pt x="930853" y="1088093"/>
                      <a:pt x="924122" y="1086981"/>
                      <a:pt x="918711" y="1083734"/>
                    </a:cubicBezTo>
                    <a:cubicBezTo>
                      <a:pt x="909985" y="1078499"/>
                      <a:pt x="893311" y="1066800"/>
                      <a:pt x="893311" y="1066800"/>
                    </a:cubicBezTo>
                    <a:cubicBezTo>
                      <a:pt x="865711" y="1020802"/>
                      <a:pt x="890048" y="1064832"/>
                      <a:pt x="876378" y="1032934"/>
                    </a:cubicBezTo>
                    <a:cubicBezTo>
                      <a:pt x="873892" y="1027133"/>
                      <a:pt x="870255" y="1021860"/>
                      <a:pt x="867911" y="1016000"/>
                    </a:cubicBezTo>
                    <a:cubicBezTo>
                      <a:pt x="864596" y="1007714"/>
                      <a:pt x="863718" y="998435"/>
                      <a:pt x="859444" y="990600"/>
                    </a:cubicBezTo>
                    <a:cubicBezTo>
                      <a:pt x="848289" y="970149"/>
                      <a:pt x="844985" y="971806"/>
                      <a:pt x="829811" y="960967"/>
                    </a:cubicBezTo>
                    <a:cubicBezTo>
                      <a:pt x="824070" y="956866"/>
                      <a:pt x="818619" y="952368"/>
                      <a:pt x="812878" y="948267"/>
                    </a:cubicBezTo>
                    <a:cubicBezTo>
                      <a:pt x="808738" y="945310"/>
                      <a:pt x="804087" y="943057"/>
                      <a:pt x="800178" y="939800"/>
                    </a:cubicBezTo>
                    <a:cubicBezTo>
                      <a:pt x="795579" y="935967"/>
                      <a:pt x="792350" y="930580"/>
                      <a:pt x="787478" y="927100"/>
                    </a:cubicBezTo>
                    <a:cubicBezTo>
                      <a:pt x="782343" y="923432"/>
                      <a:pt x="776061" y="921699"/>
                      <a:pt x="770544" y="918634"/>
                    </a:cubicBezTo>
                    <a:cubicBezTo>
                      <a:pt x="763351" y="914638"/>
                      <a:pt x="756897" y="909276"/>
                      <a:pt x="749378" y="905934"/>
                    </a:cubicBezTo>
                    <a:cubicBezTo>
                      <a:pt x="744061" y="903571"/>
                      <a:pt x="738039" y="903298"/>
                      <a:pt x="732444" y="901700"/>
                    </a:cubicBezTo>
                    <a:cubicBezTo>
                      <a:pt x="703270" y="893365"/>
                      <a:pt x="740170" y="900871"/>
                      <a:pt x="694344" y="893234"/>
                    </a:cubicBezTo>
                    <a:cubicBezTo>
                      <a:pt x="687289" y="890412"/>
                      <a:pt x="680293" y="887435"/>
                      <a:pt x="673178" y="884767"/>
                    </a:cubicBezTo>
                    <a:cubicBezTo>
                      <a:pt x="669000" y="883200"/>
                      <a:pt x="664352" y="882748"/>
                      <a:pt x="660478" y="880534"/>
                    </a:cubicBezTo>
                    <a:cubicBezTo>
                      <a:pt x="654352" y="877033"/>
                      <a:pt x="649738" y="871213"/>
                      <a:pt x="643544" y="867834"/>
                    </a:cubicBezTo>
                    <a:cubicBezTo>
                      <a:pt x="634110" y="862688"/>
                      <a:pt x="623345" y="860280"/>
                      <a:pt x="613911" y="855134"/>
                    </a:cubicBezTo>
                    <a:cubicBezTo>
                      <a:pt x="607717" y="851755"/>
                      <a:pt x="602961" y="846173"/>
                      <a:pt x="596978" y="842434"/>
                    </a:cubicBezTo>
                    <a:cubicBezTo>
                      <a:pt x="591626" y="839089"/>
                      <a:pt x="585396" y="837312"/>
                      <a:pt x="580044" y="833967"/>
                    </a:cubicBezTo>
                    <a:cubicBezTo>
                      <a:pt x="574061" y="830228"/>
                      <a:pt x="568982" y="825181"/>
                      <a:pt x="563111" y="821267"/>
                    </a:cubicBezTo>
                    <a:cubicBezTo>
                      <a:pt x="555060" y="815899"/>
                      <a:pt x="535094" y="804133"/>
                      <a:pt x="525011" y="800100"/>
                    </a:cubicBezTo>
                    <a:cubicBezTo>
                      <a:pt x="486629" y="784747"/>
                      <a:pt x="513068" y="797114"/>
                      <a:pt x="474211" y="787400"/>
                    </a:cubicBezTo>
                    <a:cubicBezTo>
                      <a:pt x="454278" y="782417"/>
                      <a:pt x="434436" y="776964"/>
                      <a:pt x="414944" y="770467"/>
                    </a:cubicBezTo>
                    <a:cubicBezTo>
                      <a:pt x="398011" y="764823"/>
                      <a:pt x="380857" y="759801"/>
                      <a:pt x="364144" y="753534"/>
                    </a:cubicBezTo>
                    <a:cubicBezTo>
                      <a:pt x="355101" y="750143"/>
                      <a:pt x="317155" y="735436"/>
                      <a:pt x="304878" y="732367"/>
                    </a:cubicBezTo>
                    <a:cubicBezTo>
                      <a:pt x="296551" y="730285"/>
                      <a:pt x="287945" y="729545"/>
                      <a:pt x="279478" y="728134"/>
                    </a:cubicBezTo>
                    <a:cubicBezTo>
                      <a:pt x="198524" y="701149"/>
                      <a:pt x="267469" y="730442"/>
                      <a:pt x="228678" y="702734"/>
                    </a:cubicBezTo>
                    <a:cubicBezTo>
                      <a:pt x="223543" y="699066"/>
                      <a:pt x="217284" y="697289"/>
                      <a:pt x="211744" y="694267"/>
                    </a:cubicBezTo>
                    <a:cubicBezTo>
                      <a:pt x="194725" y="684984"/>
                      <a:pt x="179590" y="677245"/>
                      <a:pt x="165178" y="664634"/>
                    </a:cubicBezTo>
                    <a:cubicBezTo>
                      <a:pt x="159170" y="659377"/>
                      <a:pt x="154305" y="652895"/>
                      <a:pt x="148244" y="647700"/>
                    </a:cubicBezTo>
                    <a:cubicBezTo>
                      <a:pt x="144381" y="644389"/>
                      <a:pt x="139309" y="642656"/>
                      <a:pt x="135544" y="639234"/>
                    </a:cubicBezTo>
                    <a:cubicBezTo>
                      <a:pt x="123731" y="628495"/>
                      <a:pt x="115368" y="613581"/>
                      <a:pt x="101678" y="605367"/>
                    </a:cubicBezTo>
                    <a:cubicBezTo>
                      <a:pt x="94622" y="601134"/>
                      <a:pt x="87489" y="597028"/>
                      <a:pt x="80511" y="592667"/>
                    </a:cubicBezTo>
                    <a:cubicBezTo>
                      <a:pt x="76196" y="589970"/>
                      <a:pt x="71409" y="587798"/>
                      <a:pt x="67811" y="584200"/>
                    </a:cubicBezTo>
                    <a:cubicBezTo>
                      <a:pt x="36305" y="552694"/>
                      <a:pt x="72341" y="578754"/>
                      <a:pt x="42411" y="558800"/>
                    </a:cubicBezTo>
                    <a:cubicBezTo>
                      <a:pt x="26742" y="527464"/>
                      <a:pt x="42699" y="554913"/>
                      <a:pt x="21244" y="529167"/>
                    </a:cubicBezTo>
                    <a:cubicBezTo>
                      <a:pt x="13767" y="520194"/>
                      <a:pt x="9485" y="509881"/>
                      <a:pt x="4311" y="499534"/>
                    </a:cubicBezTo>
                    <a:cubicBezTo>
                      <a:pt x="2900" y="493889"/>
                      <a:pt x="-564" y="488383"/>
                      <a:pt x="78" y="482600"/>
                    </a:cubicBezTo>
                    <a:cubicBezTo>
                      <a:pt x="2171" y="463765"/>
                      <a:pt x="9861" y="463033"/>
                      <a:pt x="17011" y="448734"/>
                    </a:cubicBezTo>
                    <a:cubicBezTo>
                      <a:pt x="20410" y="441937"/>
                      <a:pt x="22392" y="434511"/>
                      <a:pt x="25478" y="427567"/>
                    </a:cubicBezTo>
                    <a:cubicBezTo>
                      <a:pt x="28041" y="421800"/>
                      <a:pt x="31458" y="416434"/>
                      <a:pt x="33944" y="410634"/>
                    </a:cubicBezTo>
                    <a:cubicBezTo>
                      <a:pt x="35702" y="406532"/>
                      <a:pt x="36331" y="401996"/>
                      <a:pt x="38178" y="397934"/>
                    </a:cubicBezTo>
                    <a:cubicBezTo>
                      <a:pt x="43401" y="386444"/>
                      <a:pt x="44609" y="371068"/>
                      <a:pt x="55111" y="364067"/>
                    </a:cubicBezTo>
                    <a:lnTo>
                      <a:pt x="67811" y="355600"/>
                    </a:lnTo>
                    <a:cubicBezTo>
                      <a:pt x="82105" y="334160"/>
                      <a:pt x="69873" y="348580"/>
                      <a:pt x="97444" y="330200"/>
                    </a:cubicBezTo>
                    <a:cubicBezTo>
                      <a:pt x="103315" y="326286"/>
                      <a:pt x="108067" y="320655"/>
                      <a:pt x="114378" y="317500"/>
                    </a:cubicBezTo>
                    <a:cubicBezTo>
                      <a:pt x="122360" y="313509"/>
                      <a:pt x="131311" y="311856"/>
                      <a:pt x="139778" y="309034"/>
                    </a:cubicBezTo>
                    <a:lnTo>
                      <a:pt x="152478" y="304800"/>
                    </a:lnTo>
                    <a:cubicBezTo>
                      <a:pt x="156711" y="303389"/>
                      <a:pt x="161187" y="302563"/>
                      <a:pt x="165178" y="300567"/>
                    </a:cubicBezTo>
                    <a:cubicBezTo>
                      <a:pt x="183896" y="291208"/>
                      <a:pt x="188095" y="287807"/>
                      <a:pt x="211744" y="283634"/>
                    </a:cubicBezTo>
                    <a:cubicBezTo>
                      <a:pt x="225710" y="281169"/>
                      <a:pt x="239906" y="279925"/>
                      <a:pt x="254078" y="279400"/>
                    </a:cubicBezTo>
                    <a:cubicBezTo>
                      <a:pt x="278050" y="278512"/>
                      <a:pt x="301350" y="258939"/>
                      <a:pt x="317578" y="254000"/>
                    </a:cubicBezTo>
                    <a:close/>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sp>
            <p:nvSpPr>
              <p:cNvPr id="26" name="任意多边形: 形状 25">
                <a:extLst>
                  <a:ext uri="{FF2B5EF4-FFF2-40B4-BE49-F238E27FC236}">
                    <a16:creationId xmlns:a16="http://schemas.microsoft.com/office/drawing/2014/main" id="{76FB6788-2D16-A6BD-03EC-A19E58A9F5ED}"/>
                  </a:ext>
                </a:extLst>
              </p:cNvPr>
              <p:cNvSpPr/>
              <p:nvPr/>
            </p:nvSpPr>
            <p:spPr>
              <a:xfrm>
                <a:off x="3984356" y="5025294"/>
                <a:ext cx="538729" cy="451252"/>
              </a:xfrm>
              <a:custGeom>
                <a:avLst/>
                <a:gdLst>
                  <a:gd name="connsiteX0" fmla="*/ 274279 w 697301"/>
                  <a:gd name="connsiteY0" fmla="*/ 948 h 513182"/>
                  <a:gd name="connsiteX1" fmla="*/ 185379 w 697301"/>
                  <a:gd name="connsiteY1" fmla="*/ 9415 h 513182"/>
                  <a:gd name="connsiteX2" fmla="*/ 104946 w 697301"/>
                  <a:gd name="connsiteY2" fmla="*/ 17882 h 513182"/>
                  <a:gd name="connsiteX3" fmla="*/ 83779 w 697301"/>
                  <a:gd name="connsiteY3" fmla="*/ 22115 h 513182"/>
                  <a:gd name="connsiteX4" fmla="*/ 54146 w 697301"/>
                  <a:gd name="connsiteY4" fmla="*/ 26348 h 513182"/>
                  <a:gd name="connsiteX5" fmla="*/ 41446 w 697301"/>
                  <a:gd name="connsiteY5" fmla="*/ 30582 h 513182"/>
                  <a:gd name="connsiteX6" fmla="*/ 24513 w 697301"/>
                  <a:gd name="connsiteY6" fmla="*/ 55982 h 513182"/>
                  <a:gd name="connsiteX7" fmla="*/ 16046 w 697301"/>
                  <a:gd name="connsiteY7" fmla="*/ 72915 h 513182"/>
                  <a:gd name="connsiteX8" fmla="*/ 7579 w 697301"/>
                  <a:gd name="connsiteY8" fmla="*/ 85615 h 513182"/>
                  <a:gd name="connsiteX9" fmla="*/ 7579 w 697301"/>
                  <a:gd name="connsiteY9" fmla="*/ 161815 h 513182"/>
                  <a:gd name="connsiteX10" fmla="*/ 20279 w 697301"/>
                  <a:gd name="connsiteY10" fmla="*/ 178748 h 513182"/>
                  <a:gd name="connsiteX11" fmla="*/ 37213 w 697301"/>
                  <a:gd name="connsiteY11" fmla="*/ 212615 h 513182"/>
                  <a:gd name="connsiteX12" fmla="*/ 62613 w 697301"/>
                  <a:gd name="connsiteY12" fmla="*/ 238015 h 513182"/>
                  <a:gd name="connsiteX13" fmla="*/ 96479 w 697301"/>
                  <a:gd name="connsiteY13" fmla="*/ 263415 h 513182"/>
                  <a:gd name="connsiteX14" fmla="*/ 104946 w 697301"/>
                  <a:gd name="connsiteY14" fmla="*/ 280348 h 513182"/>
                  <a:gd name="connsiteX15" fmla="*/ 134579 w 697301"/>
                  <a:gd name="connsiteY15" fmla="*/ 293048 h 513182"/>
                  <a:gd name="connsiteX16" fmla="*/ 159979 w 697301"/>
                  <a:gd name="connsiteY16" fmla="*/ 318448 h 513182"/>
                  <a:gd name="connsiteX17" fmla="*/ 176913 w 697301"/>
                  <a:gd name="connsiteY17" fmla="*/ 331148 h 513182"/>
                  <a:gd name="connsiteX18" fmla="*/ 210779 w 697301"/>
                  <a:gd name="connsiteY18" fmla="*/ 365015 h 513182"/>
                  <a:gd name="connsiteX19" fmla="*/ 236179 w 697301"/>
                  <a:gd name="connsiteY19" fmla="*/ 386182 h 513182"/>
                  <a:gd name="connsiteX20" fmla="*/ 270046 w 697301"/>
                  <a:gd name="connsiteY20" fmla="*/ 390415 h 513182"/>
                  <a:gd name="connsiteX21" fmla="*/ 286979 w 697301"/>
                  <a:gd name="connsiteY21" fmla="*/ 394648 h 513182"/>
                  <a:gd name="connsiteX22" fmla="*/ 325079 w 697301"/>
                  <a:gd name="connsiteY22" fmla="*/ 403115 h 513182"/>
                  <a:gd name="connsiteX23" fmla="*/ 346246 w 697301"/>
                  <a:gd name="connsiteY23" fmla="*/ 411582 h 513182"/>
                  <a:gd name="connsiteX24" fmla="*/ 358946 w 697301"/>
                  <a:gd name="connsiteY24" fmla="*/ 424282 h 513182"/>
                  <a:gd name="connsiteX25" fmla="*/ 384346 w 697301"/>
                  <a:gd name="connsiteY25" fmla="*/ 428515 h 513182"/>
                  <a:gd name="connsiteX26" fmla="*/ 439379 w 697301"/>
                  <a:gd name="connsiteY26" fmla="*/ 441215 h 513182"/>
                  <a:gd name="connsiteX27" fmla="*/ 456313 w 697301"/>
                  <a:gd name="connsiteY27" fmla="*/ 445448 h 513182"/>
                  <a:gd name="connsiteX28" fmla="*/ 469013 w 697301"/>
                  <a:gd name="connsiteY28" fmla="*/ 449682 h 513182"/>
                  <a:gd name="connsiteX29" fmla="*/ 490179 w 697301"/>
                  <a:gd name="connsiteY29" fmla="*/ 462382 h 513182"/>
                  <a:gd name="connsiteX30" fmla="*/ 528279 w 697301"/>
                  <a:gd name="connsiteY30" fmla="*/ 470848 h 513182"/>
                  <a:gd name="connsiteX31" fmla="*/ 583313 w 697301"/>
                  <a:gd name="connsiteY31" fmla="*/ 492015 h 513182"/>
                  <a:gd name="connsiteX32" fmla="*/ 629879 w 697301"/>
                  <a:gd name="connsiteY32" fmla="*/ 513182 h 513182"/>
                  <a:gd name="connsiteX33" fmla="*/ 693379 w 697301"/>
                  <a:gd name="connsiteY33" fmla="*/ 504715 h 513182"/>
                  <a:gd name="connsiteX34" fmla="*/ 689146 w 697301"/>
                  <a:gd name="connsiteY34" fmla="*/ 466615 h 513182"/>
                  <a:gd name="connsiteX35" fmla="*/ 672213 w 697301"/>
                  <a:gd name="connsiteY35" fmla="*/ 436982 h 513182"/>
                  <a:gd name="connsiteX36" fmla="*/ 659513 w 697301"/>
                  <a:gd name="connsiteY36" fmla="*/ 428515 h 513182"/>
                  <a:gd name="connsiteX37" fmla="*/ 638346 w 697301"/>
                  <a:gd name="connsiteY37" fmla="*/ 407348 h 513182"/>
                  <a:gd name="connsiteX38" fmla="*/ 629879 w 697301"/>
                  <a:gd name="connsiteY38" fmla="*/ 394648 h 513182"/>
                  <a:gd name="connsiteX39" fmla="*/ 617179 w 697301"/>
                  <a:gd name="connsiteY39" fmla="*/ 377715 h 513182"/>
                  <a:gd name="connsiteX40" fmla="*/ 608713 w 697301"/>
                  <a:gd name="connsiteY40" fmla="*/ 360782 h 513182"/>
                  <a:gd name="connsiteX41" fmla="*/ 583313 w 697301"/>
                  <a:gd name="connsiteY41" fmla="*/ 326915 h 513182"/>
                  <a:gd name="connsiteX42" fmla="*/ 574846 w 697301"/>
                  <a:gd name="connsiteY42" fmla="*/ 314215 h 513182"/>
                  <a:gd name="connsiteX43" fmla="*/ 562146 w 697301"/>
                  <a:gd name="connsiteY43" fmla="*/ 301515 h 513182"/>
                  <a:gd name="connsiteX44" fmla="*/ 540979 w 697301"/>
                  <a:gd name="connsiteY44" fmla="*/ 267648 h 513182"/>
                  <a:gd name="connsiteX45" fmla="*/ 528279 w 697301"/>
                  <a:gd name="connsiteY45" fmla="*/ 250715 h 513182"/>
                  <a:gd name="connsiteX46" fmla="*/ 502879 w 697301"/>
                  <a:gd name="connsiteY46" fmla="*/ 212615 h 513182"/>
                  <a:gd name="connsiteX47" fmla="*/ 481713 w 697301"/>
                  <a:gd name="connsiteY47" fmla="*/ 187215 h 513182"/>
                  <a:gd name="connsiteX48" fmla="*/ 469013 w 697301"/>
                  <a:gd name="connsiteY48" fmla="*/ 182982 h 513182"/>
                  <a:gd name="connsiteX49" fmla="*/ 456313 w 697301"/>
                  <a:gd name="connsiteY49" fmla="*/ 174515 h 513182"/>
                  <a:gd name="connsiteX50" fmla="*/ 418213 w 697301"/>
                  <a:gd name="connsiteY50" fmla="*/ 161815 h 513182"/>
                  <a:gd name="connsiteX51" fmla="*/ 405513 w 697301"/>
                  <a:gd name="connsiteY51" fmla="*/ 144882 h 513182"/>
                  <a:gd name="connsiteX52" fmla="*/ 388579 w 697301"/>
                  <a:gd name="connsiteY52" fmla="*/ 132182 h 513182"/>
                  <a:gd name="connsiteX53" fmla="*/ 375879 w 697301"/>
                  <a:gd name="connsiteY53" fmla="*/ 106782 h 513182"/>
                  <a:gd name="connsiteX54" fmla="*/ 354713 w 697301"/>
                  <a:gd name="connsiteY54" fmla="*/ 64448 h 513182"/>
                  <a:gd name="connsiteX55" fmla="*/ 342013 w 697301"/>
                  <a:gd name="connsiteY55" fmla="*/ 60215 h 513182"/>
                  <a:gd name="connsiteX56" fmla="*/ 316613 w 697301"/>
                  <a:gd name="connsiteY56" fmla="*/ 55982 h 513182"/>
                  <a:gd name="connsiteX57" fmla="*/ 278513 w 697301"/>
                  <a:gd name="connsiteY57" fmla="*/ 39048 h 513182"/>
                  <a:gd name="connsiteX58" fmla="*/ 257346 w 697301"/>
                  <a:gd name="connsiteY58" fmla="*/ 30582 h 513182"/>
                  <a:gd name="connsiteX59" fmla="*/ 274279 w 697301"/>
                  <a:gd name="connsiteY59" fmla="*/ 948 h 51318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Lst>
                <a:rect l="l" t="t" r="r" b="b"/>
                <a:pathLst>
                  <a:path w="697301" h="513182">
                    <a:moveTo>
                      <a:pt x="274279" y="948"/>
                    </a:moveTo>
                    <a:cubicBezTo>
                      <a:pt x="262284" y="-2580"/>
                      <a:pt x="214741" y="4522"/>
                      <a:pt x="185379" y="9415"/>
                    </a:cubicBezTo>
                    <a:cubicBezTo>
                      <a:pt x="141831" y="16672"/>
                      <a:pt x="168537" y="12990"/>
                      <a:pt x="104946" y="17882"/>
                    </a:cubicBezTo>
                    <a:cubicBezTo>
                      <a:pt x="97890" y="19293"/>
                      <a:pt x="90876" y="20932"/>
                      <a:pt x="83779" y="22115"/>
                    </a:cubicBezTo>
                    <a:cubicBezTo>
                      <a:pt x="73937" y="23755"/>
                      <a:pt x="63930" y="24391"/>
                      <a:pt x="54146" y="26348"/>
                    </a:cubicBezTo>
                    <a:cubicBezTo>
                      <a:pt x="49770" y="27223"/>
                      <a:pt x="45679" y="29171"/>
                      <a:pt x="41446" y="30582"/>
                    </a:cubicBezTo>
                    <a:cubicBezTo>
                      <a:pt x="32366" y="57823"/>
                      <a:pt x="44331" y="28237"/>
                      <a:pt x="24513" y="55982"/>
                    </a:cubicBezTo>
                    <a:cubicBezTo>
                      <a:pt x="20845" y="61117"/>
                      <a:pt x="19177" y="67436"/>
                      <a:pt x="16046" y="72915"/>
                    </a:cubicBezTo>
                    <a:cubicBezTo>
                      <a:pt x="13522" y="77332"/>
                      <a:pt x="10401" y="81382"/>
                      <a:pt x="7579" y="85615"/>
                    </a:cubicBezTo>
                    <a:cubicBezTo>
                      <a:pt x="-2102" y="114659"/>
                      <a:pt x="-2942" y="111838"/>
                      <a:pt x="7579" y="161815"/>
                    </a:cubicBezTo>
                    <a:cubicBezTo>
                      <a:pt x="9032" y="168719"/>
                      <a:pt x="16724" y="172654"/>
                      <a:pt x="20279" y="178748"/>
                    </a:cubicBezTo>
                    <a:cubicBezTo>
                      <a:pt x="26639" y="189650"/>
                      <a:pt x="28288" y="203690"/>
                      <a:pt x="37213" y="212615"/>
                    </a:cubicBezTo>
                    <a:cubicBezTo>
                      <a:pt x="45680" y="221082"/>
                      <a:pt x="53034" y="230831"/>
                      <a:pt x="62613" y="238015"/>
                    </a:cubicBezTo>
                    <a:lnTo>
                      <a:pt x="96479" y="263415"/>
                    </a:lnTo>
                    <a:cubicBezTo>
                      <a:pt x="99301" y="269059"/>
                      <a:pt x="100484" y="275886"/>
                      <a:pt x="104946" y="280348"/>
                    </a:cubicBezTo>
                    <a:cubicBezTo>
                      <a:pt x="110179" y="285581"/>
                      <a:pt x="126988" y="290518"/>
                      <a:pt x="134579" y="293048"/>
                    </a:cubicBezTo>
                    <a:cubicBezTo>
                      <a:pt x="143046" y="301515"/>
                      <a:pt x="150400" y="311264"/>
                      <a:pt x="159979" y="318448"/>
                    </a:cubicBezTo>
                    <a:cubicBezTo>
                      <a:pt x="165624" y="322681"/>
                      <a:pt x="171712" y="326380"/>
                      <a:pt x="176913" y="331148"/>
                    </a:cubicBezTo>
                    <a:cubicBezTo>
                      <a:pt x="188681" y="341936"/>
                      <a:pt x="199490" y="353726"/>
                      <a:pt x="210779" y="365015"/>
                    </a:cubicBezTo>
                    <a:cubicBezTo>
                      <a:pt x="215806" y="370042"/>
                      <a:pt x="228076" y="383972"/>
                      <a:pt x="236179" y="386182"/>
                    </a:cubicBezTo>
                    <a:cubicBezTo>
                      <a:pt x="247155" y="389175"/>
                      <a:pt x="258757" y="389004"/>
                      <a:pt x="270046" y="390415"/>
                    </a:cubicBezTo>
                    <a:cubicBezTo>
                      <a:pt x="275690" y="391826"/>
                      <a:pt x="281300" y="393386"/>
                      <a:pt x="286979" y="394648"/>
                    </a:cubicBezTo>
                    <a:cubicBezTo>
                      <a:pt x="297034" y="396883"/>
                      <a:pt x="314763" y="399676"/>
                      <a:pt x="325079" y="403115"/>
                    </a:cubicBezTo>
                    <a:cubicBezTo>
                      <a:pt x="332288" y="405518"/>
                      <a:pt x="339190" y="408760"/>
                      <a:pt x="346246" y="411582"/>
                    </a:cubicBezTo>
                    <a:cubicBezTo>
                      <a:pt x="350479" y="415815"/>
                      <a:pt x="353475" y="421851"/>
                      <a:pt x="358946" y="424282"/>
                    </a:cubicBezTo>
                    <a:cubicBezTo>
                      <a:pt x="366790" y="427768"/>
                      <a:pt x="375901" y="426980"/>
                      <a:pt x="384346" y="428515"/>
                    </a:cubicBezTo>
                    <a:cubicBezTo>
                      <a:pt x="408245" y="432860"/>
                      <a:pt x="412567" y="434512"/>
                      <a:pt x="439379" y="441215"/>
                    </a:cubicBezTo>
                    <a:cubicBezTo>
                      <a:pt x="445024" y="442626"/>
                      <a:pt x="450793" y="443608"/>
                      <a:pt x="456313" y="445448"/>
                    </a:cubicBezTo>
                    <a:cubicBezTo>
                      <a:pt x="460546" y="446859"/>
                      <a:pt x="465022" y="447686"/>
                      <a:pt x="469013" y="449682"/>
                    </a:cubicBezTo>
                    <a:cubicBezTo>
                      <a:pt x="476372" y="453362"/>
                      <a:pt x="482430" y="459615"/>
                      <a:pt x="490179" y="462382"/>
                    </a:cubicBezTo>
                    <a:cubicBezTo>
                      <a:pt x="502431" y="466758"/>
                      <a:pt x="515882" y="466903"/>
                      <a:pt x="528279" y="470848"/>
                    </a:cubicBezTo>
                    <a:cubicBezTo>
                      <a:pt x="547009" y="476807"/>
                      <a:pt x="565733" y="483225"/>
                      <a:pt x="583313" y="492015"/>
                    </a:cubicBezTo>
                    <a:cubicBezTo>
                      <a:pt x="621170" y="510944"/>
                      <a:pt x="605206" y="504956"/>
                      <a:pt x="629879" y="513182"/>
                    </a:cubicBezTo>
                    <a:cubicBezTo>
                      <a:pt x="651046" y="510360"/>
                      <a:pt x="676588" y="517908"/>
                      <a:pt x="693379" y="504715"/>
                    </a:cubicBezTo>
                    <a:cubicBezTo>
                      <a:pt x="703427" y="496820"/>
                      <a:pt x="691247" y="479219"/>
                      <a:pt x="689146" y="466615"/>
                    </a:cubicBezTo>
                    <a:cubicBezTo>
                      <a:pt x="687209" y="454990"/>
                      <a:pt x="680433" y="445202"/>
                      <a:pt x="672213" y="436982"/>
                    </a:cubicBezTo>
                    <a:cubicBezTo>
                      <a:pt x="668615" y="433384"/>
                      <a:pt x="663746" y="431337"/>
                      <a:pt x="659513" y="428515"/>
                    </a:cubicBezTo>
                    <a:cubicBezTo>
                      <a:pt x="636934" y="394648"/>
                      <a:pt x="666569" y="435571"/>
                      <a:pt x="638346" y="407348"/>
                    </a:cubicBezTo>
                    <a:cubicBezTo>
                      <a:pt x="634748" y="403750"/>
                      <a:pt x="632836" y="398788"/>
                      <a:pt x="629879" y="394648"/>
                    </a:cubicBezTo>
                    <a:cubicBezTo>
                      <a:pt x="625778" y="388907"/>
                      <a:pt x="620918" y="383698"/>
                      <a:pt x="617179" y="377715"/>
                    </a:cubicBezTo>
                    <a:cubicBezTo>
                      <a:pt x="613834" y="372364"/>
                      <a:pt x="612213" y="366033"/>
                      <a:pt x="608713" y="360782"/>
                    </a:cubicBezTo>
                    <a:cubicBezTo>
                      <a:pt x="600886" y="349041"/>
                      <a:pt x="591141" y="338656"/>
                      <a:pt x="583313" y="326915"/>
                    </a:cubicBezTo>
                    <a:cubicBezTo>
                      <a:pt x="580491" y="322682"/>
                      <a:pt x="578103" y="318124"/>
                      <a:pt x="574846" y="314215"/>
                    </a:cubicBezTo>
                    <a:cubicBezTo>
                      <a:pt x="571013" y="309616"/>
                      <a:pt x="566042" y="306061"/>
                      <a:pt x="562146" y="301515"/>
                    </a:cubicBezTo>
                    <a:cubicBezTo>
                      <a:pt x="540006" y="275685"/>
                      <a:pt x="557658" y="294335"/>
                      <a:pt x="540979" y="267648"/>
                    </a:cubicBezTo>
                    <a:cubicBezTo>
                      <a:pt x="537240" y="261665"/>
                      <a:pt x="532295" y="256516"/>
                      <a:pt x="528279" y="250715"/>
                    </a:cubicBezTo>
                    <a:cubicBezTo>
                      <a:pt x="519591" y="238165"/>
                      <a:pt x="511346" y="225315"/>
                      <a:pt x="502879" y="212615"/>
                    </a:cubicBezTo>
                    <a:cubicBezTo>
                      <a:pt x="496631" y="203243"/>
                      <a:pt x="491493" y="193735"/>
                      <a:pt x="481713" y="187215"/>
                    </a:cubicBezTo>
                    <a:cubicBezTo>
                      <a:pt x="478000" y="184740"/>
                      <a:pt x="473246" y="184393"/>
                      <a:pt x="469013" y="182982"/>
                    </a:cubicBezTo>
                    <a:cubicBezTo>
                      <a:pt x="464780" y="180160"/>
                      <a:pt x="461010" y="176472"/>
                      <a:pt x="456313" y="174515"/>
                    </a:cubicBezTo>
                    <a:cubicBezTo>
                      <a:pt x="443956" y="169366"/>
                      <a:pt x="429776" y="168560"/>
                      <a:pt x="418213" y="161815"/>
                    </a:cubicBezTo>
                    <a:cubicBezTo>
                      <a:pt x="412119" y="158260"/>
                      <a:pt x="410502" y="149871"/>
                      <a:pt x="405513" y="144882"/>
                    </a:cubicBezTo>
                    <a:cubicBezTo>
                      <a:pt x="400524" y="139893"/>
                      <a:pt x="394224" y="136415"/>
                      <a:pt x="388579" y="132182"/>
                    </a:cubicBezTo>
                    <a:cubicBezTo>
                      <a:pt x="377938" y="100258"/>
                      <a:pt x="392293" y="139611"/>
                      <a:pt x="375879" y="106782"/>
                    </a:cubicBezTo>
                    <a:cubicBezTo>
                      <a:pt x="368821" y="92666"/>
                      <a:pt x="366489" y="76224"/>
                      <a:pt x="354713" y="64448"/>
                    </a:cubicBezTo>
                    <a:cubicBezTo>
                      <a:pt x="351558" y="61293"/>
                      <a:pt x="346369" y="61183"/>
                      <a:pt x="342013" y="60215"/>
                    </a:cubicBezTo>
                    <a:cubicBezTo>
                      <a:pt x="333634" y="58353"/>
                      <a:pt x="325080" y="57393"/>
                      <a:pt x="316613" y="55982"/>
                    </a:cubicBezTo>
                    <a:cubicBezTo>
                      <a:pt x="289732" y="47020"/>
                      <a:pt x="318937" y="57422"/>
                      <a:pt x="278513" y="39048"/>
                    </a:cubicBezTo>
                    <a:cubicBezTo>
                      <a:pt x="271595" y="35904"/>
                      <a:pt x="264143" y="33980"/>
                      <a:pt x="257346" y="30582"/>
                    </a:cubicBezTo>
                    <a:cubicBezTo>
                      <a:pt x="252795" y="28307"/>
                      <a:pt x="286274" y="4476"/>
                      <a:pt x="274279" y="948"/>
                    </a:cubicBezTo>
                    <a:close/>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sp>
            <p:nvSpPr>
              <p:cNvPr id="27" name="任意多边形: 形状 26">
                <a:extLst>
                  <a:ext uri="{FF2B5EF4-FFF2-40B4-BE49-F238E27FC236}">
                    <a16:creationId xmlns:a16="http://schemas.microsoft.com/office/drawing/2014/main" id="{775531B1-C508-CA4E-F10A-C42BBDA39248}"/>
                  </a:ext>
                </a:extLst>
              </p:cNvPr>
              <p:cNvSpPr/>
              <p:nvPr/>
            </p:nvSpPr>
            <p:spPr>
              <a:xfrm>
                <a:off x="4647523" y="4495242"/>
                <a:ext cx="404180" cy="587771"/>
              </a:xfrm>
              <a:custGeom>
                <a:avLst/>
                <a:gdLst>
                  <a:gd name="connsiteX0" fmla="*/ 0 w 543218"/>
                  <a:gd name="connsiteY0" fmla="*/ 275166 h 673100"/>
                  <a:gd name="connsiteX1" fmla="*/ 12700 w 543218"/>
                  <a:gd name="connsiteY1" fmla="*/ 207433 h 673100"/>
                  <a:gd name="connsiteX2" fmla="*/ 16934 w 543218"/>
                  <a:gd name="connsiteY2" fmla="*/ 190500 h 673100"/>
                  <a:gd name="connsiteX3" fmla="*/ 25400 w 543218"/>
                  <a:gd name="connsiteY3" fmla="*/ 173566 h 673100"/>
                  <a:gd name="connsiteX4" fmla="*/ 29634 w 543218"/>
                  <a:gd name="connsiteY4" fmla="*/ 152400 h 673100"/>
                  <a:gd name="connsiteX5" fmla="*/ 63500 w 543218"/>
                  <a:gd name="connsiteY5" fmla="*/ 101600 h 673100"/>
                  <a:gd name="connsiteX6" fmla="*/ 97367 w 543218"/>
                  <a:gd name="connsiteY6" fmla="*/ 76200 h 673100"/>
                  <a:gd name="connsiteX7" fmla="*/ 135467 w 543218"/>
                  <a:gd name="connsiteY7" fmla="*/ 50800 h 673100"/>
                  <a:gd name="connsiteX8" fmla="*/ 156634 w 543218"/>
                  <a:gd name="connsiteY8" fmla="*/ 42333 h 673100"/>
                  <a:gd name="connsiteX9" fmla="*/ 182034 w 543218"/>
                  <a:gd name="connsiteY9" fmla="*/ 25400 h 673100"/>
                  <a:gd name="connsiteX10" fmla="*/ 220134 w 543218"/>
                  <a:gd name="connsiteY10" fmla="*/ 12700 h 673100"/>
                  <a:gd name="connsiteX11" fmla="*/ 237067 w 543218"/>
                  <a:gd name="connsiteY11" fmla="*/ 4233 h 673100"/>
                  <a:gd name="connsiteX12" fmla="*/ 258234 w 543218"/>
                  <a:gd name="connsiteY12" fmla="*/ 0 h 673100"/>
                  <a:gd name="connsiteX13" fmla="*/ 440267 w 543218"/>
                  <a:gd name="connsiteY13" fmla="*/ 4233 h 673100"/>
                  <a:gd name="connsiteX14" fmla="*/ 461434 w 543218"/>
                  <a:gd name="connsiteY14" fmla="*/ 12700 h 673100"/>
                  <a:gd name="connsiteX15" fmla="*/ 474134 w 543218"/>
                  <a:gd name="connsiteY15" fmla="*/ 16933 h 673100"/>
                  <a:gd name="connsiteX16" fmla="*/ 486834 w 543218"/>
                  <a:gd name="connsiteY16" fmla="*/ 25400 h 673100"/>
                  <a:gd name="connsiteX17" fmla="*/ 508000 w 543218"/>
                  <a:gd name="connsiteY17" fmla="*/ 33866 h 673100"/>
                  <a:gd name="connsiteX18" fmla="*/ 529167 w 543218"/>
                  <a:gd name="connsiteY18" fmla="*/ 67733 h 673100"/>
                  <a:gd name="connsiteX19" fmla="*/ 537634 w 543218"/>
                  <a:gd name="connsiteY19" fmla="*/ 80433 h 673100"/>
                  <a:gd name="connsiteX20" fmla="*/ 537634 w 543218"/>
                  <a:gd name="connsiteY20" fmla="*/ 173566 h 673100"/>
                  <a:gd name="connsiteX21" fmla="*/ 533400 w 543218"/>
                  <a:gd name="connsiteY21" fmla="*/ 194733 h 673100"/>
                  <a:gd name="connsiteX22" fmla="*/ 524934 w 543218"/>
                  <a:gd name="connsiteY22" fmla="*/ 207433 h 673100"/>
                  <a:gd name="connsiteX23" fmla="*/ 520700 w 543218"/>
                  <a:gd name="connsiteY23" fmla="*/ 220133 h 673100"/>
                  <a:gd name="connsiteX24" fmla="*/ 503767 w 543218"/>
                  <a:gd name="connsiteY24" fmla="*/ 237066 h 673100"/>
                  <a:gd name="connsiteX25" fmla="*/ 495300 w 543218"/>
                  <a:gd name="connsiteY25" fmla="*/ 249766 h 673100"/>
                  <a:gd name="connsiteX26" fmla="*/ 491067 w 543218"/>
                  <a:gd name="connsiteY26" fmla="*/ 262466 h 673100"/>
                  <a:gd name="connsiteX27" fmla="*/ 474134 w 543218"/>
                  <a:gd name="connsiteY27" fmla="*/ 296333 h 673100"/>
                  <a:gd name="connsiteX28" fmla="*/ 469900 w 543218"/>
                  <a:gd name="connsiteY28" fmla="*/ 313266 h 673100"/>
                  <a:gd name="connsiteX29" fmla="*/ 486834 w 543218"/>
                  <a:gd name="connsiteY29" fmla="*/ 364066 h 673100"/>
                  <a:gd name="connsiteX30" fmla="*/ 499534 w 543218"/>
                  <a:gd name="connsiteY30" fmla="*/ 376766 h 673100"/>
                  <a:gd name="connsiteX31" fmla="*/ 516467 w 543218"/>
                  <a:gd name="connsiteY31" fmla="*/ 414866 h 673100"/>
                  <a:gd name="connsiteX32" fmla="*/ 533400 w 543218"/>
                  <a:gd name="connsiteY32" fmla="*/ 457200 h 673100"/>
                  <a:gd name="connsiteX33" fmla="*/ 529167 w 543218"/>
                  <a:gd name="connsiteY33" fmla="*/ 546100 h 673100"/>
                  <a:gd name="connsiteX34" fmla="*/ 520700 w 543218"/>
                  <a:gd name="connsiteY34" fmla="*/ 563033 h 673100"/>
                  <a:gd name="connsiteX35" fmla="*/ 495300 w 543218"/>
                  <a:gd name="connsiteY35" fmla="*/ 592666 h 673100"/>
                  <a:gd name="connsiteX36" fmla="*/ 474134 w 543218"/>
                  <a:gd name="connsiteY36" fmla="*/ 605366 h 673100"/>
                  <a:gd name="connsiteX37" fmla="*/ 465667 w 543218"/>
                  <a:gd name="connsiteY37" fmla="*/ 622300 h 673100"/>
                  <a:gd name="connsiteX38" fmla="*/ 431800 w 543218"/>
                  <a:gd name="connsiteY38" fmla="*/ 647700 h 673100"/>
                  <a:gd name="connsiteX39" fmla="*/ 410634 w 543218"/>
                  <a:gd name="connsiteY39" fmla="*/ 664633 h 673100"/>
                  <a:gd name="connsiteX40" fmla="*/ 381000 w 543218"/>
                  <a:gd name="connsiteY40" fmla="*/ 673100 h 673100"/>
                  <a:gd name="connsiteX41" fmla="*/ 321734 w 543218"/>
                  <a:gd name="connsiteY41" fmla="*/ 651933 h 673100"/>
                  <a:gd name="connsiteX42" fmla="*/ 262467 w 543218"/>
                  <a:gd name="connsiteY42" fmla="*/ 622300 h 673100"/>
                  <a:gd name="connsiteX43" fmla="*/ 237067 w 543218"/>
                  <a:gd name="connsiteY43" fmla="*/ 601133 h 673100"/>
                  <a:gd name="connsiteX44" fmla="*/ 220134 w 543218"/>
                  <a:gd name="connsiteY44" fmla="*/ 592666 h 673100"/>
                  <a:gd name="connsiteX45" fmla="*/ 198967 w 543218"/>
                  <a:gd name="connsiteY45" fmla="*/ 575733 h 673100"/>
                  <a:gd name="connsiteX46" fmla="*/ 186267 w 543218"/>
                  <a:gd name="connsiteY46" fmla="*/ 554566 h 673100"/>
                  <a:gd name="connsiteX47" fmla="*/ 160867 w 543218"/>
                  <a:gd name="connsiteY47" fmla="*/ 503766 h 673100"/>
                  <a:gd name="connsiteX48" fmla="*/ 156634 w 543218"/>
                  <a:gd name="connsiteY48" fmla="*/ 486833 h 673100"/>
                  <a:gd name="connsiteX49" fmla="*/ 148167 w 543218"/>
                  <a:gd name="connsiteY49" fmla="*/ 444500 h 673100"/>
                  <a:gd name="connsiteX50" fmla="*/ 139700 w 543218"/>
                  <a:gd name="connsiteY50" fmla="*/ 427566 h 673100"/>
                  <a:gd name="connsiteX51" fmla="*/ 118534 w 543218"/>
                  <a:gd name="connsiteY51" fmla="*/ 397933 h 673100"/>
                  <a:gd name="connsiteX52" fmla="*/ 101600 w 543218"/>
                  <a:gd name="connsiteY52" fmla="*/ 359833 h 673100"/>
                  <a:gd name="connsiteX53" fmla="*/ 93134 w 543218"/>
                  <a:gd name="connsiteY53" fmla="*/ 325966 h 673100"/>
                  <a:gd name="connsiteX54" fmla="*/ 88900 w 543218"/>
                  <a:gd name="connsiteY54" fmla="*/ 309033 h 673100"/>
                  <a:gd name="connsiteX55" fmla="*/ 84667 w 543218"/>
                  <a:gd name="connsiteY55" fmla="*/ 287866 h 673100"/>
                  <a:gd name="connsiteX56" fmla="*/ 80434 w 543218"/>
                  <a:gd name="connsiteY56" fmla="*/ 275166 h 673100"/>
                  <a:gd name="connsiteX57" fmla="*/ 76200 w 543218"/>
                  <a:gd name="connsiteY57" fmla="*/ 254000 h 673100"/>
                  <a:gd name="connsiteX58" fmla="*/ 67734 w 543218"/>
                  <a:gd name="connsiteY58" fmla="*/ 220133 h 673100"/>
                  <a:gd name="connsiteX59" fmla="*/ 76200 w 543218"/>
                  <a:gd name="connsiteY59" fmla="*/ 114300 h 673100"/>
                  <a:gd name="connsiteX60" fmla="*/ 84667 w 543218"/>
                  <a:gd name="connsiteY60" fmla="*/ 93133 h 673100"/>
                  <a:gd name="connsiteX61" fmla="*/ 97367 w 543218"/>
                  <a:gd name="connsiteY61" fmla="*/ 84666 h 673100"/>
                  <a:gd name="connsiteX62" fmla="*/ 122767 w 543218"/>
                  <a:gd name="connsiteY62" fmla="*/ 71966 h 673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Lst>
                <a:rect l="l" t="t" r="r" b="b"/>
                <a:pathLst>
                  <a:path w="543218" h="673100">
                    <a:moveTo>
                      <a:pt x="0" y="275166"/>
                    </a:moveTo>
                    <a:cubicBezTo>
                      <a:pt x="5084" y="244668"/>
                      <a:pt x="5093" y="242933"/>
                      <a:pt x="12700" y="207433"/>
                    </a:cubicBezTo>
                    <a:cubicBezTo>
                      <a:pt x="13919" y="201744"/>
                      <a:pt x="14891" y="195948"/>
                      <a:pt x="16934" y="190500"/>
                    </a:cubicBezTo>
                    <a:cubicBezTo>
                      <a:pt x="19150" y="184591"/>
                      <a:pt x="22578" y="179211"/>
                      <a:pt x="25400" y="173566"/>
                    </a:cubicBezTo>
                    <a:cubicBezTo>
                      <a:pt x="26811" y="166511"/>
                      <a:pt x="26962" y="159080"/>
                      <a:pt x="29634" y="152400"/>
                    </a:cubicBezTo>
                    <a:cubicBezTo>
                      <a:pt x="33364" y="143076"/>
                      <a:pt x="59998" y="105102"/>
                      <a:pt x="63500" y="101600"/>
                    </a:cubicBezTo>
                    <a:cubicBezTo>
                      <a:pt x="73478" y="91622"/>
                      <a:pt x="86078" y="84667"/>
                      <a:pt x="97367" y="76200"/>
                    </a:cubicBezTo>
                    <a:cubicBezTo>
                      <a:pt x="111550" y="65563"/>
                      <a:pt x="119134" y="58966"/>
                      <a:pt x="135467" y="50800"/>
                    </a:cubicBezTo>
                    <a:cubicBezTo>
                      <a:pt x="142264" y="47402"/>
                      <a:pt x="149963" y="45972"/>
                      <a:pt x="156634" y="42333"/>
                    </a:cubicBezTo>
                    <a:cubicBezTo>
                      <a:pt x="165567" y="37460"/>
                      <a:pt x="173101" y="30273"/>
                      <a:pt x="182034" y="25400"/>
                    </a:cubicBezTo>
                    <a:cubicBezTo>
                      <a:pt x="195526" y="18041"/>
                      <a:pt x="205840" y="16273"/>
                      <a:pt x="220134" y="12700"/>
                    </a:cubicBezTo>
                    <a:cubicBezTo>
                      <a:pt x="225778" y="9878"/>
                      <a:pt x="231080" y="6229"/>
                      <a:pt x="237067" y="4233"/>
                    </a:cubicBezTo>
                    <a:cubicBezTo>
                      <a:pt x="243893" y="1958"/>
                      <a:pt x="251039" y="0"/>
                      <a:pt x="258234" y="0"/>
                    </a:cubicBezTo>
                    <a:cubicBezTo>
                      <a:pt x="318928" y="0"/>
                      <a:pt x="379589" y="2822"/>
                      <a:pt x="440267" y="4233"/>
                    </a:cubicBezTo>
                    <a:cubicBezTo>
                      <a:pt x="447323" y="7055"/>
                      <a:pt x="454319" y="10032"/>
                      <a:pt x="461434" y="12700"/>
                    </a:cubicBezTo>
                    <a:cubicBezTo>
                      <a:pt x="465612" y="14267"/>
                      <a:pt x="470143" y="14937"/>
                      <a:pt x="474134" y="16933"/>
                    </a:cubicBezTo>
                    <a:cubicBezTo>
                      <a:pt x="478685" y="19208"/>
                      <a:pt x="482283" y="23125"/>
                      <a:pt x="486834" y="25400"/>
                    </a:cubicBezTo>
                    <a:cubicBezTo>
                      <a:pt x="493631" y="28798"/>
                      <a:pt x="500945" y="31044"/>
                      <a:pt x="508000" y="33866"/>
                    </a:cubicBezTo>
                    <a:cubicBezTo>
                      <a:pt x="527346" y="62884"/>
                      <a:pt x="503637" y="26885"/>
                      <a:pt x="529167" y="67733"/>
                    </a:cubicBezTo>
                    <a:cubicBezTo>
                      <a:pt x="531864" y="72048"/>
                      <a:pt x="534812" y="76200"/>
                      <a:pt x="537634" y="80433"/>
                    </a:cubicBezTo>
                    <a:cubicBezTo>
                      <a:pt x="546056" y="122549"/>
                      <a:pt x="544036" y="103149"/>
                      <a:pt x="537634" y="173566"/>
                    </a:cubicBezTo>
                    <a:cubicBezTo>
                      <a:pt x="536983" y="180732"/>
                      <a:pt x="535926" y="187996"/>
                      <a:pt x="533400" y="194733"/>
                    </a:cubicBezTo>
                    <a:cubicBezTo>
                      <a:pt x="531614" y="199497"/>
                      <a:pt x="527209" y="202882"/>
                      <a:pt x="524934" y="207433"/>
                    </a:cubicBezTo>
                    <a:cubicBezTo>
                      <a:pt x="522938" y="211424"/>
                      <a:pt x="523294" y="216502"/>
                      <a:pt x="520700" y="220133"/>
                    </a:cubicBezTo>
                    <a:cubicBezTo>
                      <a:pt x="516060" y="226628"/>
                      <a:pt x="508962" y="231005"/>
                      <a:pt x="503767" y="237066"/>
                    </a:cubicBezTo>
                    <a:cubicBezTo>
                      <a:pt x="500456" y="240929"/>
                      <a:pt x="498122" y="245533"/>
                      <a:pt x="495300" y="249766"/>
                    </a:cubicBezTo>
                    <a:cubicBezTo>
                      <a:pt x="493889" y="253999"/>
                      <a:pt x="492913" y="258404"/>
                      <a:pt x="491067" y="262466"/>
                    </a:cubicBezTo>
                    <a:cubicBezTo>
                      <a:pt x="485844" y="273956"/>
                      <a:pt x="477196" y="284089"/>
                      <a:pt x="474134" y="296333"/>
                    </a:cubicBezTo>
                    <a:lnTo>
                      <a:pt x="469900" y="313266"/>
                    </a:lnTo>
                    <a:cubicBezTo>
                      <a:pt x="475825" y="339929"/>
                      <a:pt x="472576" y="346957"/>
                      <a:pt x="486834" y="364066"/>
                    </a:cubicBezTo>
                    <a:cubicBezTo>
                      <a:pt x="490667" y="368665"/>
                      <a:pt x="496213" y="371785"/>
                      <a:pt x="499534" y="376766"/>
                    </a:cubicBezTo>
                    <a:cubicBezTo>
                      <a:pt x="517679" y="403983"/>
                      <a:pt x="507615" y="394211"/>
                      <a:pt x="516467" y="414866"/>
                    </a:cubicBezTo>
                    <a:cubicBezTo>
                      <a:pt x="535154" y="458469"/>
                      <a:pt x="514131" y="399387"/>
                      <a:pt x="533400" y="457200"/>
                    </a:cubicBezTo>
                    <a:cubicBezTo>
                      <a:pt x="531989" y="486833"/>
                      <a:pt x="532702" y="516644"/>
                      <a:pt x="529167" y="546100"/>
                    </a:cubicBezTo>
                    <a:cubicBezTo>
                      <a:pt x="528415" y="552366"/>
                      <a:pt x="523831" y="557554"/>
                      <a:pt x="520700" y="563033"/>
                    </a:cubicBezTo>
                    <a:cubicBezTo>
                      <a:pt x="514111" y="574564"/>
                      <a:pt x="505940" y="584390"/>
                      <a:pt x="495300" y="592666"/>
                    </a:cubicBezTo>
                    <a:cubicBezTo>
                      <a:pt x="488805" y="597717"/>
                      <a:pt x="481189" y="601133"/>
                      <a:pt x="474134" y="605366"/>
                    </a:cubicBezTo>
                    <a:cubicBezTo>
                      <a:pt x="471312" y="611011"/>
                      <a:pt x="469823" y="617551"/>
                      <a:pt x="465667" y="622300"/>
                    </a:cubicBezTo>
                    <a:cubicBezTo>
                      <a:pt x="454854" y="634657"/>
                      <a:pt x="443950" y="638587"/>
                      <a:pt x="431800" y="647700"/>
                    </a:cubicBezTo>
                    <a:cubicBezTo>
                      <a:pt x="424572" y="653121"/>
                      <a:pt x="418715" y="660592"/>
                      <a:pt x="410634" y="664633"/>
                    </a:cubicBezTo>
                    <a:cubicBezTo>
                      <a:pt x="401445" y="669227"/>
                      <a:pt x="390878" y="670278"/>
                      <a:pt x="381000" y="673100"/>
                    </a:cubicBezTo>
                    <a:cubicBezTo>
                      <a:pt x="361245" y="666044"/>
                      <a:pt x="340674" y="660952"/>
                      <a:pt x="321734" y="651933"/>
                    </a:cubicBezTo>
                    <a:cubicBezTo>
                      <a:pt x="236258" y="611229"/>
                      <a:pt x="343955" y="645581"/>
                      <a:pt x="262467" y="622300"/>
                    </a:cubicBezTo>
                    <a:cubicBezTo>
                      <a:pt x="254000" y="615244"/>
                      <a:pt x="246096" y="607453"/>
                      <a:pt x="237067" y="601133"/>
                    </a:cubicBezTo>
                    <a:cubicBezTo>
                      <a:pt x="231897" y="597514"/>
                      <a:pt x="225385" y="596167"/>
                      <a:pt x="220134" y="592666"/>
                    </a:cubicBezTo>
                    <a:cubicBezTo>
                      <a:pt x="212616" y="587654"/>
                      <a:pt x="206023" y="581377"/>
                      <a:pt x="198967" y="575733"/>
                    </a:cubicBezTo>
                    <a:cubicBezTo>
                      <a:pt x="194734" y="568677"/>
                      <a:pt x="190117" y="561838"/>
                      <a:pt x="186267" y="554566"/>
                    </a:cubicBezTo>
                    <a:cubicBezTo>
                      <a:pt x="177409" y="537834"/>
                      <a:pt x="160867" y="503766"/>
                      <a:pt x="160867" y="503766"/>
                    </a:cubicBezTo>
                    <a:cubicBezTo>
                      <a:pt x="159456" y="498122"/>
                      <a:pt x="157775" y="492538"/>
                      <a:pt x="156634" y="486833"/>
                    </a:cubicBezTo>
                    <a:cubicBezTo>
                      <a:pt x="154545" y="476389"/>
                      <a:pt x="152379" y="455733"/>
                      <a:pt x="148167" y="444500"/>
                    </a:cubicBezTo>
                    <a:cubicBezTo>
                      <a:pt x="145951" y="438591"/>
                      <a:pt x="143045" y="432918"/>
                      <a:pt x="139700" y="427566"/>
                    </a:cubicBezTo>
                    <a:cubicBezTo>
                      <a:pt x="124541" y="403312"/>
                      <a:pt x="130485" y="418848"/>
                      <a:pt x="118534" y="397933"/>
                    </a:cubicBezTo>
                    <a:cubicBezTo>
                      <a:pt x="113134" y="388483"/>
                      <a:pt x="104625" y="369663"/>
                      <a:pt x="101600" y="359833"/>
                    </a:cubicBezTo>
                    <a:cubicBezTo>
                      <a:pt x="98178" y="348711"/>
                      <a:pt x="95956" y="337255"/>
                      <a:pt x="93134" y="325966"/>
                    </a:cubicBezTo>
                    <a:cubicBezTo>
                      <a:pt x="91723" y="320322"/>
                      <a:pt x="90041" y="314738"/>
                      <a:pt x="88900" y="309033"/>
                    </a:cubicBezTo>
                    <a:cubicBezTo>
                      <a:pt x="87489" y="301977"/>
                      <a:pt x="86412" y="294847"/>
                      <a:pt x="84667" y="287866"/>
                    </a:cubicBezTo>
                    <a:cubicBezTo>
                      <a:pt x="83585" y="283537"/>
                      <a:pt x="81516" y="279495"/>
                      <a:pt x="80434" y="275166"/>
                    </a:cubicBezTo>
                    <a:cubicBezTo>
                      <a:pt x="78689" y="268186"/>
                      <a:pt x="77818" y="261011"/>
                      <a:pt x="76200" y="254000"/>
                    </a:cubicBezTo>
                    <a:cubicBezTo>
                      <a:pt x="73583" y="242662"/>
                      <a:pt x="67734" y="220133"/>
                      <a:pt x="67734" y="220133"/>
                    </a:cubicBezTo>
                    <a:cubicBezTo>
                      <a:pt x="70556" y="184855"/>
                      <a:pt x="71523" y="149380"/>
                      <a:pt x="76200" y="114300"/>
                    </a:cubicBezTo>
                    <a:cubicBezTo>
                      <a:pt x="77204" y="106767"/>
                      <a:pt x="80250" y="99317"/>
                      <a:pt x="84667" y="93133"/>
                    </a:cubicBezTo>
                    <a:cubicBezTo>
                      <a:pt x="87624" y="88993"/>
                      <a:pt x="92949" y="87190"/>
                      <a:pt x="97367" y="84666"/>
                    </a:cubicBezTo>
                    <a:cubicBezTo>
                      <a:pt x="105586" y="79970"/>
                      <a:pt x="114301" y="76200"/>
                      <a:pt x="122767" y="71966"/>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cxnSp>
            <p:nvCxnSpPr>
              <p:cNvPr id="28" name="直接箭头连接符 27">
                <a:extLst>
                  <a:ext uri="{FF2B5EF4-FFF2-40B4-BE49-F238E27FC236}">
                    <a16:creationId xmlns:a16="http://schemas.microsoft.com/office/drawing/2014/main" id="{11391CEA-08CC-CC62-D708-53E6CAC11E50}"/>
                  </a:ext>
                </a:extLst>
              </p:cNvPr>
              <p:cNvCxnSpPr>
                <a:cxnSpLocks/>
              </p:cNvCxnSpPr>
              <p:nvPr/>
            </p:nvCxnSpPr>
            <p:spPr>
              <a:xfrm flipH="1">
                <a:off x="4351367" y="4468387"/>
                <a:ext cx="110692" cy="86221"/>
              </a:xfrm>
              <a:prstGeom prst="straightConnector1">
                <a:avLst/>
              </a:prstGeom>
              <a:ln w="19050">
                <a:solidFill>
                  <a:srgbClr val="FFFF00"/>
                </a:solidFill>
                <a:tailEnd type="triangle"/>
              </a:ln>
            </p:spPr>
            <p:style>
              <a:lnRef idx="1">
                <a:schemeClr val="accent2"/>
              </a:lnRef>
              <a:fillRef idx="0">
                <a:schemeClr val="accent2"/>
              </a:fillRef>
              <a:effectRef idx="0">
                <a:schemeClr val="accent2"/>
              </a:effectRef>
              <a:fontRef idx="minor">
                <a:schemeClr val="tx1"/>
              </a:fontRef>
            </p:style>
          </p:cxnSp>
        </p:grpSp>
        <p:grpSp>
          <p:nvGrpSpPr>
            <p:cNvPr id="8" name="组合 7">
              <a:extLst>
                <a:ext uri="{FF2B5EF4-FFF2-40B4-BE49-F238E27FC236}">
                  <a16:creationId xmlns:a16="http://schemas.microsoft.com/office/drawing/2014/main" id="{F6DDEECD-850F-010D-617A-E2100CB3A8AD}"/>
                </a:ext>
              </a:extLst>
            </p:cNvPr>
            <p:cNvGrpSpPr/>
            <p:nvPr/>
          </p:nvGrpSpPr>
          <p:grpSpPr>
            <a:xfrm>
              <a:off x="3568082" y="901882"/>
              <a:ext cx="1912988" cy="1419358"/>
              <a:chOff x="3460729" y="2943856"/>
              <a:chExt cx="1699769" cy="1296570"/>
            </a:xfrm>
          </p:grpSpPr>
          <p:pic>
            <p:nvPicPr>
              <p:cNvPr id="18" name="图片 17">
                <a:extLst>
                  <a:ext uri="{FF2B5EF4-FFF2-40B4-BE49-F238E27FC236}">
                    <a16:creationId xmlns:a16="http://schemas.microsoft.com/office/drawing/2014/main" id="{D832F4D3-CC73-2822-0D12-D84388AC5B9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60729" y="2943856"/>
                <a:ext cx="1699769" cy="1296570"/>
              </a:xfrm>
              <a:prstGeom prst="rect">
                <a:avLst/>
              </a:prstGeom>
            </p:spPr>
          </p:pic>
          <p:sp>
            <p:nvSpPr>
              <p:cNvPr id="19" name="任意多边形: 形状 18">
                <a:extLst>
                  <a:ext uri="{FF2B5EF4-FFF2-40B4-BE49-F238E27FC236}">
                    <a16:creationId xmlns:a16="http://schemas.microsoft.com/office/drawing/2014/main" id="{9F3B1767-3CD6-7BBC-BD17-C419ED043357}"/>
                  </a:ext>
                </a:extLst>
              </p:cNvPr>
              <p:cNvSpPr/>
              <p:nvPr/>
            </p:nvSpPr>
            <p:spPr>
              <a:xfrm>
                <a:off x="3935114" y="3292932"/>
                <a:ext cx="1053978" cy="881843"/>
              </a:xfrm>
              <a:custGeom>
                <a:avLst/>
                <a:gdLst>
                  <a:gd name="connsiteX0" fmla="*/ 1172634 w 1422400"/>
                  <a:gd name="connsiteY0" fmla="*/ 97367 h 1236134"/>
                  <a:gd name="connsiteX1" fmla="*/ 994834 w 1422400"/>
                  <a:gd name="connsiteY1" fmla="*/ 101600 h 1236134"/>
                  <a:gd name="connsiteX2" fmla="*/ 969434 w 1422400"/>
                  <a:gd name="connsiteY2" fmla="*/ 105834 h 1236134"/>
                  <a:gd name="connsiteX3" fmla="*/ 935567 w 1422400"/>
                  <a:gd name="connsiteY3" fmla="*/ 118534 h 1236134"/>
                  <a:gd name="connsiteX4" fmla="*/ 893234 w 1422400"/>
                  <a:gd name="connsiteY4" fmla="*/ 135467 h 1236134"/>
                  <a:gd name="connsiteX5" fmla="*/ 872067 w 1422400"/>
                  <a:gd name="connsiteY5" fmla="*/ 143934 h 1236134"/>
                  <a:gd name="connsiteX6" fmla="*/ 855134 w 1422400"/>
                  <a:gd name="connsiteY6" fmla="*/ 148167 h 1236134"/>
                  <a:gd name="connsiteX7" fmla="*/ 821267 w 1422400"/>
                  <a:gd name="connsiteY7" fmla="*/ 165100 h 1236134"/>
                  <a:gd name="connsiteX8" fmla="*/ 791634 w 1422400"/>
                  <a:gd name="connsiteY8" fmla="*/ 177800 h 1236134"/>
                  <a:gd name="connsiteX9" fmla="*/ 774700 w 1422400"/>
                  <a:gd name="connsiteY9" fmla="*/ 190500 h 1236134"/>
                  <a:gd name="connsiteX10" fmla="*/ 728134 w 1422400"/>
                  <a:gd name="connsiteY10" fmla="*/ 211667 h 1236134"/>
                  <a:gd name="connsiteX11" fmla="*/ 690034 w 1422400"/>
                  <a:gd name="connsiteY11" fmla="*/ 232834 h 1236134"/>
                  <a:gd name="connsiteX12" fmla="*/ 673100 w 1422400"/>
                  <a:gd name="connsiteY12" fmla="*/ 237067 h 1236134"/>
                  <a:gd name="connsiteX13" fmla="*/ 656167 w 1422400"/>
                  <a:gd name="connsiteY13" fmla="*/ 203200 h 1236134"/>
                  <a:gd name="connsiteX14" fmla="*/ 647700 w 1422400"/>
                  <a:gd name="connsiteY14" fmla="*/ 186267 h 1236134"/>
                  <a:gd name="connsiteX15" fmla="*/ 639234 w 1422400"/>
                  <a:gd name="connsiteY15" fmla="*/ 160867 h 1236134"/>
                  <a:gd name="connsiteX16" fmla="*/ 626534 w 1422400"/>
                  <a:gd name="connsiteY16" fmla="*/ 148167 h 1236134"/>
                  <a:gd name="connsiteX17" fmla="*/ 618067 w 1422400"/>
                  <a:gd name="connsiteY17" fmla="*/ 135467 h 1236134"/>
                  <a:gd name="connsiteX18" fmla="*/ 588434 w 1422400"/>
                  <a:gd name="connsiteY18" fmla="*/ 114300 h 1236134"/>
                  <a:gd name="connsiteX19" fmla="*/ 571500 w 1422400"/>
                  <a:gd name="connsiteY19" fmla="*/ 97367 h 1236134"/>
                  <a:gd name="connsiteX20" fmla="*/ 546100 w 1422400"/>
                  <a:gd name="connsiteY20" fmla="*/ 80434 h 1236134"/>
                  <a:gd name="connsiteX21" fmla="*/ 529167 w 1422400"/>
                  <a:gd name="connsiteY21" fmla="*/ 63500 h 1236134"/>
                  <a:gd name="connsiteX22" fmla="*/ 495300 w 1422400"/>
                  <a:gd name="connsiteY22" fmla="*/ 46567 h 1236134"/>
                  <a:gd name="connsiteX23" fmla="*/ 482600 w 1422400"/>
                  <a:gd name="connsiteY23" fmla="*/ 38100 h 1236134"/>
                  <a:gd name="connsiteX24" fmla="*/ 427567 w 1422400"/>
                  <a:gd name="connsiteY24" fmla="*/ 8467 h 1236134"/>
                  <a:gd name="connsiteX25" fmla="*/ 347134 w 1422400"/>
                  <a:gd name="connsiteY25" fmla="*/ 0 h 1236134"/>
                  <a:gd name="connsiteX26" fmla="*/ 207434 w 1422400"/>
                  <a:gd name="connsiteY26" fmla="*/ 4234 h 1236134"/>
                  <a:gd name="connsiteX27" fmla="*/ 194734 w 1422400"/>
                  <a:gd name="connsiteY27" fmla="*/ 12700 h 1236134"/>
                  <a:gd name="connsiteX28" fmla="*/ 177800 w 1422400"/>
                  <a:gd name="connsiteY28" fmla="*/ 21167 h 1236134"/>
                  <a:gd name="connsiteX29" fmla="*/ 148167 w 1422400"/>
                  <a:gd name="connsiteY29" fmla="*/ 38100 h 1236134"/>
                  <a:gd name="connsiteX30" fmla="*/ 114300 w 1422400"/>
                  <a:gd name="connsiteY30" fmla="*/ 63500 h 1236134"/>
                  <a:gd name="connsiteX31" fmla="*/ 88900 w 1422400"/>
                  <a:gd name="connsiteY31" fmla="*/ 93134 h 1236134"/>
                  <a:gd name="connsiteX32" fmla="*/ 71967 w 1422400"/>
                  <a:gd name="connsiteY32" fmla="*/ 101600 h 1236134"/>
                  <a:gd name="connsiteX33" fmla="*/ 50800 w 1422400"/>
                  <a:gd name="connsiteY33" fmla="*/ 131234 h 1236134"/>
                  <a:gd name="connsiteX34" fmla="*/ 46567 w 1422400"/>
                  <a:gd name="connsiteY34" fmla="*/ 143934 h 1236134"/>
                  <a:gd name="connsiteX35" fmla="*/ 33867 w 1422400"/>
                  <a:gd name="connsiteY35" fmla="*/ 165100 h 1236134"/>
                  <a:gd name="connsiteX36" fmla="*/ 29634 w 1422400"/>
                  <a:gd name="connsiteY36" fmla="*/ 177800 h 1236134"/>
                  <a:gd name="connsiteX37" fmla="*/ 16934 w 1422400"/>
                  <a:gd name="connsiteY37" fmla="*/ 211667 h 1236134"/>
                  <a:gd name="connsiteX38" fmla="*/ 8467 w 1422400"/>
                  <a:gd name="connsiteY38" fmla="*/ 266700 h 1236134"/>
                  <a:gd name="connsiteX39" fmla="*/ 4234 w 1422400"/>
                  <a:gd name="connsiteY39" fmla="*/ 313267 h 1236134"/>
                  <a:gd name="connsiteX40" fmla="*/ 0 w 1422400"/>
                  <a:gd name="connsiteY40" fmla="*/ 338667 h 1236134"/>
                  <a:gd name="connsiteX41" fmla="*/ 4234 w 1422400"/>
                  <a:gd name="connsiteY41" fmla="*/ 546100 h 1236134"/>
                  <a:gd name="connsiteX42" fmla="*/ 16934 w 1422400"/>
                  <a:gd name="connsiteY42" fmla="*/ 554567 h 1236134"/>
                  <a:gd name="connsiteX43" fmla="*/ 33867 w 1422400"/>
                  <a:gd name="connsiteY43" fmla="*/ 563034 h 1236134"/>
                  <a:gd name="connsiteX44" fmla="*/ 46567 w 1422400"/>
                  <a:gd name="connsiteY44" fmla="*/ 571500 h 1236134"/>
                  <a:gd name="connsiteX45" fmla="*/ 93134 w 1422400"/>
                  <a:gd name="connsiteY45" fmla="*/ 588434 h 1236134"/>
                  <a:gd name="connsiteX46" fmla="*/ 122767 w 1422400"/>
                  <a:gd name="connsiteY46" fmla="*/ 592667 h 1236134"/>
                  <a:gd name="connsiteX47" fmla="*/ 160867 w 1422400"/>
                  <a:gd name="connsiteY47" fmla="*/ 613834 h 1236134"/>
                  <a:gd name="connsiteX48" fmla="*/ 169334 w 1422400"/>
                  <a:gd name="connsiteY48" fmla="*/ 626534 h 1236134"/>
                  <a:gd name="connsiteX49" fmla="*/ 182034 w 1422400"/>
                  <a:gd name="connsiteY49" fmla="*/ 635000 h 1236134"/>
                  <a:gd name="connsiteX50" fmla="*/ 194734 w 1422400"/>
                  <a:gd name="connsiteY50" fmla="*/ 647700 h 1236134"/>
                  <a:gd name="connsiteX51" fmla="*/ 215900 w 1422400"/>
                  <a:gd name="connsiteY51" fmla="*/ 660400 h 1236134"/>
                  <a:gd name="connsiteX52" fmla="*/ 241300 w 1422400"/>
                  <a:gd name="connsiteY52" fmla="*/ 685800 h 1236134"/>
                  <a:gd name="connsiteX53" fmla="*/ 317500 w 1422400"/>
                  <a:gd name="connsiteY53" fmla="*/ 694267 h 1236134"/>
                  <a:gd name="connsiteX54" fmla="*/ 334434 w 1422400"/>
                  <a:gd name="connsiteY54" fmla="*/ 698500 h 1236134"/>
                  <a:gd name="connsiteX55" fmla="*/ 364067 w 1422400"/>
                  <a:gd name="connsiteY55" fmla="*/ 706967 h 1236134"/>
                  <a:gd name="connsiteX56" fmla="*/ 389467 w 1422400"/>
                  <a:gd name="connsiteY56" fmla="*/ 749300 h 1236134"/>
                  <a:gd name="connsiteX57" fmla="*/ 372534 w 1422400"/>
                  <a:gd name="connsiteY57" fmla="*/ 787400 h 1236134"/>
                  <a:gd name="connsiteX58" fmla="*/ 359834 w 1422400"/>
                  <a:gd name="connsiteY58" fmla="*/ 829734 h 1236134"/>
                  <a:gd name="connsiteX59" fmla="*/ 364067 w 1422400"/>
                  <a:gd name="connsiteY59" fmla="*/ 986367 h 1236134"/>
                  <a:gd name="connsiteX60" fmla="*/ 368300 w 1422400"/>
                  <a:gd name="connsiteY60" fmla="*/ 1007534 h 1236134"/>
                  <a:gd name="connsiteX61" fmla="*/ 381000 w 1422400"/>
                  <a:gd name="connsiteY61" fmla="*/ 1024467 h 1236134"/>
                  <a:gd name="connsiteX62" fmla="*/ 393700 w 1422400"/>
                  <a:gd name="connsiteY62" fmla="*/ 1045634 h 1236134"/>
                  <a:gd name="connsiteX63" fmla="*/ 402167 w 1422400"/>
                  <a:gd name="connsiteY63" fmla="*/ 1058334 h 1236134"/>
                  <a:gd name="connsiteX64" fmla="*/ 427567 w 1422400"/>
                  <a:gd name="connsiteY64" fmla="*/ 1087967 h 1236134"/>
                  <a:gd name="connsiteX65" fmla="*/ 461434 w 1422400"/>
                  <a:gd name="connsiteY65" fmla="*/ 1113367 h 1236134"/>
                  <a:gd name="connsiteX66" fmla="*/ 469900 w 1422400"/>
                  <a:gd name="connsiteY66" fmla="*/ 1126067 h 1236134"/>
                  <a:gd name="connsiteX67" fmla="*/ 508000 w 1422400"/>
                  <a:gd name="connsiteY67" fmla="*/ 1147234 h 1236134"/>
                  <a:gd name="connsiteX68" fmla="*/ 524934 w 1422400"/>
                  <a:gd name="connsiteY68" fmla="*/ 1155700 h 1236134"/>
                  <a:gd name="connsiteX69" fmla="*/ 546100 w 1422400"/>
                  <a:gd name="connsiteY69" fmla="*/ 1164167 h 1236134"/>
                  <a:gd name="connsiteX70" fmla="*/ 563034 w 1422400"/>
                  <a:gd name="connsiteY70" fmla="*/ 1172634 h 1236134"/>
                  <a:gd name="connsiteX71" fmla="*/ 592667 w 1422400"/>
                  <a:gd name="connsiteY71" fmla="*/ 1181100 h 1236134"/>
                  <a:gd name="connsiteX72" fmla="*/ 605367 w 1422400"/>
                  <a:gd name="connsiteY72" fmla="*/ 1185334 h 1236134"/>
                  <a:gd name="connsiteX73" fmla="*/ 618067 w 1422400"/>
                  <a:gd name="connsiteY73" fmla="*/ 1198034 h 1236134"/>
                  <a:gd name="connsiteX74" fmla="*/ 651934 w 1422400"/>
                  <a:gd name="connsiteY74" fmla="*/ 1214967 h 1236134"/>
                  <a:gd name="connsiteX75" fmla="*/ 664634 w 1422400"/>
                  <a:gd name="connsiteY75" fmla="*/ 1227667 h 1236134"/>
                  <a:gd name="connsiteX76" fmla="*/ 698500 w 1422400"/>
                  <a:gd name="connsiteY76" fmla="*/ 1236134 h 1236134"/>
                  <a:gd name="connsiteX77" fmla="*/ 846667 w 1422400"/>
                  <a:gd name="connsiteY77" fmla="*/ 1231900 h 1236134"/>
                  <a:gd name="connsiteX78" fmla="*/ 901700 w 1422400"/>
                  <a:gd name="connsiteY78" fmla="*/ 1219200 h 1236134"/>
                  <a:gd name="connsiteX79" fmla="*/ 927100 w 1422400"/>
                  <a:gd name="connsiteY79" fmla="*/ 1210734 h 1236134"/>
                  <a:gd name="connsiteX80" fmla="*/ 956734 w 1422400"/>
                  <a:gd name="connsiteY80" fmla="*/ 1172634 h 1236134"/>
                  <a:gd name="connsiteX81" fmla="*/ 960967 w 1422400"/>
                  <a:gd name="connsiteY81" fmla="*/ 1155700 h 1236134"/>
                  <a:gd name="connsiteX82" fmla="*/ 977900 w 1422400"/>
                  <a:gd name="connsiteY82" fmla="*/ 1126067 h 1236134"/>
                  <a:gd name="connsiteX83" fmla="*/ 990600 w 1422400"/>
                  <a:gd name="connsiteY83" fmla="*/ 1087967 h 1236134"/>
                  <a:gd name="connsiteX84" fmla="*/ 1007534 w 1422400"/>
                  <a:gd name="connsiteY84" fmla="*/ 1028700 h 1236134"/>
                  <a:gd name="connsiteX85" fmla="*/ 1003300 w 1422400"/>
                  <a:gd name="connsiteY85" fmla="*/ 850900 h 1236134"/>
                  <a:gd name="connsiteX86" fmla="*/ 990600 w 1422400"/>
                  <a:gd name="connsiteY86" fmla="*/ 838200 h 1236134"/>
                  <a:gd name="connsiteX87" fmla="*/ 986367 w 1422400"/>
                  <a:gd name="connsiteY87" fmla="*/ 821267 h 1236134"/>
                  <a:gd name="connsiteX88" fmla="*/ 969434 w 1422400"/>
                  <a:gd name="connsiteY88" fmla="*/ 791634 h 1236134"/>
                  <a:gd name="connsiteX89" fmla="*/ 952500 w 1422400"/>
                  <a:gd name="connsiteY89" fmla="*/ 753534 h 1236134"/>
                  <a:gd name="connsiteX90" fmla="*/ 939800 w 1422400"/>
                  <a:gd name="connsiteY90" fmla="*/ 740834 h 1236134"/>
                  <a:gd name="connsiteX91" fmla="*/ 914400 w 1422400"/>
                  <a:gd name="connsiteY91" fmla="*/ 732367 h 1236134"/>
                  <a:gd name="connsiteX92" fmla="*/ 922867 w 1422400"/>
                  <a:gd name="connsiteY92" fmla="*/ 719667 h 1236134"/>
                  <a:gd name="connsiteX93" fmla="*/ 952500 w 1422400"/>
                  <a:gd name="connsiteY93" fmla="*/ 702734 h 1236134"/>
                  <a:gd name="connsiteX94" fmla="*/ 973667 w 1422400"/>
                  <a:gd name="connsiteY94" fmla="*/ 698500 h 1236134"/>
                  <a:gd name="connsiteX95" fmla="*/ 990600 w 1422400"/>
                  <a:gd name="connsiteY95" fmla="*/ 694267 h 1236134"/>
                  <a:gd name="connsiteX96" fmla="*/ 1143000 w 1422400"/>
                  <a:gd name="connsiteY96" fmla="*/ 690034 h 1236134"/>
                  <a:gd name="connsiteX97" fmla="*/ 1176867 w 1422400"/>
                  <a:gd name="connsiteY97" fmla="*/ 698500 h 1236134"/>
                  <a:gd name="connsiteX98" fmla="*/ 1202267 w 1422400"/>
                  <a:gd name="connsiteY98" fmla="*/ 702734 h 1236134"/>
                  <a:gd name="connsiteX99" fmla="*/ 1231900 w 1422400"/>
                  <a:gd name="connsiteY99" fmla="*/ 711200 h 1236134"/>
                  <a:gd name="connsiteX100" fmla="*/ 1278467 w 1422400"/>
                  <a:gd name="connsiteY100" fmla="*/ 715434 h 1236134"/>
                  <a:gd name="connsiteX101" fmla="*/ 1295400 w 1422400"/>
                  <a:gd name="connsiteY101" fmla="*/ 719667 h 1236134"/>
                  <a:gd name="connsiteX102" fmla="*/ 1333500 w 1422400"/>
                  <a:gd name="connsiteY102" fmla="*/ 728134 h 1236134"/>
                  <a:gd name="connsiteX103" fmla="*/ 1346200 w 1422400"/>
                  <a:gd name="connsiteY103" fmla="*/ 732367 h 1236134"/>
                  <a:gd name="connsiteX104" fmla="*/ 1422400 w 1422400"/>
                  <a:gd name="connsiteY104" fmla="*/ 740834 h 12361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Lst>
                <a:rect l="l" t="t" r="r" b="b"/>
                <a:pathLst>
                  <a:path w="1422400" h="1236134">
                    <a:moveTo>
                      <a:pt x="1172634" y="97367"/>
                    </a:moveTo>
                    <a:lnTo>
                      <a:pt x="994834" y="101600"/>
                    </a:lnTo>
                    <a:cubicBezTo>
                      <a:pt x="986258" y="101957"/>
                      <a:pt x="977656" y="103368"/>
                      <a:pt x="969434" y="105834"/>
                    </a:cubicBezTo>
                    <a:cubicBezTo>
                      <a:pt x="858681" y="139059"/>
                      <a:pt x="1040319" y="92341"/>
                      <a:pt x="935567" y="118534"/>
                    </a:cubicBezTo>
                    <a:cubicBezTo>
                      <a:pt x="897084" y="141623"/>
                      <a:pt x="932215" y="123773"/>
                      <a:pt x="893234" y="135467"/>
                    </a:cubicBezTo>
                    <a:cubicBezTo>
                      <a:pt x="885955" y="137651"/>
                      <a:pt x="879276" y="141531"/>
                      <a:pt x="872067" y="143934"/>
                    </a:cubicBezTo>
                    <a:cubicBezTo>
                      <a:pt x="866548" y="145774"/>
                      <a:pt x="860778" y="146756"/>
                      <a:pt x="855134" y="148167"/>
                    </a:cubicBezTo>
                    <a:cubicBezTo>
                      <a:pt x="843845" y="153811"/>
                      <a:pt x="833241" y="161108"/>
                      <a:pt x="821267" y="165100"/>
                    </a:cubicBezTo>
                    <a:cubicBezTo>
                      <a:pt x="808924" y="169215"/>
                      <a:pt x="803588" y="170329"/>
                      <a:pt x="791634" y="177800"/>
                    </a:cubicBezTo>
                    <a:cubicBezTo>
                      <a:pt x="785651" y="181539"/>
                      <a:pt x="780795" y="186945"/>
                      <a:pt x="774700" y="190500"/>
                    </a:cubicBezTo>
                    <a:cubicBezTo>
                      <a:pt x="749457" y="205225"/>
                      <a:pt x="748348" y="204930"/>
                      <a:pt x="728134" y="211667"/>
                    </a:cubicBezTo>
                    <a:cubicBezTo>
                      <a:pt x="705399" y="226823"/>
                      <a:pt x="709590" y="227246"/>
                      <a:pt x="690034" y="232834"/>
                    </a:cubicBezTo>
                    <a:cubicBezTo>
                      <a:pt x="684440" y="234432"/>
                      <a:pt x="678745" y="235656"/>
                      <a:pt x="673100" y="237067"/>
                    </a:cubicBezTo>
                    <a:cubicBezTo>
                      <a:pt x="645495" y="191058"/>
                      <a:pt x="669840" y="235103"/>
                      <a:pt x="656167" y="203200"/>
                    </a:cubicBezTo>
                    <a:cubicBezTo>
                      <a:pt x="653681" y="197400"/>
                      <a:pt x="650044" y="192126"/>
                      <a:pt x="647700" y="186267"/>
                    </a:cubicBezTo>
                    <a:cubicBezTo>
                      <a:pt x="644386" y="177981"/>
                      <a:pt x="645545" y="167178"/>
                      <a:pt x="639234" y="160867"/>
                    </a:cubicBezTo>
                    <a:cubicBezTo>
                      <a:pt x="635001" y="156634"/>
                      <a:pt x="630367" y="152766"/>
                      <a:pt x="626534" y="148167"/>
                    </a:cubicBezTo>
                    <a:cubicBezTo>
                      <a:pt x="623277" y="144258"/>
                      <a:pt x="621665" y="139065"/>
                      <a:pt x="618067" y="135467"/>
                    </a:cubicBezTo>
                    <a:cubicBezTo>
                      <a:pt x="599489" y="116889"/>
                      <a:pt x="605255" y="128718"/>
                      <a:pt x="588434" y="114300"/>
                    </a:cubicBezTo>
                    <a:cubicBezTo>
                      <a:pt x="582373" y="109105"/>
                      <a:pt x="577733" y="102354"/>
                      <a:pt x="571500" y="97367"/>
                    </a:cubicBezTo>
                    <a:cubicBezTo>
                      <a:pt x="563554" y="91010"/>
                      <a:pt x="553295" y="87629"/>
                      <a:pt x="546100" y="80434"/>
                    </a:cubicBezTo>
                    <a:cubicBezTo>
                      <a:pt x="540456" y="74789"/>
                      <a:pt x="535468" y="68401"/>
                      <a:pt x="529167" y="63500"/>
                    </a:cubicBezTo>
                    <a:cubicBezTo>
                      <a:pt x="514171" y="51837"/>
                      <a:pt x="510384" y="51595"/>
                      <a:pt x="495300" y="46567"/>
                    </a:cubicBezTo>
                    <a:cubicBezTo>
                      <a:pt x="491067" y="43745"/>
                      <a:pt x="486740" y="41057"/>
                      <a:pt x="482600" y="38100"/>
                    </a:cubicBezTo>
                    <a:cubicBezTo>
                      <a:pt x="465113" y="25609"/>
                      <a:pt x="450458" y="10877"/>
                      <a:pt x="427567" y="8467"/>
                    </a:cubicBezTo>
                    <a:lnTo>
                      <a:pt x="347134" y="0"/>
                    </a:lnTo>
                    <a:cubicBezTo>
                      <a:pt x="300567" y="1411"/>
                      <a:pt x="253861" y="365"/>
                      <a:pt x="207434" y="4234"/>
                    </a:cubicBezTo>
                    <a:cubicBezTo>
                      <a:pt x="202364" y="4657"/>
                      <a:pt x="199151" y="10176"/>
                      <a:pt x="194734" y="12700"/>
                    </a:cubicBezTo>
                    <a:cubicBezTo>
                      <a:pt x="189255" y="15831"/>
                      <a:pt x="183279" y="18036"/>
                      <a:pt x="177800" y="21167"/>
                    </a:cubicBezTo>
                    <a:cubicBezTo>
                      <a:pt x="135924" y="45096"/>
                      <a:pt x="199325" y="12523"/>
                      <a:pt x="148167" y="38100"/>
                    </a:cubicBezTo>
                    <a:cubicBezTo>
                      <a:pt x="118167" y="68100"/>
                      <a:pt x="156381" y="31940"/>
                      <a:pt x="114300" y="63500"/>
                    </a:cubicBezTo>
                    <a:cubicBezTo>
                      <a:pt x="76445" y="91891"/>
                      <a:pt x="128958" y="58798"/>
                      <a:pt x="88900" y="93134"/>
                    </a:cubicBezTo>
                    <a:cubicBezTo>
                      <a:pt x="84109" y="97241"/>
                      <a:pt x="77611" y="98778"/>
                      <a:pt x="71967" y="101600"/>
                    </a:cubicBezTo>
                    <a:cubicBezTo>
                      <a:pt x="42729" y="160076"/>
                      <a:pt x="85127" y="79742"/>
                      <a:pt x="50800" y="131234"/>
                    </a:cubicBezTo>
                    <a:cubicBezTo>
                      <a:pt x="48325" y="134947"/>
                      <a:pt x="48563" y="139943"/>
                      <a:pt x="46567" y="143934"/>
                    </a:cubicBezTo>
                    <a:cubicBezTo>
                      <a:pt x="42887" y="151293"/>
                      <a:pt x="37547" y="157741"/>
                      <a:pt x="33867" y="165100"/>
                    </a:cubicBezTo>
                    <a:cubicBezTo>
                      <a:pt x="31871" y="169091"/>
                      <a:pt x="31201" y="173622"/>
                      <a:pt x="29634" y="177800"/>
                    </a:cubicBezTo>
                    <a:cubicBezTo>
                      <a:pt x="27833" y="182602"/>
                      <a:pt x="18682" y="203800"/>
                      <a:pt x="16934" y="211667"/>
                    </a:cubicBezTo>
                    <a:cubicBezTo>
                      <a:pt x="15099" y="219926"/>
                      <a:pt x="9218" y="259936"/>
                      <a:pt x="8467" y="266700"/>
                    </a:cubicBezTo>
                    <a:cubicBezTo>
                      <a:pt x="6746" y="282191"/>
                      <a:pt x="6055" y="297787"/>
                      <a:pt x="4234" y="313267"/>
                    </a:cubicBezTo>
                    <a:cubicBezTo>
                      <a:pt x="3231" y="321792"/>
                      <a:pt x="1411" y="330200"/>
                      <a:pt x="0" y="338667"/>
                    </a:cubicBezTo>
                    <a:cubicBezTo>
                      <a:pt x="1411" y="407811"/>
                      <a:pt x="-1174" y="477153"/>
                      <a:pt x="4234" y="546100"/>
                    </a:cubicBezTo>
                    <a:cubicBezTo>
                      <a:pt x="4632" y="551172"/>
                      <a:pt x="12517" y="552043"/>
                      <a:pt x="16934" y="554567"/>
                    </a:cubicBezTo>
                    <a:cubicBezTo>
                      <a:pt x="22413" y="557698"/>
                      <a:pt x="28388" y="559903"/>
                      <a:pt x="33867" y="563034"/>
                    </a:cubicBezTo>
                    <a:cubicBezTo>
                      <a:pt x="38284" y="565558"/>
                      <a:pt x="42016" y="569225"/>
                      <a:pt x="46567" y="571500"/>
                    </a:cubicBezTo>
                    <a:cubicBezTo>
                      <a:pt x="54503" y="575468"/>
                      <a:pt x="85795" y="586740"/>
                      <a:pt x="93134" y="588434"/>
                    </a:cubicBezTo>
                    <a:cubicBezTo>
                      <a:pt x="102856" y="590678"/>
                      <a:pt x="112889" y="591256"/>
                      <a:pt x="122767" y="592667"/>
                    </a:cubicBezTo>
                    <a:cubicBezTo>
                      <a:pt x="147307" y="600847"/>
                      <a:pt x="146243" y="596286"/>
                      <a:pt x="160867" y="613834"/>
                    </a:cubicBezTo>
                    <a:cubicBezTo>
                      <a:pt x="164124" y="617743"/>
                      <a:pt x="165736" y="622936"/>
                      <a:pt x="169334" y="626534"/>
                    </a:cubicBezTo>
                    <a:cubicBezTo>
                      <a:pt x="172932" y="630131"/>
                      <a:pt x="178125" y="631743"/>
                      <a:pt x="182034" y="635000"/>
                    </a:cubicBezTo>
                    <a:cubicBezTo>
                      <a:pt x="186633" y="638833"/>
                      <a:pt x="189945" y="644108"/>
                      <a:pt x="194734" y="647700"/>
                    </a:cubicBezTo>
                    <a:cubicBezTo>
                      <a:pt x="201316" y="652637"/>
                      <a:pt x="209532" y="655190"/>
                      <a:pt x="215900" y="660400"/>
                    </a:cubicBezTo>
                    <a:cubicBezTo>
                      <a:pt x="225167" y="667982"/>
                      <a:pt x="229489" y="683831"/>
                      <a:pt x="241300" y="685800"/>
                    </a:cubicBezTo>
                    <a:cubicBezTo>
                      <a:pt x="283461" y="692828"/>
                      <a:pt x="258146" y="689321"/>
                      <a:pt x="317500" y="694267"/>
                    </a:cubicBezTo>
                    <a:cubicBezTo>
                      <a:pt x="323145" y="695678"/>
                      <a:pt x="328840" y="696902"/>
                      <a:pt x="334434" y="698500"/>
                    </a:cubicBezTo>
                    <a:cubicBezTo>
                      <a:pt x="376957" y="710650"/>
                      <a:pt x="311118" y="693731"/>
                      <a:pt x="364067" y="706967"/>
                    </a:cubicBezTo>
                    <a:cubicBezTo>
                      <a:pt x="372534" y="721078"/>
                      <a:pt x="393458" y="733335"/>
                      <a:pt x="389467" y="749300"/>
                    </a:cubicBezTo>
                    <a:cubicBezTo>
                      <a:pt x="379952" y="787366"/>
                      <a:pt x="392876" y="742649"/>
                      <a:pt x="372534" y="787400"/>
                    </a:cubicBezTo>
                    <a:cubicBezTo>
                      <a:pt x="366806" y="800001"/>
                      <a:pt x="363246" y="816085"/>
                      <a:pt x="359834" y="829734"/>
                    </a:cubicBezTo>
                    <a:cubicBezTo>
                      <a:pt x="361245" y="881945"/>
                      <a:pt x="361583" y="934196"/>
                      <a:pt x="364067" y="986367"/>
                    </a:cubicBezTo>
                    <a:cubicBezTo>
                      <a:pt x="364409" y="993554"/>
                      <a:pt x="365378" y="1000959"/>
                      <a:pt x="368300" y="1007534"/>
                    </a:cubicBezTo>
                    <a:cubicBezTo>
                      <a:pt x="371165" y="1013981"/>
                      <a:pt x="377086" y="1018596"/>
                      <a:pt x="381000" y="1024467"/>
                    </a:cubicBezTo>
                    <a:cubicBezTo>
                      <a:pt x="385564" y="1031313"/>
                      <a:pt x="389339" y="1038656"/>
                      <a:pt x="393700" y="1045634"/>
                    </a:cubicBezTo>
                    <a:cubicBezTo>
                      <a:pt x="396397" y="1049949"/>
                      <a:pt x="399210" y="1054194"/>
                      <a:pt x="402167" y="1058334"/>
                    </a:cubicBezTo>
                    <a:cubicBezTo>
                      <a:pt x="410077" y="1069408"/>
                      <a:pt x="416990" y="1079313"/>
                      <a:pt x="427567" y="1087967"/>
                    </a:cubicBezTo>
                    <a:cubicBezTo>
                      <a:pt x="438488" y="1096903"/>
                      <a:pt x="461434" y="1113367"/>
                      <a:pt x="461434" y="1113367"/>
                    </a:cubicBezTo>
                    <a:cubicBezTo>
                      <a:pt x="464256" y="1117600"/>
                      <a:pt x="466071" y="1122717"/>
                      <a:pt x="469900" y="1126067"/>
                    </a:cubicBezTo>
                    <a:cubicBezTo>
                      <a:pt x="496293" y="1149161"/>
                      <a:pt x="486840" y="1138165"/>
                      <a:pt x="508000" y="1147234"/>
                    </a:cubicBezTo>
                    <a:cubicBezTo>
                      <a:pt x="513801" y="1149720"/>
                      <a:pt x="519167" y="1153137"/>
                      <a:pt x="524934" y="1155700"/>
                    </a:cubicBezTo>
                    <a:cubicBezTo>
                      <a:pt x="531878" y="1158786"/>
                      <a:pt x="539156" y="1161081"/>
                      <a:pt x="546100" y="1164167"/>
                    </a:cubicBezTo>
                    <a:cubicBezTo>
                      <a:pt x="551867" y="1166730"/>
                      <a:pt x="557233" y="1170148"/>
                      <a:pt x="563034" y="1172634"/>
                    </a:cubicBezTo>
                    <a:cubicBezTo>
                      <a:pt x="573184" y="1176984"/>
                      <a:pt x="581926" y="1178031"/>
                      <a:pt x="592667" y="1181100"/>
                    </a:cubicBezTo>
                    <a:cubicBezTo>
                      <a:pt x="596958" y="1182326"/>
                      <a:pt x="601134" y="1183923"/>
                      <a:pt x="605367" y="1185334"/>
                    </a:cubicBezTo>
                    <a:cubicBezTo>
                      <a:pt x="609600" y="1189567"/>
                      <a:pt x="613016" y="1194820"/>
                      <a:pt x="618067" y="1198034"/>
                    </a:cubicBezTo>
                    <a:cubicBezTo>
                      <a:pt x="628715" y="1204810"/>
                      <a:pt x="643009" y="1206042"/>
                      <a:pt x="651934" y="1214967"/>
                    </a:cubicBezTo>
                    <a:cubicBezTo>
                      <a:pt x="656167" y="1219200"/>
                      <a:pt x="659184" y="1225190"/>
                      <a:pt x="664634" y="1227667"/>
                    </a:cubicBezTo>
                    <a:cubicBezTo>
                      <a:pt x="675227" y="1232482"/>
                      <a:pt x="698500" y="1236134"/>
                      <a:pt x="698500" y="1236134"/>
                    </a:cubicBezTo>
                    <a:cubicBezTo>
                      <a:pt x="747889" y="1234723"/>
                      <a:pt x="797372" y="1235261"/>
                      <a:pt x="846667" y="1231900"/>
                    </a:cubicBezTo>
                    <a:cubicBezTo>
                      <a:pt x="847118" y="1231869"/>
                      <a:pt x="891523" y="1222253"/>
                      <a:pt x="901700" y="1219200"/>
                    </a:cubicBezTo>
                    <a:cubicBezTo>
                      <a:pt x="910248" y="1216636"/>
                      <a:pt x="927100" y="1210734"/>
                      <a:pt x="927100" y="1210734"/>
                    </a:cubicBezTo>
                    <a:cubicBezTo>
                      <a:pt x="936978" y="1198034"/>
                      <a:pt x="952832" y="1188243"/>
                      <a:pt x="956734" y="1172634"/>
                    </a:cubicBezTo>
                    <a:cubicBezTo>
                      <a:pt x="958145" y="1166989"/>
                      <a:pt x="958924" y="1161148"/>
                      <a:pt x="960967" y="1155700"/>
                    </a:cubicBezTo>
                    <a:cubicBezTo>
                      <a:pt x="965569" y="1143428"/>
                      <a:pt x="970884" y="1136592"/>
                      <a:pt x="977900" y="1126067"/>
                    </a:cubicBezTo>
                    <a:cubicBezTo>
                      <a:pt x="986703" y="1082058"/>
                      <a:pt x="975995" y="1125942"/>
                      <a:pt x="990600" y="1087967"/>
                    </a:cubicBezTo>
                    <a:cubicBezTo>
                      <a:pt x="1003079" y="1055521"/>
                      <a:pt x="1002016" y="1056286"/>
                      <a:pt x="1007534" y="1028700"/>
                    </a:cubicBezTo>
                    <a:cubicBezTo>
                      <a:pt x="1006123" y="969433"/>
                      <a:pt x="1008549" y="909951"/>
                      <a:pt x="1003300" y="850900"/>
                    </a:cubicBezTo>
                    <a:cubicBezTo>
                      <a:pt x="1002770" y="844937"/>
                      <a:pt x="993570" y="843398"/>
                      <a:pt x="990600" y="838200"/>
                    </a:cubicBezTo>
                    <a:cubicBezTo>
                      <a:pt x="987713" y="833149"/>
                      <a:pt x="988410" y="826715"/>
                      <a:pt x="986367" y="821267"/>
                    </a:cubicBezTo>
                    <a:cubicBezTo>
                      <a:pt x="966098" y="767217"/>
                      <a:pt x="989081" y="835840"/>
                      <a:pt x="969434" y="791634"/>
                    </a:cubicBezTo>
                    <a:cubicBezTo>
                      <a:pt x="958886" y="767901"/>
                      <a:pt x="966187" y="769958"/>
                      <a:pt x="952500" y="753534"/>
                    </a:cubicBezTo>
                    <a:cubicBezTo>
                      <a:pt x="948667" y="748935"/>
                      <a:pt x="945033" y="743742"/>
                      <a:pt x="939800" y="740834"/>
                    </a:cubicBezTo>
                    <a:cubicBezTo>
                      <a:pt x="931998" y="736500"/>
                      <a:pt x="914400" y="732367"/>
                      <a:pt x="914400" y="732367"/>
                    </a:cubicBezTo>
                    <a:cubicBezTo>
                      <a:pt x="917222" y="728134"/>
                      <a:pt x="918851" y="722791"/>
                      <a:pt x="922867" y="719667"/>
                    </a:cubicBezTo>
                    <a:cubicBezTo>
                      <a:pt x="931847" y="712682"/>
                      <a:pt x="941999" y="707110"/>
                      <a:pt x="952500" y="702734"/>
                    </a:cubicBezTo>
                    <a:cubicBezTo>
                      <a:pt x="959142" y="699966"/>
                      <a:pt x="966643" y="700061"/>
                      <a:pt x="973667" y="698500"/>
                    </a:cubicBezTo>
                    <a:cubicBezTo>
                      <a:pt x="979346" y="697238"/>
                      <a:pt x="984956" y="695678"/>
                      <a:pt x="990600" y="694267"/>
                    </a:cubicBezTo>
                    <a:cubicBezTo>
                      <a:pt x="1041147" y="660568"/>
                      <a:pt x="1006602" y="680054"/>
                      <a:pt x="1143000" y="690034"/>
                    </a:cubicBezTo>
                    <a:cubicBezTo>
                      <a:pt x="1154605" y="690883"/>
                      <a:pt x="1165489" y="696062"/>
                      <a:pt x="1176867" y="698500"/>
                    </a:cubicBezTo>
                    <a:cubicBezTo>
                      <a:pt x="1185260" y="700298"/>
                      <a:pt x="1193903" y="700804"/>
                      <a:pt x="1202267" y="702734"/>
                    </a:cubicBezTo>
                    <a:cubicBezTo>
                      <a:pt x="1212277" y="705044"/>
                      <a:pt x="1221767" y="709511"/>
                      <a:pt x="1231900" y="711200"/>
                    </a:cubicBezTo>
                    <a:cubicBezTo>
                      <a:pt x="1247274" y="713762"/>
                      <a:pt x="1262945" y="714023"/>
                      <a:pt x="1278467" y="715434"/>
                    </a:cubicBezTo>
                    <a:cubicBezTo>
                      <a:pt x="1284111" y="716845"/>
                      <a:pt x="1289720" y="718405"/>
                      <a:pt x="1295400" y="719667"/>
                    </a:cubicBezTo>
                    <a:cubicBezTo>
                      <a:pt x="1315060" y="724036"/>
                      <a:pt x="1315418" y="722968"/>
                      <a:pt x="1333500" y="728134"/>
                    </a:cubicBezTo>
                    <a:cubicBezTo>
                      <a:pt x="1337791" y="729360"/>
                      <a:pt x="1341967" y="730956"/>
                      <a:pt x="1346200" y="732367"/>
                    </a:cubicBezTo>
                    <a:cubicBezTo>
                      <a:pt x="1376512" y="752575"/>
                      <a:pt x="1353812" y="740834"/>
                      <a:pt x="1422400" y="740834"/>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sp>
            <p:nvSpPr>
              <p:cNvPr id="20" name="任意多边形: 形状 19">
                <a:extLst>
                  <a:ext uri="{FF2B5EF4-FFF2-40B4-BE49-F238E27FC236}">
                    <a16:creationId xmlns:a16="http://schemas.microsoft.com/office/drawing/2014/main" id="{C7AE3E21-F469-80EB-C126-575D45842BE6}"/>
                  </a:ext>
                </a:extLst>
              </p:cNvPr>
              <p:cNvSpPr/>
              <p:nvPr/>
            </p:nvSpPr>
            <p:spPr>
              <a:xfrm>
                <a:off x="4271305" y="3056136"/>
                <a:ext cx="423262" cy="354468"/>
              </a:xfrm>
              <a:custGeom>
                <a:avLst/>
                <a:gdLst>
                  <a:gd name="connsiteX0" fmla="*/ 77293 w 479460"/>
                  <a:gd name="connsiteY0" fmla="*/ 21167 h 440267"/>
                  <a:gd name="connsiteX1" fmla="*/ 166193 w 479460"/>
                  <a:gd name="connsiteY1" fmla="*/ 12700 h 440267"/>
                  <a:gd name="connsiteX2" fmla="*/ 204293 w 479460"/>
                  <a:gd name="connsiteY2" fmla="*/ 4234 h 440267"/>
                  <a:gd name="connsiteX3" fmla="*/ 335526 w 479460"/>
                  <a:gd name="connsiteY3" fmla="*/ 0 h 440267"/>
                  <a:gd name="connsiteX4" fmla="*/ 420193 w 479460"/>
                  <a:gd name="connsiteY4" fmla="*/ 25400 h 440267"/>
                  <a:gd name="connsiteX5" fmla="*/ 432893 w 479460"/>
                  <a:gd name="connsiteY5" fmla="*/ 38100 h 440267"/>
                  <a:gd name="connsiteX6" fmla="*/ 441360 w 479460"/>
                  <a:gd name="connsiteY6" fmla="*/ 67734 h 440267"/>
                  <a:gd name="connsiteX7" fmla="*/ 458293 w 479460"/>
                  <a:gd name="connsiteY7" fmla="*/ 110067 h 440267"/>
                  <a:gd name="connsiteX8" fmla="*/ 462526 w 479460"/>
                  <a:gd name="connsiteY8" fmla="*/ 131234 h 440267"/>
                  <a:gd name="connsiteX9" fmla="*/ 475226 w 479460"/>
                  <a:gd name="connsiteY9" fmla="*/ 203200 h 440267"/>
                  <a:gd name="connsiteX10" fmla="*/ 479460 w 479460"/>
                  <a:gd name="connsiteY10" fmla="*/ 220134 h 440267"/>
                  <a:gd name="connsiteX11" fmla="*/ 470993 w 479460"/>
                  <a:gd name="connsiteY11" fmla="*/ 292100 h 440267"/>
                  <a:gd name="connsiteX12" fmla="*/ 432893 w 479460"/>
                  <a:gd name="connsiteY12" fmla="*/ 351367 h 440267"/>
                  <a:gd name="connsiteX13" fmla="*/ 399026 w 479460"/>
                  <a:gd name="connsiteY13" fmla="*/ 389467 h 440267"/>
                  <a:gd name="connsiteX14" fmla="*/ 373626 w 479460"/>
                  <a:gd name="connsiteY14" fmla="*/ 406400 h 440267"/>
                  <a:gd name="connsiteX15" fmla="*/ 335526 w 479460"/>
                  <a:gd name="connsiteY15" fmla="*/ 423334 h 440267"/>
                  <a:gd name="connsiteX16" fmla="*/ 297426 w 479460"/>
                  <a:gd name="connsiteY16" fmla="*/ 431800 h 440267"/>
                  <a:gd name="connsiteX17" fmla="*/ 284726 w 479460"/>
                  <a:gd name="connsiteY17" fmla="*/ 436034 h 440267"/>
                  <a:gd name="connsiteX18" fmla="*/ 242393 w 479460"/>
                  <a:gd name="connsiteY18" fmla="*/ 440267 h 440267"/>
                  <a:gd name="connsiteX19" fmla="*/ 170426 w 479460"/>
                  <a:gd name="connsiteY19" fmla="*/ 431800 h 440267"/>
                  <a:gd name="connsiteX20" fmla="*/ 136560 w 479460"/>
                  <a:gd name="connsiteY20" fmla="*/ 410634 h 440267"/>
                  <a:gd name="connsiteX21" fmla="*/ 119626 w 479460"/>
                  <a:gd name="connsiteY21" fmla="*/ 402167 h 440267"/>
                  <a:gd name="connsiteX22" fmla="*/ 89993 w 479460"/>
                  <a:gd name="connsiteY22" fmla="*/ 381000 h 440267"/>
                  <a:gd name="connsiteX23" fmla="*/ 60360 w 479460"/>
                  <a:gd name="connsiteY23" fmla="*/ 351367 h 440267"/>
                  <a:gd name="connsiteX24" fmla="*/ 47660 w 479460"/>
                  <a:gd name="connsiteY24" fmla="*/ 325967 h 440267"/>
                  <a:gd name="connsiteX25" fmla="*/ 39193 w 479460"/>
                  <a:gd name="connsiteY25" fmla="*/ 300567 h 440267"/>
                  <a:gd name="connsiteX26" fmla="*/ 30726 w 479460"/>
                  <a:gd name="connsiteY26" fmla="*/ 279400 h 440267"/>
                  <a:gd name="connsiteX27" fmla="*/ 26493 w 479460"/>
                  <a:gd name="connsiteY27" fmla="*/ 254000 h 440267"/>
                  <a:gd name="connsiteX28" fmla="*/ 18026 w 479460"/>
                  <a:gd name="connsiteY28" fmla="*/ 241300 h 440267"/>
                  <a:gd name="connsiteX29" fmla="*/ 9560 w 479460"/>
                  <a:gd name="connsiteY29" fmla="*/ 224367 h 440267"/>
                  <a:gd name="connsiteX30" fmla="*/ 5326 w 479460"/>
                  <a:gd name="connsiteY30" fmla="*/ 190500 h 440267"/>
                  <a:gd name="connsiteX31" fmla="*/ 5326 w 479460"/>
                  <a:gd name="connsiteY31" fmla="*/ 97367 h 440267"/>
                  <a:gd name="connsiteX32" fmla="*/ 13793 w 479460"/>
                  <a:gd name="connsiteY32" fmla="*/ 80434 h 440267"/>
                  <a:gd name="connsiteX33" fmla="*/ 26493 w 479460"/>
                  <a:gd name="connsiteY33" fmla="*/ 67734 h 44026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Lst>
                <a:rect l="l" t="t" r="r" b="b"/>
                <a:pathLst>
                  <a:path w="479460" h="440267">
                    <a:moveTo>
                      <a:pt x="77293" y="21167"/>
                    </a:moveTo>
                    <a:cubicBezTo>
                      <a:pt x="98026" y="19572"/>
                      <a:pt x="142294" y="17045"/>
                      <a:pt x="166193" y="12700"/>
                    </a:cubicBezTo>
                    <a:cubicBezTo>
                      <a:pt x="198094" y="6900"/>
                      <a:pt x="153220" y="6995"/>
                      <a:pt x="204293" y="4234"/>
                    </a:cubicBezTo>
                    <a:cubicBezTo>
                      <a:pt x="247996" y="1872"/>
                      <a:pt x="291782" y="1411"/>
                      <a:pt x="335526" y="0"/>
                    </a:cubicBezTo>
                    <a:cubicBezTo>
                      <a:pt x="391802" y="10552"/>
                      <a:pt x="390532" y="-24"/>
                      <a:pt x="420193" y="25400"/>
                    </a:cubicBezTo>
                    <a:cubicBezTo>
                      <a:pt x="424739" y="29296"/>
                      <a:pt x="428660" y="33867"/>
                      <a:pt x="432893" y="38100"/>
                    </a:cubicBezTo>
                    <a:cubicBezTo>
                      <a:pt x="435715" y="47978"/>
                      <a:pt x="437849" y="58079"/>
                      <a:pt x="441360" y="67734"/>
                    </a:cubicBezTo>
                    <a:cubicBezTo>
                      <a:pt x="451392" y="95322"/>
                      <a:pt x="451260" y="74901"/>
                      <a:pt x="458293" y="110067"/>
                    </a:cubicBezTo>
                    <a:cubicBezTo>
                      <a:pt x="459704" y="117123"/>
                      <a:pt x="461276" y="124148"/>
                      <a:pt x="462526" y="131234"/>
                    </a:cubicBezTo>
                    <a:cubicBezTo>
                      <a:pt x="467154" y="157462"/>
                      <a:pt x="469731" y="178474"/>
                      <a:pt x="475226" y="203200"/>
                    </a:cubicBezTo>
                    <a:cubicBezTo>
                      <a:pt x="476488" y="208880"/>
                      <a:pt x="478049" y="214489"/>
                      <a:pt x="479460" y="220134"/>
                    </a:cubicBezTo>
                    <a:cubicBezTo>
                      <a:pt x="479191" y="223358"/>
                      <a:pt x="476626" y="277453"/>
                      <a:pt x="470993" y="292100"/>
                    </a:cubicBezTo>
                    <a:cubicBezTo>
                      <a:pt x="457607" y="326905"/>
                      <a:pt x="454739" y="324060"/>
                      <a:pt x="432893" y="351367"/>
                    </a:cubicBezTo>
                    <a:cubicBezTo>
                      <a:pt x="418387" y="369499"/>
                      <a:pt x="419268" y="372905"/>
                      <a:pt x="399026" y="389467"/>
                    </a:cubicBezTo>
                    <a:cubicBezTo>
                      <a:pt x="391150" y="395911"/>
                      <a:pt x="382727" y="401849"/>
                      <a:pt x="373626" y="406400"/>
                    </a:cubicBezTo>
                    <a:cubicBezTo>
                      <a:pt x="354464" y="415981"/>
                      <a:pt x="352384" y="418517"/>
                      <a:pt x="335526" y="423334"/>
                    </a:cubicBezTo>
                    <a:cubicBezTo>
                      <a:pt x="305111" y="432024"/>
                      <a:pt x="332338" y="423072"/>
                      <a:pt x="297426" y="431800"/>
                    </a:cubicBezTo>
                    <a:cubicBezTo>
                      <a:pt x="293097" y="432882"/>
                      <a:pt x="289137" y="435355"/>
                      <a:pt x="284726" y="436034"/>
                    </a:cubicBezTo>
                    <a:cubicBezTo>
                      <a:pt x="270710" y="438190"/>
                      <a:pt x="256504" y="438856"/>
                      <a:pt x="242393" y="440267"/>
                    </a:cubicBezTo>
                    <a:cubicBezTo>
                      <a:pt x="218404" y="437445"/>
                      <a:pt x="194154" y="436320"/>
                      <a:pt x="170426" y="431800"/>
                    </a:cubicBezTo>
                    <a:cubicBezTo>
                      <a:pt x="158082" y="429449"/>
                      <a:pt x="146355" y="416756"/>
                      <a:pt x="136560" y="410634"/>
                    </a:cubicBezTo>
                    <a:cubicBezTo>
                      <a:pt x="131208" y="407289"/>
                      <a:pt x="125105" y="405298"/>
                      <a:pt x="119626" y="402167"/>
                    </a:cubicBezTo>
                    <a:cubicBezTo>
                      <a:pt x="113430" y="398626"/>
                      <a:pt x="93836" y="384494"/>
                      <a:pt x="89993" y="381000"/>
                    </a:cubicBezTo>
                    <a:cubicBezTo>
                      <a:pt x="79657" y="371603"/>
                      <a:pt x="60360" y="351367"/>
                      <a:pt x="60360" y="351367"/>
                    </a:cubicBezTo>
                    <a:cubicBezTo>
                      <a:pt x="44915" y="305039"/>
                      <a:pt x="69549" y="375218"/>
                      <a:pt x="47660" y="325967"/>
                    </a:cubicBezTo>
                    <a:cubicBezTo>
                      <a:pt x="44035" y="317811"/>
                      <a:pt x="42243" y="308954"/>
                      <a:pt x="39193" y="300567"/>
                    </a:cubicBezTo>
                    <a:cubicBezTo>
                      <a:pt x="36596" y="293425"/>
                      <a:pt x="33548" y="286456"/>
                      <a:pt x="30726" y="279400"/>
                    </a:cubicBezTo>
                    <a:cubicBezTo>
                      <a:pt x="29315" y="270933"/>
                      <a:pt x="29207" y="262143"/>
                      <a:pt x="26493" y="254000"/>
                    </a:cubicBezTo>
                    <a:cubicBezTo>
                      <a:pt x="24884" y="249173"/>
                      <a:pt x="20550" y="245718"/>
                      <a:pt x="18026" y="241300"/>
                    </a:cubicBezTo>
                    <a:cubicBezTo>
                      <a:pt x="14895" y="235821"/>
                      <a:pt x="12382" y="230011"/>
                      <a:pt x="9560" y="224367"/>
                    </a:cubicBezTo>
                    <a:cubicBezTo>
                      <a:pt x="8149" y="213078"/>
                      <a:pt x="6830" y="201777"/>
                      <a:pt x="5326" y="190500"/>
                    </a:cubicBezTo>
                    <a:cubicBezTo>
                      <a:pt x="-203" y="149037"/>
                      <a:pt x="-3194" y="151326"/>
                      <a:pt x="5326" y="97367"/>
                    </a:cubicBezTo>
                    <a:cubicBezTo>
                      <a:pt x="6310" y="91134"/>
                      <a:pt x="10125" y="85569"/>
                      <a:pt x="13793" y="80434"/>
                    </a:cubicBezTo>
                    <a:cubicBezTo>
                      <a:pt x="17273" y="75562"/>
                      <a:pt x="22260" y="71967"/>
                      <a:pt x="26493" y="67734"/>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sp>
            <p:nvSpPr>
              <p:cNvPr id="21" name="任意多边形: 形状 20">
                <a:extLst>
                  <a:ext uri="{FF2B5EF4-FFF2-40B4-BE49-F238E27FC236}">
                    <a16:creationId xmlns:a16="http://schemas.microsoft.com/office/drawing/2014/main" id="{60D4C703-6475-D684-C322-9B15D69D45D8}"/>
                  </a:ext>
                </a:extLst>
              </p:cNvPr>
              <p:cNvSpPr/>
              <p:nvPr/>
            </p:nvSpPr>
            <p:spPr>
              <a:xfrm>
                <a:off x="3805661" y="3089307"/>
                <a:ext cx="362711" cy="304999"/>
              </a:xfrm>
              <a:custGeom>
                <a:avLst/>
                <a:gdLst>
                  <a:gd name="connsiteX0" fmla="*/ 745067 w 745067"/>
                  <a:gd name="connsiteY0" fmla="*/ 241300 h 402167"/>
                  <a:gd name="connsiteX1" fmla="*/ 732367 w 745067"/>
                  <a:gd name="connsiteY1" fmla="*/ 186267 h 402167"/>
                  <a:gd name="connsiteX2" fmla="*/ 715433 w 745067"/>
                  <a:gd name="connsiteY2" fmla="*/ 173567 h 402167"/>
                  <a:gd name="connsiteX3" fmla="*/ 706967 w 745067"/>
                  <a:gd name="connsiteY3" fmla="*/ 160867 h 402167"/>
                  <a:gd name="connsiteX4" fmla="*/ 681567 w 745067"/>
                  <a:gd name="connsiteY4" fmla="*/ 127000 h 402167"/>
                  <a:gd name="connsiteX5" fmla="*/ 635000 w 745067"/>
                  <a:gd name="connsiteY5" fmla="*/ 114300 h 402167"/>
                  <a:gd name="connsiteX6" fmla="*/ 622300 w 745067"/>
                  <a:gd name="connsiteY6" fmla="*/ 110067 h 402167"/>
                  <a:gd name="connsiteX7" fmla="*/ 571500 w 745067"/>
                  <a:gd name="connsiteY7" fmla="*/ 105833 h 402167"/>
                  <a:gd name="connsiteX8" fmla="*/ 537633 w 745067"/>
                  <a:gd name="connsiteY8" fmla="*/ 93133 h 402167"/>
                  <a:gd name="connsiteX9" fmla="*/ 503767 w 745067"/>
                  <a:gd name="connsiteY9" fmla="*/ 71967 h 402167"/>
                  <a:gd name="connsiteX10" fmla="*/ 491067 w 745067"/>
                  <a:gd name="connsiteY10" fmla="*/ 63500 h 402167"/>
                  <a:gd name="connsiteX11" fmla="*/ 469900 w 745067"/>
                  <a:gd name="connsiteY11" fmla="*/ 55033 h 402167"/>
                  <a:gd name="connsiteX12" fmla="*/ 452967 w 745067"/>
                  <a:gd name="connsiteY12" fmla="*/ 46567 h 402167"/>
                  <a:gd name="connsiteX13" fmla="*/ 436033 w 745067"/>
                  <a:gd name="connsiteY13" fmla="*/ 42333 h 402167"/>
                  <a:gd name="connsiteX14" fmla="*/ 423333 w 745067"/>
                  <a:gd name="connsiteY14" fmla="*/ 38100 h 402167"/>
                  <a:gd name="connsiteX15" fmla="*/ 385233 w 745067"/>
                  <a:gd name="connsiteY15" fmla="*/ 29633 h 402167"/>
                  <a:gd name="connsiteX16" fmla="*/ 347133 w 745067"/>
                  <a:gd name="connsiteY16" fmla="*/ 21167 h 402167"/>
                  <a:gd name="connsiteX17" fmla="*/ 330200 w 745067"/>
                  <a:gd name="connsiteY17" fmla="*/ 12700 h 402167"/>
                  <a:gd name="connsiteX18" fmla="*/ 300567 w 745067"/>
                  <a:gd name="connsiteY18" fmla="*/ 4233 h 402167"/>
                  <a:gd name="connsiteX19" fmla="*/ 287867 w 745067"/>
                  <a:gd name="connsiteY19" fmla="*/ 0 h 402167"/>
                  <a:gd name="connsiteX20" fmla="*/ 84667 w 745067"/>
                  <a:gd name="connsiteY20" fmla="*/ 4233 h 402167"/>
                  <a:gd name="connsiteX21" fmla="*/ 67733 w 745067"/>
                  <a:gd name="connsiteY21" fmla="*/ 12700 h 402167"/>
                  <a:gd name="connsiteX22" fmla="*/ 38100 w 745067"/>
                  <a:gd name="connsiteY22" fmla="*/ 21167 h 402167"/>
                  <a:gd name="connsiteX23" fmla="*/ 0 w 745067"/>
                  <a:gd name="connsiteY23" fmla="*/ 63500 h 402167"/>
                  <a:gd name="connsiteX24" fmla="*/ 4233 w 745067"/>
                  <a:gd name="connsiteY24" fmla="*/ 139700 h 402167"/>
                  <a:gd name="connsiteX25" fmla="*/ 25400 w 745067"/>
                  <a:gd name="connsiteY25" fmla="*/ 173567 h 402167"/>
                  <a:gd name="connsiteX26" fmla="*/ 29633 w 745067"/>
                  <a:gd name="connsiteY26" fmla="*/ 186267 h 402167"/>
                  <a:gd name="connsiteX27" fmla="*/ 42333 w 745067"/>
                  <a:gd name="connsiteY27" fmla="*/ 194733 h 402167"/>
                  <a:gd name="connsiteX28" fmla="*/ 67733 w 745067"/>
                  <a:gd name="connsiteY28" fmla="*/ 215900 h 402167"/>
                  <a:gd name="connsiteX29" fmla="*/ 84667 w 745067"/>
                  <a:gd name="connsiteY29" fmla="*/ 224367 h 402167"/>
                  <a:gd name="connsiteX30" fmla="*/ 114300 w 745067"/>
                  <a:gd name="connsiteY30" fmla="*/ 254000 h 402167"/>
                  <a:gd name="connsiteX31" fmla="*/ 139700 w 745067"/>
                  <a:gd name="connsiteY31" fmla="*/ 287867 h 402167"/>
                  <a:gd name="connsiteX32" fmla="*/ 143933 w 745067"/>
                  <a:gd name="connsiteY32" fmla="*/ 300567 h 402167"/>
                  <a:gd name="connsiteX33" fmla="*/ 165100 w 745067"/>
                  <a:gd name="connsiteY33" fmla="*/ 325967 h 402167"/>
                  <a:gd name="connsiteX34" fmla="*/ 186267 w 745067"/>
                  <a:gd name="connsiteY34" fmla="*/ 351367 h 402167"/>
                  <a:gd name="connsiteX35" fmla="*/ 211667 w 745067"/>
                  <a:gd name="connsiteY35" fmla="*/ 359833 h 402167"/>
                  <a:gd name="connsiteX36" fmla="*/ 237067 w 745067"/>
                  <a:gd name="connsiteY36" fmla="*/ 372533 h 402167"/>
                  <a:gd name="connsiteX37" fmla="*/ 254000 w 745067"/>
                  <a:gd name="connsiteY37" fmla="*/ 376767 h 402167"/>
                  <a:gd name="connsiteX38" fmla="*/ 296333 w 745067"/>
                  <a:gd name="connsiteY38" fmla="*/ 385233 h 402167"/>
                  <a:gd name="connsiteX39" fmla="*/ 313267 w 745067"/>
                  <a:gd name="connsiteY39" fmla="*/ 389467 h 402167"/>
                  <a:gd name="connsiteX40" fmla="*/ 359833 w 745067"/>
                  <a:gd name="connsiteY40" fmla="*/ 397933 h 402167"/>
                  <a:gd name="connsiteX41" fmla="*/ 368300 w 745067"/>
                  <a:gd name="connsiteY41" fmla="*/ 402167 h 40216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Lst>
                <a:rect l="l" t="t" r="r" b="b"/>
                <a:pathLst>
                  <a:path w="745067" h="402167">
                    <a:moveTo>
                      <a:pt x="745067" y="241300"/>
                    </a:moveTo>
                    <a:cubicBezTo>
                      <a:pt x="742972" y="228729"/>
                      <a:pt x="738610" y="196672"/>
                      <a:pt x="732367" y="186267"/>
                    </a:cubicBezTo>
                    <a:cubicBezTo>
                      <a:pt x="728737" y="180217"/>
                      <a:pt x="721078" y="177800"/>
                      <a:pt x="715433" y="173567"/>
                    </a:cubicBezTo>
                    <a:cubicBezTo>
                      <a:pt x="712611" y="169334"/>
                      <a:pt x="709491" y="165284"/>
                      <a:pt x="706967" y="160867"/>
                    </a:cubicBezTo>
                    <a:cubicBezTo>
                      <a:pt x="697358" y="144050"/>
                      <a:pt x="699892" y="139217"/>
                      <a:pt x="681567" y="127000"/>
                    </a:cubicBezTo>
                    <a:cubicBezTo>
                      <a:pt x="666271" y="116803"/>
                      <a:pt x="652263" y="118136"/>
                      <a:pt x="635000" y="114300"/>
                    </a:cubicBezTo>
                    <a:cubicBezTo>
                      <a:pt x="630644" y="113332"/>
                      <a:pt x="626723" y="110657"/>
                      <a:pt x="622300" y="110067"/>
                    </a:cubicBezTo>
                    <a:cubicBezTo>
                      <a:pt x="605457" y="107821"/>
                      <a:pt x="588433" y="107244"/>
                      <a:pt x="571500" y="105833"/>
                    </a:cubicBezTo>
                    <a:cubicBezTo>
                      <a:pt x="553546" y="101345"/>
                      <a:pt x="554237" y="102819"/>
                      <a:pt x="537633" y="93133"/>
                    </a:cubicBezTo>
                    <a:cubicBezTo>
                      <a:pt x="526134" y="86425"/>
                      <a:pt x="514843" y="79351"/>
                      <a:pt x="503767" y="71967"/>
                    </a:cubicBezTo>
                    <a:cubicBezTo>
                      <a:pt x="499534" y="69145"/>
                      <a:pt x="495618" y="65775"/>
                      <a:pt x="491067" y="63500"/>
                    </a:cubicBezTo>
                    <a:cubicBezTo>
                      <a:pt x="484270" y="60101"/>
                      <a:pt x="476844" y="58119"/>
                      <a:pt x="469900" y="55033"/>
                    </a:cubicBezTo>
                    <a:cubicBezTo>
                      <a:pt x="464133" y="52470"/>
                      <a:pt x="458876" y="48783"/>
                      <a:pt x="452967" y="46567"/>
                    </a:cubicBezTo>
                    <a:cubicBezTo>
                      <a:pt x="447519" y="44524"/>
                      <a:pt x="441628" y="43931"/>
                      <a:pt x="436033" y="42333"/>
                    </a:cubicBezTo>
                    <a:cubicBezTo>
                      <a:pt x="431742" y="41107"/>
                      <a:pt x="427624" y="39326"/>
                      <a:pt x="423333" y="38100"/>
                    </a:cubicBezTo>
                    <a:cubicBezTo>
                      <a:pt x="405274" y="32941"/>
                      <a:pt x="404865" y="33996"/>
                      <a:pt x="385233" y="29633"/>
                    </a:cubicBezTo>
                    <a:cubicBezTo>
                      <a:pt x="331490" y="17690"/>
                      <a:pt x="410896" y="33918"/>
                      <a:pt x="347133" y="21167"/>
                    </a:cubicBezTo>
                    <a:cubicBezTo>
                      <a:pt x="341489" y="18345"/>
                      <a:pt x="336000" y="15186"/>
                      <a:pt x="330200" y="12700"/>
                    </a:cubicBezTo>
                    <a:cubicBezTo>
                      <a:pt x="320058" y="8353"/>
                      <a:pt x="311297" y="7299"/>
                      <a:pt x="300567" y="4233"/>
                    </a:cubicBezTo>
                    <a:cubicBezTo>
                      <a:pt x="296276" y="3007"/>
                      <a:pt x="292100" y="1411"/>
                      <a:pt x="287867" y="0"/>
                    </a:cubicBezTo>
                    <a:cubicBezTo>
                      <a:pt x="220134" y="1411"/>
                      <a:pt x="152303" y="331"/>
                      <a:pt x="84667" y="4233"/>
                    </a:cubicBezTo>
                    <a:cubicBezTo>
                      <a:pt x="78367" y="4596"/>
                      <a:pt x="73534" y="10214"/>
                      <a:pt x="67733" y="12700"/>
                    </a:cubicBezTo>
                    <a:cubicBezTo>
                      <a:pt x="59235" y="16342"/>
                      <a:pt x="46686" y="19020"/>
                      <a:pt x="38100" y="21167"/>
                    </a:cubicBezTo>
                    <a:cubicBezTo>
                      <a:pt x="7711" y="51556"/>
                      <a:pt x="19884" y="36988"/>
                      <a:pt x="0" y="63500"/>
                    </a:cubicBezTo>
                    <a:cubicBezTo>
                      <a:pt x="1411" y="88900"/>
                      <a:pt x="-126" y="114637"/>
                      <a:pt x="4233" y="139700"/>
                    </a:cubicBezTo>
                    <a:cubicBezTo>
                      <a:pt x="4834" y="143156"/>
                      <a:pt x="21469" y="167670"/>
                      <a:pt x="25400" y="173567"/>
                    </a:cubicBezTo>
                    <a:cubicBezTo>
                      <a:pt x="26811" y="177800"/>
                      <a:pt x="26845" y="182783"/>
                      <a:pt x="29633" y="186267"/>
                    </a:cubicBezTo>
                    <a:cubicBezTo>
                      <a:pt x="32811" y="190240"/>
                      <a:pt x="38317" y="191609"/>
                      <a:pt x="42333" y="194733"/>
                    </a:cubicBezTo>
                    <a:cubicBezTo>
                      <a:pt x="51033" y="201499"/>
                      <a:pt x="58704" y="209580"/>
                      <a:pt x="67733" y="215900"/>
                    </a:cubicBezTo>
                    <a:cubicBezTo>
                      <a:pt x="72903" y="219519"/>
                      <a:pt x="79783" y="220371"/>
                      <a:pt x="84667" y="224367"/>
                    </a:cubicBezTo>
                    <a:cubicBezTo>
                      <a:pt x="95479" y="233213"/>
                      <a:pt x="107113" y="242022"/>
                      <a:pt x="114300" y="254000"/>
                    </a:cubicBezTo>
                    <a:cubicBezTo>
                      <a:pt x="130080" y="280301"/>
                      <a:pt x="121182" y="269349"/>
                      <a:pt x="139700" y="287867"/>
                    </a:cubicBezTo>
                    <a:cubicBezTo>
                      <a:pt x="141111" y="292100"/>
                      <a:pt x="141937" y="296576"/>
                      <a:pt x="143933" y="300567"/>
                    </a:cubicBezTo>
                    <a:cubicBezTo>
                      <a:pt x="150963" y="314626"/>
                      <a:pt x="154401" y="313931"/>
                      <a:pt x="165100" y="325967"/>
                    </a:cubicBezTo>
                    <a:cubicBezTo>
                      <a:pt x="172422" y="334204"/>
                      <a:pt x="177354" y="344885"/>
                      <a:pt x="186267" y="351367"/>
                    </a:cubicBezTo>
                    <a:cubicBezTo>
                      <a:pt x="193485" y="356616"/>
                      <a:pt x="203685" y="355842"/>
                      <a:pt x="211667" y="359833"/>
                    </a:cubicBezTo>
                    <a:cubicBezTo>
                      <a:pt x="220134" y="364066"/>
                      <a:pt x="228278" y="369017"/>
                      <a:pt x="237067" y="372533"/>
                    </a:cubicBezTo>
                    <a:cubicBezTo>
                      <a:pt x="242469" y="374694"/>
                      <a:pt x="248311" y="375548"/>
                      <a:pt x="254000" y="376767"/>
                    </a:cubicBezTo>
                    <a:cubicBezTo>
                      <a:pt x="268071" y="379782"/>
                      <a:pt x="282372" y="381742"/>
                      <a:pt x="296333" y="385233"/>
                    </a:cubicBezTo>
                    <a:cubicBezTo>
                      <a:pt x="301978" y="386644"/>
                      <a:pt x="307542" y="388426"/>
                      <a:pt x="313267" y="389467"/>
                    </a:cubicBezTo>
                    <a:cubicBezTo>
                      <a:pt x="332654" y="392992"/>
                      <a:pt x="342553" y="392173"/>
                      <a:pt x="359833" y="397933"/>
                    </a:cubicBezTo>
                    <a:cubicBezTo>
                      <a:pt x="362827" y="398931"/>
                      <a:pt x="365478" y="400756"/>
                      <a:pt x="368300" y="402167"/>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cxnSp>
            <p:nvCxnSpPr>
              <p:cNvPr id="22" name="直接箭头连接符 21">
                <a:extLst>
                  <a:ext uri="{FF2B5EF4-FFF2-40B4-BE49-F238E27FC236}">
                    <a16:creationId xmlns:a16="http://schemas.microsoft.com/office/drawing/2014/main" id="{DE1E047A-8E99-1816-8F9A-AD8B7B13355B}"/>
                  </a:ext>
                </a:extLst>
              </p:cNvPr>
              <p:cNvCxnSpPr>
                <a:cxnSpLocks/>
              </p:cNvCxnSpPr>
              <p:nvPr/>
            </p:nvCxnSpPr>
            <p:spPr>
              <a:xfrm flipH="1">
                <a:off x="4382894" y="3726866"/>
                <a:ext cx="110692" cy="86221"/>
              </a:xfrm>
              <a:prstGeom prst="straightConnector1">
                <a:avLst/>
              </a:prstGeom>
              <a:ln w="19050">
                <a:solidFill>
                  <a:srgbClr val="FFFF00"/>
                </a:solidFill>
                <a:tailEnd type="triangle"/>
              </a:ln>
            </p:spPr>
            <p:style>
              <a:lnRef idx="1">
                <a:schemeClr val="accent2"/>
              </a:lnRef>
              <a:fillRef idx="0">
                <a:schemeClr val="accent2"/>
              </a:fillRef>
              <a:effectRef idx="0">
                <a:schemeClr val="accent2"/>
              </a:effectRef>
              <a:fontRef idx="minor">
                <a:schemeClr val="tx1"/>
              </a:fontRef>
            </p:style>
          </p:cxnSp>
          <p:cxnSp>
            <p:nvCxnSpPr>
              <p:cNvPr id="23" name="直接箭头连接符 22">
                <a:extLst>
                  <a:ext uri="{FF2B5EF4-FFF2-40B4-BE49-F238E27FC236}">
                    <a16:creationId xmlns:a16="http://schemas.microsoft.com/office/drawing/2014/main" id="{02FE4A7B-96DA-0734-9EC7-0FE377E94B68}"/>
                  </a:ext>
                </a:extLst>
              </p:cNvPr>
              <p:cNvCxnSpPr>
                <a:cxnSpLocks/>
              </p:cNvCxnSpPr>
              <p:nvPr/>
            </p:nvCxnSpPr>
            <p:spPr>
              <a:xfrm flipH="1">
                <a:off x="4127524" y="3354322"/>
                <a:ext cx="110692" cy="86221"/>
              </a:xfrm>
              <a:prstGeom prst="straightConnector1">
                <a:avLst/>
              </a:prstGeom>
              <a:ln w="19050">
                <a:solidFill>
                  <a:srgbClr val="FFFF00"/>
                </a:solidFill>
                <a:tailEnd type="triangle"/>
              </a:ln>
            </p:spPr>
            <p:style>
              <a:lnRef idx="1">
                <a:schemeClr val="accent2"/>
              </a:lnRef>
              <a:fillRef idx="0">
                <a:schemeClr val="accent2"/>
              </a:fillRef>
              <a:effectRef idx="0">
                <a:schemeClr val="accent2"/>
              </a:effectRef>
              <a:fontRef idx="minor">
                <a:schemeClr val="tx1"/>
              </a:fontRef>
            </p:style>
          </p:cxnSp>
        </p:grpSp>
        <p:grpSp>
          <p:nvGrpSpPr>
            <p:cNvPr id="9" name="组合 8">
              <a:extLst>
                <a:ext uri="{FF2B5EF4-FFF2-40B4-BE49-F238E27FC236}">
                  <a16:creationId xmlns:a16="http://schemas.microsoft.com/office/drawing/2014/main" id="{26941E0E-E8AA-B4ED-5A2D-7B33F025F83D}"/>
                </a:ext>
              </a:extLst>
            </p:cNvPr>
            <p:cNvGrpSpPr/>
            <p:nvPr/>
          </p:nvGrpSpPr>
          <p:grpSpPr>
            <a:xfrm>
              <a:off x="1454047" y="892755"/>
              <a:ext cx="2564020" cy="1428485"/>
              <a:chOff x="1679597" y="2943856"/>
              <a:chExt cx="2144376" cy="1296570"/>
            </a:xfrm>
          </p:grpSpPr>
          <p:pic>
            <p:nvPicPr>
              <p:cNvPr id="14" name="内容占位符 5">
                <a:extLst>
                  <a:ext uri="{FF2B5EF4-FFF2-40B4-BE49-F238E27FC236}">
                    <a16:creationId xmlns:a16="http://schemas.microsoft.com/office/drawing/2014/main" id="{548910FC-C16A-680B-5EAE-E45D47BFED7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79597" y="2943856"/>
                <a:ext cx="1730423" cy="1296570"/>
              </a:xfrm>
              <a:prstGeom prst="rect">
                <a:avLst/>
              </a:prstGeom>
            </p:spPr>
          </p:pic>
          <p:sp>
            <p:nvSpPr>
              <p:cNvPr id="15" name="任意多边形: 形状 14">
                <a:extLst>
                  <a:ext uri="{FF2B5EF4-FFF2-40B4-BE49-F238E27FC236}">
                    <a16:creationId xmlns:a16="http://schemas.microsoft.com/office/drawing/2014/main" id="{BB70BD5B-B548-032E-4538-1736CE1EA444}"/>
                  </a:ext>
                </a:extLst>
              </p:cNvPr>
              <p:cNvSpPr/>
              <p:nvPr/>
            </p:nvSpPr>
            <p:spPr>
              <a:xfrm>
                <a:off x="3599422" y="3298985"/>
                <a:ext cx="224551" cy="345332"/>
              </a:xfrm>
              <a:custGeom>
                <a:avLst/>
                <a:gdLst>
                  <a:gd name="connsiteX0" fmla="*/ 296333 w 389466"/>
                  <a:gd name="connsiteY0" fmla="*/ 0 h 436472"/>
                  <a:gd name="connsiteX1" fmla="*/ 203200 w 389466"/>
                  <a:gd name="connsiteY1" fmla="*/ 8467 h 436472"/>
                  <a:gd name="connsiteX2" fmla="*/ 152400 w 389466"/>
                  <a:gd name="connsiteY2" fmla="*/ 12700 h 436472"/>
                  <a:gd name="connsiteX3" fmla="*/ 93133 w 389466"/>
                  <a:gd name="connsiteY3" fmla="*/ 29634 h 436472"/>
                  <a:gd name="connsiteX4" fmla="*/ 76200 w 389466"/>
                  <a:gd name="connsiteY4" fmla="*/ 38100 h 436472"/>
                  <a:gd name="connsiteX5" fmla="*/ 55033 w 389466"/>
                  <a:gd name="connsiteY5" fmla="*/ 55034 h 436472"/>
                  <a:gd name="connsiteX6" fmla="*/ 42333 w 389466"/>
                  <a:gd name="connsiteY6" fmla="*/ 63500 h 436472"/>
                  <a:gd name="connsiteX7" fmla="*/ 33866 w 389466"/>
                  <a:gd name="connsiteY7" fmla="*/ 76200 h 436472"/>
                  <a:gd name="connsiteX8" fmla="*/ 12700 w 389466"/>
                  <a:gd name="connsiteY8" fmla="*/ 97367 h 436472"/>
                  <a:gd name="connsiteX9" fmla="*/ 8466 w 389466"/>
                  <a:gd name="connsiteY9" fmla="*/ 110067 h 436472"/>
                  <a:gd name="connsiteX10" fmla="*/ 0 w 389466"/>
                  <a:gd name="connsiteY10" fmla="*/ 131234 h 436472"/>
                  <a:gd name="connsiteX11" fmla="*/ 8466 w 389466"/>
                  <a:gd name="connsiteY11" fmla="*/ 160867 h 436472"/>
                  <a:gd name="connsiteX12" fmla="*/ 46566 w 389466"/>
                  <a:gd name="connsiteY12" fmla="*/ 207434 h 436472"/>
                  <a:gd name="connsiteX13" fmla="*/ 55033 w 389466"/>
                  <a:gd name="connsiteY13" fmla="*/ 220134 h 436472"/>
                  <a:gd name="connsiteX14" fmla="*/ 71966 w 389466"/>
                  <a:gd name="connsiteY14" fmla="*/ 224367 h 436472"/>
                  <a:gd name="connsiteX15" fmla="*/ 84666 w 389466"/>
                  <a:gd name="connsiteY15" fmla="*/ 237067 h 436472"/>
                  <a:gd name="connsiteX16" fmla="*/ 93133 w 389466"/>
                  <a:gd name="connsiteY16" fmla="*/ 254000 h 436472"/>
                  <a:gd name="connsiteX17" fmla="*/ 101600 w 389466"/>
                  <a:gd name="connsiteY17" fmla="*/ 266700 h 436472"/>
                  <a:gd name="connsiteX18" fmla="*/ 110066 w 389466"/>
                  <a:gd name="connsiteY18" fmla="*/ 292100 h 436472"/>
                  <a:gd name="connsiteX19" fmla="*/ 122766 w 389466"/>
                  <a:gd name="connsiteY19" fmla="*/ 325967 h 436472"/>
                  <a:gd name="connsiteX20" fmla="*/ 160866 w 389466"/>
                  <a:gd name="connsiteY20" fmla="*/ 355600 h 436472"/>
                  <a:gd name="connsiteX21" fmla="*/ 194733 w 389466"/>
                  <a:gd name="connsiteY21" fmla="*/ 381000 h 436472"/>
                  <a:gd name="connsiteX22" fmla="*/ 228600 w 389466"/>
                  <a:gd name="connsiteY22" fmla="*/ 397934 h 436472"/>
                  <a:gd name="connsiteX23" fmla="*/ 241300 w 389466"/>
                  <a:gd name="connsiteY23" fmla="*/ 402167 h 436472"/>
                  <a:gd name="connsiteX24" fmla="*/ 262466 w 389466"/>
                  <a:gd name="connsiteY24" fmla="*/ 414867 h 436472"/>
                  <a:gd name="connsiteX25" fmla="*/ 279400 w 389466"/>
                  <a:gd name="connsiteY25" fmla="*/ 427567 h 436472"/>
                  <a:gd name="connsiteX26" fmla="*/ 296333 w 389466"/>
                  <a:gd name="connsiteY26" fmla="*/ 431800 h 436472"/>
                  <a:gd name="connsiteX27" fmla="*/ 389466 w 389466"/>
                  <a:gd name="connsiteY27" fmla="*/ 436034 h 4364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389466" h="436472">
                    <a:moveTo>
                      <a:pt x="296333" y="0"/>
                    </a:moveTo>
                    <a:cubicBezTo>
                      <a:pt x="245906" y="8406"/>
                      <a:pt x="286650" y="2507"/>
                      <a:pt x="203200" y="8467"/>
                    </a:cubicBezTo>
                    <a:cubicBezTo>
                      <a:pt x="186251" y="9678"/>
                      <a:pt x="169333" y="11289"/>
                      <a:pt x="152400" y="12700"/>
                    </a:cubicBezTo>
                    <a:cubicBezTo>
                      <a:pt x="131266" y="17984"/>
                      <a:pt x="115485" y="21651"/>
                      <a:pt x="93133" y="29634"/>
                    </a:cubicBezTo>
                    <a:cubicBezTo>
                      <a:pt x="87190" y="31756"/>
                      <a:pt x="81451" y="34600"/>
                      <a:pt x="76200" y="38100"/>
                    </a:cubicBezTo>
                    <a:cubicBezTo>
                      <a:pt x="68682" y="43112"/>
                      <a:pt x="62262" y="49613"/>
                      <a:pt x="55033" y="55034"/>
                    </a:cubicBezTo>
                    <a:cubicBezTo>
                      <a:pt x="50963" y="58087"/>
                      <a:pt x="46566" y="60678"/>
                      <a:pt x="42333" y="63500"/>
                    </a:cubicBezTo>
                    <a:cubicBezTo>
                      <a:pt x="39511" y="67733"/>
                      <a:pt x="37216" y="72371"/>
                      <a:pt x="33866" y="76200"/>
                    </a:cubicBezTo>
                    <a:cubicBezTo>
                      <a:pt x="27296" y="83709"/>
                      <a:pt x="18687" y="89385"/>
                      <a:pt x="12700" y="97367"/>
                    </a:cubicBezTo>
                    <a:cubicBezTo>
                      <a:pt x="10023" y="100937"/>
                      <a:pt x="10033" y="105889"/>
                      <a:pt x="8466" y="110067"/>
                    </a:cubicBezTo>
                    <a:cubicBezTo>
                      <a:pt x="5798" y="117182"/>
                      <a:pt x="2822" y="124178"/>
                      <a:pt x="0" y="131234"/>
                    </a:cubicBezTo>
                    <a:cubicBezTo>
                      <a:pt x="657" y="133864"/>
                      <a:pt x="5966" y="156938"/>
                      <a:pt x="8466" y="160867"/>
                    </a:cubicBezTo>
                    <a:cubicBezTo>
                      <a:pt x="47651" y="222444"/>
                      <a:pt x="19564" y="175032"/>
                      <a:pt x="46566" y="207434"/>
                    </a:cubicBezTo>
                    <a:cubicBezTo>
                      <a:pt x="49823" y="211343"/>
                      <a:pt x="50800" y="217312"/>
                      <a:pt x="55033" y="220134"/>
                    </a:cubicBezTo>
                    <a:cubicBezTo>
                      <a:pt x="59874" y="223361"/>
                      <a:pt x="66322" y="222956"/>
                      <a:pt x="71966" y="224367"/>
                    </a:cubicBezTo>
                    <a:cubicBezTo>
                      <a:pt x="76199" y="228600"/>
                      <a:pt x="81186" y="232195"/>
                      <a:pt x="84666" y="237067"/>
                    </a:cubicBezTo>
                    <a:cubicBezTo>
                      <a:pt x="88334" y="242202"/>
                      <a:pt x="90002" y="248521"/>
                      <a:pt x="93133" y="254000"/>
                    </a:cubicBezTo>
                    <a:cubicBezTo>
                      <a:pt x="95657" y="258417"/>
                      <a:pt x="98778" y="262467"/>
                      <a:pt x="101600" y="266700"/>
                    </a:cubicBezTo>
                    <a:cubicBezTo>
                      <a:pt x="104422" y="275167"/>
                      <a:pt x="107901" y="283442"/>
                      <a:pt x="110066" y="292100"/>
                    </a:cubicBezTo>
                    <a:cubicBezTo>
                      <a:pt x="113278" y="304948"/>
                      <a:pt x="114466" y="314901"/>
                      <a:pt x="122766" y="325967"/>
                    </a:cubicBezTo>
                    <a:cubicBezTo>
                      <a:pt x="137833" y="346055"/>
                      <a:pt x="140777" y="341537"/>
                      <a:pt x="160866" y="355600"/>
                    </a:cubicBezTo>
                    <a:cubicBezTo>
                      <a:pt x="174123" y="364880"/>
                      <a:pt x="181206" y="373621"/>
                      <a:pt x="194733" y="381000"/>
                    </a:cubicBezTo>
                    <a:cubicBezTo>
                      <a:pt x="205813" y="387044"/>
                      <a:pt x="216626" y="393943"/>
                      <a:pt x="228600" y="397934"/>
                    </a:cubicBezTo>
                    <a:cubicBezTo>
                      <a:pt x="232833" y="399345"/>
                      <a:pt x="237309" y="400171"/>
                      <a:pt x="241300" y="402167"/>
                    </a:cubicBezTo>
                    <a:cubicBezTo>
                      <a:pt x="248659" y="405847"/>
                      <a:pt x="255620" y="410303"/>
                      <a:pt x="262466" y="414867"/>
                    </a:cubicBezTo>
                    <a:cubicBezTo>
                      <a:pt x="268337" y="418781"/>
                      <a:pt x="273089" y="424412"/>
                      <a:pt x="279400" y="427567"/>
                    </a:cubicBezTo>
                    <a:cubicBezTo>
                      <a:pt x="284604" y="430169"/>
                      <a:pt x="290594" y="430843"/>
                      <a:pt x="296333" y="431800"/>
                    </a:cubicBezTo>
                    <a:cubicBezTo>
                      <a:pt x="336440" y="438485"/>
                      <a:pt x="342027" y="436034"/>
                      <a:pt x="389466" y="436034"/>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sp>
            <p:nvSpPr>
              <p:cNvPr id="16" name="任意多边形: 形状 15">
                <a:extLst>
                  <a:ext uri="{FF2B5EF4-FFF2-40B4-BE49-F238E27FC236}">
                    <a16:creationId xmlns:a16="http://schemas.microsoft.com/office/drawing/2014/main" id="{99754703-4578-FC8A-CD50-3B17F945E3E1}"/>
                  </a:ext>
                </a:extLst>
              </p:cNvPr>
              <p:cNvSpPr/>
              <p:nvPr/>
            </p:nvSpPr>
            <p:spPr>
              <a:xfrm>
                <a:off x="2043613" y="3208567"/>
                <a:ext cx="891908" cy="713069"/>
              </a:xfrm>
              <a:custGeom>
                <a:avLst/>
                <a:gdLst>
                  <a:gd name="connsiteX0" fmla="*/ 1010492 w 1223816"/>
                  <a:gd name="connsiteY0" fmla="*/ 425302 h 962246"/>
                  <a:gd name="connsiteX1" fmla="*/ 952013 w 1223816"/>
                  <a:gd name="connsiteY1" fmla="*/ 388088 h 962246"/>
                  <a:gd name="connsiteX2" fmla="*/ 904166 w 1223816"/>
                  <a:gd name="connsiteY2" fmla="*/ 350874 h 962246"/>
                  <a:gd name="connsiteX3" fmla="*/ 888218 w 1223816"/>
                  <a:gd name="connsiteY3" fmla="*/ 345558 h 962246"/>
                  <a:gd name="connsiteX4" fmla="*/ 866953 w 1223816"/>
                  <a:gd name="connsiteY4" fmla="*/ 329609 h 962246"/>
                  <a:gd name="connsiteX5" fmla="*/ 845687 w 1223816"/>
                  <a:gd name="connsiteY5" fmla="*/ 318976 h 962246"/>
                  <a:gd name="connsiteX6" fmla="*/ 803157 w 1223816"/>
                  <a:gd name="connsiteY6" fmla="*/ 292395 h 962246"/>
                  <a:gd name="connsiteX7" fmla="*/ 760627 w 1223816"/>
                  <a:gd name="connsiteY7" fmla="*/ 255181 h 962246"/>
                  <a:gd name="connsiteX8" fmla="*/ 749994 w 1223816"/>
                  <a:gd name="connsiteY8" fmla="*/ 239232 h 962246"/>
                  <a:gd name="connsiteX9" fmla="*/ 734046 w 1223816"/>
                  <a:gd name="connsiteY9" fmla="*/ 223283 h 962246"/>
                  <a:gd name="connsiteX10" fmla="*/ 723413 w 1223816"/>
                  <a:gd name="connsiteY10" fmla="*/ 207335 h 962246"/>
                  <a:gd name="connsiteX11" fmla="*/ 707464 w 1223816"/>
                  <a:gd name="connsiteY11" fmla="*/ 202018 h 962246"/>
                  <a:gd name="connsiteX12" fmla="*/ 664934 w 1223816"/>
                  <a:gd name="connsiteY12" fmla="*/ 154172 h 962246"/>
                  <a:gd name="connsiteX13" fmla="*/ 633036 w 1223816"/>
                  <a:gd name="connsiteY13" fmla="*/ 132907 h 962246"/>
                  <a:gd name="connsiteX14" fmla="*/ 617087 w 1223816"/>
                  <a:gd name="connsiteY14" fmla="*/ 116958 h 962246"/>
                  <a:gd name="connsiteX15" fmla="*/ 601139 w 1223816"/>
                  <a:gd name="connsiteY15" fmla="*/ 106325 h 962246"/>
                  <a:gd name="connsiteX16" fmla="*/ 574557 w 1223816"/>
                  <a:gd name="connsiteY16" fmla="*/ 74428 h 962246"/>
                  <a:gd name="connsiteX17" fmla="*/ 558608 w 1223816"/>
                  <a:gd name="connsiteY17" fmla="*/ 63795 h 962246"/>
                  <a:gd name="connsiteX18" fmla="*/ 532027 w 1223816"/>
                  <a:gd name="connsiteY18" fmla="*/ 31897 h 962246"/>
                  <a:gd name="connsiteX19" fmla="*/ 494813 w 1223816"/>
                  <a:gd name="connsiteY19" fmla="*/ 15948 h 962246"/>
                  <a:gd name="connsiteX20" fmla="*/ 431018 w 1223816"/>
                  <a:gd name="connsiteY20" fmla="*/ 5316 h 962246"/>
                  <a:gd name="connsiteX21" fmla="*/ 404436 w 1223816"/>
                  <a:gd name="connsiteY21" fmla="*/ 0 h 962246"/>
                  <a:gd name="connsiteX22" fmla="*/ 207734 w 1223816"/>
                  <a:gd name="connsiteY22" fmla="*/ 5316 h 962246"/>
                  <a:gd name="connsiteX23" fmla="*/ 143939 w 1223816"/>
                  <a:gd name="connsiteY23" fmla="*/ 26581 h 962246"/>
                  <a:gd name="connsiteX24" fmla="*/ 117357 w 1223816"/>
                  <a:gd name="connsiteY24" fmla="*/ 37214 h 962246"/>
                  <a:gd name="connsiteX25" fmla="*/ 64194 w 1223816"/>
                  <a:gd name="connsiteY25" fmla="*/ 90376 h 962246"/>
                  <a:gd name="connsiteX26" fmla="*/ 16348 w 1223816"/>
                  <a:gd name="connsiteY26" fmla="*/ 159488 h 962246"/>
                  <a:gd name="connsiteX27" fmla="*/ 399 w 1223816"/>
                  <a:gd name="connsiteY27" fmla="*/ 223283 h 962246"/>
                  <a:gd name="connsiteX28" fmla="*/ 11032 w 1223816"/>
                  <a:gd name="connsiteY28" fmla="*/ 366823 h 962246"/>
                  <a:gd name="connsiteX29" fmla="*/ 21664 w 1223816"/>
                  <a:gd name="connsiteY29" fmla="*/ 388088 h 962246"/>
                  <a:gd name="connsiteX30" fmla="*/ 37613 w 1223816"/>
                  <a:gd name="connsiteY30" fmla="*/ 419986 h 962246"/>
                  <a:gd name="connsiteX31" fmla="*/ 42929 w 1223816"/>
                  <a:gd name="connsiteY31" fmla="*/ 435935 h 962246"/>
                  <a:gd name="connsiteX32" fmla="*/ 53562 w 1223816"/>
                  <a:gd name="connsiteY32" fmla="*/ 451883 h 962246"/>
                  <a:gd name="connsiteX33" fmla="*/ 64194 w 1223816"/>
                  <a:gd name="connsiteY33" fmla="*/ 473148 h 962246"/>
                  <a:gd name="connsiteX34" fmla="*/ 85459 w 1223816"/>
                  <a:gd name="connsiteY34" fmla="*/ 536944 h 962246"/>
                  <a:gd name="connsiteX35" fmla="*/ 101408 w 1223816"/>
                  <a:gd name="connsiteY35" fmla="*/ 579474 h 962246"/>
                  <a:gd name="connsiteX36" fmla="*/ 112041 w 1223816"/>
                  <a:gd name="connsiteY36" fmla="*/ 653902 h 962246"/>
                  <a:gd name="connsiteX37" fmla="*/ 149255 w 1223816"/>
                  <a:gd name="connsiteY37" fmla="*/ 733646 h 962246"/>
                  <a:gd name="connsiteX38" fmla="*/ 159887 w 1223816"/>
                  <a:gd name="connsiteY38" fmla="*/ 754911 h 962246"/>
                  <a:gd name="connsiteX39" fmla="*/ 181153 w 1223816"/>
                  <a:gd name="connsiteY39" fmla="*/ 776176 h 962246"/>
                  <a:gd name="connsiteX40" fmla="*/ 197101 w 1223816"/>
                  <a:gd name="connsiteY40" fmla="*/ 797441 h 962246"/>
                  <a:gd name="connsiteX41" fmla="*/ 239632 w 1223816"/>
                  <a:gd name="connsiteY41" fmla="*/ 802758 h 962246"/>
                  <a:gd name="connsiteX42" fmla="*/ 260897 w 1223816"/>
                  <a:gd name="connsiteY42" fmla="*/ 808074 h 962246"/>
                  <a:gd name="connsiteX43" fmla="*/ 308743 w 1223816"/>
                  <a:gd name="connsiteY43" fmla="*/ 839972 h 962246"/>
                  <a:gd name="connsiteX44" fmla="*/ 324692 w 1223816"/>
                  <a:gd name="connsiteY44" fmla="*/ 850604 h 962246"/>
                  <a:gd name="connsiteX45" fmla="*/ 351273 w 1223816"/>
                  <a:gd name="connsiteY45" fmla="*/ 866553 h 962246"/>
                  <a:gd name="connsiteX46" fmla="*/ 404436 w 1223816"/>
                  <a:gd name="connsiteY46" fmla="*/ 893135 h 962246"/>
                  <a:gd name="connsiteX47" fmla="*/ 446966 w 1223816"/>
                  <a:gd name="connsiteY47" fmla="*/ 909083 h 962246"/>
                  <a:gd name="connsiteX48" fmla="*/ 468232 w 1223816"/>
                  <a:gd name="connsiteY48" fmla="*/ 914400 h 962246"/>
                  <a:gd name="connsiteX49" fmla="*/ 500129 w 1223816"/>
                  <a:gd name="connsiteY49" fmla="*/ 925032 h 962246"/>
                  <a:gd name="connsiteX50" fmla="*/ 659618 w 1223816"/>
                  <a:gd name="connsiteY50" fmla="*/ 919716 h 962246"/>
                  <a:gd name="connsiteX51" fmla="*/ 702148 w 1223816"/>
                  <a:gd name="connsiteY51" fmla="*/ 914400 h 962246"/>
                  <a:gd name="connsiteX52" fmla="*/ 749994 w 1223816"/>
                  <a:gd name="connsiteY52" fmla="*/ 898451 h 962246"/>
                  <a:gd name="connsiteX53" fmla="*/ 803157 w 1223816"/>
                  <a:gd name="connsiteY53" fmla="*/ 887818 h 962246"/>
                  <a:gd name="connsiteX54" fmla="*/ 973278 w 1223816"/>
                  <a:gd name="connsiteY54" fmla="*/ 893135 h 962246"/>
                  <a:gd name="connsiteX55" fmla="*/ 1005176 w 1223816"/>
                  <a:gd name="connsiteY55" fmla="*/ 903767 h 962246"/>
                  <a:gd name="connsiteX56" fmla="*/ 1042390 w 1223816"/>
                  <a:gd name="connsiteY56" fmla="*/ 909083 h 962246"/>
                  <a:gd name="connsiteX57" fmla="*/ 1079604 w 1223816"/>
                  <a:gd name="connsiteY57" fmla="*/ 925032 h 962246"/>
                  <a:gd name="connsiteX58" fmla="*/ 1122134 w 1223816"/>
                  <a:gd name="connsiteY58" fmla="*/ 935665 h 962246"/>
                  <a:gd name="connsiteX59" fmla="*/ 1138083 w 1223816"/>
                  <a:gd name="connsiteY59" fmla="*/ 946297 h 962246"/>
                  <a:gd name="connsiteX60" fmla="*/ 1180613 w 1223816"/>
                  <a:gd name="connsiteY60" fmla="*/ 956930 h 962246"/>
                  <a:gd name="connsiteX61" fmla="*/ 1201878 w 1223816"/>
                  <a:gd name="connsiteY61" fmla="*/ 962246 h 962246"/>
                  <a:gd name="connsiteX62" fmla="*/ 1223143 w 1223816"/>
                  <a:gd name="connsiteY62" fmla="*/ 956930 h 962246"/>
                  <a:gd name="connsiteX63" fmla="*/ 1212511 w 1223816"/>
                  <a:gd name="connsiteY63" fmla="*/ 903767 h 962246"/>
                  <a:gd name="connsiteX64" fmla="*/ 1191246 w 1223816"/>
                  <a:gd name="connsiteY64" fmla="*/ 855921 h 962246"/>
                  <a:gd name="connsiteX65" fmla="*/ 1175297 w 1223816"/>
                  <a:gd name="connsiteY65" fmla="*/ 839972 h 962246"/>
                  <a:gd name="connsiteX66" fmla="*/ 1169980 w 1223816"/>
                  <a:gd name="connsiteY66" fmla="*/ 813390 h 962246"/>
                  <a:gd name="connsiteX67" fmla="*/ 1159348 w 1223816"/>
                  <a:gd name="connsiteY67" fmla="*/ 669851 h 962246"/>
                  <a:gd name="connsiteX68" fmla="*/ 1132766 w 1223816"/>
                  <a:gd name="connsiteY68" fmla="*/ 616688 h 962246"/>
                  <a:gd name="connsiteX69" fmla="*/ 1111501 w 1223816"/>
                  <a:gd name="connsiteY69" fmla="*/ 579474 h 962246"/>
                  <a:gd name="connsiteX70" fmla="*/ 1095553 w 1223816"/>
                  <a:gd name="connsiteY70" fmla="*/ 558209 h 962246"/>
                  <a:gd name="connsiteX71" fmla="*/ 1074287 w 1223816"/>
                  <a:gd name="connsiteY71" fmla="*/ 542260 h 962246"/>
                  <a:gd name="connsiteX72" fmla="*/ 1047706 w 1223816"/>
                  <a:gd name="connsiteY72" fmla="*/ 499730 h 962246"/>
                  <a:gd name="connsiteX73" fmla="*/ 1031757 w 1223816"/>
                  <a:gd name="connsiteY73" fmla="*/ 483781 h 962246"/>
                  <a:gd name="connsiteX74" fmla="*/ 999859 w 1223816"/>
                  <a:gd name="connsiteY74" fmla="*/ 446567 h 962246"/>
                  <a:gd name="connsiteX75" fmla="*/ 1010492 w 1223816"/>
                  <a:gd name="connsiteY75" fmla="*/ 425302 h 9622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Lst>
                <a:rect l="l" t="t" r="r" b="b"/>
                <a:pathLst>
                  <a:path w="1223816" h="962246">
                    <a:moveTo>
                      <a:pt x="1010492" y="425302"/>
                    </a:moveTo>
                    <a:cubicBezTo>
                      <a:pt x="1002518" y="415556"/>
                      <a:pt x="970008" y="401584"/>
                      <a:pt x="952013" y="388088"/>
                    </a:cubicBezTo>
                    <a:cubicBezTo>
                      <a:pt x="942605" y="381032"/>
                      <a:pt x="918982" y="358282"/>
                      <a:pt x="904166" y="350874"/>
                    </a:cubicBezTo>
                    <a:cubicBezTo>
                      <a:pt x="899154" y="348368"/>
                      <a:pt x="893534" y="347330"/>
                      <a:pt x="888218" y="345558"/>
                    </a:cubicBezTo>
                    <a:cubicBezTo>
                      <a:pt x="881130" y="340242"/>
                      <a:pt x="874467" y="334305"/>
                      <a:pt x="866953" y="329609"/>
                    </a:cubicBezTo>
                    <a:cubicBezTo>
                      <a:pt x="860232" y="325409"/>
                      <a:pt x="852281" y="323372"/>
                      <a:pt x="845687" y="318976"/>
                    </a:cubicBezTo>
                    <a:cubicBezTo>
                      <a:pt x="802347" y="290083"/>
                      <a:pt x="835986" y="303337"/>
                      <a:pt x="803157" y="292395"/>
                    </a:cubicBezTo>
                    <a:cubicBezTo>
                      <a:pt x="788794" y="280905"/>
                      <a:pt x="772613" y="269565"/>
                      <a:pt x="760627" y="255181"/>
                    </a:cubicBezTo>
                    <a:cubicBezTo>
                      <a:pt x="756537" y="250272"/>
                      <a:pt x="754084" y="244141"/>
                      <a:pt x="749994" y="239232"/>
                    </a:cubicBezTo>
                    <a:cubicBezTo>
                      <a:pt x="745181" y="233456"/>
                      <a:pt x="738859" y="229059"/>
                      <a:pt x="734046" y="223283"/>
                    </a:cubicBezTo>
                    <a:cubicBezTo>
                      <a:pt x="729956" y="218375"/>
                      <a:pt x="728402" y="211326"/>
                      <a:pt x="723413" y="207335"/>
                    </a:cubicBezTo>
                    <a:cubicBezTo>
                      <a:pt x="719037" y="203834"/>
                      <a:pt x="712780" y="203790"/>
                      <a:pt x="707464" y="202018"/>
                    </a:cubicBezTo>
                    <a:cubicBezTo>
                      <a:pt x="694680" y="182841"/>
                      <a:pt x="686786" y="168740"/>
                      <a:pt x="664934" y="154172"/>
                    </a:cubicBezTo>
                    <a:cubicBezTo>
                      <a:pt x="654301" y="147084"/>
                      <a:pt x="642072" y="141943"/>
                      <a:pt x="633036" y="132907"/>
                    </a:cubicBezTo>
                    <a:cubicBezTo>
                      <a:pt x="627720" y="127591"/>
                      <a:pt x="622863" y="121771"/>
                      <a:pt x="617087" y="116958"/>
                    </a:cubicBezTo>
                    <a:cubicBezTo>
                      <a:pt x="612179" y="112868"/>
                      <a:pt x="606047" y="110415"/>
                      <a:pt x="601139" y="106325"/>
                    </a:cubicBezTo>
                    <a:cubicBezTo>
                      <a:pt x="548871" y="62766"/>
                      <a:pt x="616386" y="116255"/>
                      <a:pt x="574557" y="74428"/>
                    </a:cubicBezTo>
                    <a:cubicBezTo>
                      <a:pt x="570039" y="69910"/>
                      <a:pt x="563924" y="67339"/>
                      <a:pt x="558608" y="63795"/>
                    </a:cubicBezTo>
                    <a:cubicBezTo>
                      <a:pt x="550130" y="51077"/>
                      <a:pt x="545052" y="41200"/>
                      <a:pt x="532027" y="31897"/>
                    </a:cubicBezTo>
                    <a:cubicBezTo>
                      <a:pt x="525306" y="27096"/>
                      <a:pt x="504451" y="17876"/>
                      <a:pt x="494813" y="15948"/>
                    </a:cubicBezTo>
                    <a:cubicBezTo>
                      <a:pt x="473673" y="11720"/>
                      <a:pt x="452248" y="9062"/>
                      <a:pt x="431018" y="5316"/>
                    </a:cubicBezTo>
                    <a:cubicBezTo>
                      <a:pt x="422119" y="3746"/>
                      <a:pt x="413297" y="1772"/>
                      <a:pt x="404436" y="0"/>
                    </a:cubicBezTo>
                    <a:cubicBezTo>
                      <a:pt x="338869" y="1772"/>
                      <a:pt x="273180" y="953"/>
                      <a:pt x="207734" y="5316"/>
                    </a:cubicBezTo>
                    <a:cubicBezTo>
                      <a:pt x="172573" y="7660"/>
                      <a:pt x="170108" y="14950"/>
                      <a:pt x="143939" y="26581"/>
                    </a:cubicBezTo>
                    <a:cubicBezTo>
                      <a:pt x="135218" y="30457"/>
                      <a:pt x="126218" y="33670"/>
                      <a:pt x="117357" y="37214"/>
                    </a:cubicBezTo>
                    <a:cubicBezTo>
                      <a:pt x="99636" y="54935"/>
                      <a:pt x="79230" y="70327"/>
                      <a:pt x="64194" y="90376"/>
                    </a:cubicBezTo>
                    <a:cubicBezTo>
                      <a:pt x="26097" y="141173"/>
                      <a:pt x="41415" y="117711"/>
                      <a:pt x="16348" y="159488"/>
                    </a:cubicBezTo>
                    <a:cubicBezTo>
                      <a:pt x="14435" y="166183"/>
                      <a:pt x="399" y="211511"/>
                      <a:pt x="399" y="223283"/>
                    </a:cubicBezTo>
                    <a:cubicBezTo>
                      <a:pt x="399" y="224622"/>
                      <a:pt x="-3172" y="328946"/>
                      <a:pt x="11032" y="366823"/>
                    </a:cubicBezTo>
                    <a:cubicBezTo>
                      <a:pt x="13815" y="374243"/>
                      <a:pt x="18542" y="380804"/>
                      <a:pt x="21664" y="388088"/>
                    </a:cubicBezTo>
                    <a:cubicBezTo>
                      <a:pt x="34869" y="418901"/>
                      <a:pt x="17180" y="389338"/>
                      <a:pt x="37613" y="419986"/>
                    </a:cubicBezTo>
                    <a:cubicBezTo>
                      <a:pt x="39385" y="425302"/>
                      <a:pt x="40423" y="430923"/>
                      <a:pt x="42929" y="435935"/>
                    </a:cubicBezTo>
                    <a:cubicBezTo>
                      <a:pt x="45786" y="441650"/>
                      <a:pt x="50392" y="446336"/>
                      <a:pt x="53562" y="451883"/>
                    </a:cubicBezTo>
                    <a:cubicBezTo>
                      <a:pt x="57494" y="458764"/>
                      <a:pt x="60975" y="465906"/>
                      <a:pt x="64194" y="473148"/>
                    </a:cubicBezTo>
                    <a:cubicBezTo>
                      <a:pt x="77570" y="503245"/>
                      <a:pt x="74974" y="501995"/>
                      <a:pt x="85459" y="536944"/>
                    </a:cubicBezTo>
                    <a:cubicBezTo>
                      <a:pt x="90456" y="553601"/>
                      <a:pt x="94379" y="561901"/>
                      <a:pt x="101408" y="579474"/>
                    </a:cubicBezTo>
                    <a:cubicBezTo>
                      <a:pt x="104952" y="604283"/>
                      <a:pt x="106878" y="629378"/>
                      <a:pt x="112041" y="653902"/>
                    </a:cubicBezTo>
                    <a:cubicBezTo>
                      <a:pt x="115313" y="669443"/>
                      <a:pt x="148963" y="733063"/>
                      <a:pt x="149255" y="733646"/>
                    </a:cubicBezTo>
                    <a:cubicBezTo>
                      <a:pt x="152799" y="740734"/>
                      <a:pt x="154283" y="749307"/>
                      <a:pt x="159887" y="754911"/>
                    </a:cubicBezTo>
                    <a:cubicBezTo>
                      <a:pt x="166976" y="761999"/>
                      <a:pt x="174552" y="768632"/>
                      <a:pt x="181153" y="776176"/>
                    </a:cubicBezTo>
                    <a:cubicBezTo>
                      <a:pt x="186988" y="782844"/>
                      <a:pt x="189035" y="793775"/>
                      <a:pt x="197101" y="797441"/>
                    </a:cubicBezTo>
                    <a:cubicBezTo>
                      <a:pt x="210108" y="803353"/>
                      <a:pt x="225539" y="800409"/>
                      <a:pt x="239632" y="802758"/>
                    </a:cubicBezTo>
                    <a:cubicBezTo>
                      <a:pt x="246839" y="803959"/>
                      <a:pt x="253809" y="806302"/>
                      <a:pt x="260897" y="808074"/>
                    </a:cubicBezTo>
                    <a:lnTo>
                      <a:pt x="308743" y="839972"/>
                    </a:lnTo>
                    <a:cubicBezTo>
                      <a:pt x="314059" y="843516"/>
                      <a:pt x="319274" y="847218"/>
                      <a:pt x="324692" y="850604"/>
                    </a:cubicBezTo>
                    <a:cubicBezTo>
                      <a:pt x="333454" y="856080"/>
                      <a:pt x="343007" y="860353"/>
                      <a:pt x="351273" y="866553"/>
                    </a:cubicBezTo>
                    <a:cubicBezTo>
                      <a:pt x="376192" y="885242"/>
                      <a:pt x="370853" y="884740"/>
                      <a:pt x="404436" y="893135"/>
                    </a:cubicBezTo>
                    <a:cubicBezTo>
                      <a:pt x="459014" y="906779"/>
                      <a:pt x="391372" y="888235"/>
                      <a:pt x="446966" y="909083"/>
                    </a:cubicBezTo>
                    <a:cubicBezTo>
                      <a:pt x="453808" y="911649"/>
                      <a:pt x="461233" y="912300"/>
                      <a:pt x="468232" y="914400"/>
                    </a:cubicBezTo>
                    <a:cubicBezTo>
                      <a:pt x="478967" y="917620"/>
                      <a:pt x="500129" y="925032"/>
                      <a:pt x="500129" y="925032"/>
                    </a:cubicBezTo>
                    <a:lnTo>
                      <a:pt x="659618" y="919716"/>
                    </a:lnTo>
                    <a:cubicBezTo>
                      <a:pt x="673885" y="918965"/>
                      <a:pt x="688241" y="917672"/>
                      <a:pt x="702148" y="914400"/>
                    </a:cubicBezTo>
                    <a:cubicBezTo>
                      <a:pt x="718513" y="910550"/>
                      <a:pt x="733509" y="901748"/>
                      <a:pt x="749994" y="898451"/>
                    </a:cubicBezTo>
                    <a:lnTo>
                      <a:pt x="803157" y="887818"/>
                    </a:lnTo>
                    <a:cubicBezTo>
                      <a:pt x="859864" y="889590"/>
                      <a:pt x="916719" y="888670"/>
                      <a:pt x="973278" y="893135"/>
                    </a:cubicBezTo>
                    <a:cubicBezTo>
                      <a:pt x="984451" y="894017"/>
                      <a:pt x="994255" y="901247"/>
                      <a:pt x="1005176" y="903767"/>
                    </a:cubicBezTo>
                    <a:cubicBezTo>
                      <a:pt x="1017386" y="906584"/>
                      <a:pt x="1029985" y="907311"/>
                      <a:pt x="1042390" y="909083"/>
                    </a:cubicBezTo>
                    <a:cubicBezTo>
                      <a:pt x="1054795" y="914399"/>
                      <a:pt x="1066801" y="920764"/>
                      <a:pt x="1079604" y="925032"/>
                    </a:cubicBezTo>
                    <a:cubicBezTo>
                      <a:pt x="1093467" y="929653"/>
                      <a:pt x="1122134" y="935665"/>
                      <a:pt x="1122134" y="935665"/>
                    </a:cubicBezTo>
                    <a:cubicBezTo>
                      <a:pt x="1127450" y="939209"/>
                      <a:pt x="1132368" y="943440"/>
                      <a:pt x="1138083" y="946297"/>
                    </a:cubicBezTo>
                    <a:cubicBezTo>
                      <a:pt x="1149487" y="951999"/>
                      <a:pt x="1169687" y="954502"/>
                      <a:pt x="1180613" y="956930"/>
                    </a:cubicBezTo>
                    <a:cubicBezTo>
                      <a:pt x="1187745" y="958515"/>
                      <a:pt x="1194790" y="960474"/>
                      <a:pt x="1201878" y="962246"/>
                    </a:cubicBezTo>
                    <a:cubicBezTo>
                      <a:pt x="1208966" y="960474"/>
                      <a:pt x="1221836" y="964119"/>
                      <a:pt x="1223143" y="956930"/>
                    </a:cubicBezTo>
                    <a:cubicBezTo>
                      <a:pt x="1226376" y="939150"/>
                      <a:pt x="1217167" y="921229"/>
                      <a:pt x="1212511" y="903767"/>
                    </a:cubicBezTo>
                    <a:cubicBezTo>
                      <a:pt x="1210738" y="897120"/>
                      <a:pt x="1196343" y="863057"/>
                      <a:pt x="1191246" y="855921"/>
                    </a:cubicBezTo>
                    <a:cubicBezTo>
                      <a:pt x="1186876" y="849803"/>
                      <a:pt x="1180613" y="845288"/>
                      <a:pt x="1175297" y="839972"/>
                    </a:cubicBezTo>
                    <a:cubicBezTo>
                      <a:pt x="1173525" y="831111"/>
                      <a:pt x="1170837" y="822385"/>
                      <a:pt x="1169980" y="813390"/>
                    </a:cubicBezTo>
                    <a:cubicBezTo>
                      <a:pt x="1164814" y="759147"/>
                      <a:pt x="1166291" y="721930"/>
                      <a:pt x="1159348" y="669851"/>
                    </a:cubicBezTo>
                    <a:cubicBezTo>
                      <a:pt x="1154972" y="637026"/>
                      <a:pt x="1151021" y="653200"/>
                      <a:pt x="1132766" y="616688"/>
                    </a:cubicBezTo>
                    <a:cubicBezTo>
                      <a:pt x="1122381" y="595917"/>
                      <a:pt x="1124027" y="597011"/>
                      <a:pt x="1111501" y="579474"/>
                    </a:cubicBezTo>
                    <a:cubicBezTo>
                      <a:pt x="1106351" y="572264"/>
                      <a:pt x="1101818" y="564474"/>
                      <a:pt x="1095553" y="558209"/>
                    </a:cubicBezTo>
                    <a:cubicBezTo>
                      <a:pt x="1089288" y="551944"/>
                      <a:pt x="1081376" y="547576"/>
                      <a:pt x="1074287" y="542260"/>
                    </a:cubicBezTo>
                    <a:cubicBezTo>
                      <a:pt x="1072060" y="538548"/>
                      <a:pt x="1053553" y="506747"/>
                      <a:pt x="1047706" y="499730"/>
                    </a:cubicBezTo>
                    <a:cubicBezTo>
                      <a:pt x="1042893" y="493954"/>
                      <a:pt x="1036268" y="489796"/>
                      <a:pt x="1031757" y="483781"/>
                    </a:cubicBezTo>
                    <a:cubicBezTo>
                      <a:pt x="1002902" y="445309"/>
                      <a:pt x="1030353" y="466897"/>
                      <a:pt x="999859" y="446567"/>
                    </a:cubicBezTo>
                    <a:cubicBezTo>
                      <a:pt x="977611" y="413195"/>
                      <a:pt x="1018466" y="435048"/>
                      <a:pt x="1010492" y="425302"/>
                    </a:cubicBezTo>
                    <a:close/>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Arial" panose="020B0604020202020204" pitchFamily="34" charset="0"/>
                  <a:cs typeface="Arial" panose="020B0604020202020204" pitchFamily="34" charset="0"/>
                </a:endParaRPr>
              </a:p>
            </p:txBody>
          </p:sp>
          <p:cxnSp>
            <p:nvCxnSpPr>
              <p:cNvPr id="17" name="直接箭头连接符 16">
                <a:extLst>
                  <a:ext uri="{FF2B5EF4-FFF2-40B4-BE49-F238E27FC236}">
                    <a16:creationId xmlns:a16="http://schemas.microsoft.com/office/drawing/2014/main" id="{85219D6C-B0F9-F93A-F2E3-C69B9E89B709}"/>
                  </a:ext>
                </a:extLst>
              </p:cNvPr>
              <p:cNvCxnSpPr>
                <a:cxnSpLocks/>
              </p:cNvCxnSpPr>
              <p:nvPr/>
            </p:nvCxnSpPr>
            <p:spPr>
              <a:xfrm flipH="1">
                <a:off x="2347849" y="3268101"/>
                <a:ext cx="110692" cy="86221"/>
              </a:xfrm>
              <a:prstGeom prst="straightConnector1">
                <a:avLst/>
              </a:prstGeom>
              <a:ln w="19050">
                <a:solidFill>
                  <a:srgbClr val="FFFF00"/>
                </a:solidFill>
                <a:tailEnd type="triangle"/>
              </a:ln>
            </p:spPr>
            <p:style>
              <a:lnRef idx="1">
                <a:schemeClr val="accent2"/>
              </a:lnRef>
              <a:fillRef idx="0">
                <a:schemeClr val="accent2"/>
              </a:fillRef>
              <a:effectRef idx="0">
                <a:schemeClr val="accent2"/>
              </a:effectRef>
              <a:fontRef idx="minor">
                <a:schemeClr val="tx1"/>
              </a:fontRef>
            </p:style>
          </p:cxnSp>
        </p:grpSp>
        <p:sp>
          <p:nvSpPr>
            <p:cNvPr id="10" name="文本框 9">
              <a:extLst>
                <a:ext uri="{FF2B5EF4-FFF2-40B4-BE49-F238E27FC236}">
                  <a16:creationId xmlns:a16="http://schemas.microsoft.com/office/drawing/2014/main" id="{29DC0182-4B96-0C9E-C1C3-1118310E9EC1}"/>
                </a:ext>
              </a:extLst>
            </p:cNvPr>
            <p:cNvSpPr txBox="1"/>
            <p:nvPr/>
          </p:nvSpPr>
          <p:spPr>
            <a:xfrm>
              <a:off x="1438236" y="3621723"/>
              <a:ext cx="840105" cy="271521"/>
            </a:xfrm>
            <a:prstGeom prst="rect">
              <a:avLst/>
            </a:prstGeom>
            <a:noFill/>
          </p:spPr>
          <p:txBody>
            <a:bodyPr wrap="square" rtlCol="0">
              <a:spAutoFit/>
            </a:bodyPr>
            <a:lstStyle/>
            <a:p>
              <a:r>
                <a:rPr lang="en-US" altLang="zh-CN" sz="900" b="1" dirty="0">
                  <a:solidFill>
                    <a:srgbClr val="00B050"/>
                  </a:solidFill>
                  <a:latin typeface="Arial" panose="020B0604020202020204" pitchFamily="34" charset="0"/>
                  <a:cs typeface="Arial" panose="020B0604020202020204" pitchFamily="34" charset="0"/>
                </a:rPr>
                <a:t>BODIPY</a:t>
              </a:r>
              <a:endParaRPr lang="zh-CN" altLang="en-US" sz="900" b="1" dirty="0">
                <a:solidFill>
                  <a:srgbClr val="00B050"/>
                </a:solidFill>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BF7DE260-CC92-CEA9-7A3D-EBF11B7C5C69}"/>
                </a:ext>
              </a:extLst>
            </p:cNvPr>
            <p:cNvSpPr txBox="1"/>
            <p:nvPr/>
          </p:nvSpPr>
          <p:spPr>
            <a:xfrm>
              <a:off x="1635175" y="686639"/>
              <a:ext cx="1512400" cy="271521"/>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Wing disc</a:t>
              </a:r>
              <a:endParaRPr lang="zh-CN" altLang="en-US" sz="900" b="1"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AD325111-CF2A-7874-2DDC-04B5583D6B6E}"/>
                </a:ext>
              </a:extLst>
            </p:cNvPr>
            <p:cNvSpPr txBox="1"/>
            <p:nvPr/>
          </p:nvSpPr>
          <p:spPr>
            <a:xfrm>
              <a:off x="3781643" y="692701"/>
              <a:ext cx="1512400" cy="271521"/>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Brain</a:t>
              </a:r>
              <a:endParaRPr lang="zh-CN" altLang="en-US" sz="900" b="1" dirty="0">
                <a:latin typeface="Arial" panose="020B0604020202020204" pitchFamily="34" charset="0"/>
                <a:cs typeface="Arial" panose="020B0604020202020204" pitchFamily="34" charset="0"/>
              </a:endParaRPr>
            </a:p>
          </p:txBody>
        </p:sp>
        <p:cxnSp>
          <p:nvCxnSpPr>
            <p:cNvPr id="13" name="直接连接符 12">
              <a:extLst>
                <a:ext uri="{FF2B5EF4-FFF2-40B4-BE49-F238E27FC236}">
                  <a16:creationId xmlns:a16="http://schemas.microsoft.com/office/drawing/2014/main" id="{557E6322-EAD6-D111-BF71-CAC05929E586}"/>
                </a:ext>
              </a:extLst>
            </p:cNvPr>
            <p:cNvCxnSpPr>
              <a:cxnSpLocks/>
            </p:cNvCxnSpPr>
            <p:nvPr/>
          </p:nvCxnSpPr>
          <p:spPr>
            <a:xfrm>
              <a:off x="3139834" y="3770931"/>
              <a:ext cx="24679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48" name="组合 47">
            <a:extLst>
              <a:ext uri="{FF2B5EF4-FFF2-40B4-BE49-F238E27FC236}">
                <a16:creationId xmlns:a16="http://schemas.microsoft.com/office/drawing/2014/main" id="{F11D73D1-51CD-38AE-9792-AF972D79574D}"/>
              </a:ext>
            </a:extLst>
          </p:cNvPr>
          <p:cNvGrpSpPr/>
          <p:nvPr/>
        </p:nvGrpSpPr>
        <p:grpSpPr>
          <a:xfrm>
            <a:off x="278040" y="3515157"/>
            <a:ext cx="4171018" cy="3471100"/>
            <a:chOff x="414162" y="3982872"/>
            <a:chExt cx="4171018" cy="3471100"/>
          </a:xfrm>
        </p:grpSpPr>
        <p:pic>
          <p:nvPicPr>
            <p:cNvPr id="34" name="内容占位符 9">
              <a:extLst>
                <a:ext uri="{FF2B5EF4-FFF2-40B4-BE49-F238E27FC236}">
                  <a16:creationId xmlns:a16="http://schemas.microsoft.com/office/drawing/2014/main" id="{FA2B243B-465B-72C4-A843-42AD0BF4FE07}"/>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31668" y="5906013"/>
              <a:ext cx="2026151" cy="1518154"/>
            </a:xfrm>
            <a:prstGeom prst="rect">
              <a:avLst/>
            </a:prstGeom>
          </p:spPr>
        </p:pic>
        <p:pic>
          <p:nvPicPr>
            <p:cNvPr id="35" name="图片 34">
              <a:extLst>
                <a:ext uri="{FF2B5EF4-FFF2-40B4-BE49-F238E27FC236}">
                  <a16:creationId xmlns:a16="http://schemas.microsoft.com/office/drawing/2014/main" id="{7AA7F26E-CE16-AA5C-9627-4AD36A6F9B8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500067" y="4181952"/>
              <a:ext cx="2016467" cy="1510897"/>
            </a:xfrm>
            <a:prstGeom prst="rect">
              <a:avLst/>
            </a:prstGeom>
          </p:spPr>
        </p:pic>
        <p:pic>
          <p:nvPicPr>
            <p:cNvPr id="36" name="图片 35">
              <a:extLst>
                <a:ext uri="{FF2B5EF4-FFF2-40B4-BE49-F238E27FC236}">
                  <a16:creationId xmlns:a16="http://schemas.microsoft.com/office/drawing/2014/main" id="{0C829854-F5AF-F6F3-99FC-05717AB0364E}"/>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497107" y="5912250"/>
              <a:ext cx="2026151" cy="1518154"/>
            </a:xfrm>
            <a:prstGeom prst="rect">
              <a:avLst/>
            </a:prstGeom>
          </p:spPr>
        </p:pic>
        <p:sp>
          <p:nvSpPr>
            <p:cNvPr id="37" name="文本框 36">
              <a:extLst>
                <a:ext uri="{FF2B5EF4-FFF2-40B4-BE49-F238E27FC236}">
                  <a16:creationId xmlns:a16="http://schemas.microsoft.com/office/drawing/2014/main" id="{44CB6731-AAA0-4A5D-E726-E5FEDBD91CF3}"/>
                </a:ext>
              </a:extLst>
            </p:cNvPr>
            <p:cNvSpPr txBox="1"/>
            <p:nvPr/>
          </p:nvSpPr>
          <p:spPr>
            <a:xfrm>
              <a:off x="414162" y="7223140"/>
              <a:ext cx="840105" cy="230832"/>
            </a:xfrm>
            <a:prstGeom prst="rect">
              <a:avLst/>
            </a:prstGeom>
            <a:noFill/>
          </p:spPr>
          <p:txBody>
            <a:bodyPr wrap="square" rtlCol="0">
              <a:spAutoFit/>
            </a:bodyPr>
            <a:lstStyle/>
            <a:p>
              <a:r>
                <a:rPr lang="en-US" altLang="zh-CN" sz="900" b="1" dirty="0">
                  <a:solidFill>
                    <a:srgbClr val="00B050"/>
                  </a:solidFill>
                  <a:latin typeface="Arial" panose="020B0604020202020204" pitchFamily="34" charset="0"/>
                  <a:cs typeface="Arial" panose="020B0604020202020204" pitchFamily="34" charset="0"/>
                </a:rPr>
                <a:t>BODIPY</a:t>
              </a:r>
              <a:endParaRPr lang="zh-CN" altLang="en-US" sz="900" b="1" dirty="0">
                <a:solidFill>
                  <a:srgbClr val="00B050"/>
                </a:solidFill>
                <a:latin typeface="Arial" panose="020B0604020202020204" pitchFamily="34" charset="0"/>
                <a:cs typeface="Arial" panose="020B0604020202020204" pitchFamily="34" charset="0"/>
              </a:endParaRPr>
            </a:p>
          </p:txBody>
        </p:sp>
        <p:sp>
          <p:nvSpPr>
            <p:cNvPr id="38" name="文本框 37">
              <a:extLst>
                <a:ext uri="{FF2B5EF4-FFF2-40B4-BE49-F238E27FC236}">
                  <a16:creationId xmlns:a16="http://schemas.microsoft.com/office/drawing/2014/main" id="{A294A52D-6805-EFE7-C3B9-180AE17863B5}"/>
                </a:ext>
              </a:extLst>
            </p:cNvPr>
            <p:cNvSpPr txBox="1"/>
            <p:nvPr/>
          </p:nvSpPr>
          <p:spPr>
            <a:xfrm>
              <a:off x="2793892" y="3996275"/>
              <a:ext cx="1517107" cy="230832"/>
            </a:xfrm>
            <a:prstGeom prst="rect">
              <a:avLst/>
            </a:prstGeom>
            <a:noFill/>
          </p:spPr>
          <p:txBody>
            <a:bodyPr wrap="square" rtlCol="0">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a:latin typeface="Arial" panose="020B0604020202020204" pitchFamily="34" charset="0"/>
                  <a:cs typeface="Arial" panose="020B0604020202020204" pitchFamily="34" charset="0"/>
                </a:rPr>
                <a:t>white RNAi</a:t>
              </a:r>
              <a:r>
                <a:rPr lang="en-US" altLang="zh-CN" sz="900" b="1" dirty="0">
                  <a:latin typeface="Arial" panose="020B0604020202020204" pitchFamily="34" charset="0"/>
                  <a:cs typeface="Arial" panose="020B0604020202020204" pitchFamily="34" charset="0"/>
                </a:rPr>
                <a:t>;</a:t>
              </a:r>
              <a:r>
                <a:rPr lang="en-US" altLang="zh-CN" sz="900" b="1" i="1" dirty="0">
                  <a:latin typeface="Arial" panose="020B0604020202020204" pitchFamily="34" charset="0"/>
                  <a:cs typeface="Arial" panose="020B0604020202020204" pitchFamily="34" charset="0"/>
                </a:rPr>
                <a:t>ACC</a:t>
              </a:r>
              <a:r>
                <a:rPr lang="en-US" altLang="zh-CN" sz="900" b="1" i="1" baseline="30000" dirty="0">
                  <a:latin typeface="Arial" panose="020B0604020202020204" pitchFamily="34" charset="0"/>
                  <a:cs typeface="Arial" panose="020B0604020202020204" pitchFamily="34" charset="0"/>
                </a:rPr>
                <a:t>OE</a:t>
              </a:r>
              <a:endParaRPr lang="zh-CN" altLang="en-US" sz="900" b="1" i="1" baseline="30000" dirty="0">
                <a:latin typeface="Arial" panose="020B0604020202020204" pitchFamily="34" charset="0"/>
                <a:cs typeface="Arial" panose="020B0604020202020204" pitchFamily="34" charset="0"/>
              </a:endParaRPr>
            </a:p>
          </p:txBody>
        </p:sp>
        <p:sp>
          <p:nvSpPr>
            <p:cNvPr id="39" name="文本框 38">
              <a:extLst>
                <a:ext uri="{FF2B5EF4-FFF2-40B4-BE49-F238E27FC236}">
                  <a16:creationId xmlns:a16="http://schemas.microsoft.com/office/drawing/2014/main" id="{0A9C3C62-88A9-EDB4-6B75-A681DDE9C691}"/>
                </a:ext>
              </a:extLst>
            </p:cNvPr>
            <p:cNvSpPr txBox="1"/>
            <p:nvPr/>
          </p:nvSpPr>
          <p:spPr>
            <a:xfrm>
              <a:off x="2816137" y="5692849"/>
              <a:ext cx="1769043" cy="230832"/>
            </a:xfrm>
            <a:prstGeom prst="rect">
              <a:avLst/>
            </a:prstGeom>
            <a:noFill/>
          </p:spPr>
          <p:txBody>
            <a:bodyPr wrap="square" rtlCol="0">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RNAi</a:t>
              </a:r>
              <a:r>
                <a:rPr lang="en-US" altLang="zh-CN" sz="900" b="1" dirty="0">
                  <a:latin typeface="Arial" panose="020B0604020202020204" pitchFamily="34" charset="0"/>
                  <a:cs typeface="Arial" panose="020B0604020202020204" pitchFamily="34" charset="0"/>
                </a:rPr>
                <a:t>;</a:t>
              </a:r>
              <a:r>
                <a:rPr lang="en-US" altLang="zh-CN" sz="900" b="1" i="1" dirty="0">
                  <a:latin typeface="Arial" panose="020B0604020202020204" pitchFamily="34" charset="0"/>
                  <a:cs typeface="Arial" panose="020B0604020202020204" pitchFamily="34" charset="0"/>
                </a:rPr>
                <a:t>ACC</a:t>
              </a:r>
              <a:r>
                <a:rPr lang="en-US" altLang="zh-CN" sz="900" b="1" i="1" baseline="30000" dirty="0">
                  <a:latin typeface="Arial" panose="020B0604020202020204" pitchFamily="34" charset="0"/>
                  <a:cs typeface="Arial" panose="020B0604020202020204" pitchFamily="34" charset="0"/>
                </a:rPr>
                <a:t>OE</a:t>
              </a:r>
              <a:endParaRPr lang="zh-CN" altLang="en-US" sz="900" b="1" i="1" baseline="300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6BFEDE41-CBA9-3680-61E1-177C7E243447}"/>
                </a:ext>
              </a:extLst>
            </p:cNvPr>
            <p:cNvSpPr txBox="1"/>
            <p:nvPr/>
          </p:nvSpPr>
          <p:spPr>
            <a:xfrm>
              <a:off x="778558" y="5706927"/>
              <a:ext cx="1559034" cy="230832"/>
            </a:xfrm>
            <a:prstGeom prst="rect">
              <a:avLst/>
            </a:prstGeom>
            <a:noFill/>
          </p:spPr>
          <p:txBody>
            <a:bodyPr wrap="square" rtlCol="0">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a:t>
              </a:r>
              <a:r>
                <a:rPr lang="en-US" altLang="zh-CN" sz="900" b="1" i="1" dirty="0" err="1">
                  <a:latin typeface="Arial" panose="020B0604020202020204" pitchFamily="34" charset="0"/>
                  <a:cs typeface="Arial" panose="020B0604020202020204" pitchFamily="34" charset="0"/>
                </a:rPr>
                <a:t>RNAi;EGFP</a:t>
              </a:r>
              <a:endParaRPr lang="zh-CN" altLang="en-US" sz="900" b="1" i="1" baseline="30000" dirty="0">
                <a:latin typeface="Arial" panose="020B0604020202020204" pitchFamily="34" charset="0"/>
                <a:cs typeface="Arial" panose="020B0604020202020204" pitchFamily="34" charset="0"/>
              </a:endParaRPr>
            </a:p>
          </p:txBody>
        </p:sp>
        <p:pic>
          <p:nvPicPr>
            <p:cNvPr id="41" name="内容占位符 4">
              <a:extLst>
                <a:ext uri="{FF2B5EF4-FFF2-40B4-BE49-F238E27FC236}">
                  <a16:creationId xmlns:a16="http://schemas.microsoft.com/office/drawing/2014/main" id="{DC58502B-4F4A-F903-BB36-BC099C8640DB}"/>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31959" y="4175841"/>
              <a:ext cx="2026152" cy="1518154"/>
            </a:xfrm>
            <a:prstGeom prst="rect">
              <a:avLst/>
            </a:prstGeom>
          </p:spPr>
        </p:pic>
        <p:sp>
          <p:nvSpPr>
            <p:cNvPr id="42" name="文本框 41">
              <a:extLst>
                <a:ext uri="{FF2B5EF4-FFF2-40B4-BE49-F238E27FC236}">
                  <a16:creationId xmlns:a16="http://schemas.microsoft.com/office/drawing/2014/main" id="{1525764D-F3BA-77B5-31CD-3AD44A50AEB0}"/>
                </a:ext>
              </a:extLst>
            </p:cNvPr>
            <p:cNvSpPr txBox="1"/>
            <p:nvPr/>
          </p:nvSpPr>
          <p:spPr>
            <a:xfrm>
              <a:off x="1058132" y="3982872"/>
              <a:ext cx="1100230" cy="230832"/>
            </a:xfrm>
            <a:prstGeom prst="rect">
              <a:avLst/>
            </a:prstGeom>
            <a:noFill/>
          </p:spPr>
          <p:txBody>
            <a:bodyPr wrap="square" rtlCol="0">
              <a:spAutoFit/>
            </a:bodyPr>
            <a:lstStyle/>
            <a:p>
              <a:r>
                <a:rPr lang="en-US" altLang="zh-CN" sz="900" b="1" i="1" dirty="0">
                  <a:latin typeface="Arial" panose="020B0604020202020204" pitchFamily="34" charset="0"/>
                  <a:cs typeface="Arial" panose="020B0604020202020204" pitchFamily="34" charset="0"/>
                </a:rPr>
                <a:t>cg &gt; ACC RNAi</a:t>
              </a:r>
              <a:endParaRPr lang="zh-CN" altLang="en-US" sz="900" b="1" i="1" dirty="0">
                <a:latin typeface="Arial" panose="020B0604020202020204" pitchFamily="34" charset="0"/>
                <a:cs typeface="Arial" panose="020B0604020202020204" pitchFamily="34" charset="0"/>
              </a:endParaRPr>
            </a:p>
          </p:txBody>
        </p:sp>
        <p:cxnSp>
          <p:nvCxnSpPr>
            <p:cNvPr id="44" name="直接连接符 43">
              <a:extLst>
                <a:ext uri="{FF2B5EF4-FFF2-40B4-BE49-F238E27FC236}">
                  <a16:creationId xmlns:a16="http://schemas.microsoft.com/office/drawing/2014/main" id="{4A993B7B-003E-B7B0-5108-4E1347F1C729}"/>
                </a:ext>
              </a:extLst>
            </p:cNvPr>
            <p:cNvCxnSpPr>
              <a:cxnSpLocks/>
            </p:cNvCxnSpPr>
            <p:nvPr/>
          </p:nvCxnSpPr>
          <p:spPr>
            <a:xfrm>
              <a:off x="2170540" y="7316065"/>
              <a:ext cx="12730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5" name="直接连接符 44">
              <a:extLst>
                <a:ext uri="{FF2B5EF4-FFF2-40B4-BE49-F238E27FC236}">
                  <a16:creationId xmlns:a16="http://schemas.microsoft.com/office/drawing/2014/main" id="{FDAC9738-469F-AEEF-D797-D790AB06468B}"/>
                </a:ext>
              </a:extLst>
            </p:cNvPr>
            <p:cNvCxnSpPr>
              <a:cxnSpLocks/>
            </p:cNvCxnSpPr>
            <p:nvPr/>
          </p:nvCxnSpPr>
          <p:spPr>
            <a:xfrm>
              <a:off x="4230212" y="5583021"/>
              <a:ext cx="127308" cy="0"/>
            </a:xfrm>
            <a:prstGeom prst="line">
              <a:avLst/>
            </a:prstGeom>
            <a:ln w="12700">
              <a:solidFill>
                <a:schemeClr val="accent4">
                  <a:lumMod val="75000"/>
                </a:schemeClr>
              </a:solidFill>
            </a:ln>
          </p:spPr>
          <p:style>
            <a:lnRef idx="1">
              <a:schemeClr val="accent1"/>
            </a:lnRef>
            <a:fillRef idx="0">
              <a:schemeClr val="accent1"/>
            </a:fillRef>
            <a:effectRef idx="0">
              <a:schemeClr val="accent1"/>
            </a:effectRef>
            <a:fontRef idx="minor">
              <a:schemeClr val="tx1"/>
            </a:fontRef>
          </p:style>
        </p:cxnSp>
        <p:cxnSp>
          <p:nvCxnSpPr>
            <p:cNvPr id="46" name="直接连接符 45">
              <a:extLst>
                <a:ext uri="{FF2B5EF4-FFF2-40B4-BE49-F238E27FC236}">
                  <a16:creationId xmlns:a16="http://schemas.microsoft.com/office/drawing/2014/main" id="{299EB4FB-E8EE-D0EB-FDEA-2E58378DAB60}"/>
                </a:ext>
              </a:extLst>
            </p:cNvPr>
            <p:cNvCxnSpPr>
              <a:cxnSpLocks/>
            </p:cNvCxnSpPr>
            <p:nvPr/>
          </p:nvCxnSpPr>
          <p:spPr>
            <a:xfrm>
              <a:off x="4245314" y="7326868"/>
              <a:ext cx="12730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7" name="直接连接符 46">
              <a:extLst>
                <a:ext uri="{FF2B5EF4-FFF2-40B4-BE49-F238E27FC236}">
                  <a16:creationId xmlns:a16="http://schemas.microsoft.com/office/drawing/2014/main" id="{C67571BF-6F86-DB6E-C191-7906A845F56D}"/>
                </a:ext>
              </a:extLst>
            </p:cNvPr>
            <p:cNvCxnSpPr>
              <a:cxnSpLocks/>
            </p:cNvCxnSpPr>
            <p:nvPr/>
          </p:nvCxnSpPr>
          <p:spPr>
            <a:xfrm>
              <a:off x="2112520" y="5583021"/>
              <a:ext cx="24679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aphicFrame>
        <p:nvGraphicFramePr>
          <p:cNvPr id="49" name="对象 48">
            <a:extLst>
              <a:ext uri="{FF2B5EF4-FFF2-40B4-BE49-F238E27FC236}">
                <a16:creationId xmlns:a16="http://schemas.microsoft.com/office/drawing/2014/main" id="{35C9C942-4ED7-0B12-AAE8-4B81AF77011D}"/>
              </a:ext>
            </a:extLst>
          </p:cNvPr>
          <p:cNvGraphicFramePr>
            <a:graphicFrameLocks noChangeAspect="1"/>
          </p:cNvGraphicFramePr>
          <p:nvPr>
            <p:extLst>
              <p:ext uri="{D42A27DB-BD31-4B8C-83A1-F6EECF244321}">
                <p14:modId xmlns:p14="http://schemas.microsoft.com/office/powerpoint/2010/main" val="4144672822"/>
              </p:ext>
            </p:extLst>
          </p:nvPr>
        </p:nvGraphicFramePr>
        <p:xfrm>
          <a:off x="4387850" y="3841750"/>
          <a:ext cx="1966913" cy="2951163"/>
        </p:xfrm>
        <a:graphic>
          <a:graphicData uri="http://schemas.openxmlformats.org/presentationml/2006/ole">
            <mc:AlternateContent xmlns:mc="http://schemas.openxmlformats.org/markup-compatibility/2006">
              <mc:Choice xmlns:v="urn:schemas-microsoft-com:vml" Requires="v">
                <p:oleObj name="Prism 9" r:id="rId10" imgW="2459568" imgH="3689247" progId="Prism9.Document">
                  <p:embed/>
                </p:oleObj>
              </mc:Choice>
              <mc:Fallback>
                <p:oleObj name="Prism 9" r:id="rId10" imgW="2459568" imgH="3689247" progId="Prism9.Document">
                  <p:embed/>
                  <p:pic>
                    <p:nvPicPr>
                      <p:cNvPr id="49" name="对象 48">
                        <a:extLst>
                          <a:ext uri="{FF2B5EF4-FFF2-40B4-BE49-F238E27FC236}">
                            <a16:creationId xmlns:a16="http://schemas.microsoft.com/office/drawing/2014/main" id="{35C9C942-4ED7-0B12-AAE8-4B81AF77011D}"/>
                          </a:ext>
                        </a:extLst>
                      </p:cNvPr>
                      <p:cNvPicPr/>
                      <p:nvPr/>
                    </p:nvPicPr>
                    <p:blipFill>
                      <a:blip r:embed="rId11"/>
                      <a:stretch>
                        <a:fillRect/>
                      </a:stretch>
                    </p:blipFill>
                    <p:spPr>
                      <a:xfrm>
                        <a:off x="4387850" y="3841750"/>
                        <a:ext cx="1966913" cy="2951163"/>
                      </a:xfrm>
                      <a:prstGeom prst="rect">
                        <a:avLst/>
                      </a:prstGeom>
                    </p:spPr>
                  </p:pic>
                </p:oleObj>
              </mc:Fallback>
            </mc:AlternateContent>
          </a:graphicData>
        </a:graphic>
      </p:graphicFrame>
      <p:sp>
        <p:nvSpPr>
          <p:cNvPr id="50" name="文本框 49">
            <a:extLst>
              <a:ext uri="{FF2B5EF4-FFF2-40B4-BE49-F238E27FC236}">
                <a16:creationId xmlns:a16="http://schemas.microsoft.com/office/drawing/2014/main" id="{2B31017E-852C-7817-CFBB-0C6FD3E7C92C}"/>
              </a:ext>
            </a:extLst>
          </p:cNvPr>
          <p:cNvSpPr txBox="1"/>
          <p:nvPr/>
        </p:nvSpPr>
        <p:spPr>
          <a:xfrm>
            <a:off x="1255370" y="470381"/>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sp>
        <p:nvSpPr>
          <p:cNvPr id="51" name="文本框 50">
            <a:extLst>
              <a:ext uri="{FF2B5EF4-FFF2-40B4-BE49-F238E27FC236}">
                <a16:creationId xmlns:a16="http://schemas.microsoft.com/office/drawing/2014/main" id="{1218CA26-0ED0-6D07-4045-ACA93A3339B5}"/>
              </a:ext>
            </a:extLst>
          </p:cNvPr>
          <p:cNvSpPr txBox="1"/>
          <p:nvPr/>
        </p:nvSpPr>
        <p:spPr>
          <a:xfrm>
            <a:off x="194046" y="3436965"/>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sp>
        <p:nvSpPr>
          <p:cNvPr id="52" name="文本框 51">
            <a:extLst>
              <a:ext uri="{FF2B5EF4-FFF2-40B4-BE49-F238E27FC236}">
                <a16:creationId xmlns:a16="http://schemas.microsoft.com/office/drawing/2014/main" id="{BE6C19E6-7833-AEB2-4BEA-E6A2620A4BDB}"/>
              </a:ext>
            </a:extLst>
          </p:cNvPr>
          <p:cNvSpPr txBox="1"/>
          <p:nvPr/>
        </p:nvSpPr>
        <p:spPr>
          <a:xfrm>
            <a:off x="4504158" y="3643976"/>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c</a:t>
            </a:r>
            <a:endParaRPr lang="zh-CN" altLang="en-US" sz="1200" b="1" dirty="0">
              <a:latin typeface="Arial" panose="020B0604020202020204" pitchFamily="34" charset="0"/>
              <a:cs typeface="Arial" panose="020B0604020202020204" pitchFamily="34" charset="0"/>
            </a:endParaRPr>
          </a:p>
        </p:txBody>
      </p:sp>
      <p:sp>
        <p:nvSpPr>
          <p:cNvPr id="53" name="文本框 52">
            <a:extLst>
              <a:ext uri="{FF2B5EF4-FFF2-40B4-BE49-F238E27FC236}">
                <a16:creationId xmlns:a16="http://schemas.microsoft.com/office/drawing/2014/main" id="{51E65608-3000-9D33-7B58-0119FCBDE71C}"/>
              </a:ext>
            </a:extLst>
          </p:cNvPr>
          <p:cNvSpPr txBox="1"/>
          <p:nvPr/>
        </p:nvSpPr>
        <p:spPr>
          <a:xfrm>
            <a:off x="304824" y="7327789"/>
            <a:ext cx="6199539" cy="415498"/>
          </a:xfrm>
          <a:prstGeom prst="rect">
            <a:avLst/>
          </a:prstGeom>
          <a:noFill/>
        </p:spPr>
        <p:txBody>
          <a:bodyPr wrap="square">
            <a:spAutoFit/>
          </a:bodyPr>
          <a:lstStyle/>
          <a:p>
            <a:pPr marL="0" marR="0" lvl="0" algn="ctr" defTabSz="536433" rtl="0" eaLnBrk="1" fontAlgn="auto" latinLnBrk="0" hangingPunct="1">
              <a:buClrTx/>
              <a:buSzTx/>
              <a:buFontTx/>
              <a:buNone/>
              <a:tabLst/>
              <a:defRPr/>
            </a:pP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Fig. </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S3</a:t>
            </a: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 </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F</a:t>
            </a: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at body specific </a:t>
            </a:r>
            <a:r>
              <a:rPr lang="en-US" altLang="zh-CN" sz="1050" b="1" i="1" dirty="0">
                <a:effectLst/>
                <a:latin typeface="Times New Roman" panose="02020603050405020304" pitchFamily="18" charset="0"/>
                <a:ea typeface="宋体" panose="02010600030101010101" pitchFamily="2" charset="-122"/>
                <a:cs typeface="宋体" panose="02010600030101010101" pitchFamily="2" charset="-122"/>
              </a:rPr>
              <a:t>dAcsl</a:t>
            </a: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 knock-down affect exclusively gut lipid homeostasis and gut lipid accumulation can’t be </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res</a:t>
            </a: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tored by elevated fatty acid level</a:t>
            </a:r>
            <a:endParaRPr kumimoji="0" lang="zh-CN"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mn-cs"/>
            </a:endParaRPr>
          </a:p>
        </p:txBody>
      </p:sp>
      <p:sp>
        <p:nvSpPr>
          <p:cNvPr id="55" name="文本框 54">
            <a:extLst>
              <a:ext uri="{FF2B5EF4-FFF2-40B4-BE49-F238E27FC236}">
                <a16:creationId xmlns:a16="http://schemas.microsoft.com/office/drawing/2014/main" id="{6822DBF6-0926-3850-48A8-F1B219D0C90D}"/>
              </a:ext>
            </a:extLst>
          </p:cNvPr>
          <p:cNvSpPr txBox="1"/>
          <p:nvPr/>
        </p:nvSpPr>
        <p:spPr>
          <a:xfrm>
            <a:off x="116832" y="7779026"/>
            <a:ext cx="6510691" cy="1223412"/>
          </a:xfrm>
          <a:prstGeom prst="rect">
            <a:avLst/>
          </a:prstGeom>
          <a:noFill/>
        </p:spPr>
        <p:txBody>
          <a:bodyPr wrap="square">
            <a:spAutoFit/>
          </a:bodyPr>
          <a:lstStyle/>
          <a:p>
            <a:pPr algn="just"/>
            <a:r>
              <a:rPr lang="en-US" altLang="zh-CN" sz="1050" kern="100" dirty="0">
                <a:latin typeface="Times New Roman" panose="02020603050405020304" pitchFamily="18" charset="0"/>
                <a:ea typeface="宋体" panose="02010600030101010101" pitchFamily="2" charset="-122"/>
              </a:rPr>
              <a:t>(a) </a:t>
            </a:r>
            <a:r>
              <a:rPr lang="en-US" altLang="zh-CN" sz="1050" kern="100" dirty="0">
                <a:effectLst/>
                <a:latin typeface="Times New Roman" panose="02020603050405020304" pitchFamily="18" charset="0"/>
                <a:ea typeface="宋体" panose="02010600030101010101" pitchFamily="2" charset="-122"/>
              </a:rPr>
              <a:t>The green indicates BODIPY-labeled lipid droplets, </a:t>
            </a:r>
            <a:r>
              <a:rPr lang="en-US" altLang="zh-CN" sz="1050" kern="100" dirty="0">
                <a:latin typeface="Times New Roman" panose="02020603050405020304" pitchFamily="18" charset="0"/>
                <a:ea typeface="宋体" panose="02010600030101010101" pitchFamily="2" charset="-122"/>
              </a:rPr>
              <a:t>T</a:t>
            </a:r>
            <a:r>
              <a:rPr lang="en-US" altLang="zh-CN" sz="1050" kern="100" dirty="0">
                <a:effectLst/>
                <a:latin typeface="Times New Roman" panose="02020603050405020304" pitchFamily="18" charset="0"/>
                <a:ea typeface="宋体" panose="02010600030101010101" pitchFamily="2" charset="-122"/>
              </a:rPr>
              <a:t>he two pictures on the left represent the wing discs, and the two pictures on the right represent the larval. The yellow arrows mark the sites that are rich in neutral lipids. Scale bar = 20 μm. (b) Neutral lipid accumulation phenotype in the gut appears after ACC knockdown in the fat body, overexpression of </a:t>
            </a:r>
            <a:r>
              <a:rPr lang="en-US" altLang="zh-CN" sz="1050" i="1" kern="100" dirty="0">
                <a:effectLst/>
                <a:latin typeface="Times New Roman" panose="02020603050405020304" pitchFamily="18" charset="0"/>
                <a:ea typeface="宋体" panose="02010600030101010101" pitchFamily="2" charset="-122"/>
              </a:rPr>
              <a:t>ACC</a:t>
            </a:r>
            <a:r>
              <a:rPr lang="en-US" altLang="zh-CN" sz="1050" kern="100" dirty="0">
                <a:effectLst/>
                <a:latin typeface="Times New Roman" panose="02020603050405020304" pitchFamily="18" charset="0"/>
                <a:ea typeface="宋体" panose="02010600030101010101" pitchFamily="2" charset="-122"/>
              </a:rPr>
              <a:t> in the background of </a:t>
            </a:r>
            <a:r>
              <a:rPr lang="en-US" altLang="zh-CN" sz="1050" i="1" kern="100" dirty="0">
                <a:effectLst/>
                <a:latin typeface="Times New Roman" panose="02020603050405020304" pitchFamily="18" charset="0"/>
                <a:ea typeface="宋体" panose="02010600030101010101" pitchFamily="2" charset="-122"/>
              </a:rPr>
              <a:t>dAcsl</a:t>
            </a:r>
            <a:r>
              <a:rPr lang="en-US" altLang="zh-CN" sz="1050" kern="100" dirty="0">
                <a:effectLst/>
                <a:latin typeface="Times New Roman" panose="02020603050405020304" pitchFamily="18" charset="0"/>
                <a:ea typeface="宋体" panose="02010600030101010101" pitchFamily="2" charset="-122"/>
              </a:rPr>
              <a:t> RNAi cannot restore the intestinal neutral lipid accumulation phenotype. Green fluorescence is BODIPY-labeled lipid droplets. </a:t>
            </a:r>
            <a:r>
              <a:rPr lang="en-US" altLang="zh-CN" sz="1050" kern="100" dirty="0">
                <a:latin typeface="Times New Roman" panose="02020603050405020304" pitchFamily="18" charset="0"/>
                <a:ea typeface="宋体" panose="02010600030101010101" pitchFamily="2" charset="-122"/>
              </a:rPr>
              <a:t>(c) Statistical analysis results showed that there was no significant difference in green fluorescence between the </a:t>
            </a:r>
            <a:r>
              <a:rPr lang="en-US" altLang="zh-CN" sz="1050" i="1" kern="100" dirty="0">
                <a:latin typeface="Times New Roman" panose="02020603050405020304" pitchFamily="18" charset="0"/>
                <a:ea typeface="宋体" panose="02010600030101010101" pitchFamily="2" charset="-122"/>
              </a:rPr>
              <a:t>cg</a:t>
            </a:r>
            <a:r>
              <a:rPr lang="en-US" altLang="zh-CN" sz="1050" kern="100" dirty="0">
                <a:latin typeface="Times New Roman" panose="02020603050405020304" pitchFamily="18" charset="0"/>
                <a:ea typeface="宋体" panose="02010600030101010101" pitchFamily="2" charset="-122"/>
              </a:rPr>
              <a:t> &gt; </a:t>
            </a:r>
            <a:r>
              <a:rPr lang="en-US" altLang="zh-CN" sz="1050" i="1" kern="100" dirty="0">
                <a:latin typeface="Times New Roman" panose="02020603050405020304" pitchFamily="18" charset="0"/>
                <a:ea typeface="宋体" panose="02010600030101010101" pitchFamily="2" charset="-122"/>
              </a:rPr>
              <a:t>dAcsl</a:t>
            </a:r>
            <a:r>
              <a:rPr lang="en-US" altLang="zh-CN" sz="1050" kern="100" dirty="0">
                <a:latin typeface="Times New Roman" panose="02020603050405020304" pitchFamily="18" charset="0"/>
                <a:ea typeface="宋体" panose="02010600030101010101" pitchFamily="2" charset="-122"/>
              </a:rPr>
              <a:t> </a:t>
            </a:r>
            <a:r>
              <a:rPr lang="en-US" altLang="zh-CN" sz="1050" i="1" kern="100" dirty="0">
                <a:latin typeface="Times New Roman" panose="02020603050405020304" pitchFamily="18" charset="0"/>
                <a:ea typeface="宋体" panose="02010600030101010101" pitchFamily="2" charset="-122"/>
              </a:rPr>
              <a:t>RNAi</a:t>
            </a:r>
            <a:r>
              <a:rPr lang="en-US" altLang="zh-CN" sz="1050" kern="100" dirty="0">
                <a:latin typeface="Times New Roman" panose="02020603050405020304" pitchFamily="18" charset="0"/>
                <a:ea typeface="宋体" panose="02010600030101010101" pitchFamily="2" charset="-122"/>
              </a:rPr>
              <a:t> and </a:t>
            </a:r>
            <a:r>
              <a:rPr lang="en-US" altLang="zh-CN" sz="1050" i="1" kern="100" dirty="0">
                <a:latin typeface="Times New Roman" panose="02020603050405020304" pitchFamily="18" charset="0"/>
                <a:ea typeface="宋体" panose="02010600030101010101" pitchFamily="2" charset="-122"/>
              </a:rPr>
              <a:t>cg &gt; dAcsl RNAi; ACC</a:t>
            </a:r>
            <a:r>
              <a:rPr lang="en-US" altLang="zh-CN" sz="1050" i="1" kern="100" baseline="30000" dirty="0">
                <a:latin typeface="Times New Roman" panose="02020603050405020304" pitchFamily="18" charset="0"/>
                <a:ea typeface="宋体" panose="02010600030101010101" pitchFamily="2" charset="-122"/>
              </a:rPr>
              <a:t>OE</a:t>
            </a:r>
            <a:r>
              <a:rPr lang="en-US" altLang="zh-CN" sz="1050" i="1" kern="100" dirty="0">
                <a:latin typeface="Times New Roman" panose="02020603050405020304" pitchFamily="18" charset="0"/>
                <a:ea typeface="宋体" panose="02010600030101010101" pitchFamily="2" charset="-122"/>
              </a:rPr>
              <a:t> </a:t>
            </a:r>
            <a:r>
              <a:rPr lang="en-US" altLang="zh-CN" sz="1050" kern="100" dirty="0">
                <a:latin typeface="Times New Roman" panose="02020603050405020304" pitchFamily="18" charset="0"/>
                <a:ea typeface="宋体" panose="02010600030101010101" pitchFamily="2" charset="-122"/>
              </a:rPr>
              <a:t>groups (n = 6). Numbers in the figure represent </a:t>
            </a:r>
            <a:r>
              <a:rPr lang="en-US" altLang="zh-CN" sz="1050" i="1" kern="100" dirty="0">
                <a:latin typeface="Times New Roman" panose="02020603050405020304" pitchFamily="18" charset="0"/>
                <a:ea typeface="宋体" panose="02010600030101010101" pitchFamily="2" charset="-122"/>
              </a:rPr>
              <a:t>P</a:t>
            </a:r>
            <a:r>
              <a:rPr lang="en-US" altLang="zh-CN" sz="1050" kern="100" dirty="0">
                <a:latin typeface="Times New Roman" panose="02020603050405020304" pitchFamily="18" charset="0"/>
                <a:ea typeface="宋体" panose="02010600030101010101" pitchFamily="2" charset="-122"/>
              </a:rPr>
              <a:t> values, ns mean no significant difference, scale bar = 20 </a:t>
            </a:r>
            <a:r>
              <a:rPr lang="el-GR" altLang="zh-CN" sz="1050" kern="100" dirty="0">
                <a:latin typeface="Times New Roman" panose="02020603050405020304" pitchFamily="18" charset="0"/>
                <a:ea typeface="宋体" panose="02010600030101010101" pitchFamily="2" charset="-122"/>
              </a:rPr>
              <a:t>μ</a:t>
            </a:r>
            <a:r>
              <a:rPr lang="en-US" altLang="zh-CN" sz="1050" kern="100" dirty="0">
                <a:latin typeface="Times New Roman" panose="02020603050405020304" pitchFamily="18" charset="0"/>
                <a:ea typeface="宋体" panose="02010600030101010101" pitchFamily="2" charset="-122"/>
              </a:rPr>
              <a:t>m.</a:t>
            </a:r>
            <a:endParaRPr lang="zh-CN" altLang="zh-CN" sz="1050" kern="100" dirty="0">
              <a:effectLst/>
              <a:latin typeface="Times New Roman" panose="02020603050405020304" pitchFamily="18" charset="0"/>
              <a:ea typeface="宋体" panose="02010600030101010101" pitchFamily="2" charset="-122"/>
            </a:endParaRPr>
          </a:p>
        </p:txBody>
      </p:sp>
    </p:spTree>
    <p:extLst>
      <p:ext uri="{BB962C8B-B14F-4D97-AF65-F5344CB8AC3E}">
        <p14:creationId xmlns:p14="http://schemas.microsoft.com/office/powerpoint/2010/main" val="31742162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8" name="对象 47">
            <a:extLst>
              <a:ext uri="{FF2B5EF4-FFF2-40B4-BE49-F238E27FC236}">
                <a16:creationId xmlns:a16="http://schemas.microsoft.com/office/drawing/2014/main" id="{7A10113B-9661-DE16-CB5D-80AD14291BD4}"/>
              </a:ext>
            </a:extLst>
          </p:cNvPr>
          <p:cNvGraphicFramePr>
            <a:graphicFrameLocks noChangeAspect="1"/>
          </p:cNvGraphicFramePr>
          <p:nvPr>
            <p:extLst>
              <p:ext uri="{D42A27DB-BD31-4B8C-83A1-F6EECF244321}">
                <p14:modId xmlns:p14="http://schemas.microsoft.com/office/powerpoint/2010/main" val="2897802678"/>
              </p:ext>
            </p:extLst>
          </p:nvPr>
        </p:nvGraphicFramePr>
        <p:xfrm>
          <a:off x="2886177" y="845248"/>
          <a:ext cx="1501586" cy="2450398"/>
        </p:xfrm>
        <a:graphic>
          <a:graphicData uri="http://schemas.openxmlformats.org/presentationml/2006/ole">
            <mc:AlternateContent xmlns:mc="http://schemas.openxmlformats.org/markup-compatibility/2006">
              <mc:Choice xmlns:v="urn:schemas-microsoft-com:vml" Requires="v">
                <p:oleObj name="Prism 8" r:id="rId2" imgW="2280739" imgH="3722167" progId="Prism8.Document">
                  <p:embed/>
                </p:oleObj>
              </mc:Choice>
              <mc:Fallback>
                <p:oleObj name="Prism 8" r:id="rId2" imgW="2280739" imgH="3722167" progId="Prism8.Document">
                  <p:embed/>
                  <p:pic>
                    <p:nvPicPr>
                      <p:cNvPr id="48" name="对象 47">
                        <a:extLst>
                          <a:ext uri="{FF2B5EF4-FFF2-40B4-BE49-F238E27FC236}">
                            <a16:creationId xmlns:a16="http://schemas.microsoft.com/office/drawing/2014/main" id="{7A10113B-9661-DE16-CB5D-80AD14291BD4}"/>
                          </a:ext>
                        </a:extLst>
                      </p:cNvPr>
                      <p:cNvPicPr/>
                      <p:nvPr/>
                    </p:nvPicPr>
                    <p:blipFill>
                      <a:blip r:embed="rId3"/>
                      <a:stretch>
                        <a:fillRect/>
                      </a:stretch>
                    </p:blipFill>
                    <p:spPr>
                      <a:xfrm>
                        <a:off x="2886177" y="845248"/>
                        <a:ext cx="1501586" cy="2450398"/>
                      </a:xfrm>
                      <a:prstGeom prst="rect">
                        <a:avLst/>
                      </a:prstGeom>
                    </p:spPr>
                  </p:pic>
                </p:oleObj>
              </mc:Fallback>
            </mc:AlternateContent>
          </a:graphicData>
        </a:graphic>
      </p:graphicFrame>
      <p:grpSp>
        <p:nvGrpSpPr>
          <p:cNvPr id="36" name="组合 35">
            <a:extLst>
              <a:ext uri="{FF2B5EF4-FFF2-40B4-BE49-F238E27FC236}">
                <a16:creationId xmlns:a16="http://schemas.microsoft.com/office/drawing/2014/main" id="{AC0D0356-A495-3558-DD77-49AB2BB0E31F}"/>
              </a:ext>
            </a:extLst>
          </p:cNvPr>
          <p:cNvGrpSpPr/>
          <p:nvPr/>
        </p:nvGrpSpPr>
        <p:grpSpPr>
          <a:xfrm>
            <a:off x="368679" y="1204475"/>
            <a:ext cx="2434629" cy="1510412"/>
            <a:chOff x="302292" y="1891947"/>
            <a:chExt cx="3409546" cy="2167674"/>
          </a:xfrm>
        </p:grpSpPr>
        <p:grpSp>
          <p:nvGrpSpPr>
            <p:cNvPr id="37" name="组合 36">
              <a:extLst>
                <a:ext uri="{FF2B5EF4-FFF2-40B4-BE49-F238E27FC236}">
                  <a16:creationId xmlns:a16="http://schemas.microsoft.com/office/drawing/2014/main" id="{6202EFF2-BC5E-CDE9-D5FC-E645531C5809}"/>
                </a:ext>
              </a:extLst>
            </p:cNvPr>
            <p:cNvGrpSpPr/>
            <p:nvPr/>
          </p:nvGrpSpPr>
          <p:grpSpPr>
            <a:xfrm>
              <a:off x="302292" y="1891947"/>
              <a:ext cx="3409546" cy="2167674"/>
              <a:chOff x="1202986" y="5199517"/>
              <a:chExt cx="2564111" cy="1830397"/>
            </a:xfrm>
          </p:grpSpPr>
          <p:pic>
            <p:nvPicPr>
              <p:cNvPr id="39" name="内容占位符 4">
                <a:extLst>
                  <a:ext uri="{FF2B5EF4-FFF2-40B4-BE49-F238E27FC236}">
                    <a16:creationId xmlns:a16="http://schemas.microsoft.com/office/drawing/2014/main" id="{66C6D0AC-DCC2-CB52-945D-72A270D9E169}"/>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contrast="50000"/>
                        </a14:imgEffect>
                      </a14:imgLayer>
                    </a14:imgProps>
                  </a:ext>
                  <a:ext uri="{28A0092B-C50C-407E-A947-70E740481C1C}">
                    <a14:useLocalDpi xmlns:a14="http://schemas.microsoft.com/office/drawing/2010/main" val="0"/>
                  </a:ext>
                </a:extLst>
              </a:blip>
              <a:srcRect b="3088"/>
              <a:stretch/>
            </p:blipFill>
            <p:spPr>
              <a:xfrm flipH="1">
                <a:off x="1202986" y="5199517"/>
                <a:ext cx="2518872" cy="1799384"/>
              </a:xfrm>
              <a:prstGeom prst="rect">
                <a:avLst/>
              </a:prstGeom>
            </p:spPr>
          </p:pic>
          <p:sp>
            <p:nvSpPr>
              <p:cNvPr id="40" name="矩形 39">
                <a:extLst>
                  <a:ext uri="{FF2B5EF4-FFF2-40B4-BE49-F238E27FC236}">
                    <a16:creationId xmlns:a16="http://schemas.microsoft.com/office/drawing/2014/main" id="{45D02B72-375C-1973-46AB-B3B3BDCD9DEC}"/>
                  </a:ext>
                </a:extLst>
              </p:cNvPr>
              <p:cNvSpPr/>
              <p:nvPr/>
            </p:nvSpPr>
            <p:spPr>
              <a:xfrm>
                <a:off x="1260591" y="5221981"/>
                <a:ext cx="2475350" cy="1807933"/>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Arial" panose="020B0604020202020204" pitchFamily="34" charset="0"/>
                  <a:cs typeface="Arial" panose="020B0604020202020204" pitchFamily="34" charset="0"/>
                </a:endParaRPr>
              </a:p>
            </p:txBody>
          </p:sp>
          <p:sp>
            <p:nvSpPr>
              <p:cNvPr id="41" name="矩形 40">
                <a:extLst>
                  <a:ext uri="{FF2B5EF4-FFF2-40B4-BE49-F238E27FC236}">
                    <a16:creationId xmlns:a16="http://schemas.microsoft.com/office/drawing/2014/main" id="{EBA76DD2-10DF-83D7-BFAD-0550C0622835}"/>
                  </a:ext>
                </a:extLst>
              </p:cNvPr>
              <p:cNvSpPr/>
              <p:nvPr/>
            </p:nvSpPr>
            <p:spPr>
              <a:xfrm>
                <a:off x="1451480" y="5524837"/>
                <a:ext cx="2259674" cy="235457"/>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dirty="0">
                  <a:latin typeface="Arial" panose="020B0604020202020204" pitchFamily="34" charset="0"/>
                  <a:cs typeface="Arial" panose="020B0604020202020204" pitchFamily="34" charset="0"/>
                </a:endParaRPr>
              </a:p>
            </p:txBody>
          </p:sp>
          <p:sp>
            <p:nvSpPr>
              <p:cNvPr id="42" name="文本框 41">
                <a:extLst>
                  <a:ext uri="{FF2B5EF4-FFF2-40B4-BE49-F238E27FC236}">
                    <a16:creationId xmlns:a16="http://schemas.microsoft.com/office/drawing/2014/main" id="{75792A99-275B-9A01-9B03-BD6203EEA806}"/>
                  </a:ext>
                </a:extLst>
              </p:cNvPr>
              <p:cNvSpPr txBox="1"/>
              <p:nvPr/>
            </p:nvSpPr>
            <p:spPr>
              <a:xfrm>
                <a:off x="1248224" y="5296517"/>
                <a:ext cx="2518873" cy="372980"/>
              </a:xfrm>
              <a:prstGeom prst="rect">
                <a:avLst/>
              </a:prstGeom>
              <a:noFill/>
            </p:spPr>
            <p:txBody>
              <a:bodyPr wrap="square" rtlCol="0">
                <a:spAutoFit/>
              </a:bodyPr>
              <a:lstStyle/>
              <a:p>
                <a:r>
                  <a:rPr lang="en-US" altLang="zh-CN" sz="700" b="1" i="1" dirty="0">
                    <a:latin typeface="Arial" panose="020B0604020202020204" pitchFamily="34" charset="0"/>
                    <a:cs typeface="Arial" panose="020B0604020202020204" pitchFamily="34" charset="0"/>
                  </a:rPr>
                  <a:t>        white </a:t>
                </a:r>
                <a:r>
                  <a:rPr lang="en-US" altLang="zh-CN" sz="700" b="1" dirty="0">
                    <a:latin typeface="Arial" panose="020B0604020202020204" pitchFamily="34" charset="0"/>
                    <a:cs typeface="Arial" panose="020B0604020202020204" pitchFamily="34" charset="0"/>
                  </a:rPr>
                  <a:t>RNAi</a:t>
                </a:r>
                <a:r>
                  <a:rPr lang="en-US" altLang="zh-CN" sz="700" b="1" i="1" dirty="0">
                    <a:latin typeface="Arial" panose="020B0604020202020204" pitchFamily="34" charset="0"/>
                    <a:cs typeface="Arial" panose="020B0604020202020204" pitchFamily="34" charset="0"/>
                  </a:rPr>
                  <a:t>       dAcsl </a:t>
                </a:r>
                <a:r>
                  <a:rPr lang="en-US" altLang="zh-CN" sz="700" b="1" dirty="0">
                    <a:latin typeface="Arial" panose="020B0604020202020204" pitchFamily="34" charset="0"/>
                    <a:cs typeface="Arial" panose="020B0604020202020204" pitchFamily="34" charset="0"/>
                  </a:rPr>
                  <a:t>RNAi-1</a:t>
                </a:r>
                <a:r>
                  <a:rPr lang="en-US" altLang="zh-CN" sz="700" b="1" i="1" dirty="0">
                    <a:latin typeface="Arial" panose="020B0604020202020204" pitchFamily="34" charset="0"/>
                    <a:cs typeface="Arial" panose="020B0604020202020204" pitchFamily="34" charset="0"/>
                  </a:rPr>
                  <a:t>     dAcsl </a:t>
                </a:r>
                <a:r>
                  <a:rPr lang="en-US" altLang="zh-CN" sz="700" b="1" dirty="0">
                    <a:latin typeface="Arial" panose="020B0604020202020204" pitchFamily="34" charset="0"/>
                    <a:cs typeface="Arial" panose="020B0604020202020204" pitchFamily="34" charset="0"/>
                  </a:rPr>
                  <a:t>RNAi-2</a:t>
                </a:r>
                <a:r>
                  <a:rPr lang="en-US" altLang="zh-CN" sz="700" b="1" i="1" dirty="0">
                    <a:latin typeface="Arial" panose="020B0604020202020204" pitchFamily="34" charset="0"/>
                    <a:cs typeface="Arial" panose="020B0604020202020204" pitchFamily="34" charset="0"/>
                  </a:rPr>
                  <a:t> </a:t>
                </a:r>
                <a:endParaRPr lang="zh-CN" altLang="en-US" sz="700" dirty="0">
                  <a:latin typeface="Arial" panose="020B0604020202020204" pitchFamily="34" charset="0"/>
                  <a:cs typeface="Arial" panose="020B0604020202020204" pitchFamily="34" charset="0"/>
                </a:endParaRPr>
              </a:p>
              <a:p>
                <a:endParaRPr lang="zh-CN" altLang="en-US" sz="700" dirty="0">
                  <a:latin typeface="Arial" panose="020B0604020202020204" pitchFamily="34" charset="0"/>
                  <a:cs typeface="Arial" panose="020B0604020202020204" pitchFamily="34" charset="0"/>
                </a:endParaRPr>
              </a:p>
            </p:txBody>
          </p:sp>
        </p:grpSp>
        <p:sp>
          <p:nvSpPr>
            <p:cNvPr id="38" name="文本框 37">
              <a:extLst>
                <a:ext uri="{FF2B5EF4-FFF2-40B4-BE49-F238E27FC236}">
                  <a16:creationId xmlns:a16="http://schemas.microsoft.com/office/drawing/2014/main" id="{C41DC9FB-1AEB-9ECB-1504-43FB76FA9B1C}"/>
                </a:ext>
              </a:extLst>
            </p:cNvPr>
            <p:cNvSpPr txBox="1"/>
            <p:nvPr/>
          </p:nvSpPr>
          <p:spPr>
            <a:xfrm>
              <a:off x="374979" y="2227675"/>
              <a:ext cx="254973" cy="331279"/>
            </a:xfrm>
            <a:prstGeom prst="rect">
              <a:avLst/>
            </a:prstGeom>
            <a:noFill/>
          </p:spPr>
          <p:txBody>
            <a:bodyPr wrap="square" rtlCol="0">
              <a:spAutoFit/>
            </a:bodyPr>
            <a:lstStyle/>
            <a:p>
              <a:r>
                <a:rPr lang="en-US" altLang="zh-CN" sz="900" dirty="0">
                  <a:solidFill>
                    <a:srgbClr val="FF0000"/>
                  </a:solidFill>
                  <a:latin typeface="Arial" panose="020B0604020202020204" pitchFamily="34" charset="0"/>
                  <a:cs typeface="Arial" panose="020B0604020202020204" pitchFamily="34" charset="0"/>
                </a:rPr>
                <a:t>*</a:t>
              </a:r>
              <a:endParaRPr lang="zh-CN" altLang="en-US" sz="900" dirty="0">
                <a:solidFill>
                  <a:srgbClr val="FF0000"/>
                </a:solidFill>
                <a:latin typeface="Arial" panose="020B0604020202020204" pitchFamily="34" charset="0"/>
                <a:cs typeface="Arial" panose="020B0604020202020204" pitchFamily="34" charset="0"/>
              </a:endParaRPr>
            </a:p>
          </p:txBody>
        </p:sp>
      </p:grpSp>
      <p:pic>
        <p:nvPicPr>
          <p:cNvPr id="45" name="图片 44">
            <a:extLst>
              <a:ext uri="{FF2B5EF4-FFF2-40B4-BE49-F238E27FC236}">
                <a16:creationId xmlns:a16="http://schemas.microsoft.com/office/drawing/2014/main" id="{7D4EAED5-D064-7D9E-C062-17D2EB4F5A0A}"/>
              </a:ext>
            </a:extLst>
          </p:cNvPr>
          <p:cNvPicPr>
            <a:picLocks noChangeAspect="1"/>
          </p:cNvPicPr>
          <p:nvPr/>
        </p:nvPicPr>
        <p:blipFill>
          <a:blip r:embed="rId6"/>
          <a:stretch>
            <a:fillRect/>
          </a:stretch>
        </p:blipFill>
        <p:spPr>
          <a:xfrm>
            <a:off x="4498553" y="1019317"/>
            <a:ext cx="2227802" cy="1975102"/>
          </a:xfrm>
          <a:prstGeom prst="rect">
            <a:avLst/>
          </a:prstGeom>
        </p:spPr>
      </p:pic>
      <p:sp>
        <p:nvSpPr>
          <p:cNvPr id="46" name="文本框 45">
            <a:extLst>
              <a:ext uri="{FF2B5EF4-FFF2-40B4-BE49-F238E27FC236}">
                <a16:creationId xmlns:a16="http://schemas.microsoft.com/office/drawing/2014/main" id="{8114F24F-EF14-B4EF-8218-48B727182169}"/>
              </a:ext>
            </a:extLst>
          </p:cNvPr>
          <p:cNvSpPr txBox="1"/>
          <p:nvPr/>
        </p:nvSpPr>
        <p:spPr>
          <a:xfrm>
            <a:off x="222075" y="829303"/>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sp>
        <p:nvSpPr>
          <p:cNvPr id="47" name="文本框 46">
            <a:extLst>
              <a:ext uri="{FF2B5EF4-FFF2-40B4-BE49-F238E27FC236}">
                <a16:creationId xmlns:a16="http://schemas.microsoft.com/office/drawing/2014/main" id="{8E6412B1-FAC2-5AE9-59D7-C1C29D63E0C4}"/>
              </a:ext>
            </a:extLst>
          </p:cNvPr>
          <p:cNvSpPr txBox="1"/>
          <p:nvPr/>
        </p:nvSpPr>
        <p:spPr>
          <a:xfrm>
            <a:off x="2842878" y="845547"/>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sp>
        <p:nvSpPr>
          <p:cNvPr id="49" name="文本框 48">
            <a:extLst>
              <a:ext uri="{FF2B5EF4-FFF2-40B4-BE49-F238E27FC236}">
                <a16:creationId xmlns:a16="http://schemas.microsoft.com/office/drawing/2014/main" id="{DE49C790-4B6E-811D-30E8-ABE03C993CCE}"/>
              </a:ext>
            </a:extLst>
          </p:cNvPr>
          <p:cNvSpPr txBox="1"/>
          <p:nvPr/>
        </p:nvSpPr>
        <p:spPr>
          <a:xfrm>
            <a:off x="4226941" y="845547"/>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c</a:t>
            </a:r>
            <a:endParaRPr lang="zh-CN" altLang="en-US" sz="1200" b="1" dirty="0">
              <a:latin typeface="Arial" panose="020B0604020202020204" pitchFamily="34" charset="0"/>
              <a:cs typeface="Arial" panose="020B0604020202020204" pitchFamily="34" charset="0"/>
            </a:endParaRPr>
          </a:p>
        </p:txBody>
      </p:sp>
      <p:sp>
        <p:nvSpPr>
          <p:cNvPr id="50" name="文本框 49">
            <a:extLst>
              <a:ext uri="{FF2B5EF4-FFF2-40B4-BE49-F238E27FC236}">
                <a16:creationId xmlns:a16="http://schemas.microsoft.com/office/drawing/2014/main" id="{EBD69E80-24D3-0980-48D4-BB7FF265A633}"/>
              </a:ext>
            </a:extLst>
          </p:cNvPr>
          <p:cNvSpPr txBox="1"/>
          <p:nvPr/>
        </p:nvSpPr>
        <p:spPr>
          <a:xfrm>
            <a:off x="350751" y="7482941"/>
            <a:ext cx="6199539" cy="415498"/>
          </a:xfrm>
          <a:prstGeom prst="rect">
            <a:avLst/>
          </a:prstGeom>
          <a:noFill/>
        </p:spPr>
        <p:txBody>
          <a:bodyPr wrap="square">
            <a:spAutoFit/>
          </a:bodyPr>
          <a:lstStyle/>
          <a:p>
            <a:pPr marL="0" marR="0" lvl="0" algn="ctr" defTabSz="536433" rtl="0" eaLnBrk="1" fontAlgn="auto" latinLnBrk="0" hangingPunct="1">
              <a:buClrTx/>
              <a:buSzTx/>
              <a:buFontTx/>
              <a:buNone/>
              <a:tabLst/>
              <a:defRPr/>
            </a:pP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Fig. </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S4. </a:t>
            </a:r>
            <a:r>
              <a:rPr lang="en-US" altLang="zh-CN" sz="1050" b="1" i="1" dirty="0">
                <a:latin typeface="Times New Roman" panose="02020603050405020304" pitchFamily="18" charset="0"/>
                <a:ea typeface="宋体" panose="02010600030101010101" pitchFamily="2" charset="-122"/>
                <a:cs typeface="宋体" panose="02010600030101010101" pitchFamily="2" charset="-122"/>
              </a:rPr>
              <a:t>dAcsl</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 knockdown reduces lipoprotein content in hemolymph and caused ER and glycosylation disorder</a:t>
            </a:r>
            <a:endParaRPr kumimoji="0" lang="zh-CN"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mn-cs"/>
            </a:endParaRPr>
          </a:p>
        </p:txBody>
      </p:sp>
      <p:sp>
        <p:nvSpPr>
          <p:cNvPr id="52" name="文本框 51">
            <a:extLst>
              <a:ext uri="{FF2B5EF4-FFF2-40B4-BE49-F238E27FC236}">
                <a16:creationId xmlns:a16="http://schemas.microsoft.com/office/drawing/2014/main" id="{B9F134FC-A439-48E9-D295-792CAD1EF27E}"/>
              </a:ext>
            </a:extLst>
          </p:cNvPr>
          <p:cNvSpPr txBox="1"/>
          <p:nvPr/>
        </p:nvSpPr>
        <p:spPr>
          <a:xfrm>
            <a:off x="105081" y="7864851"/>
            <a:ext cx="6488203" cy="1546577"/>
          </a:xfrm>
          <a:prstGeom prst="rect">
            <a:avLst/>
          </a:prstGeom>
          <a:noFill/>
        </p:spPr>
        <p:txBody>
          <a:bodyPr wrap="square">
            <a:spAutoFit/>
          </a:bodyPr>
          <a:lstStyle/>
          <a:p>
            <a:pPr algn="just"/>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a) Coomassie blue staining of hemolymph showed that the band at the 250 kDa position was weakened in the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dAcsl</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RNAi strain of flies, and the red box indicated the position of the 250 kDa band (n = 3). (b) Three duplicate bands were pooled into one sample for protein profiling, apoLpp PSMs level change between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white </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RNAi</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and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dAcsl </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RNAi.</a:t>
            </a:r>
          </a:p>
          <a:p>
            <a:pPr algn="just"/>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c</a:t>
            </a:r>
            <a:r>
              <a:rPr lang="en-US" altLang="zh-CN" sz="1050" dirty="0">
                <a:solidFill>
                  <a:srgbClr val="000000"/>
                </a:solidFill>
                <a:latin typeface="Times New Roman" panose="02020603050405020304" pitchFamily="18" charset="0"/>
                <a:ea typeface="宋体" panose="02010600030101010101" pitchFamily="2" charset="-122"/>
                <a:cs typeface="宋体" panose="02010600030101010101" pitchFamily="2" charset="-122"/>
              </a:rPr>
              <a:t>) </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The PCA result shows that the fat body proteomic data of the control group and the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dAcsl</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RNAi group were well grouped, in which CTRL indicates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cg</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gt;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white</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RNAi</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and RNAi indicates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cg</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gt;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dAcsl</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RNAi</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a:t>
            </a:r>
            <a:r>
              <a:rPr lang="en-US" altLang="zh-CN" sz="1050" i="1"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n</a:t>
            </a:r>
            <a:r>
              <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 = 3). (d and e) Relative protein content of ER (d) (PDI, SEL, HSC70-3, ERP60 and ATL) and glycosylation (e) (CG9035, CG4603, CG11999,GALE and GALT) related pathway in fat body (n = 3). </a:t>
            </a:r>
            <a:r>
              <a:rPr lang="en-US" altLang="zh-CN" sz="1050" kern="1200" dirty="0">
                <a:solidFill>
                  <a:srgbClr val="000000"/>
                </a:solidFill>
                <a:effectLst/>
                <a:latin typeface="Times New Roman" panose="02020603050405020304" pitchFamily="18" charset="0"/>
                <a:ea typeface="等线" panose="02010600030101010101" pitchFamily="2" charset="-122"/>
              </a:rPr>
              <a:t>(f) The green fluorescent labeled neutral lipids are BODIPY labeled. Scale bar = 20 </a:t>
            </a:r>
            <a:r>
              <a:rPr lang="en-US" altLang="zh-CN" sz="1050" kern="1200" dirty="0" err="1">
                <a:solidFill>
                  <a:srgbClr val="000000"/>
                </a:solidFill>
                <a:effectLst/>
                <a:latin typeface="Times New Roman" panose="02020603050405020304" pitchFamily="18" charset="0"/>
                <a:ea typeface="等线" panose="02010600030101010101" pitchFamily="2" charset="-122"/>
              </a:rPr>
              <a:t>μm</a:t>
            </a:r>
            <a:r>
              <a:rPr lang="en-US" altLang="zh-CN" sz="1050" kern="1200" dirty="0">
                <a:solidFill>
                  <a:srgbClr val="000000"/>
                </a:solidFill>
                <a:effectLst/>
                <a:latin typeface="Times New Roman" panose="02020603050405020304" pitchFamily="18" charset="0"/>
                <a:ea typeface="等线" panose="02010600030101010101" pitchFamily="2" charset="-122"/>
              </a:rPr>
              <a:t>.</a:t>
            </a:r>
            <a:r>
              <a:rPr lang="en-US" altLang="zh-CN" sz="1050" kern="0" dirty="0">
                <a:effectLst/>
                <a:latin typeface="Times New Roman" panose="02020603050405020304" pitchFamily="18" charset="0"/>
                <a:ea typeface="等线" panose="02010600030101010101" pitchFamily="2" charset="-122"/>
              </a:rPr>
              <a:t> </a:t>
            </a:r>
            <a:r>
              <a:rPr lang="en-US" altLang="zh-CN" sz="1050" kern="1200" dirty="0">
                <a:solidFill>
                  <a:srgbClr val="000000"/>
                </a:solidFill>
                <a:effectLst/>
                <a:latin typeface="Times New Roman" panose="02020603050405020304" pitchFamily="18" charset="0"/>
                <a:ea typeface="等线" panose="02010600030101010101" pitchFamily="2" charset="-122"/>
              </a:rPr>
              <a:t>(g) Statistical results of </a:t>
            </a:r>
            <a:r>
              <a:rPr lang="en-US" altLang="zh-CN" sz="1050" i="1" kern="1200" dirty="0">
                <a:solidFill>
                  <a:srgbClr val="000000"/>
                </a:solidFill>
                <a:effectLst/>
                <a:latin typeface="Times New Roman" panose="02020603050405020304" pitchFamily="18" charset="0"/>
                <a:ea typeface="等线" panose="02010600030101010101" pitchFamily="2" charset="-122"/>
              </a:rPr>
              <a:t>cg</a:t>
            </a:r>
            <a:r>
              <a:rPr lang="en-US" altLang="zh-CN" sz="1050" kern="1200" dirty="0">
                <a:solidFill>
                  <a:srgbClr val="000000"/>
                </a:solidFill>
                <a:effectLst/>
                <a:latin typeface="Times New Roman" panose="02020603050405020304" pitchFamily="18" charset="0"/>
                <a:ea typeface="等线" panose="02010600030101010101" pitchFamily="2" charset="-122"/>
              </a:rPr>
              <a:t> &gt; </a:t>
            </a:r>
            <a:r>
              <a:rPr lang="en-US" altLang="zh-CN" sz="1050" i="1" kern="1200" dirty="0" err="1">
                <a:solidFill>
                  <a:srgbClr val="000000"/>
                </a:solidFill>
                <a:effectLst/>
                <a:latin typeface="Times New Roman" panose="02020603050405020304" pitchFamily="18" charset="0"/>
                <a:ea typeface="等线" panose="02010600030101010101" pitchFamily="2" charset="-122"/>
              </a:rPr>
              <a:t>dAcsl</a:t>
            </a:r>
            <a:r>
              <a:rPr lang="en-US" altLang="zh-CN" sz="1050" i="1" kern="1200" dirty="0">
                <a:solidFill>
                  <a:srgbClr val="000000"/>
                </a:solidFill>
                <a:effectLst/>
                <a:latin typeface="Times New Roman" panose="02020603050405020304" pitchFamily="18" charset="0"/>
                <a:ea typeface="等线" panose="02010600030101010101" pitchFamily="2" charset="-122"/>
              </a:rPr>
              <a:t> RNAi</a:t>
            </a:r>
            <a:r>
              <a:rPr lang="en-US" altLang="zh-CN" sz="1050" kern="1200" dirty="0">
                <a:solidFill>
                  <a:srgbClr val="000000"/>
                </a:solidFill>
                <a:effectLst/>
                <a:latin typeface="Times New Roman" panose="02020603050405020304" pitchFamily="18" charset="0"/>
                <a:ea typeface="等线" panose="02010600030101010101" pitchFamily="2" charset="-122"/>
              </a:rPr>
              <a:t>; </a:t>
            </a:r>
            <a:r>
              <a:rPr lang="en-US" altLang="zh-CN" sz="1050" i="1" kern="1200" dirty="0">
                <a:solidFill>
                  <a:srgbClr val="000000"/>
                </a:solidFill>
                <a:effectLst/>
                <a:latin typeface="Times New Roman" panose="02020603050405020304" pitchFamily="18" charset="0"/>
                <a:ea typeface="等线" panose="02010600030101010101" pitchFamily="2" charset="-122"/>
              </a:rPr>
              <a:t>eEF1</a:t>
            </a:r>
            <a:r>
              <a:rPr lang="el-GR" altLang="zh-CN" sz="1050" i="1" kern="1200" dirty="0">
                <a:solidFill>
                  <a:srgbClr val="000000"/>
                </a:solidFill>
                <a:effectLst/>
                <a:latin typeface="Times New Roman" panose="02020603050405020304" pitchFamily="18" charset="0"/>
                <a:ea typeface="等线" panose="02010600030101010101" pitchFamily="2" charset="-122"/>
              </a:rPr>
              <a:t>α1 </a:t>
            </a:r>
            <a:r>
              <a:rPr lang="en-US" altLang="zh-CN" sz="1050" i="1" kern="1200" dirty="0">
                <a:solidFill>
                  <a:srgbClr val="000000"/>
                </a:solidFill>
                <a:effectLst/>
                <a:latin typeface="Times New Roman" panose="02020603050405020304" pitchFamily="18" charset="0"/>
                <a:ea typeface="等线" panose="02010600030101010101" pitchFamily="2" charset="-122"/>
              </a:rPr>
              <a:t>RNAi </a:t>
            </a:r>
            <a:r>
              <a:rPr lang="en-US" altLang="zh-CN" sz="1050" kern="1200" dirty="0">
                <a:solidFill>
                  <a:srgbClr val="000000"/>
                </a:solidFill>
                <a:effectLst/>
                <a:latin typeface="Times New Roman" panose="02020603050405020304" pitchFamily="18" charset="0"/>
                <a:ea typeface="等线" panose="02010600030101010101" pitchFamily="2" charset="-122"/>
              </a:rPr>
              <a:t>and </a:t>
            </a:r>
            <a:r>
              <a:rPr lang="en-US" altLang="zh-CN" sz="1050" i="1" kern="1200" dirty="0">
                <a:solidFill>
                  <a:srgbClr val="000000"/>
                </a:solidFill>
                <a:effectLst/>
                <a:latin typeface="Times New Roman" panose="02020603050405020304" pitchFamily="18" charset="0"/>
                <a:ea typeface="等线" panose="02010600030101010101" pitchFamily="2" charset="-122"/>
              </a:rPr>
              <a:t>cg &gt; </a:t>
            </a:r>
            <a:r>
              <a:rPr lang="en-US" altLang="zh-CN" sz="1050" i="1" kern="1200" dirty="0" err="1">
                <a:solidFill>
                  <a:srgbClr val="000000"/>
                </a:solidFill>
                <a:effectLst/>
                <a:latin typeface="Times New Roman" panose="02020603050405020304" pitchFamily="18" charset="0"/>
                <a:ea typeface="等线" panose="02010600030101010101" pitchFamily="2" charset="-122"/>
              </a:rPr>
              <a:t>dAcsl</a:t>
            </a:r>
            <a:r>
              <a:rPr lang="en-US" altLang="zh-CN" sz="1050" i="1" kern="1200" dirty="0">
                <a:solidFill>
                  <a:srgbClr val="000000"/>
                </a:solidFill>
                <a:effectLst/>
                <a:latin typeface="Times New Roman" panose="02020603050405020304" pitchFamily="18" charset="0"/>
                <a:ea typeface="等线" panose="02010600030101010101" pitchFamily="2" charset="-122"/>
              </a:rPr>
              <a:t> RNAi</a:t>
            </a:r>
            <a:r>
              <a:rPr lang="en-US" altLang="zh-CN" sz="1050" kern="1200" dirty="0">
                <a:solidFill>
                  <a:srgbClr val="000000"/>
                </a:solidFill>
                <a:effectLst/>
                <a:latin typeface="Times New Roman" panose="02020603050405020304" pitchFamily="18" charset="0"/>
                <a:ea typeface="等线" panose="02010600030101010101" pitchFamily="2" charset="-122"/>
              </a:rPr>
              <a:t> (</a:t>
            </a:r>
            <a:r>
              <a:rPr lang="en-US" altLang="zh-CN" sz="1050" i="1" kern="1200" dirty="0">
                <a:solidFill>
                  <a:srgbClr val="000000"/>
                </a:solidFill>
                <a:effectLst/>
                <a:latin typeface="Times New Roman" panose="02020603050405020304" pitchFamily="18" charset="0"/>
                <a:ea typeface="等线" panose="02010600030101010101" pitchFamily="2" charset="-122"/>
              </a:rPr>
              <a:t>n</a:t>
            </a:r>
            <a:r>
              <a:rPr lang="en-US" altLang="zh-CN" sz="1050" kern="1200" dirty="0">
                <a:solidFill>
                  <a:srgbClr val="000000"/>
                </a:solidFill>
                <a:effectLst/>
                <a:latin typeface="Times New Roman" panose="02020603050405020304" pitchFamily="18" charset="0"/>
                <a:ea typeface="等线" panose="02010600030101010101" pitchFamily="2" charset="-122"/>
              </a:rPr>
              <a:t> </a:t>
            </a:r>
            <a:r>
              <a:rPr lang="zh-CN" altLang="en-US" sz="1050" dirty="0">
                <a:solidFill>
                  <a:srgbClr val="000000"/>
                </a:solidFill>
                <a:latin typeface="Times New Roman" panose="02020603050405020304" pitchFamily="18" charset="0"/>
                <a:ea typeface="等线" panose="02010600030101010101" pitchFamily="2" charset="-122"/>
              </a:rPr>
              <a:t>≈</a:t>
            </a:r>
            <a:r>
              <a:rPr lang="en-US" altLang="zh-CN" sz="1050" kern="1200" dirty="0">
                <a:solidFill>
                  <a:srgbClr val="000000"/>
                </a:solidFill>
                <a:effectLst/>
                <a:latin typeface="Times New Roman" panose="02020603050405020304" pitchFamily="18" charset="0"/>
                <a:ea typeface="等线" panose="02010600030101010101" pitchFamily="2" charset="-122"/>
              </a:rPr>
              <a:t> 9). Numbers in the figure represent </a:t>
            </a:r>
            <a:r>
              <a:rPr lang="en-US" altLang="zh-CN" sz="1050" i="1" kern="1200" dirty="0">
                <a:solidFill>
                  <a:srgbClr val="000000"/>
                </a:solidFill>
                <a:effectLst/>
                <a:latin typeface="Times New Roman" panose="02020603050405020304" pitchFamily="18" charset="0"/>
                <a:ea typeface="等线" panose="02010600030101010101" pitchFamily="2" charset="-122"/>
              </a:rPr>
              <a:t>p </a:t>
            </a:r>
            <a:r>
              <a:rPr lang="en-US" altLang="zh-CN" sz="1050" kern="1200" dirty="0">
                <a:solidFill>
                  <a:srgbClr val="000000"/>
                </a:solidFill>
                <a:effectLst/>
                <a:latin typeface="Times New Roman" panose="02020603050405020304" pitchFamily="18" charset="0"/>
                <a:ea typeface="等线" panose="02010600030101010101" pitchFamily="2" charset="-122"/>
              </a:rPr>
              <a:t>values.</a:t>
            </a:r>
            <a:endParaRPr lang="en-US" altLang="zh-CN" sz="1050" kern="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endParaRPr>
          </a:p>
        </p:txBody>
      </p:sp>
      <p:sp>
        <p:nvSpPr>
          <p:cNvPr id="53" name="文本框 52">
            <a:extLst>
              <a:ext uri="{FF2B5EF4-FFF2-40B4-BE49-F238E27FC236}">
                <a16:creationId xmlns:a16="http://schemas.microsoft.com/office/drawing/2014/main" id="{0A19DDDA-9C48-CCCA-EC38-E3810127EB3F}"/>
              </a:ext>
            </a:extLst>
          </p:cNvPr>
          <p:cNvSpPr txBox="1"/>
          <p:nvPr/>
        </p:nvSpPr>
        <p:spPr>
          <a:xfrm>
            <a:off x="1091054" y="1184417"/>
            <a:ext cx="979136" cy="200055"/>
          </a:xfrm>
          <a:prstGeom prst="rect">
            <a:avLst/>
          </a:prstGeom>
          <a:noFill/>
        </p:spPr>
        <p:txBody>
          <a:bodyPr wrap="square" rtlCol="0">
            <a:spAutoFit/>
          </a:bodyPr>
          <a:lstStyle/>
          <a:p>
            <a:pPr algn="ctr"/>
            <a:r>
              <a:rPr lang="en-US" altLang="zh-CN" sz="700" b="1" i="1" dirty="0">
                <a:latin typeface="Arial" panose="020B0604020202020204" pitchFamily="34" charset="0"/>
                <a:cs typeface="Arial" panose="020B0604020202020204" pitchFamily="34" charset="0"/>
              </a:rPr>
              <a:t>(THU2816)</a:t>
            </a:r>
            <a:endParaRPr lang="zh-CN" altLang="en-US" sz="700" b="1" i="1" dirty="0">
              <a:latin typeface="Arial" panose="020B0604020202020204" pitchFamily="34" charset="0"/>
              <a:cs typeface="Arial" panose="020B0604020202020204" pitchFamily="34" charset="0"/>
            </a:endParaRPr>
          </a:p>
        </p:txBody>
      </p:sp>
      <p:sp>
        <p:nvSpPr>
          <p:cNvPr id="54" name="文本框 53">
            <a:extLst>
              <a:ext uri="{FF2B5EF4-FFF2-40B4-BE49-F238E27FC236}">
                <a16:creationId xmlns:a16="http://schemas.microsoft.com/office/drawing/2014/main" id="{C4FD2034-3BE9-CCF2-4F56-6427A38CA671}"/>
              </a:ext>
            </a:extLst>
          </p:cNvPr>
          <p:cNvSpPr txBox="1"/>
          <p:nvPr/>
        </p:nvSpPr>
        <p:spPr>
          <a:xfrm>
            <a:off x="1795927" y="1195511"/>
            <a:ext cx="979136" cy="200055"/>
          </a:xfrm>
          <a:prstGeom prst="rect">
            <a:avLst/>
          </a:prstGeom>
          <a:noFill/>
        </p:spPr>
        <p:txBody>
          <a:bodyPr wrap="square" rtlCol="0">
            <a:spAutoFit/>
          </a:bodyPr>
          <a:lstStyle/>
          <a:p>
            <a:pPr algn="ctr"/>
            <a:r>
              <a:rPr lang="en-US" altLang="zh-CN" sz="700" b="1" i="1" dirty="0">
                <a:latin typeface="Arial" panose="020B0604020202020204" pitchFamily="34" charset="0"/>
                <a:cs typeface="Arial" panose="020B0604020202020204" pitchFamily="34" charset="0"/>
              </a:rPr>
              <a:t>(THU5325)</a:t>
            </a:r>
            <a:endParaRPr lang="zh-CN" altLang="en-US" sz="700" b="1" i="1" dirty="0">
              <a:latin typeface="Arial" panose="020B0604020202020204" pitchFamily="34" charset="0"/>
              <a:cs typeface="Arial" panose="020B0604020202020204" pitchFamily="34" charset="0"/>
            </a:endParaRPr>
          </a:p>
        </p:txBody>
      </p:sp>
      <p:graphicFrame>
        <p:nvGraphicFramePr>
          <p:cNvPr id="2" name="对象 1">
            <a:extLst>
              <a:ext uri="{FF2B5EF4-FFF2-40B4-BE49-F238E27FC236}">
                <a16:creationId xmlns:a16="http://schemas.microsoft.com/office/drawing/2014/main" id="{6F598596-3505-76B2-A8F2-DCEF2CFE627A}"/>
              </a:ext>
            </a:extLst>
          </p:cNvPr>
          <p:cNvGraphicFramePr>
            <a:graphicFrameLocks noChangeAspect="1"/>
          </p:cNvGraphicFramePr>
          <p:nvPr>
            <p:extLst>
              <p:ext uri="{D42A27DB-BD31-4B8C-83A1-F6EECF244321}">
                <p14:modId xmlns:p14="http://schemas.microsoft.com/office/powerpoint/2010/main" val="4036511762"/>
              </p:ext>
            </p:extLst>
          </p:nvPr>
        </p:nvGraphicFramePr>
        <p:xfrm>
          <a:off x="3678238" y="3348038"/>
          <a:ext cx="3127375" cy="2125662"/>
        </p:xfrm>
        <a:graphic>
          <a:graphicData uri="http://schemas.openxmlformats.org/presentationml/2006/ole">
            <mc:AlternateContent xmlns:mc="http://schemas.openxmlformats.org/markup-compatibility/2006">
              <mc:Choice xmlns:v="urn:schemas-microsoft-com:vml" Requires="v">
                <p:oleObj name="Prism 9" r:id="rId7" imgW="4664288" imgH="3168022" progId="Prism9.Document">
                  <p:embed/>
                </p:oleObj>
              </mc:Choice>
              <mc:Fallback>
                <p:oleObj name="Prism 9" r:id="rId7" imgW="4664288" imgH="3168022" progId="Prism9.Document">
                  <p:embed/>
                  <p:pic>
                    <p:nvPicPr>
                      <p:cNvPr id="2" name="对象 1">
                        <a:extLst>
                          <a:ext uri="{FF2B5EF4-FFF2-40B4-BE49-F238E27FC236}">
                            <a16:creationId xmlns:a16="http://schemas.microsoft.com/office/drawing/2014/main" id="{6F598596-3505-76B2-A8F2-DCEF2CFE627A}"/>
                          </a:ext>
                        </a:extLst>
                      </p:cNvPr>
                      <p:cNvPicPr/>
                      <p:nvPr/>
                    </p:nvPicPr>
                    <p:blipFill>
                      <a:blip r:embed="rId8"/>
                      <a:stretch>
                        <a:fillRect/>
                      </a:stretch>
                    </p:blipFill>
                    <p:spPr>
                      <a:xfrm>
                        <a:off x="3678238" y="3348038"/>
                        <a:ext cx="3127375" cy="2125662"/>
                      </a:xfrm>
                      <a:prstGeom prst="rect">
                        <a:avLst/>
                      </a:prstGeom>
                    </p:spPr>
                  </p:pic>
                </p:oleObj>
              </mc:Fallback>
            </mc:AlternateContent>
          </a:graphicData>
        </a:graphic>
      </p:graphicFrame>
      <p:graphicFrame>
        <p:nvGraphicFramePr>
          <p:cNvPr id="3" name="对象 2">
            <a:extLst>
              <a:ext uri="{FF2B5EF4-FFF2-40B4-BE49-F238E27FC236}">
                <a16:creationId xmlns:a16="http://schemas.microsoft.com/office/drawing/2014/main" id="{48678ADC-82EB-97CB-0B44-1C78BB918860}"/>
              </a:ext>
            </a:extLst>
          </p:cNvPr>
          <p:cNvGraphicFramePr>
            <a:graphicFrameLocks noChangeAspect="1"/>
          </p:cNvGraphicFramePr>
          <p:nvPr>
            <p:extLst>
              <p:ext uri="{D42A27DB-BD31-4B8C-83A1-F6EECF244321}">
                <p14:modId xmlns:p14="http://schemas.microsoft.com/office/powerpoint/2010/main" val="2784124143"/>
              </p:ext>
            </p:extLst>
          </p:nvPr>
        </p:nvGraphicFramePr>
        <p:xfrm>
          <a:off x="566738" y="3363913"/>
          <a:ext cx="3222625" cy="1990725"/>
        </p:xfrm>
        <a:graphic>
          <a:graphicData uri="http://schemas.openxmlformats.org/presentationml/2006/ole">
            <mc:AlternateContent xmlns:mc="http://schemas.openxmlformats.org/markup-compatibility/2006">
              <mc:Choice xmlns:v="urn:schemas-microsoft-com:vml" Requires="v">
                <p:oleObj name="Prism 9" r:id="rId9" imgW="4801430" imgH="2965364" progId="Prism9.Document">
                  <p:embed/>
                </p:oleObj>
              </mc:Choice>
              <mc:Fallback>
                <p:oleObj name="Prism 9" r:id="rId9" imgW="4801430" imgH="2965364" progId="Prism9.Document">
                  <p:embed/>
                  <p:pic>
                    <p:nvPicPr>
                      <p:cNvPr id="3" name="对象 2">
                        <a:extLst>
                          <a:ext uri="{FF2B5EF4-FFF2-40B4-BE49-F238E27FC236}">
                            <a16:creationId xmlns:a16="http://schemas.microsoft.com/office/drawing/2014/main" id="{48678ADC-82EB-97CB-0B44-1C78BB918860}"/>
                          </a:ext>
                        </a:extLst>
                      </p:cNvPr>
                      <p:cNvPicPr/>
                      <p:nvPr/>
                    </p:nvPicPr>
                    <p:blipFill>
                      <a:blip r:embed="rId10"/>
                      <a:stretch>
                        <a:fillRect/>
                      </a:stretch>
                    </p:blipFill>
                    <p:spPr>
                      <a:xfrm>
                        <a:off x="566738" y="3363913"/>
                        <a:ext cx="3222625" cy="1990725"/>
                      </a:xfrm>
                      <a:prstGeom prst="rect">
                        <a:avLst/>
                      </a:prstGeom>
                    </p:spPr>
                  </p:pic>
                </p:oleObj>
              </mc:Fallback>
            </mc:AlternateContent>
          </a:graphicData>
        </a:graphic>
      </p:graphicFrame>
      <p:sp>
        <p:nvSpPr>
          <p:cNvPr id="4" name="文本框 3">
            <a:extLst>
              <a:ext uri="{FF2B5EF4-FFF2-40B4-BE49-F238E27FC236}">
                <a16:creationId xmlns:a16="http://schemas.microsoft.com/office/drawing/2014/main" id="{7B756A8E-4356-F700-3F01-785DDAE94999}"/>
              </a:ext>
            </a:extLst>
          </p:cNvPr>
          <p:cNvSpPr txBox="1"/>
          <p:nvPr/>
        </p:nvSpPr>
        <p:spPr>
          <a:xfrm>
            <a:off x="484069" y="3259490"/>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d</a:t>
            </a:r>
            <a:endParaRPr lang="zh-CN" altLang="en-US" sz="1200" b="1" dirty="0">
              <a:latin typeface="Arial" panose="020B0604020202020204" pitchFamily="34" charset="0"/>
              <a:cs typeface="Arial" panose="020B0604020202020204" pitchFamily="34" charset="0"/>
            </a:endParaRPr>
          </a:p>
        </p:txBody>
      </p:sp>
      <p:sp>
        <p:nvSpPr>
          <p:cNvPr id="5" name="文本框 4">
            <a:extLst>
              <a:ext uri="{FF2B5EF4-FFF2-40B4-BE49-F238E27FC236}">
                <a16:creationId xmlns:a16="http://schemas.microsoft.com/office/drawing/2014/main" id="{25625A0E-A0E2-4B57-9CF9-774E38F8C4DF}"/>
              </a:ext>
            </a:extLst>
          </p:cNvPr>
          <p:cNvSpPr txBox="1"/>
          <p:nvPr/>
        </p:nvSpPr>
        <p:spPr>
          <a:xfrm>
            <a:off x="3636643" y="3259489"/>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e</a:t>
            </a:r>
            <a:endParaRPr lang="zh-CN" altLang="en-US" sz="1200" b="1" dirty="0">
              <a:latin typeface="Arial" panose="020B0604020202020204" pitchFamily="34" charset="0"/>
              <a:cs typeface="Arial" panose="020B0604020202020204" pitchFamily="34" charset="0"/>
            </a:endParaRPr>
          </a:p>
        </p:txBody>
      </p:sp>
      <p:graphicFrame>
        <p:nvGraphicFramePr>
          <p:cNvPr id="6" name="对象 5">
            <a:extLst>
              <a:ext uri="{FF2B5EF4-FFF2-40B4-BE49-F238E27FC236}">
                <a16:creationId xmlns:a16="http://schemas.microsoft.com/office/drawing/2014/main" id="{F1838C3A-FA5A-682D-83B7-A8591BE8C1DE}"/>
              </a:ext>
            </a:extLst>
          </p:cNvPr>
          <p:cNvGraphicFramePr>
            <a:graphicFrameLocks noChangeAspect="1"/>
          </p:cNvGraphicFramePr>
          <p:nvPr>
            <p:extLst>
              <p:ext uri="{D42A27DB-BD31-4B8C-83A1-F6EECF244321}">
                <p14:modId xmlns:p14="http://schemas.microsoft.com/office/powerpoint/2010/main" val="1876016433"/>
              </p:ext>
            </p:extLst>
          </p:nvPr>
        </p:nvGraphicFramePr>
        <p:xfrm>
          <a:off x="4995863" y="5346700"/>
          <a:ext cx="1571625" cy="2266950"/>
        </p:xfrm>
        <a:graphic>
          <a:graphicData uri="http://schemas.openxmlformats.org/presentationml/2006/ole">
            <mc:AlternateContent xmlns:mc="http://schemas.openxmlformats.org/markup-compatibility/2006">
              <mc:Choice xmlns:v="urn:schemas-microsoft-com:vml" Requires="v">
                <p:oleObj name="Prism 9" r:id="rId11" imgW="2592031" imgH="3739641" progId="Prism9.Document">
                  <p:embed/>
                </p:oleObj>
              </mc:Choice>
              <mc:Fallback>
                <p:oleObj name="Prism 9" r:id="rId11" imgW="2592031" imgH="3739641" progId="Prism9.Document">
                  <p:embed/>
                  <p:pic>
                    <p:nvPicPr>
                      <p:cNvPr id="2" name="对象 1">
                        <a:extLst>
                          <a:ext uri="{FF2B5EF4-FFF2-40B4-BE49-F238E27FC236}">
                            <a16:creationId xmlns:a16="http://schemas.microsoft.com/office/drawing/2014/main" id="{A17DE82A-19D9-ED35-4244-FE6C5ACEF08C}"/>
                          </a:ext>
                        </a:extLst>
                      </p:cNvPr>
                      <p:cNvPicPr/>
                      <p:nvPr/>
                    </p:nvPicPr>
                    <p:blipFill>
                      <a:blip r:embed="rId12"/>
                      <a:stretch>
                        <a:fillRect/>
                      </a:stretch>
                    </p:blipFill>
                    <p:spPr>
                      <a:xfrm>
                        <a:off x="4995863" y="5346700"/>
                        <a:ext cx="1571625" cy="2266950"/>
                      </a:xfrm>
                      <a:prstGeom prst="rect">
                        <a:avLst/>
                      </a:prstGeom>
                    </p:spPr>
                  </p:pic>
                </p:oleObj>
              </mc:Fallback>
            </mc:AlternateContent>
          </a:graphicData>
        </a:graphic>
      </p:graphicFrame>
      <p:grpSp>
        <p:nvGrpSpPr>
          <p:cNvPr id="7" name="组合 6">
            <a:extLst>
              <a:ext uri="{FF2B5EF4-FFF2-40B4-BE49-F238E27FC236}">
                <a16:creationId xmlns:a16="http://schemas.microsoft.com/office/drawing/2014/main" id="{0D516887-FE3A-A838-E592-7FBF5C27C286}"/>
              </a:ext>
            </a:extLst>
          </p:cNvPr>
          <p:cNvGrpSpPr/>
          <p:nvPr/>
        </p:nvGrpSpPr>
        <p:grpSpPr>
          <a:xfrm>
            <a:off x="398691" y="5591564"/>
            <a:ext cx="5991150" cy="2273287"/>
            <a:chOff x="627391" y="709088"/>
            <a:chExt cx="5991150" cy="2273287"/>
          </a:xfrm>
        </p:grpSpPr>
        <p:sp>
          <p:nvSpPr>
            <p:cNvPr id="8" name="文本框 7">
              <a:extLst>
                <a:ext uri="{FF2B5EF4-FFF2-40B4-BE49-F238E27FC236}">
                  <a16:creationId xmlns:a16="http://schemas.microsoft.com/office/drawing/2014/main" id="{1DD426EA-F320-E5F7-3D94-E1183AFB9A67}"/>
                </a:ext>
              </a:extLst>
            </p:cNvPr>
            <p:cNvSpPr txBox="1"/>
            <p:nvPr/>
          </p:nvSpPr>
          <p:spPr>
            <a:xfrm>
              <a:off x="679725" y="729777"/>
              <a:ext cx="2426506" cy="230832"/>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a:latin typeface="Arial" panose="020B0604020202020204" pitchFamily="34" charset="0"/>
                  <a:cs typeface="Arial" panose="020B0604020202020204" pitchFamily="34" charset="0"/>
                </a:rPr>
                <a:t>white RNAi</a:t>
              </a:r>
              <a:r>
                <a:rPr lang="en-US" altLang="zh-CN" sz="900" b="1" dirty="0">
                  <a:latin typeface="Arial" panose="020B0604020202020204" pitchFamily="34" charset="0"/>
                  <a:cs typeface="Arial" panose="020B0604020202020204" pitchFamily="34" charset="0"/>
                </a:rPr>
                <a:t>; </a:t>
              </a:r>
              <a:r>
                <a:rPr lang="en-US" altLang="zh-CN" sz="900" b="1" i="1" dirty="0">
                  <a:latin typeface="Arial" panose="020B0604020202020204" pitchFamily="34" charset="0"/>
                  <a:cs typeface="Arial" panose="020B0604020202020204" pitchFamily="34" charset="0"/>
                </a:rPr>
                <a:t>EGFP</a:t>
              </a:r>
              <a:endParaRPr lang="zh-CN" altLang="en-US" sz="900" b="1" i="1"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B26EA2CC-FCF3-4356-91BC-EFD86A1A5F15}"/>
                </a:ext>
              </a:extLst>
            </p:cNvPr>
            <p:cNvSpPr txBox="1"/>
            <p:nvPr/>
          </p:nvSpPr>
          <p:spPr>
            <a:xfrm>
              <a:off x="2138539" y="730315"/>
              <a:ext cx="2484805" cy="230832"/>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RNAi</a:t>
              </a:r>
              <a:r>
                <a:rPr lang="en-US" altLang="zh-CN" sz="900" b="1" dirty="0">
                  <a:latin typeface="Arial" panose="020B0604020202020204" pitchFamily="34" charset="0"/>
                  <a:cs typeface="Arial" panose="020B0604020202020204" pitchFamily="34" charset="0"/>
                </a:rPr>
                <a:t>; </a:t>
              </a:r>
              <a:r>
                <a:rPr lang="en-US" altLang="zh-CN" sz="900" b="1" i="1" dirty="0">
                  <a:latin typeface="Arial" panose="020B0604020202020204" pitchFamily="34" charset="0"/>
                  <a:cs typeface="Arial" panose="020B0604020202020204" pitchFamily="34" charset="0"/>
                </a:rPr>
                <a:t>EGFP</a:t>
              </a:r>
            </a:p>
          </p:txBody>
        </p:sp>
        <p:sp>
          <p:nvSpPr>
            <p:cNvPr id="10" name="文本框 9">
              <a:extLst>
                <a:ext uri="{FF2B5EF4-FFF2-40B4-BE49-F238E27FC236}">
                  <a16:creationId xmlns:a16="http://schemas.microsoft.com/office/drawing/2014/main" id="{46777F58-009B-D5C3-59D4-9FAD1D4B6DE8}"/>
                </a:ext>
              </a:extLst>
            </p:cNvPr>
            <p:cNvSpPr txBox="1"/>
            <p:nvPr/>
          </p:nvSpPr>
          <p:spPr>
            <a:xfrm>
              <a:off x="3444691" y="709088"/>
              <a:ext cx="3173850" cy="230832"/>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a:t>
              </a:r>
              <a:r>
                <a:rPr lang="en-US" altLang="zh-CN" sz="900" b="1" dirty="0">
                  <a:latin typeface="Arial" panose="020B0604020202020204" pitchFamily="34" charset="0"/>
                  <a:cs typeface="Arial" panose="020B0604020202020204" pitchFamily="34" charset="0"/>
                </a:rPr>
                <a:t>&gt; </a:t>
              </a:r>
              <a:r>
                <a:rPr lang="en-US" altLang="zh-CN" sz="900" b="1" i="1" dirty="0" err="1">
                  <a:latin typeface="Arial" panose="020B0604020202020204" pitchFamily="34" charset="0"/>
                  <a:cs typeface="Arial" panose="020B0604020202020204" pitchFamily="34" charset="0"/>
                </a:rPr>
                <a:t>dAcsl</a:t>
              </a:r>
              <a:r>
                <a:rPr lang="en-US" altLang="zh-CN" sz="900" b="1" i="1" dirty="0">
                  <a:latin typeface="Arial" panose="020B0604020202020204" pitchFamily="34" charset="0"/>
                  <a:cs typeface="Arial" panose="020B0604020202020204" pitchFamily="34" charset="0"/>
                </a:rPr>
                <a:t> RNAi</a:t>
              </a:r>
              <a:r>
                <a:rPr lang="en-US" altLang="zh-CN" sz="900" b="1" dirty="0">
                  <a:latin typeface="Arial" panose="020B0604020202020204" pitchFamily="34" charset="0"/>
                  <a:cs typeface="Arial" panose="020B0604020202020204" pitchFamily="34" charset="0"/>
                </a:rPr>
                <a:t>/</a:t>
              </a:r>
              <a:r>
                <a:rPr lang="en-US" altLang="zh-CN" sz="900" b="1" i="1" dirty="0">
                  <a:latin typeface="Arial" panose="020B0604020202020204" pitchFamily="34" charset="0"/>
                  <a:cs typeface="Arial" panose="020B0604020202020204" pitchFamily="34" charset="0"/>
                </a:rPr>
                <a:t>eEF1α1 RNAi</a:t>
              </a:r>
            </a:p>
          </p:txBody>
        </p:sp>
        <p:pic>
          <p:nvPicPr>
            <p:cNvPr id="11" name="图片 10">
              <a:extLst>
                <a:ext uri="{FF2B5EF4-FFF2-40B4-BE49-F238E27FC236}">
                  <a16:creationId xmlns:a16="http://schemas.microsoft.com/office/drawing/2014/main" id="{85CD377F-115A-9AF3-2FA4-443C6F0B2D01}"/>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629668" y="1013026"/>
              <a:ext cx="1411381" cy="1057519"/>
            </a:xfrm>
            <a:prstGeom prst="rect">
              <a:avLst/>
            </a:prstGeom>
          </p:spPr>
        </p:pic>
        <p:sp>
          <p:nvSpPr>
            <p:cNvPr id="12" name="文本框 11">
              <a:extLst>
                <a:ext uri="{FF2B5EF4-FFF2-40B4-BE49-F238E27FC236}">
                  <a16:creationId xmlns:a16="http://schemas.microsoft.com/office/drawing/2014/main" id="{922DE8EC-3C10-2579-B17E-6F1E244EF7FD}"/>
                </a:ext>
              </a:extLst>
            </p:cNvPr>
            <p:cNvSpPr txBox="1"/>
            <p:nvPr/>
          </p:nvSpPr>
          <p:spPr>
            <a:xfrm>
              <a:off x="627391" y="1838142"/>
              <a:ext cx="981679" cy="230832"/>
            </a:xfrm>
            <a:prstGeom prst="rect">
              <a:avLst/>
            </a:prstGeom>
            <a:noFill/>
          </p:spPr>
          <p:txBody>
            <a:bodyPr wrap="square" rtlCol="0">
              <a:spAutoFit/>
            </a:bodyPr>
            <a:lstStyle/>
            <a:p>
              <a:r>
                <a:rPr lang="en-US" altLang="zh-CN" sz="900" b="1" dirty="0">
                  <a:solidFill>
                    <a:srgbClr val="07B10F"/>
                  </a:solidFill>
                  <a:latin typeface="Arial" panose="020B0604020202020204" pitchFamily="34" charset="0"/>
                  <a:cs typeface="Arial" panose="020B0604020202020204" pitchFamily="34" charset="0"/>
                </a:rPr>
                <a:t>BODIPY</a:t>
              </a:r>
              <a:endParaRPr lang="zh-CN" altLang="en-US" sz="900" b="1" dirty="0">
                <a:solidFill>
                  <a:srgbClr val="07B10F"/>
                </a:solidFill>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303E8F92-3CDA-21D5-A4C2-18D4C2AF552C}"/>
                </a:ext>
              </a:extLst>
            </p:cNvPr>
            <p:cNvSpPr txBox="1"/>
            <p:nvPr/>
          </p:nvSpPr>
          <p:spPr>
            <a:xfrm>
              <a:off x="2186185" y="2705460"/>
              <a:ext cx="896815" cy="253916"/>
            </a:xfrm>
            <a:prstGeom prst="rect">
              <a:avLst/>
            </a:prstGeom>
            <a:noFill/>
          </p:spPr>
          <p:txBody>
            <a:bodyPr wrap="square" rtlCol="0">
              <a:spAutoFit/>
            </a:bodyPr>
            <a:lstStyle/>
            <a:p>
              <a:r>
                <a:rPr lang="en-US" altLang="zh-CN" sz="1050" b="1" dirty="0">
                  <a:solidFill>
                    <a:schemeClr val="bg1"/>
                  </a:solidFill>
                  <a:latin typeface="Times New Roman" panose="02020603050405020304" pitchFamily="18" charset="0"/>
                  <a:cs typeface="Times New Roman" panose="02020603050405020304" pitchFamily="18" charset="0"/>
                </a:rPr>
                <a:t>20 μm</a:t>
              </a:r>
              <a:endParaRPr lang="zh-CN" altLang="en-US" sz="1050" b="1" dirty="0">
                <a:solidFill>
                  <a:schemeClr val="bg1"/>
                </a:solidFill>
                <a:latin typeface="Times New Roman" panose="02020603050405020304" pitchFamily="18" charset="0"/>
                <a:cs typeface="Times New Roman" panose="02020603050405020304" pitchFamily="18" charset="0"/>
              </a:endParaRPr>
            </a:p>
          </p:txBody>
        </p:sp>
        <p:cxnSp>
          <p:nvCxnSpPr>
            <p:cNvPr id="14" name="直接连接符 13">
              <a:extLst>
                <a:ext uri="{FF2B5EF4-FFF2-40B4-BE49-F238E27FC236}">
                  <a16:creationId xmlns:a16="http://schemas.microsoft.com/office/drawing/2014/main" id="{EADC6446-DD71-D175-31EB-CAB66B794069}"/>
                </a:ext>
              </a:extLst>
            </p:cNvPr>
            <p:cNvCxnSpPr>
              <a:cxnSpLocks/>
            </p:cNvCxnSpPr>
            <p:nvPr/>
          </p:nvCxnSpPr>
          <p:spPr>
            <a:xfrm>
              <a:off x="2283304" y="2982375"/>
              <a:ext cx="35128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5" name="图片 14">
              <a:extLst>
                <a:ext uri="{FF2B5EF4-FFF2-40B4-BE49-F238E27FC236}">
                  <a16:creationId xmlns:a16="http://schemas.microsoft.com/office/drawing/2014/main" id="{362395B5-BFBE-6560-51DC-EE9BC30A66A0}"/>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115177" y="1005757"/>
              <a:ext cx="1418986" cy="1063217"/>
            </a:xfrm>
            <a:prstGeom prst="rect">
              <a:avLst/>
            </a:prstGeom>
          </p:spPr>
        </p:pic>
        <p:pic>
          <p:nvPicPr>
            <p:cNvPr id="16" name="图片 15">
              <a:extLst>
                <a:ext uri="{FF2B5EF4-FFF2-40B4-BE49-F238E27FC236}">
                  <a16:creationId xmlns:a16="http://schemas.microsoft.com/office/drawing/2014/main" id="{D48E7E9B-EFF6-28A6-CF9E-50253100DE98}"/>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3594305" y="1007823"/>
              <a:ext cx="1411382" cy="1057520"/>
            </a:xfrm>
            <a:prstGeom prst="rect">
              <a:avLst/>
            </a:prstGeom>
          </p:spPr>
        </p:pic>
      </p:grpSp>
      <p:cxnSp>
        <p:nvCxnSpPr>
          <p:cNvPr id="19" name="直接连接符 18">
            <a:extLst>
              <a:ext uri="{FF2B5EF4-FFF2-40B4-BE49-F238E27FC236}">
                <a16:creationId xmlns:a16="http://schemas.microsoft.com/office/drawing/2014/main" id="{D9E38238-D984-5BEE-8B6C-028AC34A378D}"/>
              </a:ext>
            </a:extLst>
          </p:cNvPr>
          <p:cNvCxnSpPr>
            <a:cxnSpLocks/>
          </p:cNvCxnSpPr>
          <p:nvPr/>
        </p:nvCxnSpPr>
        <p:spPr>
          <a:xfrm>
            <a:off x="4498553" y="6836034"/>
            <a:ext cx="186758" cy="0"/>
          </a:xfrm>
          <a:prstGeom prst="line">
            <a:avLst/>
          </a:prstGeom>
          <a:ln w="0">
            <a:solidFill>
              <a:schemeClr val="bg1"/>
            </a:solidFill>
          </a:ln>
        </p:spPr>
        <p:style>
          <a:lnRef idx="1">
            <a:schemeClr val="accent1"/>
          </a:lnRef>
          <a:fillRef idx="0">
            <a:schemeClr val="accent1"/>
          </a:fillRef>
          <a:effectRef idx="0">
            <a:schemeClr val="accent1"/>
          </a:effectRef>
          <a:fontRef idx="minor">
            <a:schemeClr val="tx1"/>
          </a:fontRef>
        </p:style>
      </p:cxnSp>
      <p:sp>
        <p:nvSpPr>
          <p:cNvPr id="20" name="文本框 19">
            <a:extLst>
              <a:ext uri="{FF2B5EF4-FFF2-40B4-BE49-F238E27FC236}">
                <a16:creationId xmlns:a16="http://schemas.microsoft.com/office/drawing/2014/main" id="{CDDBB9CA-1533-6B6C-3808-163D33D1D8F2}"/>
              </a:ext>
            </a:extLst>
          </p:cNvPr>
          <p:cNvSpPr txBox="1"/>
          <p:nvPr/>
        </p:nvSpPr>
        <p:spPr>
          <a:xfrm>
            <a:off x="153198" y="5365410"/>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f</a:t>
            </a:r>
            <a:endParaRPr lang="zh-CN" altLang="en-US" sz="1200" b="1" dirty="0">
              <a:latin typeface="Arial" panose="020B0604020202020204" pitchFamily="34" charset="0"/>
              <a:cs typeface="Arial" panose="020B0604020202020204" pitchFamily="34" charset="0"/>
            </a:endParaRPr>
          </a:p>
        </p:txBody>
      </p:sp>
      <p:sp>
        <p:nvSpPr>
          <p:cNvPr id="21" name="文本框 4">
            <a:extLst>
              <a:ext uri="{FF2B5EF4-FFF2-40B4-BE49-F238E27FC236}">
                <a16:creationId xmlns:a16="http://schemas.microsoft.com/office/drawing/2014/main" id="{25625A0E-A0E2-4B57-9CF9-774E38F8C4DF}"/>
              </a:ext>
            </a:extLst>
          </p:cNvPr>
          <p:cNvSpPr txBox="1"/>
          <p:nvPr/>
        </p:nvSpPr>
        <p:spPr>
          <a:xfrm>
            <a:off x="4889668" y="5356661"/>
            <a:ext cx="543224" cy="27699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altLang="zh-CN" sz="1200" b="1" dirty="0">
                <a:latin typeface="Arial" panose="020B0604020202020204" pitchFamily="34" charset="0"/>
                <a:cs typeface="Arial" panose="020B0604020202020204" pitchFamily="34" charset="0"/>
              </a:rPr>
              <a:t>g</a:t>
            </a:r>
            <a:endParaRPr lang="zh-CN" altLang="en-US" sz="1200" b="1" dirty="0">
              <a:latin typeface="Arial" panose="020B0604020202020204" pitchFamily="34" charset="0"/>
              <a:cs typeface="Arial" panose="020B0604020202020204" pitchFamily="34" charset="0"/>
            </a:endParaRPr>
          </a:p>
        </p:txBody>
      </p:sp>
      <p:sp>
        <p:nvSpPr>
          <p:cNvPr id="17" name="文本框 16">
            <a:extLst>
              <a:ext uri="{FF2B5EF4-FFF2-40B4-BE49-F238E27FC236}">
                <a16:creationId xmlns:a16="http://schemas.microsoft.com/office/drawing/2014/main" id="{DEC0FD45-99CF-0DDF-2F9A-57B44908E4CB}"/>
              </a:ext>
            </a:extLst>
          </p:cNvPr>
          <p:cNvSpPr txBox="1"/>
          <p:nvPr/>
        </p:nvSpPr>
        <p:spPr>
          <a:xfrm>
            <a:off x="-73711" y="1434957"/>
            <a:ext cx="1117164" cy="21544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250 kDa</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167265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6" name="组合 75">
            <a:extLst>
              <a:ext uri="{FF2B5EF4-FFF2-40B4-BE49-F238E27FC236}">
                <a16:creationId xmlns:a16="http://schemas.microsoft.com/office/drawing/2014/main" id="{423C5CA9-2BA4-5BD0-3A77-500DE2EE5880}"/>
              </a:ext>
            </a:extLst>
          </p:cNvPr>
          <p:cNvGrpSpPr/>
          <p:nvPr/>
        </p:nvGrpSpPr>
        <p:grpSpPr>
          <a:xfrm>
            <a:off x="93987" y="39825"/>
            <a:ext cx="6324276" cy="3089138"/>
            <a:chOff x="83101" y="622210"/>
            <a:chExt cx="6324276" cy="3089138"/>
          </a:xfrm>
        </p:grpSpPr>
        <p:grpSp>
          <p:nvGrpSpPr>
            <p:cNvPr id="34" name="组合 33">
              <a:extLst>
                <a:ext uri="{FF2B5EF4-FFF2-40B4-BE49-F238E27FC236}">
                  <a16:creationId xmlns:a16="http://schemas.microsoft.com/office/drawing/2014/main" id="{5F531429-2537-DCF9-29F0-32AD7357C902}"/>
                </a:ext>
              </a:extLst>
            </p:cNvPr>
            <p:cNvGrpSpPr/>
            <p:nvPr/>
          </p:nvGrpSpPr>
          <p:grpSpPr>
            <a:xfrm>
              <a:off x="2805339" y="622210"/>
              <a:ext cx="2319338" cy="3089138"/>
              <a:chOff x="2805339" y="622210"/>
              <a:chExt cx="2319338" cy="3089138"/>
            </a:xfrm>
          </p:grpSpPr>
          <p:sp>
            <p:nvSpPr>
              <p:cNvPr id="41" name="文本框 40">
                <a:extLst>
                  <a:ext uri="{FF2B5EF4-FFF2-40B4-BE49-F238E27FC236}">
                    <a16:creationId xmlns:a16="http://schemas.microsoft.com/office/drawing/2014/main" id="{682F976A-D970-F4C9-8B38-243016A407A8}"/>
                  </a:ext>
                </a:extLst>
              </p:cNvPr>
              <p:cNvSpPr txBox="1"/>
              <p:nvPr/>
            </p:nvSpPr>
            <p:spPr>
              <a:xfrm>
                <a:off x="2867932" y="622210"/>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grpSp>
            <p:nvGrpSpPr>
              <p:cNvPr id="4" name="组合 3">
                <a:extLst>
                  <a:ext uri="{FF2B5EF4-FFF2-40B4-BE49-F238E27FC236}">
                    <a16:creationId xmlns:a16="http://schemas.microsoft.com/office/drawing/2014/main" id="{7C55D925-3E28-1E8D-3108-C55879B61E58}"/>
                  </a:ext>
                </a:extLst>
              </p:cNvPr>
              <p:cNvGrpSpPr/>
              <p:nvPr/>
            </p:nvGrpSpPr>
            <p:grpSpPr>
              <a:xfrm>
                <a:off x="2805339" y="691923"/>
                <a:ext cx="2319338" cy="3019425"/>
                <a:chOff x="374125" y="3257532"/>
                <a:chExt cx="2571249" cy="3137964"/>
              </a:xfrm>
            </p:grpSpPr>
            <p:graphicFrame>
              <p:nvGraphicFramePr>
                <p:cNvPr id="5" name="对象 4">
                  <a:extLst>
                    <a:ext uri="{FF2B5EF4-FFF2-40B4-BE49-F238E27FC236}">
                      <a16:creationId xmlns:a16="http://schemas.microsoft.com/office/drawing/2014/main" id="{A225287E-6BCD-A736-8205-7EBC0C88D22A}"/>
                    </a:ext>
                  </a:extLst>
                </p:cNvPr>
                <p:cNvGraphicFramePr>
                  <a:graphicFrameLocks noChangeAspect="1"/>
                </p:cNvGraphicFramePr>
                <p:nvPr>
                  <p:extLst>
                    <p:ext uri="{D42A27DB-BD31-4B8C-83A1-F6EECF244321}">
                      <p14:modId xmlns:p14="http://schemas.microsoft.com/office/powerpoint/2010/main" val="1497079728"/>
                    </p:ext>
                  </p:extLst>
                </p:nvPr>
              </p:nvGraphicFramePr>
              <p:xfrm>
                <a:off x="374125" y="3257532"/>
                <a:ext cx="2571249" cy="3137964"/>
              </p:xfrm>
              <a:graphic>
                <a:graphicData uri="http://schemas.openxmlformats.org/presentationml/2006/ole">
                  <mc:AlternateContent xmlns:mc="http://schemas.openxmlformats.org/markup-compatibility/2006">
                    <mc:Choice xmlns:v="urn:schemas-microsoft-com:vml" Requires="v">
                      <p:oleObj name="Prism 9" r:id="rId2" imgW="3225910" imgH="3934380" progId="Prism9.Document">
                        <p:embed/>
                      </p:oleObj>
                    </mc:Choice>
                    <mc:Fallback>
                      <p:oleObj name="Prism 9" r:id="rId2" imgW="3225910" imgH="3934380" progId="Prism9.Document">
                        <p:embed/>
                        <p:pic>
                          <p:nvPicPr>
                            <p:cNvPr id="5" name="对象 4">
                              <a:extLst>
                                <a:ext uri="{FF2B5EF4-FFF2-40B4-BE49-F238E27FC236}">
                                  <a16:creationId xmlns:a16="http://schemas.microsoft.com/office/drawing/2014/main" id="{A225287E-6BCD-A736-8205-7EBC0C88D22A}"/>
                                </a:ext>
                              </a:extLst>
                            </p:cNvPr>
                            <p:cNvPicPr/>
                            <p:nvPr/>
                          </p:nvPicPr>
                          <p:blipFill>
                            <a:blip r:embed="rId3"/>
                            <a:stretch>
                              <a:fillRect/>
                            </a:stretch>
                          </p:blipFill>
                          <p:spPr>
                            <a:xfrm>
                              <a:off x="374125" y="3257532"/>
                              <a:ext cx="2571249" cy="3137964"/>
                            </a:xfrm>
                            <a:prstGeom prst="rect">
                              <a:avLst/>
                            </a:prstGeom>
                          </p:spPr>
                        </p:pic>
                      </p:oleObj>
                    </mc:Fallback>
                  </mc:AlternateContent>
                </a:graphicData>
              </a:graphic>
            </p:graphicFrame>
            <p:sp>
              <p:nvSpPr>
                <p:cNvPr id="7" name="文本框 6">
                  <a:extLst>
                    <a:ext uri="{FF2B5EF4-FFF2-40B4-BE49-F238E27FC236}">
                      <a16:creationId xmlns:a16="http://schemas.microsoft.com/office/drawing/2014/main" id="{05DC0207-9E01-AB3F-2C5F-93FB4795961E}"/>
                    </a:ext>
                  </a:extLst>
                </p:cNvPr>
                <p:cNvSpPr txBox="1"/>
                <p:nvPr/>
              </p:nvSpPr>
              <p:spPr>
                <a:xfrm>
                  <a:off x="445296" y="4327531"/>
                  <a:ext cx="259142" cy="246221"/>
                </a:xfrm>
                <a:prstGeom prst="rect">
                  <a:avLst/>
                </a:prstGeom>
                <a:noFill/>
              </p:spPr>
              <p:txBody>
                <a:bodyPr wrap="square" rtlCol="0">
                  <a:spAutoFit/>
                </a:bodyPr>
                <a:lstStyle/>
                <a:p>
                  <a:r>
                    <a:rPr lang="en-US" altLang="zh-CN" sz="1000" dirty="0">
                      <a:solidFill>
                        <a:srgbClr val="FF0000"/>
                      </a:solidFill>
                      <a:latin typeface="Arial" panose="020B0604020202020204" pitchFamily="34" charset="0"/>
                      <a:cs typeface="Arial" panose="020B0604020202020204" pitchFamily="34" charset="0"/>
                    </a:rPr>
                    <a:t>*</a:t>
                  </a:r>
                  <a:endParaRPr lang="zh-CN" altLang="en-US" sz="1000" dirty="0">
                    <a:solidFill>
                      <a:srgbClr val="FF0000"/>
                    </a:solidFill>
                    <a:latin typeface="Arial" panose="020B0604020202020204" pitchFamily="34" charset="0"/>
                    <a:cs typeface="Arial" panose="020B0604020202020204" pitchFamily="34" charset="0"/>
                  </a:endParaRPr>
                </a:p>
              </p:txBody>
            </p:sp>
            <p:sp>
              <p:nvSpPr>
                <p:cNvPr id="8" name="文本框 7">
                  <a:extLst>
                    <a:ext uri="{FF2B5EF4-FFF2-40B4-BE49-F238E27FC236}">
                      <a16:creationId xmlns:a16="http://schemas.microsoft.com/office/drawing/2014/main" id="{3BDD8F6D-28E2-FC37-EBC4-689FA6C972AF}"/>
                    </a:ext>
                  </a:extLst>
                </p:cNvPr>
                <p:cNvSpPr txBox="1"/>
                <p:nvPr/>
              </p:nvSpPr>
              <p:spPr>
                <a:xfrm>
                  <a:off x="756426" y="5242562"/>
                  <a:ext cx="259142" cy="246221"/>
                </a:xfrm>
                <a:prstGeom prst="rect">
                  <a:avLst/>
                </a:prstGeom>
                <a:noFill/>
              </p:spPr>
              <p:txBody>
                <a:bodyPr wrap="square" rtlCol="0">
                  <a:spAutoFit/>
                </a:bodyPr>
                <a:lstStyle/>
                <a:p>
                  <a:r>
                    <a:rPr lang="en-US" altLang="zh-CN" sz="1000" dirty="0">
                      <a:solidFill>
                        <a:srgbClr val="FF0000"/>
                      </a:solidFill>
                      <a:latin typeface="Arial" panose="020B0604020202020204" pitchFamily="34" charset="0"/>
                      <a:cs typeface="Arial" panose="020B0604020202020204" pitchFamily="34" charset="0"/>
                    </a:rPr>
                    <a:t>*</a:t>
                  </a:r>
                  <a:endParaRPr lang="zh-CN" altLang="en-US" sz="1000" dirty="0">
                    <a:solidFill>
                      <a:srgbClr val="FF0000"/>
                    </a:solidFill>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1DE783CE-8942-CB56-207B-5CB005BDE559}"/>
                    </a:ext>
                  </a:extLst>
                </p:cNvPr>
                <p:cNvSpPr txBox="1"/>
                <p:nvPr/>
              </p:nvSpPr>
              <p:spPr>
                <a:xfrm>
                  <a:off x="776984" y="3434007"/>
                  <a:ext cx="259142" cy="246221"/>
                </a:xfrm>
                <a:prstGeom prst="rect">
                  <a:avLst/>
                </a:prstGeom>
                <a:noFill/>
              </p:spPr>
              <p:txBody>
                <a:bodyPr wrap="square" rtlCol="0">
                  <a:spAutoFit/>
                </a:bodyPr>
                <a:lstStyle/>
                <a:p>
                  <a:r>
                    <a:rPr lang="en-US" altLang="zh-CN" sz="1000" dirty="0">
                      <a:solidFill>
                        <a:srgbClr val="FF0000"/>
                      </a:solidFill>
                      <a:latin typeface="Arial" panose="020B0604020202020204" pitchFamily="34" charset="0"/>
                      <a:cs typeface="Arial" panose="020B0604020202020204" pitchFamily="34" charset="0"/>
                    </a:rPr>
                    <a:t>*</a:t>
                  </a:r>
                  <a:endParaRPr lang="zh-CN" altLang="en-US" sz="1000" dirty="0">
                    <a:solidFill>
                      <a:srgbClr val="FF0000"/>
                    </a:solidFill>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2B1BDFAD-BC29-A37F-4A21-4D6FB23F8530}"/>
                    </a:ext>
                  </a:extLst>
                </p:cNvPr>
                <p:cNvSpPr txBox="1"/>
                <p:nvPr/>
              </p:nvSpPr>
              <p:spPr>
                <a:xfrm>
                  <a:off x="656246" y="3618263"/>
                  <a:ext cx="366887" cy="246221"/>
                </a:xfrm>
                <a:prstGeom prst="rect">
                  <a:avLst/>
                </a:prstGeom>
                <a:noFill/>
              </p:spPr>
              <p:txBody>
                <a:bodyPr wrap="square" rtlCol="0">
                  <a:spAutoFit/>
                </a:bodyPr>
                <a:lstStyle/>
                <a:p>
                  <a:r>
                    <a:rPr lang="en-US" altLang="zh-CN" sz="1000" dirty="0">
                      <a:solidFill>
                        <a:srgbClr val="FF0000"/>
                      </a:solidFill>
                      <a:latin typeface="Arial" panose="020B0604020202020204" pitchFamily="34" charset="0"/>
                      <a:cs typeface="Arial" panose="020B0604020202020204" pitchFamily="34" charset="0"/>
                    </a:rPr>
                    <a:t>**</a:t>
                  </a:r>
                  <a:endParaRPr lang="zh-CN" altLang="en-US" sz="1000" dirty="0">
                    <a:solidFill>
                      <a:srgbClr val="FF0000"/>
                    </a:solidFill>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9DC41DBB-AC25-30E6-EF22-E34695AB6509}"/>
                    </a:ext>
                  </a:extLst>
                </p:cNvPr>
                <p:cNvSpPr txBox="1"/>
                <p:nvPr/>
              </p:nvSpPr>
              <p:spPr>
                <a:xfrm>
                  <a:off x="732000" y="4148639"/>
                  <a:ext cx="366887" cy="246221"/>
                </a:xfrm>
                <a:prstGeom prst="rect">
                  <a:avLst/>
                </a:prstGeom>
                <a:noFill/>
              </p:spPr>
              <p:txBody>
                <a:bodyPr wrap="square" rtlCol="0">
                  <a:spAutoFit/>
                </a:bodyPr>
                <a:lstStyle/>
                <a:p>
                  <a:r>
                    <a:rPr lang="en-US" altLang="zh-CN" sz="1000" dirty="0">
                      <a:solidFill>
                        <a:srgbClr val="FF0000"/>
                      </a:solidFill>
                      <a:latin typeface="Arial" panose="020B0604020202020204" pitchFamily="34" charset="0"/>
                      <a:cs typeface="Arial" panose="020B0604020202020204" pitchFamily="34" charset="0"/>
                    </a:rPr>
                    <a:t>**</a:t>
                  </a:r>
                  <a:endParaRPr lang="zh-CN" altLang="en-US" sz="1000" dirty="0">
                    <a:solidFill>
                      <a:srgbClr val="FF0000"/>
                    </a:solidFill>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93816030-A5FF-75B3-78F5-039E0446DAC0}"/>
                    </a:ext>
                  </a:extLst>
                </p:cNvPr>
                <p:cNvSpPr txBox="1"/>
                <p:nvPr/>
              </p:nvSpPr>
              <p:spPr>
                <a:xfrm>
                  <a:off x="753796" y="3795593"/>
                  <a:ext cx="259142" cy="246221"/>
                </a:xfrm>
                <a:prstGeom prst="rect">
                  <a:avLst/>
                </a:prstGeom>
                <a:noFill/>
              </p:spPr>
              <p:txBody>
                <a:bodyPr wrap="square" rtlCol="0">
                  <a:spAutoFit/>
                </a:bodyPr>
                <a:lstStyle/>
                <a:p>
                  <a:r>
                    <a:rPr lang="en-US" altLang="zh-CN" sz="1000" dirty="0">
                      <a:solidFill>
                        <a:srgbClr val="FF0000"/>
                      </a:solidFill>
                      <a:latin typeface="Arial" panose="020B0604020202020204" pitchFamily="34" charset="0"/>
                      <a:cs typeface="Arial" panose="020B0604020202020204" pitchFamily="34" charset="0"/>
                    </a:rPr>
                    <a:t>*</a:t>
                  </a:r>
                  <a:endParaRPr lang="zh-CN" altLang="en-US" sz="1000" dirty="0">
                    <a:solidFill>
                      <a:srgbClr val="FF0000"/>
                    </a:solidFill>
                    <a:latin typeface="Arial" panose="020B0604020202020204" pitchFamily="34" charset="0"/>
                    <a:cs typeface="Arial" panose="020B0604020202020204" pitchFamily="34" charset="0"/>
                  </a:endParaRPr>
                </a:p>
              </p:txBody>
            </p:sp>
          </p:grpSp>
        </p:grpSp>
        <p:grpSp>
          <p:nvGrpSpPr>
            <p:cNvPr id="30" name="组合 29">
              <a:extLst>
                <a:ext uri="{FF2B5EF4-FFF2-40B4-BE49-F238E27FC236}">
                  <a16:creationId xmlns:a16="http://schemas.microsoft.com/office/drawing/2014/main" id="{F68E64C9-E91F-5043-A335-C27FF890878C}"/>
                </a:ext>
              </a:extLst>
            </p:cNvPr>
            <p:cNvGrpSpPr/>
            <p:nvPr/>
          </p:nvGrpSpPr>
          <p:grpSpPr>
            <a:xfrm>
              <a:off x="83101" y="1360682"/>
              <a:ext cx="2905260" cy="1444120"/>
              <a:chOff x="83101" y="1360682"/>
              <a:chExt cx="2905260" cy="1444120"/>
            </a:xfrm>
          </p:grpSpPr>
          <p:sp>
            <p:nvSpPr>
              <p:cNvPr id="40" name="文本框 39">
                <a:extLst>
                  <a:ext uri="{FF2B5EF4-FFF2-40B4-BE49-F238E27FC236}">
                    <a16:creationId xmlns:a16="http://schemas.microsoft.com/office/drawing/2014/main" id="{8A2BA05D-4C09-7658-E17C-228D9F67B41E}"/>
                  </a:ext>
                </a:extLst>
              </p:cNvPr>
              <p:cNvSpPr txBox="1"/>
              <p:nvPr/>
            </p:nvSpPr>
            <p:spPr>
              <a:xfrm>
                <a:off x="83101" y="1360682"/>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grpSp>
            <p:nvGrpSpPr>
              <p:cNvPr id="2" name="组合 1">
                <a:extLst>
                  <a:ext uri="{FF2B5EF4-FFF2-40B4-BE49-F238E27FC236}">
                    <a16:creationId xmlns:a16="http://schemas.microsoft.com/office/drawing/2014/main" id="{5F88311E-01D5-9F37-7841-C9D4684C7B4A}"/>
                  </a:ext>
                </a:extLst>
              </p:cNvPr>
              <p:cNvGrpSpPr/>
              <p:nvPr/>
            </p:nvGrpSpPr>
            <p:grpSpPr>
              <a:xfrm>
                <a:off x="163558" y="1480110"/>
                <a:ext cx="2824803" cy="1324692"/>
                <a:chOff x="576833" y="4369494"/>
                <a:chExt cx="2852548" cy="1433982"/>
              </a:xfrm>
            </p:grpSpPr>
            <p:pic>
              <p:nvPicPr>
                <p:cNvPr id="3" name="内容占位符 4">
                  <a:extLst>
                    <a:ext uri="{FF2B5EF4-FFF2-40B4-BE49-F238E27FC236}">
                      <a16:creationId xmlns:a16="http://schemas.microsoft.com/office/drawing/2014/main" id="{4AB88B58-2EB4-51B8-CB14-237401F297D4}"/>
                    </a:ext>
                  </a:extLst>
                </p:cNvPr>
                <p:cNvPicPr>
                  <a:picLocks noChangeAspect="1"/>
                </p:cNvPicPr>
                <p:nvPr/>
              </p:nvPicPr>
              <p:blipFill rotWithShape="1">
                <a:blip r:embed="rId4">
                  <a:extLst>
                    <a:ext uri="{28A0092B-C50C-407E-A947-70E740481C1C}">
                      <a14:useLocalDpi xmlns:a14="http://schemas.microsoft.com/office/drawing/2010/main" val="0"/>
                    </a:ext>
                  </a:extLst>
                </a:blip>
                <a:srcRect l="27741" t="41633" r="22097" b="37925"/>
                <a:stretch/>
              </p:blipFill>
              <p:spPr>
                <a:xfrm>
                  <a:off x="1152147" y="4631372"/>
                  <a:ext cx="1767789" cy="579790"/>
                </a:xfrm>
                <a:prstGeom prst="rect">
                  <a:avLst/>
                </a:prstGeom>
                <a:ln w="6350">
                  <a:solidFill>
                    <a:srgbClr val="FFFFFF"/>
                  </a:solidFill>
                </a:ln>
              </p:spPr>
            </p:pic>
            <p:pic>
              <p:nvPicPr>
                <p:cNvPr id="14" name="图片 13">
                  <a:extLst>
                    <a:ext uri="{FF2B5EF4-FFF2-40B4-BE49-F238E27FC236}">
                      <a16:creationId xmlns:a16="http://schemas.microsoft.com/office/drawing/2014/main" id="{CBE627DA-D656-CBEB-EE1B-5BF1A77EC899}"/>
                    </a:ext>
                  </a:extLst>
                </p:cNvPr>
                <p:cNvPicPr>
                  <a:picLocks noChangeAspect="1"/>
                </p:cNvPicPr>
                <p:nvPr/>
              </p:nvPicPr>
              <p:blipFill rotWithShape="1">
                <a:blip r:embed="rId5">
                  <a:extLst>
                    <a:ext uri="{28A0092B-C50C-407E-A947-70E740481C1C}">
                      <a14:useLocalDpi xmlns:a14="http://schemas.microsoft.com/office/drawing/2010/main" val="0"/>
                    </a:ext>
                  </a:extLst>
                </a:blip>
                <a:srcRect l="21215" t="27690" r="28790" b="53933"/>
                <a:stretch/>
              </p:blipFill>
              <p:spPr>
                <a:xfrm>
                  <a:off x="1161535" y="5309676"/>
                  <a:ext cx="1758484" cy="493800"/>
                </a:xfrm>
                <a:prstGeom prst="rect">
                  <a:avLst/>
                </a:prstGeom>
              </p:spPr>
            </p:pic>
            <p:sp>
              <p:nvSpPr>
                <p:cNvPr id="15" name="矩形 14">
                  <a:extLst>
                    <a:ext uri="{FF2B5EF4-FFF2-40B4-BE49-F238E27FC236}">
                      <a16:creationId xmlns:a16="http://schemas.microsoft.com/office/drawing/2014/main" id="{E456CC0F-C0FE-D566-FC2B-CC2A929A6946}"/>
                    </a:ext>
                  </a:extLst>
                </p:cNvPr>
                <p:cNvSpPr/>
                <p:nvPr/>
              </p:nvSpPr>
              <p:spPr>
                <a:xfrm>
                  <a:off x="1155835" y="4631372"/>
                  <a:ext cx="1761494" cy="57979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Arial" panose="020B0604020202020204" pitchFamily="34" charset="0"/>
                    <a:cs typeface="Arial" panose="020B0604020202020204" pitchFamily="34" charset="0"/>
                  </a:endParaRPr>
                </a:p>
              </p:txBody>
            </p:sp>
            <p:sp>
              <p:nvSpPr>
                <p:cNvPr id="16" name="矩形 15">
                  <a:extLst>
                    <a:ext uri="{FF2B5EF4-FFF2-40B4-BE49-F238E27FC236}">
                      <a16:creationId xmlns:a16="http://schemas.microsoft.com/office/drawing/2014/main" id="{6E8E3C86-9857-C267-392D-9FE9B915B306}"/>
                    </a:ext>
                  </a:extLst>
                </p:cNvPr>
                <p:cNvSpPr/>
                <p:nvPr/>
              </p:nvSpPr>
              <p:spPr>
                <a:xfrm>
                  <a:off x="1158187" y="5309676"/>
                  <a:ext cx="1765180" cy="493799"/>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Arial" panose="020B0604020202020204" pitchFamily="34" charset="0"/>
                    <a:cs typeface="Arial" panose="020B0604020202020204" pitchFamily="34" charset="0"/>
                  </a:endParaRPr>
                </a:p>
              </p:txBody>
            </p:sp>
            <p:grpSp>
              <p:nvGrpSpPr>
                <p:cNvPr id="17" name="组合 16">
                  <a:extLst>
                    <a:ext uri="{FF2B5EF4-FFF2-40B4-BE49-F238E27FC236}">
                      <a16:creationId xmlns:a16="http://schemas.microsoft.com/office/drawing/2014/main" id="{0518EAFF-E3DC-F2E6-8D26-C2D63E020162}"/>
                    </a:ext>
                  </a:extLst>
                </p:cNvPr>
                <p:cNvGrpSpPr/>
                <p:nvPr/>
              </p:nvGrpSpPr>
              <p:grpSpPr>
                <a:xfrm>
                  <a:off x="576833" y="4749177"/>
                  <a:ext cx="729992" cy="950747"/>
                  <a:chOff x="1827969" y="2937234"/>
                  <a:chExt cx="1297768" cy="1376514"/>
                </a:xfrm>
              </p:grpSpPr>
              <p:cxnSp>
                <p:nvCxnSpPr>
                  <p:cNvPr id="31" name="直接箭头连接符 30">
                    <a:extLst>
                      <a:ext uri="{FF2B5EF4-FFF2-40B4-BE49-F238E27FC236}">
                        <a16:creationId xmlns:a16="http://schemas.microsoft.com/office/drawing/2014/main" id="{E1BEFF4F-95B0-6079-4496-1F8AC62EEF44}"/>
                      </a:ext>
                    </a:extLst>
                  </p:cNvPr>
                  <p:cNvCxnSpPr>
                    <a:cxnSpLocks/>
                  </p:cNvCxnSpPr>
                  <p:nvPr/>
                </p:nvCxnSpPr>
                <p:spPr>
                  <a:xfrm>
                    <a:off x="2590119" y="4172310"/>
                    <a:ext cx="241537"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2" name="直接箭头连接符 31">
                    <a:extLst>
                      <a:ext uri="{FF2B5EF4-FFF2-40B4-BE49-F238E27FC236}">
                        <a16:creationId xmlns:a16="http://schemas.microsoft.com/office/drawing/2014/main" id="{FEBE840B-5D7D-9388-041D-9B44363A59AA}"/>
                      </a:ext>
                    </a:extLst>
                  </p:cNvPr>
                  <p:cNvCxnSpPr/>
                  <p:nvPr/>
                </p:nvCxnSpPr>
                <p:spPr>
                  <a:xfrm>
                    <a:off x="2583304" y="3117192"/>
                    <a:ext cx="241537"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3" name="文本框 32">
                    <a:extLst>
                      <a:ext uri="{FF2B5EF4-FFF2-40B4-BE49-F238E27FC236}">
                        <a16:creationId xmlns:a16="http://schemas.microsoft.com/office/drawing/2014/main" id="{5F87A06B-CBC3-1991-2400-E30795CD4585}"/>
                      </a:ext>
                    </a:extLst>
                  </p:cNvPr>
                  <p:cNvSpPr txBox="1"/>
                  <p:nvPr/>
                </p:nvSpPr>
                <p:spPr>
                  <a:xfrm>
                    <a:off x="1827969" y="2937234"/>
                    <a:ext cx="1251083" cy="337660"/>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55 kDa</a:t>
                    </a:r>
                    <a:endParaRPr lang="zh-CN" altLang="en-US" sz="800" b="1" dirty="0">
                      <a:latin typeface="Arial" panose="020B0604020202020204" pitchFamily="34" charset="0"/>
                      <a:cs typeface="Arial" panose="020B0604020202020204" pitchFamily="34" charset="0"/>
                    </a:endParaRPr>
                  </a:p>
                </p:txBody>
              </p:sp>
              <p:sp>
                <p:nvSpPr>
                  <p:cNvPr id="36" name="文本框 35">
                    <a:extLst>
                      <a:ext uri="{FF2B5EF4-FFF2-40B4-BE49-F238E27FC236}">
                        <a16:creationId xmlns:a16="http://schemas.microsoft.com/office/drawing/2014/main" id="{77E1088C-487A-7BC5-A638-5B2EC12DA275}"/>
                      </a:ext>
                    </a:extLst>
                  </p:cNvPr>
                  <p:cNvSpPr txBox="1"/>
                  <p:nvPr/>
                </p:nvSpPr>
                <p:spPr>
                  <a:xfrm>
                    <a:off x="1833435" y="3976088"/>
                    <a:ext cx="1292302" cy="337660"/>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68 kDa</a:t>
                    </a:r>
                    <a:endParaRPr lang="zh-CN" altLang="en-US" sz="800" b="1" dirty="0">
                      <a:latin typeface="Arial" panose="020B0604020202020204" pitchFamily="34" charset="0"/>
                      <a:cs typeface="Arial" panose="020B0604020202020204" pitchFamily="34" charset="0"/>
                    </a:endParaRPr>
                  </a:p>
                </p:txBody>
              </p:sp>
            </p:grpSp>
            <p:grpSp>
              <p:nvGrpSpPr>
                <p:cNvPr id="18" name="组合 17">
                  <a:extLst>
                    <a:ext uri="{FF2B5EF4-FFF2-40B4-BE49-F238E27FC236}">
                      <a16:creationId xmlns:a16="http://schemas.microsoft.com/office/drawing/2014/main" id="{BF4111C2-E66D-7617-8F9D-8D454F4F4A37}"/>
                    </a:ext>
                  </a:extLst>
                </p:cNvPr>
                <p:cNvGrpSpPr/>
                <p:nvPr/>
              </p:nvGrpSpPr>
              <p:grpSpPr>
                <a:xfrm>
                  <a:off x="2828037" y="4823246"/>
                  <a:ext cx="601344" cy="839848"/>
                  <a:chOff x="5094747" y="2950721"/>
                  <a:chExt cx="1069056" cy="1493065"/>
                </a:xfrm>
              </p:grpSpPr>
              <p:sp>
                <p:nvSpPr>
                  <p:cNvPr id="27" name="文本框 26">
                    <a:extLst>
                      <a:ext uri="{FF2B5EF4-FFF2-40B4-BE49-F238E27FC236}">
                        <a16:creationId xmlns:a16="http://schemas.microsoft.com/office/drawing/2014/main" id="{1DB29595-8B70-5C0C-AE5A-1AFA629FEDBC}"/>
                      </a:ext>
                    </a:extLst>
                  </p:cNvPr>
                  <p:cNvSpPr txBox="1"/>
                  <p:nvPr/>
                </p:nvSpPr>
                <p:spPr>
                  <a:xfrm>
                    <a:off x="5094747" y="2950721"/>
                    <a:ext cx="1069056" cy="414612"/>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Tubulin</a:t>
                    </a:r>
                    <a:endParaRPr lang="zh-CN" altLang="en-US" sz="800" b="1"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A116EE4E-3360-D535-28AC-E5426DA7C337}"/>
                      </a:ext>
                    </a:extLst>
                  </p:cNvPr>
                  <p:cNvSpPr txBox="1"/>
                  <p:nvPr/>
                </p:nvSpPr>
                <p:spPr>
                  <a:xfrm>
                    <a:off x="5120810" y="4029175"/>
                    <a:ext cx="923026" cy="414611"/>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KDEL</a:t>
                    </a:r>
                    <a:endParaRPr lang="zh-CN" altLang="en-US" sz="800" b="1" dirty="0">
                      <a:latin typeface="Arial" panose="020B0604020202020204" pitchFamily="34" charset="0"/>
                      <a:cs typeface="Arial" panose="020B0604020202020204" pitchFamily="34" charset="0"/>
                    </a:endParaRPr>
                  </a:p>
                </p:txBody>
              </p:sp>
            </p:grpSp>
            <p:grpSp>
              <p:nvGrpSpPr>
                <p:cNvPr id="19" name="组合 18">
                  <a:extLst>
                    <a:ext uri="{FF2B5EF4-FFF2-40B4-BE49-F238E27FC236}">
                      <a16:creationId xmlns:a16="http://schemas.microsoft.com/office/drawing/2014/main" id="{72BB5C87-CD4B-C83A-661F-82EF117E578B}"/>
                    </a:ext>
                  </a:extLst>
                </p:cNvPr>
                <p:cNvGrpSpPr/>
                <p:nvPr/>
              </p:nvGrpSpPr>
              <p:grpSpPr>
                <a:xfrm>
                  <a:off x="1145478" y="4369494"/>
                  <a:ext cx="1722624" cy="239139"/>
                  <a:chOff x="1135161" y="4396653"/>
                  <a:chExt cx="1722624" cy="239139"/>
                </a:xfrm>
              </p:grpSpPr>
              <p:grpSp>
                <p:nvGrpSpPr>
                  <p:cNvPr id="20" name="组合 19">
                    <a:extLst>
                      <a:ext uri="{FF2B5EF4-FFF2-40B4-BE49-F238E27FC236}">
                        <a16:creationId xmlns:a16="http://schemas.microsoft.com/office/drawing/2014/main" id="{5AD3D024-4CB4-395D-0D28-329829C11F2C}"/>
                      </a:ext>
                    </a:extLst>
                  </p:cNvPr>
                  <p:cNvGrpSpPr/>
                  <p:nvPr/>
                </p:nvGrpSpPr>
                <p:grpSpPr>
                  <a:xfrm>
                    <a:off x="1135161" y="4396653"/>
                    <a:ext cx="1722624" cy="239139"/>
                    <a:chOff x="2320532" y="2414768"/>
                    <a:chExt cx="2793687" cy="425134"/>
                  </a:xfrm>
                </p:grpSpPr>
                <p:sp>
                  <p:nvSpPr>
                    <p:cNvPr id="24" name="文本框 23">
                      <a:extLst>
                        <a:ext uri="{FF2B5EF4-FFF2-40B4-BE49-F238E27FC236}">
                          <a16:creationId xmlns:a16="http://schemas.microsoft.com/office/drawing/2014/main" id="{678E9C4A-2394-9BD6-BCAC-C3CCA0C3EA4C}"/>
                        </a:ext>
                      </a:extLst>
                    </p:cNvPr>
                    <p:cNvSpPr txBox="1"/>
                    <p:nvPr/>
                  </p:nvSpPr>
                  <p:spPr>
                    <a:xfrm>
                      <a:off x="2320532" y="2414768"/>
                      <a:ext cx="1437251" cy="414609"/>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Supernatant</a:t>
                      </a:r>
                      <a:endParaRPr lang="zh-CN" altLang="en-US" sz="800" b="1" dirty="0">
                        <a:latin typeface="Arial" panose="020B0604020202020204" pitchFamily="34" charset="0"/>
                        <a:cs typeface="Arial" panose="020B0604020202020204" pitchFamily="34" charset="0"/>
                      </a:endParaRPr>
                    </a:p>
                  </p:txBody>
                </p:sp>
                <p:sp>
                  <p:nvSpPr>
                    <p:cNvPr id="25" name="文本框 24">
                      <a:extLst>
                        <a:ext uri="{FF2B5EF4-FFF2-40B4-BE49-F238E27FC236}">
                          <a16:creationId xmlns:a16="http://schemas.microsoft.com/office/drawing/2014/main" id="{36224F6C-BDAD-8ECE-5070-50D0291ED625}"/>
                        </a:ext>
                      </a:extLst>
                    </p:cNvPr>
                    <p:cNvSpPr txBox="1"/>
                    <p:nvPr/>
                  </p:nvSpPr>
                  <p:spPr>
                    <a:xfrm>
                      <a:off x="3421472" y="2425293"/>
                      <a:ext cx="915320" cy="414609"/>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 PMF</a:t>
                      </a:r>
                      <a:endParaRPr lang="zh-CN" altLang="en-US" sz="800" b="1" dirty="0">
                        <a:latin typeface="Arial" panose="020B0604020202020204" pitchFamily="34" charset="0"/>
                        <a:cs typeface="Arial" panose="020B0604020202020204" pitchFamily="34" charset="0"/>
                      </a:endParaRPr>
                    </a:p>
                  </p:txBody>
                </p:sp>
                <p:sp>
                  <p:nvSpPr>
                    <p:cNvPr id="26" name="文本框 25">
                      <a:extLst>
                        <a:ext uri="{FF2B5EF4-FFF2-40B4-BE49-F238E27FC236}">
                          <a16:creationId xmlns:a16="http://schemas.microsoft.com/office/drawing/2014/main" id="{60DEF66B-D267-840E-9EF7-E1A5D981CCB5}"/>
                        </a:ext>
                      </a:extLst>
                    </p:cNvPr>
                    <p:cNvSpPr txBox="1"/>
                    <p:nvPr/>
                  </p:nvSpPr>
                  <p:spPr>
                    <a:xfrm>
                      <a:off x="4307586" y="2417079"/>
                      <a:ext cx="806633" cy="414609"/>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ER</a:t>
                      </a:r>
                      <a:endParaRPr lang="zh-CN" altLang="en-US" sz="800" b="1" dirty="0">
                        <a:latin typeface="Arial" panose="020B0604020202020204" pitchFamily="34" charset="0"/>
                        <a:cs typeface="Arial" panose="020B0604020202020204" pitchFamily="34" charset="0"/>
                      </a:endParaRPr>
                    </a:p>
                  </p:txBody>
                </p:sp>
              </p:grpSp>
              <p:cxnSp>
                <p:nvCxnSpPr>
                  <p:cNvPr id="21" name="直接连接符 20">
                    <a:extLst>
                      <a:ext uri="{FF2B5EF4-FFF2-40B4-BE49-F238E27FC236}">
                        <a16:creationId xmlns:a16="http://schemas.microsoft.com/office/drawing/2014/main" id="{485613BB-2C10-68BB-4035-438DD9EF7383}"/>
                      </a:ext>
                    </a:extLst>
                  </p:cNvPr>
                  <p:cNvCxnSpPr>
                    <a:cxnSpLocks/>
                  </p:cNvCxnSpPr>
                  <p:nvPr/>
                </p:nvCxnSpPr>
                <p:spPr>
                  <a:xfrm>
                    <a:off x="1292171" y="4585109"/>
                    <a:ext cx="45684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2" name="直接连接符 21">
                    <a:extLst>
                      <a:ext uri="{FF2B5EF4-FFF2-40B4-BE49-F238E27FC236}">
                        <a16:creationId xmlns:a16="http://schemas.microsoft.com/office/drawing/2014/main" id="{A68C54D6-AEF0-1F81-61C9-6EC3C9A018EC}"/>
                      </a:ext>
                    </a:extLst>
                  </p:cNvPr>
                  <p:cNvCxnSpPr>
                    <a:cxnSpLocks/>
                  </p:cNvCxnSpPr>
                  <p:nvPr/>
                </p:nvCxnSpPr>
                <p:spPr>
                  <a:xfrm>
                    <a:off x="1819383" y="4587585"/>
                    <a:ext cx="430709"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3" name="直接连接符 22">
                    <a:extLst>
                      <a:ext uri="{FF2B5EF4-FFF2-40B4-BE49-F238E27FC236}">
                        <a16:creationId xmlns:a16="http://schemas.microsoft.com/office/drawing/2014/main" id="{DD85A49D-BAFD-29B3-6F8E-F6967AF1F21C}"/>
                      </a:ext>
                    </a:extLst>
                  </p:cNvPr>
                  <p:cNvCxnSpPr>
                    <a:cxnSpLocks/>
                  </p:cNvCxnSpPr>
                  <p:nvPr/>
                </p:nvCxnSpPr>
                <p:spPr>
                  <a:xfrm>
                    <a:off x="2319792" y="4587820"/>
                    <a:ext cx="430709" cy="0"/>
                  </a:xfrm>
                  <a:prstGeom prst="line">
                    <a:avLst/>
                  </a:prstGeom>
                  <a:ln w="12700"/>
                </p:spPr>
                <p:style>
                  <a:lnRef idx="1">
                    <a:schemeClr val="dk1"/>
                  </a:lnRef>
                  <a:fillRef idx="0">
                    <a:schemeClr val="dk1"/>
                  </a:fillRef>
                  <a:effectRef idx="0">
                    <a:schemeClr val="dk1"/>
                  </a:effectRef>
                  <a:fontRef idx="minor">
                    <a:schemeClr val="tx1"/>
                  </a:fontRef>
                </p:style>
              </p:cxnSp>
            </p:grpSp>
          </p:grpSp>
        </p:grpSp>
        <p:grpSp>
          <p:nvGrpSpPr>
            <p:cNvPr id="6" name="组合 5">
              <a:extLst>
                <a:ext uri="{FF2B5EF4-FFF2-40B4-BE49-F238E27FC236}">
                  <a16:creationId xmlns:a16="http://schemas.microsoft.com/office/drawing/2014/main" id="{759F42B3-9033-9FFD-C004-20EB0A9D71CA}"/>
                </a:ext>
              </a:extLst>
            </p:cNvPr>
            <p:cNvGrpSpPr/>
            <p:nvPr/>
          </p:nvGrpSpPr>
          <p:grpSpPr>
            <a:xfrm>
              <a:off x="5145216" y="1194344"/>
              <a:ext cx="1262161" cy="2039166"/>
              <a:chOff x="5145216" y="1194344"/>
              <a:chExt cx="1262161" cy="2039166"/>
            </a:xfrm>
          </p:grpSpPr>
          <p:graphicFrame>
            <p:nvGraphicFramePr>
              <p:cNvPr id="13" name="对象 12">
                <a:extLst>
                  <a:ext uri="{FF2B5EF4-FFF2-40B4-BE49-F238E27FC236}">
                    <a16:creationId xmlns:a16="http://schemas.microsoft.com/office/drawing/2014/main" id="{109FDDFC-DC2A-96CC-FD57-879758DB592A}"/>
                  </a:ext>
                </a:extLst>
              </p:cNvPr>
              <p:cNvGraphicFramePr>
                <a:graphicFrameLocks noChangeAspect="1"/>
              </p:cNvGraphicFramePr>
              <p:nvPr>
                <p:extLst>
                  <p:ext uri="{D42A27DB-BD31-4B8C-83A1-F6EECF244321}">
                    <p14:modId xmlns:p14="http://schemas.microsoft.com/office/powerpoint/2010/main" val="4139643203"/>
                  </p:ext>
                </p:extLst>
              </p:nvPr>
            </p:nvGraphicFramePr>
            <p:xfrm>
              <a:off x="5265964" y="1331685"/>
              <a:ext cx="1141413" cy="1901825"/>
            </p:xfrm>
            <a:graphic>
              <a:graphicData uri="http://schemas.openxmlformats.org/presentationml/2006/ole">
                <mc:AlternateContent xmlns:mc="http://schemas.openxmlformats.org/markup-compatibility/2006">
                  <mc:Choice xmlns:v="urn:schemas-microsoft-com:vml" Requires="v">
                    <p:oleObj name="Prism 9" r:id="rId6" imgW="1927555" imgH="3206178" progId="Prism9.Document">
                      <p:embed/>
                    </p:oleObj>
                  </mc:Choice>
                  <mc:Fallback>
                    <p:oleObj name="Prism 9" r:id="rId6" imgW="1927555" imgH="3206178" progId="Prism9.Document">
                      <p:embed/>
                      <p:pic>
                        <p:nvPicPr>
                          <p:cNvPr id="13" name="对象 12">
                            <a:extLst>
                              <a:ext uri="{FF2B5EF4-FFF2-40B4-BE49-F238E27FC236}">
                                <a16:creationId xmlns:a16="http://schemas.microsoft.com/office/drawing/2014/main" id="{109FDDFC-DC2A-96CC-FD57-879758DB592A}"/>
                              </a:ext>
                            </a:extLst>
                          </p:cNvPr>
                          <p:cNvPicPr/>
                          <p:nvPr/>
                        </p:nvPicPr>
                        <p:blipFill>
                          <a:blip r:embed="rId7"/>
                          <a:stretch>
                            <a:fillRect/>
                          </a:stretch>
                        </p:blipFill>
                        <p:spPr>
                          <a:xfrm>
                            <a:off x="5265964" y="1331685"/>
                            <a:ext cx="1141413" cy="1901825"/>
                          </a:xfrm>
                          <a:prstGeom prst="rect">
                            <a:avLst/>
                          </a:prstGeom>
                        </p:spPr>
                      </p:pic>
                    </p:oleObj>
                  </mc:Fallback>
                </mc:AlternateContent>
              </a:graphicData>
            </a:graphic>
          </p:graphicFrame>
          <p:sp>
            <p:nvSpPr>
              <p:cNvPr id="42" name="文本框 41">
                <a:extLst>
                  <a:ext uri="{FF2B5EF4-FFF2-40B4-BE49-F238E27FC236}">
                    <a16:creationId xmlns:a16="http://schemas.microsoft.com/office/drawing/2014/main" id="{88365214-0437-2468-4524-2B991B4EFBCB}"/>
                  </a:ext>
                </a:extLst>
              </p:cNvPr>
              <p:cNvSpPr txBox="1"/>
              <p:nvPr/>
            </p:nvSpPr>
            <p:spPr>
              <a:xfrm>
                <a:off x="5145216" y="1194344"/>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c</a:t>
                </a:r>
                <a:endParaRPr lang="zh-CN" altLang="en-US" sz="1200" b="1" dirty="0">
                  <a:latin typeface="Arial" panose="020B0604020202020204" pitchFamily="34" charset="0"/>
                  <a:cs typeface="Arial" panose="020B0604020202020204" pitchFamily="34" charset="0"/>
                </a:endParaRPr>
              </a:p>
            </p:txBody>
          </p:sp>
        </p:grpSp>
      </p:grpSp>
      <p:grpSp>
        <p:nvGrpSpPr>
          <p:cNvPr id="77" name="组合 76">
            <a:extLst>
              <a:ext uri="{FF2B5EF4-FFF2-40B4-BE49-F238E27FC236}">
                <a16:creationId xmlns:a16="http://schemas.microsoft.com/office/drawing/2014/main" id="{EEF3C4C5-68B8-DB20-11E5-42E9235BA367}"/>
              </a:ext>
            </a:extLst>
          </p:cNvPr>
          <p:cNvGrpSpPr/>
          <p:nvPr/>
        </p:nvGrpSpPr>
        <p:grpSpPr>
          <a:xfrm>
            <a:off x="63500" y="2820411"/>
            <a:ext cx="6880225" cy="3188277"/>
            <a:chOff x="55238" y="3560643"/>
            <a:chExt cx="6880225" cy="3188277"/>
          </a:xfrm>
        </p:grpSpPr>
        <p:graphicFrame>
          <p:nvGraphicFramePr>
            <p:cNvPr id="39" name="对象 38">
              <a:extLst>
                <a:ext uri="{FF2B5EF4-FFF2-40B4-BE49-F238E27FC236}">
                  <a16:creationId xmlns:a16="http://schemas.microsoft.com/office/drawing/2014/main" id="{3ECAD67E-D0BF-78BD-B423-71ABC46FF680}"/>
                </a:ext>
              </a:extLst>
            </p:cNvPr>
            <p:cNvGraphicFramePr>
              <a:graphicFrameLocks noChangeAspect="1"/>
            </p:cNvGraphicFramePr>
            <p:nvPr>
              <p:extLst>
                <p:ext uri="{D42A27DB-BD31-4B8C-83A1-F6EECF244321}">
                  <p14:modId xmlns:p14="http://schemas.microsoft.com/office/powerpoint/2010/main" val="3958049371"/>
                </p:ext>
              </p:extLst>
            </p:nvPr>
          </p:nvGraphicFramePr>
          <p:xfrm>
            <a:off x="55238" y="3669170"/>
            <a:ext cx="6880225" cy="3079750"/>
          </p:xfrm>
          <a:graphic>
            <a:graphicData uri="http://schemas.openxmlformats.org/presentationml/2006/ole">
              <mc:AlternateContent xmlns:mc="http://schemas.openxmlformats.org/markup-compatibility/2006">
                <mc:Choice xmlns:v="urn:schemas-microsoft-com:vml" Requires="v">
                  <p:oleObj name="Prism 9" r:id="rId8" imgW="6762821" imgH="3029437" progId="Prism9.Document">
                    <p:embed/>
                  </p:oleObj>
                </mc:Choice>
                <mc:Fallback>
                  <p:oleObj name="Prism 9" r:id="rId8" imgW="6762821" imgH="3029437" progId="Prism9.Document">
                    <p:embed/>
                    <p:pic>
                      <p:nvPicPr>
                        <p:cNvPr id="39" name="对象 38">
                          <a:extLst>
                            <a:ext uri="{FF2B5EF4-FFF2-40B4-BE49-F238E27FC236}">
                              <a16:creationId xmlns:a16="http://schemas.microsoft.com/office/drawing/2014/main" id="{3ECAD67E-D0BF-78BD-B423-71ABC46FF680}"/>
                            </a:ext>
                          </a:extLst>
                        </p:cNvPr>
                        <p:cNvPicPr/>
                        <p:nvPr/>
                      </p:nvPicPr>
                      <p:blipFill>
                        <a:blip r:embed="rId9"/>
                        <a:stretch>
                          <a:fillRect/>
                        </a:stretch>
                      </p:blipFill>
                      <p:spPr>
                        <a:xfrm>
                          <a:off x="55238" y="3669170"/>
                          <a:ext cx="6880225" cy="3079750"/>
                        </a:xfrm>
                        <a:prstGeom prst="rect">
                          <a:avLst/>
                        </a:prstGeom>
                      </p:spPr>
                    </p:pic>
                  </p:oleObj>
                </mc:Fallback>
              </mc:AlternateContent>
            </a:graphicData>
          </a:graphic>
        </p:graphicFrame>
        <p:sp>
          <p:nvSpPr>
            <p:cNvPr id="43" name="文本框 42">
              <a:extLst>
                <a:ext uri="{FF2B5EF4-FFF2-40B4-BE49-F238E27FC236}">
                  <a16:creationId xmlns:a16="http://schemas.microsoft.com/office/drawing/2014/main" id="{A8C8F688-961C-5BA1-1E24-816864F73EDF}"/>
                </a:ext>
              </a:extLst>
            </p:cNvPr>
            <p:cNvSpPr txBox="1"/>
            <p:nvPr/>
          </p:nvSpPr>
          <p:spPr>
            <a:xfrm>
              <a:off x="722500" y="3560643"/>
              <a:ext cx="543224"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d</a:t>
              </a:r>
              <a:endParaRPr lang="zh-CN" altLang="en-US" sz="1200" b="1" dirty="0">
                <a:latin typeface="Arial" panose="020B0604020202020204" pitchFamily="34" charset="0"/>
                <a:cs typeface="Arial" panose="020B0604020202020204" pitchFamily="34" charset="0"/>
              </a:endParaRPr>
            </a:p>
          </p:txBody>
        </p:sp>
      </p:grpSp>
      <p:sp>
        <p:nvSpPr>
          <p:cNvPr id="46" name="文本框 45">
            <a:extLst>
              <a:ext uri="{FF2B5EF4-FFF2-40B4-BE49-F238E27FC236}">
                <a16:creationId xmlns:a16="http://schemas.microsoft.com/office/drawing/2014/main" id="{B3DFC627-0799-A440-44DA-E4DDFB29B082}"/>
              </a:ext>
            </a:extLst>
          </p:cNvPr>
          <p:cNvSpPr txBox="1"/>
          <p:nvPr/>
        </p:nvSpPr>
        <p:spPr>
          <a:xfrm>
            <a:off x="223923" y="8345871"/>
            <a:ext cx="6477972" cy="1061829"/>
          </a:xfrm>
          <a:prstGeom prst="rect">
            <a:avLst/>
          </a:prstGeom>
          <a:noFill/>
        </p:spPr>
        <p:txBody>
          <a:bodyPr wrap="square">
            <a:spAutoFit/>
          </a:bodyPr>
          <a:lstStyle/>
          <a:p>
            <a:pPr algn="just"/>
            <a:r>
              <a:rPr lang="en-US" altLang="zh-CN" sz="1050" kern="100" dirty="0">
                <a:solidFill>
                  <a:prstClr val="black"/>
                </a:solidFill>
                <a:effectLst/>
                <a:latin typeface="Times New Roman" panose="02020603050405020304" pitchFamily="18" charset="0"/>
                <a:ea typeface="宋体" panose="02010600030101010101" pitchFamily="2" charset="-122"/>
                <a:cs typeface="Times New Roman" panose="02020603050405020304" pitchFamily="18" charset="0"/>
              </a:rPr>
              <a:t>(a) </a:t>
            </a:r>
            <a:r>
              <a:rPr lang="en-US" altLang="zh-CN" sz="1050" dirty="0">
                <a:effectLst/>
                <a:latin typeface="Times New Roman" panose="02020603050405020304" pitchFamily="18" charset="0"/>
                <a:ea typeface="宋体" panose="02010600030101010101" pitchFamily="2" charset="-122"/>
              </a:rPr>
              <a:t>Western blot results showed that the ER marker protein KDEL was significantly enriched in the isolated ER with less contamination of microtubules. </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b) Heatmap results comparing </a:t>
            </a:r>
            <a:r>
              <a:rPr kumimoji="0" lang="en-US" altLang="zh-CN" sz="1050" b="0" i="1"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dAcsl</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RNAi and control </a:t>
            </a:r>
            <a:r>
              <a:rPr kumimoji="0" lang="en-US" altLang="zh-CN" sz="1050" b="0" i="1"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white</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RNAi </a:t>
            </a:r>
            <a:r>
              <a:rPr lang="en-US" altLang="zh-CN" sz="1050" kern="1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in </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fat body ER lipidome (n = 3). (c and d) Quantified levels of total PEs (c). Changes in the content of PEs </a:t>
            </a:r>
            <a:r>
              <a:rPr kumimoji="0" lang="en-US" altLang="zh-CN" sz="105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d) </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with different chain lengths in the </a:t>
            </a:r>
            <a:r>
              <a:rPr kumimoji="0" lang="en-US" altLang="zh-CN" sz="1050" b="0" i="1"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dAcsl</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RNAi fat body ER (</a:t>
            </a:r>
            <a:r>
              <a:rPr kumimoji="0" lang="en-US" altLang="zh-CN" sz="1050" b="0" i="1"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n</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 3). Numbers in the figure represent </a:t>
            </a:r>
            <a:r>
              <a:rPr kumimoji="0" lang="en-US" altLang="zh-CN" sz="1050" b="0" i="1"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a:t>
            </a:r>
            <a:r>
              <a:rPr kumimoji="0" lang="en-US" altLang="zh-CN" sz="1050" b="0" i="0" u="none" strike="noStrike" kern="1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values.</a:t>
            </a:r>
            <a:r>
              <a:rPr lang="en-US" altLang="zh-CN" sz="1050" kern="1200" dirty="0">
                <a:solidFill>
                  <a:srgbClr val="000000"/>
                </a:solidFill>
                <a:effectLst/>
                <a:latin typeface="Times New Roman" panose="02020603050405020304" pitchFamily="18" charset="0"/>
                <a:ea typeface="等线" panose="02010600030101010101" pitchFamily="2" charset="-122"/>
              </a:rPr>
              <a:t> (e) The green fluorescent labeled neutral lipids are BODIPY labeled. Scale bar = 20 </a:t>
            </a:r>
            <a:r>
              <a:rPr lang="en-US" altLang="zh-CN" sz="1050" kern="1200" dirty="0" err="1">
                <a:solidFill>
                  <a:srgbClr val="000000"/>
                </a:solidFill>
                <a:effectLst/>
                <a:latin typeface="Times New Roman" panose="02020603050405020304" pitchFamily="18" charset="0"/>
                <a:ea typeface="等线" panose="02010600030101010101" pitchFamily="2" charset="-122"/>
              </a:rPr>
              <a:t>μm</a:t>
            </a:r>
            <a:r>
              <a:rPr lang="en-US" altLang="zh-CN" sz="1050" kern="1200" dirty="0">
                <a:solidFill>
                  <a:srgbClr val="000000"/>
                </a:solidFill>
                <a:effectLst/>
                <a:latin typeface="Times New Roman" panose="02020603050405020304" pitchFamily="18" charset="0"/>
                <a:ea typeface="等线" panose="02010600030101010101" pitchFamily="2" charset="-122"/>
              </a:rPr>
              <a:t>.</a:t>
            </a:r>
            <a:r>
              <a:rPr lang="en-US" altLang="zh-CN" sz="1050" kern="0" dirty="0">
                <a:effectLst/>
                <a:latin typeface="Times New Roman" panose="02020603050405020304" pitchFamily="18" charset="0"/>
                <a:ea typeface="等线" panose="02010600030101010101" pitchFamily="2" charset="-122"/>
              </a:rPr>
              <a:t> </a:t>
            </a:r>
            <a:r>
              <a:rPr lang="en-US" altLang="zh-CN" sz="1050" kern="1200" dirty="0">
                <a:solidFill>
                  <a:srgbClr val="000000"/>
                </a:solidFill>
                <a:effectLst/>
                <a:latin typeface="Times New Roman" panose="02020603050405020304" pitchFamily="18" charset="0"/>
                <a:ea typeface="等线" panose="02010600030101010101" pitchFamily="2" charset="-122"/>
              </a:rPr>
              <a:t>(f) Statistical results of cg &gt; </a:t>
            </a:r>
            <a:r>
              <a:rPr lang="en-US" altLang="zh-CN" sz="1050" i="1" kern="1200" dirty="0" err="1">
                <a:solidFill>
                  <a:srgbClr val="000000"/>
                </a:solidFill>
                <a:effectLst/>
                <a:latin typeface="Times New Roman" panose="02020603050405020304" pitchFamily="18" charset="0"/>
                <a:ea typeface="等线" panose="02010600030101010101" pitchFamily="2" charset="-122"/>
              </a:rPr>
              <a:t>dAcsl</a:t>
            </a:r>
            <a:r>
              <a:rPr lang="en-US" altLang="zh-CN" sz="1050" i="1" kern="1200" dirty="0">
                <a:solidFill>
                  <a:srgbClr val="000000"/>
                </a:solidFill>
                <a:effectLst/>
                <a:latin typeface="Times New Roman" panose="02020603050405020304" pitchFamily="18" charset="0"/>
                <a:ea typeface="等线" panose="02010600030101010101" pitchFamily="2" charset="-122"/>
              </a:rPr>
              <a:t> RNAi</a:t>
            </a:r>
            <a:r>
              <a:rPr lang="en-US" altLang="zh-CN" sz="1050" kern="1200" dirty="0">
                <a:solidFill>
                  <a:srgbClr val="000000"/>
                </a:solidFill>
                <a:effectLst/>
                <a:latin typeface="Times New Roman" panose="02020603050405020304" pitchFamily="18" charset="0"/>
                <a:ea typeface="等线" panose="02010600030101010101" pitchFamily="2" charset="-122"/>
              </a:rPr>
              <a:t>; </a:t>
            </a:r>
            <a:r>
              <a:rPr lang="en-US" altLang="zh-CN" sz="1050" i="1" kern="1200" dirty="0" err="1">
                <a:solidFill>
                  <a:srgbClr val="000000"/>
                </a:solidFill>
                <a:effectLst/>
                <a:latin typeface="Times New Roman" panose="02020603050405020304" pitchFamily="18" charset="0"/>
                <a:ea typeface="等线" panose="02010600030101010101" pitchFamily="2" charset="-122"/>
              </a:rPr>
              <a:t>pect</a:t>
            </a:r>
            <a:r>
              <a:rPr lang="en-US" altLang="zh-CN" sz="1050" i="1" kern="1200" dirty="0">
                <a:solidFill>
                  <a:srgbClr val="000000"/>
                </a:solidFill>
                <a:effectLst/>
                <a:latin typeface="Times New Roman" panose="02020603050405020304" pitchFamily="18" charset="0"/>
                <a:ea typeface="等线" panose="02010600030101010101" pitchFamily="2" charset="-122"/>
              </a:rPr>
              <a:t> RNAi </a:t>
            </a:r>
            <a:r>
              <a:rPr lang="en-US" altLang="zh-CN" sz="1050" kern="1200" dirty="0">
                <a:solidFill>
                  <a:srgbClr val="000000"/>
                </a:solidFill>
                <a:effectLst/>
                <a:latin typeface="Times New Roman" panose="02020603050405020304" pitchFamily="18" charset="0"/>
                <a:ea typeface="等线" panose="02010600030101010101" pitchFamily="2" charset="-122"/>
              </a:rPr>
              <a:t>and </a:t>
            </a:r>
            <a:r>
              <a:rPr lang="en-US" altLang="zh-CN" sz="1050" i="1" kern="1200" dirty="0">
                <a:solidFill>
                  <a:srgbClr val="000000"/>
                </a:solidFill>
                <a:effectLst/>
                <a:latin typeface="Times New Roman" panose="02020603050405020304" pitchFamily="18" charset="0"/>
                <a:ea typeface="等线" panose="02010600030101010101" pitchFamily="2" charset="-122"/>
              </a:rPr>
              <a:t>cg &gt; </a:t>
            </a:r>
            <a:r>
              <a:rPr lang="en-US" altLang="zh-CN" sz="1050" i="1" kern="1200" dirty="0" err="1">
                <a:solidFill>
                  <a:srgbClr val="000000"/>
                </a:solidFill>
                <a:effectLst/>
                <a:latin typeface="Times New Roman" panose="02020603050405020304" pitchFamily="18" charset="0"/>
                <a:ea typeface="等线" panose="02010600030101010101" pitchFamily="2" charset="-122"/>
              </a:rPr>
              <a:t>dAcsl</a:t>
            </a:r>
            <a:r>
              <a:rPr lang="en-US" altLang="zh-CN" sz="1050" i="1" kern="1200" dirty="0">
                <a:solidFill>
                  <a:srgbClr val="000000"/>
                </a:solidFill>
                <a:effectLst/>
                <a:latin typeface="Times New Roman" panose="02020603050405020304" pitchFamily="18" charset="0"/>
                <a:ea typeface="等线" panose="02010600030101010101" pitchFamily="2" charset="-122"/>
              </a:rPr>
              <a:t> RNAi</a:t>
            </a:r>
            <a:r>
              <a:rPr lang="en-US" altLang="zh-CN" sz="1050" kern="1200" dirty="0">
                <a:solidFill>
                  <a:srgbClr val="000000"/>
                </a:solidFill>
                <a:effectLst/>
                <a:latin typeface="Times New Roman" panose="02020603050405020304" pitchFamily="18" charset="0"/>
                <a:ea typeface="等线" panose="02010600030101010101" pitchFamily="2" charset="-122"/>
              </a:rPr>
              <a:t> (</a:t>
            </a:r>
            <a:r>
              <a:rPr lang="en-US" altLang="zh-CN" sz="1050" i="1" kern="1200" dirty="0">
                <a:solidFill>
                  <a:srgbClr val="000000"/>
                </a:solidFill>
                <a:effectLst/>
                <a:latin typeface="Times New Roman" panose="02020603050405020304" pitchFamily="18" charset="0"/>
                <a:ea typeface="等线" panose="02010600030101010101" pitchFamily="2" charset="-122"/>
              </a:rPr>
              <a:t>n</a:t>
            </a:r>
            <a:r>
              <a:rPr lang="en-US" altLang="zh-CN" sz="1050" kern="1200" dirty="0">
                <a:solidFill>
                  <a:srgbClr val="000000"/>
                </a:solidFill>
                <a:effectLst/>
                <a:latin typeface="Times New Roman" panose="02020603050405020304" pitchFamily="18" charset="0"/>
                <a:ea typeface="等线" panose="02010600030101010101" pitchFamily="2" charset="-122"/>
              </a:rPr>
              <a:t> </a:t>
            </a:r>
            <a:r>
              <a:rPr lang="zh-CN" altLang="en-US" sz="1050" dirty="0">
                <a:solidFill>
                  <a:srgbClr val="000000"/>
                </a:solidFill>
                <a:latin typeface="Times New Roman" panose="02020603050405020304" pitchFamily="18" charset="0"/>
                <a:ea typeface="等线" panose="02010600030101010101" pitchFamily="2" charset="-122"/>
              </a:rPr>
              <a:t>≈</a:t>
            </a:r>
            <a:r>
              <a:rPr lang="en-US" altLang="zh-CN" sz="1050" kern="1200" dirty="0">
                <a:solidFill>
                  <a:srgbClr val="000000"/>
                </a:solidFill>
                <a:effectLst/>
                <a:latin typeface="Times New Roman" panose="02020603050405020304" pitchFamily="18" charset="0"/>
                <a:ea typeface="等线" panose="02010600030101010101" pitchFamily="2" charset="-122"/>
              </a:rPr>
              <a:t> 12). Numbers in the figure represent </a:t>
            </a:r>
            <a:r>
              <a:rPr lang="en-US" altLang="zh-CN" sz="1050" i="1" kern="1200" dirty="0">
                <a:solidFill>
                  <a:srgbClr val="000000"/>
                </a:solidFill>
                <a:effectLst/>
                <a:latin typeface="Times New Roman" panose="02020603050405020304" pitchFamily="18" charset="0"/>
                <a:ea typeface="等线" panose="02010600030101010101" pitchFamily="2" charset="-122"/>
              </a:rPr>
              <a:t>P </a:t>
            </a:r>
            <a:r>
              <a:rPr lang="en-US" altLang="zh-CN" sz="1050" kern="1200" dirty="0">
                <a:solidFill>
                  <a:srgbClr val="000000"/>
                </a:solidFill>
                <a:effectLst/>
                <a:latin typeface="Times New Roman" panose="02020603050405020304" pitchFamily="18" charset="0"/>
                <a:ea typeface="等线" panose="02010600030101010101" pitchFamily="2" charset="-122"/>
              </a:rPr>
              <a:t>values.</a:t>
            </a:r>
            <a:endParaRPr lang="zh-CN" altLang="en-US" sz="1050" dirty="0"/>
          </a:p>
        </p:txBody>
      </p:sp>
      <p:sp>
        <p:nvSpPr>
          <p:cNvPr id="48" name="文本框 47">
            <a:extLst>
              <a:ext uri="{FF2B5EF4-FFF2-40B4-BE49-F238E27FC236}">
                <a16:creationId xmlns:a16="http://schemas.microsoft.com/office/drawing/2014/main" id="{B1882FE4-8D0C-7974-88AE-09D47C36AF5B}"/>
              </a:ext>
            </a:extLst>
          </p:cNvPr>
          <p:cNvSpPr txBox="1"/>
          <p:nvPr/>
        </p:nvSpPr>
        <p:spPr>
          <a:xfrm>
            <a:off x="285699" y="8075198"/>
            <a:ext cx="6416196" cy="253916"/>
          </a:xfrm>
          <a:prstGeom prst="rect">
            <a:avLst/>
          </a:prstGeom>
          <a:noFill/>
        </p:spPr>
        <p:txBody>
          <a:bodyPr wrap="square">
            <a:spAutoFit/>
          </a:bodyPr>
          <a:lstStyle/>
          <a:p>
            <a:pPr algn="ctr"/>
            <a:r>
              <a:rPr lang="en-US" altLang="zh-CN" sz="1050" b="1" dirty="0">
                <a:effectLst/>
                <a:latin typeface="Times New Roman" panose="02020603050405020304" pitchFamily="18" charset="0"/>
                <a:ea typeface="宋体" panose="02010600030101010101" pitchFamily="2" charset="-122"/>
                <a:cs typeface="宋体" panose="02010600030101010101" pitchFamily="2" charset="-122"/>
              </a:rPr>
              <a:t>Fig. </a:t>
            </a:r>
            <a:r>
              <a:rPr lang="en-US" altLang="zh-CN" sz="1050" b="1" dirty="0">
                <a:latin typeface="Times New Roman" panose="02020603050405020304" pitchFamily="18" charset="0"/>
                <a:ea typeface="宋体" panose="02010600030101010101" pitchFamily="2" charset="-122"/>
                <a:cs typeface="宋体" panose="02010600030101010101" pitchFamily="2" charset="-122"/>
              </a:rPr>
              <a:t>S5. </a:t>
            </a:r>
            <a:r>
              <a:rPr lang="en-US" altLang="zh-CN" sz="1050" b="1" dirty="0">
                <a:effectLst/>
                <a:latin typeface="Times New Roman" panose="02020603050405020304" pitchFamily="18" charset="0"/>
                <a:ea typeface="宋体" panose="02010600030101010101" pitchFamily="2" charset="-122"/>
              </a:rPr>
              <a:t>Content changes of  PEs with different chain lengths in the fat body endoplasmic reticulum</a:t>
            </a:r>
            <a:endParaRPr lang="zh-CN" altLang="zh-CN" sz="1050" b="1" kern="100" dirty="0">
              <a:effectLst/>
              <a:latin typeface="Times New Roman" panose="02020603050405020304" pitchFamily="18" charset="0"/>
              <a:ea typeface="宋体" panose="02010600030101010101" pitchFamily="2" charset="-122"/>
            </a:endParaRPr>
          </a:p>
        </p:txBody>
      </p:sp>
      <p:graphicFrame>
        <p:nvGraphicFramePr>
          <p:cNvPr id="89" name="对象 88">
            <a:extLst>
              <a:ext uri="{FF2B5EF4-FFF2-40B4-BE49-F238E27FC236}">
                <a16:creationId xmlns:a16="http://schemas.microsoft.com/office/drawing/2014/main" id="{9644856F-91D1-69A7-D8A2-5D2A675309E8}"/>
              </a:ext>
            </a:extLst>
          </p:cNvPr>
          <p:cNvGraphicFramePr>
            <a:graphicFrameLocks noChangeAspect="1"/>
          </p:cNvGraphicFramePr>
          <p:nvPr>
            <p:extLst>
              <p:ext uri="{D42A27DB-BD31-4B8C-83A1-F6EECF244321}">
                <p14:modId xmlns:p14="http://schemas.microsoft.com/office/powerpoint/2010/main" val="2911884068"/>
              </p:ext>
            </p:extLst>
          </p:nvPr>
        </p:nvGraphicFramePr>
        <p:xfrm>
          <a:off x="4918075" y="5856288"/>
          <a:ext cx="1543050" cy="2200275"/>
        </p:xfrm>
        <a:graphic>
          <a:graphicData uri="http://schemas.openxmlformats.org/presentationml/2006/ole">
            <mc:AlternateContent xmlns:mc="http://schemas.openxmlformats.org/markup-compatibility/2006">
              <mc:Choice xmlns:v="urn:schemas-microsoft-com:vml" Requires="v">
                <p:oleObj name="Prism 9" r:id="rId10" imgW="2401615" imgH="3425755" progId="Prism9.Document">
                  <p:embed/>
                </p:oleObj>
              </mc:Choice>
              <mc:Fallback>
                <p:oleObj name="Prism 9" r:id="rId10" imgW="2401615" imgH="3425755" progId="Prism9.Document">
                  <p:embed/>
                  <p:pic>
                    <p:nvPicPr>
                      <p:cNvPr id="2" name="对象 1">
                        <a:extLst>
                          <a:ext uri="{FF2B5EF4-FFF2-40B4-BE49-F238E27FC236}">
                            <a16:creationId xmlns:a16="http://schemas.microsoft.com/office/drawing/2014/main" id="{9940AC54-B9F5-23F6-417B-7E45D3293758}"/>
                          </a:ext>
                        </a:extLst>
                      </p:cNvPr>
                      <p:cNvPicPr/>
                      <p:nvPr/>
                    </p:nvPicPr>
                    <p:blipFill>
                      <a:blip r:embed="rId11"/>
                      <a:stretch>
                        <a:fillRect/>
                      </a:stretch>
                    </p:blipFill>
                    <p:spPr>
                      <a:xfrm>
                        <a:off x="4918075" y="5856288"/>
                        <a:ext cx="1543050" cy="2200275"/>
                      </a:xfrm>
                      <a:prstGeom prst="rect">
                        <a:avLst/>
                      </a:prstGeom>
                    </p:spPr>
                  </p:pic>
                </p:oleObj>
              </mc:Fallback>
            </mc:AlternateContent>
          </a:graphicData>
        </a:graphic>
      </p:graphicFrame>
      <p:grpSp>
        <p:nvGrpSpPr>
          <p:cNvPr id="101" name="组合 100">
            <a:extLst>
              <a:ext uri="{FF2B5EF4-FFF2-40B4-BE49-F238E27FC236}">
                <a16:creationId xmlns:a16="http://schemas.microsoft.com/office/drawing/2014/main" id="{87F58B60-4E1F-C44F-1669-4B22420C1923}"/>
              </a:ext>
            </a:extLst>
          </p:cNvPr>
          <p:cNvGrpSpPr/>
          <p:nvPr/>
        </p:nvGrpSpPr>
        <p:grpSpPr>
          <a:xfrm>
            <a:off x="460772" y="6097934"/>
            <a:ext cx="5482235" cy="1302974"/>
            <a:chOff x="421786" y="6112150"/>
            <a:chExt cx="5482235" cy="1302974"/>
          </a:xfrm>
        </p:grpSpPr>
        <p:sp>
          <p:nvSpPr>
            <p:cNvPr id="90" name="文本框 89">
              <a:extLst>
                <a:ext uri="{FF2B5EF4-FFF2-40B4-BE49-F238E27FC236}">
                  <a16:creationId xmlns:a16="http://schemas.microsoft.com/office/drawing/2014/main" id="{5268FE62-AF15-72C0-5C4C-AD45DC3309ED}"/>
                </a:ext>
              </a:extLst>
            </p:cNvPr>
            <p:cNvSpPr txBox="1"/>
            <p:nvPr/>
          </p:nvSpPr>
          <p:spPr>
            <a:xfrm>
              <a:off x="3362662" y="6112150"/>
              <a:ext cx="2541359" cy="230832"/>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gt; dAcsl RNAi/</a:t>
              </a:r>
              <a:r>
                <a:rPr lang="en-US" altLang="zh-CN" sz="900" b="1" i="1" dirty="0" err="1">
                  <a:latin typeface="Arial" panose="020B0604020202020204" pitchFamily="34" charset="0"/>
                  <a:cs typeface="Arial" panose="020B0604020202020204" pitchFamily="34" charset="0"/>
                </a:rPr>
                <a:t>pect</a:t>
              </a:r>
              <a:r>
                <a:rPr lang="en-US" altLang="zh-CN" sz="900" b="1" i="1" dirty="0">
                  <a:latin typeface="Arial" panose="020B0604020202020204" pitchFamily="34" charset="0"/>
                  <a:cs typeface="Arial" panose="020B0604020202020204" pitchFamily="34" charset="0"/>
                </a:rPr>
                <a:t> RNAi</a:t>
              </a:r>
            </a:p>
          </p:txBody>
        </p:sp>
        <p:grpSp>
          <p:nvGrpSpPr>
            <p:cNvPr id="91" name="组合 90">
              <a:extLst>
                <a:ext uri="{FF2B5EF4-FFF2-40B4-BE49-F238E27FC236}">
                  <a16:creationId xmlns:a16="http://schemas.microsoft.com/office/drawing/2014/main" id="{D8D7AAD5-8453-2AE6-01E0-BB943424E69E}"/>
                </a:ext>
              </a:extLst>
            </p:cNvPr>
            <p:cNvGrpSpPr/>
            <p:nvPr/>
          </p:nvGrpSpPr>
          <p:grpSpPr>
            <a:xfrm>
              <a:off x="429598" y="6336159"/>
              <a:ext cx="1443944" cy="1078965"/>
              <a:chOff x="553096" y="2384093"/>
              <a:chExt cx="1443944" cy="1078965"/>
            </a:xfrm>
          </p:grpSpPr>
          <p:pic>
            <p:nvPicPr>
              <p:cNvPr id="96" name="图片 95">
                <a:extLst>
                  <a:ext uri="{FF2B5EF4-FFF2-40B4-BE49-F238E27FC236}">
                    <a16:creationId xmlns:a16="http://schemas.microsoft.com/office/drawing/2014/main" id="{F17631BD-C4E4-A091-F392-0DF07AE9FE96}"/>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78320" y="2384093"/>
                <a:ext cx="1418720" cy="1063017"/>
              </a:xfrm>
              <a:prstGeom prst="rect">
                <a:avLst/>
              </a:prstGeom>
            </p:spPr>
          </p:pic>
          <p:sp>
            <p:nvSpPr>
              <p:cNvPr id="97" name="文本框 96">
                <a:extLst>
                  <a:ext uri="{FF2B5EF4-FFF2-40B4-BE49-F238E27FC236}">
                    <a16:creationId xmlns:a16="http://schemas.microsoft.com/office/drawing/2014/main" id="{764031A8-FC0C-6701-1209-83C92FD68B2B}"/>
                  </a:ext>
                </a:extLst>
              </p:cNvPr>
              <p:cNvSpPr txBox="1"/>
              <p:nvPr/>
            </p:nvSpPr>
            <p:spPr>
              <a:xfrm>
                <a:off x="553096" y="3232226"/>
                <a:ext cx="981679" cy="230832"/>
              </a:xfrm>
              <a:prstGeom prst="rect">
                <a:avLst/>
              </a:prstGeom>
              <a:noFill/>
            </p:spPr>
            <p:txBody>
              <a:bodyPr wrap="square" rtlCol="0">
                <a:spAutoFit/>
              </a:bodyPr>
              <a:lstStyle/>
              <a:p>
                <a:r>
                  <a:rPr lang="en-US" altLang="zh-CN" sz="900" b="1" dirty="0">
                    <a:solidFill>
                      <a:srgbClr val="07B10F"/>
                    </a:solidFill>
                    <a:latin typeface="Arial" panose="020B0604020202020204" pitchFamily="34" charset="0"/>
                    <a:cs typeface="Arial" panose="020B0604020202020204" pitchFamily="34" charset="0"/>
                  </a:rPr>
                  <a:t>BODIPY</a:t>
                </a:r>
                <a:endParaRPr lang="zh-CN" altLang="en-US" sz="900" b="1" dirty="0">
                  <a:solidFill>
                    <a:srgbClr val="07B10F"/>
                  </a:solidFill>
                  <a:latin typeface="Arial" panose="020B0604020202020204" pitchFamily="34" charset="0"/>
                  <a:cs typeface="Arial" panose="020B0604020202020204" pitchFamily="34" charset="0"/>
                </a:endParaRPr>
              </a:p>
            </p:txBody>
          </p:sp>
        </p:grpSp>
        <p:sp>
          <p:nvSpPr>
            <p:cNvPr id="92" name="文本框 91">
              <a:extLst>
                <a:ext uri="{FF2B5EF4-FFF2-40B4-BE49-F238E27FC236}">
                  <a16:creationId xmlns:a16="http://schemas.microsoft.com/office/drawing/2014/main" id="{22FBF4E3-C16E-633A-2E7D-8B7CC528C337}"/>
                </a:ext>
              </a:extLst>
            </p:cNvPr>
            <p:cNvSpPr txBox="1"/>
            <p:nvPr/>
          </p:nvSpPr>
          <p:spPr>
            <a:xfrm>
              <a:off x="421786" y="6115144"/>
              <a:ext cx="2485407" cy="230832"/>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gt; white RNAi; EGFP</a:t>
              </a:r>
              <a:endParaRPr lang="zh-CN" altLang="en-US" sz="900" b="1" i="1" dirty="0">
                <a:latin typeface="Arial" panose="020B0604020202020204" pitchFamily="34" charset="0"/>
                <a:cs typeface="Arial" panose="020B0604020202020204" pitchFamily="34" charset="0"/>
              </a:endParaRPr>
            </a:p>
          </p:txBody>
        </p:sp>
        <p:sp>
          <p:nvSpPr>
            <p:cNvPr id="93" name="文本框 92">
              <a:extLst>
                <a:ext uri="{FF2B5EF4-FFF2-40B4-BE49-F238E27FC236}">
                  <a16:creationId xmlns:a16="http://schemas.microsoft.com/office/drawing/2014/main" id="{27FF5910-9F88-EDAA-AB99-5E49883E5042}"/>
                </a:ext>
              </a:extLst>
            </p:cNvPr>
            <p:cNvSpPr txBox="1"/>
            <p:nvPr/>
          </p:nvSpPr>
          <p:spPr>
            <a:xfrm>
              <a:off x="1975909" y="6114779"/>
              <a:ext cx="2151622" cy="230832"/>
            </a:xfrm>
            <a:prstGeom prst="rect">
              <a:avLst/>
            </a:prstGeom>
            <a:noFill/>
          </p:spPr>
          <p:txBody>
            <a:bodyPr wrap="square">
              <a:spAutoFit/>
            </a:bodyPr>
            <a:lstStyle/>
            <a:p>
              <a:r>
                <a:rPr lang="en-US" altLang="zh-CN" sz="900" b="1" i="1" dirty="0">
                  <a:latin typeface="Arial" panose="020B0604020202020204" pitchFamily="34" charset="0"/>
                  <a:cs typeface="Arial" panose="020B0604020202020204" pitchFamily="34" charset="0"/>
                </a:rPr>
                <a:t>cg &gt; dAcsl RNAi; EGFP</a:t>
              </a:r>
            </a:p>
          </p:txBody>
        </p:sp>
        <p:pic>
          <p:nvPicPr>
            <p:cNvPr id="94" name="图片 93">
              <a:extLst>
                <a:ext uri="{FF2B5EF4-FFF2-40B4-BE49-F238E27FC236}">
                  <a16:creationId xmlns:a16="http://schemas.microsoft.com/office/drawing/2014/main" id="{F1676D76-E10B-8A79-2B2C-3E685EB6E4A3}"/>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963804" y="6343892"/>
              <a:ext cx="1418720" cy="1063017"/>
            </a:xfrm>
            <a:prstGeom prst="rect">
              <a:avLst/>
            </a:prstGeom>
          </p:spPr>
        </p:pic>
        <p:pic>
          <p:nvPicPr>
            <p:cNvPr id="95" name="图片 94">
              <a:extLst>
                <a:ext uri="{FF2B5EF4-FFF2-40B4-BE49-F238E27FC236}">
                  <a16:creationId xmlns:a16="http://schemas.microsoft.com/office/drawing/2014/main" id="{DF813834-4971-CE5B-269D-C02281FFDEBA}"/>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3502987" y="6343893"/>
              <a:ext cx="1418719" cy="1063016"/>
            </a:xfrm>
            <a:prstGeom prst="rect">
              <a:avLst/>
            </a:prstGeom>
          </p:spPr>
        </p:pic>
      </p:grpSp>
      <p:sp>
        <p:nvSpPr>
          <p:cNvPr id="103" name="文本框 102">
            <a:extLst>
              <a:ext uri="{FF2B5EF4-FFF2-40B4-BE49-F238E27FC236}">
                <a16:creationId xmlns:a16="http://schemas.microsoft.com/office/drawing/2014/main" id="{E39FD6D6-D70A-00D8-F891-D1E32A495518}"/>
              </a:ext>
            </a:extLst>
          </p:cNvPr>
          <p:cNvSpPr txBox="1"/>
          <p:nvPr/>
        </p:nvSpPr>
        <p:spPr>
          <a:xfrm>
            <a:off x="223923" y="5854032"/>
            <a:ext cx="3429000" cy="276999"/>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07" name="文本框 106">
            <a:extLst>
              <a:ext uri="{FF2B5EF4-FFF2-40B4-BE49-F238E27FC236}">
                <a16:creationId xmlns:a16="http://schemas.microsoft.com/office/drawing/2014/main" id="{6419D0AA-F66D-9B7F-EAE9-9083D89A15E5}"/>
              </a:ext>
            </a:extLst>
          </p:cNvPr>
          <p:cNvSpPr txBox="1"/>
          <p:nvPr/>
        </p:nvSpPr>
        <p:spPr>
          <a:xfrm>
            <a:off x="4938666" y="5817017"/>
            <a:ext cx="3429000" cy="276999"/>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f</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cxnSp>
        <p:nvCxnSpPr>
          <p:cNvPr id="29" name="直接连接符 28">
            <a:extLst>
              <a:ext uri="{FF2B5EF4-FFF2-40B4-BE49-F238E27FC236}">
                <a16:creationId xmlns:a16="http://schemas.microsoft.com/office/drawing/2014/main" id="{2D1ECC27-1E30-146B-F235-B4FFC11F8CD1}"/>
              </a:ext>
            </a:extLst>
          </p:cNvPr>
          <p:cNvCxnSpPr>
            <a:cxnSpLocks/>
          </p:cNvCxnSpPr>
          <p:nvPr/>
        </p:nvCxnSpPr>
        <p:spPr>
          <a:xfrm>
            <a:off x="4662283" y="7258302"/>
            <a:ext cx="186758" cy="0"/>
          </a:xfrm>
          <a:prstGeom prst="line">
            <a:avLst/>
          </a:prstGeom>
          <a:ln w="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062466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a:extLst>
              <a:ext uri="{FF2B5EF4-FFF2-40B4-BE49-F238E27FC236}">
                <a16:creationId xmlns:a16="http://schemas.microsoft.com/office/drawing/2014/main" id="{D94D9039-409C-21BD-C080-4C6510869DD1}"/>
              </a:ext>
            </a:extLst>
          </p:cNvPr>
          <p:cNvGraphicFramePr>
            <a:graphicFrameLocks noGrp="1"/>
          </p:cNvGraphicFramePr>
          <p:nvPr>
            <p:extLst>
              <p:ext uri="{D42A27DB-BD31-4B8C-83A1-F6EECF244321}">
                <p14:modId xmlns:p14="http://schemas.microsoft.com/office/powerpoint/2010/main" val="1467720463"/>
              </p:ext>
            </p:extLst>
          </p:nvPr>
        </p:nvGraphicFramePr>
        <p:xfrm>
          <a:off x="1295397" y="1938618"/>
          <a:ext cx="4267200" cy="7645400"/>
        </p:xfrm>
        <a:graphic>
          <a:graphicData uri="http://schemas.openxmlformats.org/drawingml/2006/table">
            <a:tbl>
              <a:tblPr>
                <a:tableStyleId>{0505E3EF-67EA-436B-97B2-0124C06EBD24}</a:tableStyleId>
              </a:tblPr>
              <a:tblGrid>
                <a:gridCol w="1066800">
                  <a:extLst>
                    <a:ext uri="{9D8B030D-6E8A-4147-A177-3AD203B41FA5}">
                      <a16:colId xmlns:a16="http://schemas.microsoft.com/office/drawing/2014/main" val="2414577881"/>
                    </a:ext>
                  </a:extLst>
                </a:gridCol>
                <a:gridCol w="1130300">
                  <a:extLst>
                    <a:ext uri="{9D8B030D-6E8A-4147-A177-3AD203B41FA5}">
                      <a16:colId xmlns:a16="http://schemas.microsoft.com/office/drawing/2014/main" val="903718773"/>
                    </a:ext>
                  </a:extLst>
                </a:gridCol>
                <a:gridCol w="2070100">
                  <a:extLst>
                    <a:ext uri="{9D8B030D-6E8A-4147-A177-3AD203B41FA5}">
                      <a16:colId xmlns:a16="http://schemas.microsoft.com/office/drawing/2014/main" val="3383792465"/>
                    </a:ext>
                  </a:extLst>
                </a:gridCol>
              </a:tblGrid>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Gene</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Stock number</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Obvious gut lipids accumulatio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80498266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588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374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129856611"/>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5925</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05275.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871647658"/>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732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233.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496631608"/>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7292</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3244.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73595222"/>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0075</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788.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466435510"/>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0075</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113.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214874474"/>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289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057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598966934"/>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289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057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1932540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210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362.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520026739"/>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8769</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3929</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16086229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352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a:effectLst/>
                          <a:latin typeface="Times New Roman" panose="02020603050405020304" pitchFamily="18" charset="0"/>
                          <a:cs typeface="Times New Roman" panose="02020603050405020304" pitchFamily="18" charset="0"/>
                        </a:rPr>
                        <a:t>THU1732</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338811168"/>
                  </a:ext>
                </a:extLst>
              </a:tr>
              <a:tr h="177800">
                <a:tc>
                  <a:txBody>
                    <a:bodyPr/>
                    <a:lstStyle/>
                    <a:p>
                      <a:pPr algn="ctr" fontAlgn="t"/>
                      <a:r>
                        <a:rPr lang="en-US" sz="1100" b="1" u="none" strike="noStrike">
                          <a:effectLst/>
                          <a:latin typeface="Times New Roman" panose="02020603050405020304" pitchFamily="18" charset="0"/>
                          <a:cs typeface="Times New Roman" panose="02020603050405020304" pitchFamily="18" charset="0"/>
                        </a:rPr>
                        <a:t>CG11198</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146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132679089"/>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939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428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904750824"/>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3199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a:effectLst/>
                          <a:latin typeface="Times New Roman" panose="02020603050405020304" pitchFamily="18" charset="0"/>
                          <a:cs typeface="Times New Roman" panose="02020603050405020304" pitchFamily="18" charset="0"/>
                        </a:rPr>
                        <a:t>TH05016.N</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92439266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389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832.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89127712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931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578.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994654882"/>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931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255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261794569"/>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532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269.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671356850"/>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210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195.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468016410"/>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04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338.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915611892"/>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04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582.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604336149"/>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305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236.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223098580"/>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970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651.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91919490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711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817.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548744881"/>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990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125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557577115"/>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567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2914</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052969786"/>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0814</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042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43642985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4335</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1256</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051111670"/>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463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TH03983.N</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836512094"/>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CG4389</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601.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045425768"/>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654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04462.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815734404"/>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759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183.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p>
                  </a:txBody>
                  <a:tcPr marL="6350" marR="6350" marT="6350" marB="0" anchor="ctr"/>
                </a:tc>
                <a:extLst>
                  <a:ext uri="{0D108BD9-81ED-4DB2-BD59-A6C34878D82A}">
                    <a16:rowId xmlns:a16="http://schemas.microsoft.com/office/drawing/2014/main" val="3369691574"/>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2</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8540</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844105181"/>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2</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51079</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03630201"/>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Agpat2</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5116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81727628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9657</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252004263"/>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44418</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59711268"/>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Agpat4</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9865</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343910681"/>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4</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46850</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061692369"/>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4</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730</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743790459"/>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5284</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601138359"/>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Agpat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4859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209965819"/>
                  </a:ext>
                </a:extLst>
              </a:tr>
            </a:tbl>
          </a:graphicData>
        </a:graphic>
      </p:graphicFrame>
      <p:sp>
        <p:nvSpPr>
          <p:cNvPr id="2" name="文本框 1">
            <a:extLst>
              <a:ext uri="{FF2B5EF4-FFF2-40B4-BE49-F238E27FC236}">
                <a16:creationId xmlns:a16="http://schemas.microsoft.com/office/drawing/2014/main" id="{EDEF2CDD-FB3B-3F93-0A8F-3EF0EA0BA9EE}"/>
              </a:ext>
            </a:extLst>
          </p:cNvPr>
          <p:cNvSpPr txBox="1"/>
          <p:nvPr/>
        </p:nvSpPr>
        <p:spPr>
          <a:xfrm>
            <a:off x="265578" y="1000044"/>
            <a:ext cx="6326839" cy="769441"/>
          </a:xfrm>
          <a:prstGeom prst="rect">
            <a:avLst/>
          </a:prstGeom>
          <a:noFill/>
        </p:spPr>
        <p:txBody>
          <a:bodyPr wrap="square">
            <a:spAutoFit/>
          </a:bodyPr>
          <a:lstStyle/>
          <a:p>
            <a:pPr algn="just"/>
            <a:r>
              <a:rPr lang="en-US" altLang="zh-CN" sz="1100" i="0" u="none" strike="noStrike" baseline="0" dirty="0">
                <a:latin typeface="Times New Roman" panose="02020603050405020304" pitchFamily="18" charset="0"/>
                <a:cs typeface="Times New Roman" panose="02020603050405020304" pitchFamily="18" charset="0"/>
              </a:rPr>
              <a:t>List of genes examined in acyl-CoAs metabolism related pathway screen. Genes are listed and the stock number in the screen is indicated as is the VDRC or </a:t>
            </a:r>
            <a:r>
              <a:rPr lang="en-US" altLang="zh-CN" sz="1100" dirty="0">
                <a:solidFill>
                  <a:srgbClr val="000000"/>
                </a:solidFill>
                <a:effectLst/>
                <a:latin typeface="Times New Roman" panose="02020603050405020304" pitchFamily="18" charset="0"/>
                <a:ea typeface="宋体" panose="02010600030101010101" pitchFamily="2" charset="-122"/>
              </a:rPr>
              <a:t>Tsinghua Fly Center </a:t>
            </a:r>
            <a:r>
              <a:rPr lang="en-US" altLang="zh-CN" sz="1100" i="0" u="none" strike="noStrike" baseline="0" dirty="0">
                <a:latin typeface="Times New Roman" panose="02020603050405020304" pitchFamily="18" charset="0"/>
                <a:cs typeface="Times New Roman" panose="02020603050405020304" pitchFamily="18" charset="0"/>
              </a:rPr>
              <a:t>stock number. The third column of results showed whether a phenotype of intestinal lipid accumulation was observed during the screening process.</a:t>
            </a:r>
            <a:endParaRPr lang="zh-CN" altLang="en-US" sz="1100" dirty="0">
              <a:latin typeface="Times New Roman" panose="02020603050405020304" pitchFamily="18" charset="0"/>
              <a:cs typeface="Times New Roman" panose="02020603050405020304" pitchFamily="18" charset="0"/>
            </a:endParaRPr>
          </a:p>
        </p:txBody>
      </p:sp>
      <p:sp>
        <p:nvSpPr>
          <p:cNvPr id="3" name="文本框 2">
            <a:extLst>
              <a:ext uri="{FF2B5EF4-FFF2-40B4-BE49-F238E27FC236}">
                <a16:creationId xmlns:a16="http://schemas.microsoft.com/office/drawing/2014/main" id="{4C72D413-2238-8E0A-EDF2-CD236A5338CD}"/>
              </a:ext>
            </a:extLst>
          </p:cNvPr>
          <p:cNvSpPr txBox="1"/>
          <p:nvPr/>
        </p:nvSpPr>
        <p:spPr>
          <a:xfrm>
            <a:off x="-86552" y="653868"/>
            <a:ext cx="7254582" cy="261610"/>
          </a:xfrm>
          <a:prstGeom prst="rect">
            <a:avLst/>
          </a:prstGeom>
          <a:noFill/>
        </p:spPr>
        <p:txBody>
          <a:bodyPr wrap="square">
            <a:spAutoFit/>
          </a:bodyPr>
          <a:lstStyle/>
          <a:p>
            <a:pPr algn="ctr">
              <a:spcAft>
                <a:spcPts val="600"/>
              </a:spcAft>
            </a:pPr>
            <a:r>
              <a:rPr lang="en-US" altLang="zh-CN" sz="1100" b="1" kern="100" dirty="0">
                <a:solidFill>
                  <a:srgbClr val="000000"/>
                </a:solidFill>
                <a:latin typeface="Times New Roman" panose="02020603050405020304" pitchFamily="18" charset="0"/>
                <a:ea typeface="宋体" panose="02010600030101010101" pitchFamily="2" charset="-122"/>
              </a:rPr>
              <a:t>Supplementary Table S1</a:t>
            </a:r>
            <a:r>
              <a:rPr lang="en-US" altLang="zh-CN" sz="1100" b="1" kern="100" dirty="0">
                <a:solidFill>
                  <a:srgbClr val="000000"/>
                </a:solidFill>
                <a:effectLst/>
                <a:latin typeface="Times New Roman" panose="02020603050405020304" pitchFamily="18" charset="0"/>
                <a:ea typeface="宋体" panose="02010600030101010101" pitchFamily="2" charset="-122"/>
              </a:rPr>
              <a:t>. Screen for acyl-CoA metabolism related genes involved in gut lipid homeastasis.</a:t>
            </a:r>
            <a:endParaRPr lang="zh-CN" altLang="zh-CN" sz="1100" b="1" kern="100" dirty="0">
              <a:effectLst/>
              <a:latin typeface="Times New Roman" panose="02020603050405020304" pitchFamily="18" charset="0"/>
              <a:ea typeface="宋体" panose="02010600030101010101" pitchFamily="2" charset="-122"/>
            </a:endParaRPr>
          </a:p>
        </p:txBody>
      </p:sp>
    </p:spTree>
    <p:extLst>
      <p:ext uri="{BB962C8B-B14F-4D97-AF65-F5344CB8AC3E}">
        <p14:creationId xmlns:p14="http://schemas.microsoft.com/office/powerpoint/2010/main" val="25224794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内容占位符 3">
            <a:extLst>
              <a:ext uri="{FF2B5EF4-FFF2-40B4-BE49-F238E27FC236}">
                <a16:creationId xmlns:a16="http://schemas.microsoft.com/office/drawing/2014/main" id="{291D6374-B0FB-1186-0B88-EC684AB9A6FF}"/>
              </a:ext>
            </a:extLst>
          </p:cNvPr>
          <p:cNvGraphicFramePr>
            <a:graphicFrameLocks noGrp="1"/>
          </p:cNvGraphicFramePr>
          <p:nvPr>
            <p:ph idx="1"/>
            <p:extLst>
              <p:ext uri="{D42A27DB-BD31-4B8C-83A1-F6EECF244321}">
                <p14:modId xmlns:p14="http://schemas.microsoft.com/office/powerpoint/2010/main" val="2750216782"/>
              </p:ext>
            </p:extLst>
          </p:nvPr>
        </p:nvGraphicFramePr>
        <p:xfrm>
          <a:off x="1193800" y="762794"/>
          <a:ext cx="4470400" cy="3911600"/>
        </p:xfrm>
        <a:graphic>
          <a:graphicData uri="http://schemas.openxmlformats.org/drawingml/2006/table">
            <a:tbl>
              <a:tblPr>
                <a:tableStyleId>{0505E3EF-67EA-436B-97B2-0124C06EBD24}</a:tableStyleId>
              </a:tblPr>
              <a:tblGrid>
                <a:gridCol w="1016000">
                  <a:extLst>
                    <a:ext uri="{9D8B030D-6E8A-4147-A177-3AD203B41FA5}">
                      <a16:colId xmlns:a16="http://schemas.microsoft.com/office/drawing/2014/main" val="466995425"/>
                    </a:ext>
                  </a:extLst>
                </a:gridCol>
                <a:gridCol w="1054100">
                  <a:extLst>
                    <a:ext uri="{9D8B030D-6E8A-4147-A177-3AD203B41FA5}">
                      <a16:colId xmlns:a16="http://schemas.microsoft.com/office/drawing/2014/main" val="3646702471"/>
                    </a:ext>
                  </a:extLst>
                </a:gridCol>
                <a:gridCol w="2400300">
                  <a:extLst>
                    <a:ext uri="{9D8B030D-6E8A-4147-A177-3AD203B41FA5}">
                      <a16:colId xmlns:a16="http://schemas.microsoft.com/office/drawing/2014/main" val="2558415189"/>
                    </a:ext>
                  </a:extLst>
                </a:gridCol>
              </a:tblGrid>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Gene</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Stock number</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Obvious gut lipids accumulatio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664920603"/>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Lpi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7707</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717666717"/>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Lpi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v36006</a:t>
                      </a:r>
                      <a:endParaRPr lang="en-US" sz="1100" b="1" i="0" u="none" strike="noStrike">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73647133"/>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mdy</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5016.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66031641"/>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mdy</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altLang="zh-CN" sz="1100" b="1" u="none" strike="noStrike" dirty="0">
                          <a:effectLst/>
                          <a:latin typeface="Times New Roman" panose="02020603050405020304" pitchFamily="18" charset="0"/>
                          <a:cs typeface="Times New Roman" panose="02020603050405020304" pitchFamily="18" charset="0"/>
                        </a:rPr>
                        <a:t>20167</a:t>
                      </a:r>
                      <a:endParaRPr lang="en-US" altLang="zh-CN"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200139919"/>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Cds</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111.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733352006"/>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Cd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altLang="zh-CN" sz="1100" b="1" u="none" strike="noStrike" dirty="0">
                          <a:effectLst/>
                          <a:latin typeface="Times New Roman" panose="02020603050405020304" pitchFamily="18" charset="0"/>
                          <a:cs typeface="Times New Roman" panose="02020603050405020304" pitchFamily="18" charset="0"/>
                        </a:rPr>
                        <a:t>16893</a:t>
                      </a:r>
                      <a:endParaRPr lang="en-US" altLang="zh-CN"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139783629"/>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Cd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a:effectLst/>
                          <a:latin typeface="Times New Roman" panose="02020603050405020304" pitchFamily="18" charset="0"/>
                          <a:cs typeface="Times New Roman" panose="02020603050405020304" pitchFamily="18" charset="0"/>
                        </a:rPr>
                        <a:t>THU2916</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936399768"/>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bbc</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10371</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57973917"/>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bbc</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altLang="zh-CN" sz="1100" b="1" u="none" strike="noStrike">
                          <a:effectLst/>
                          <a:latin typeface="Times New Roman" panose="02020603050405020304" pitchFamily="18" charset="0"/>
                          <a:cs typeface="Times New Roman" panose="02020603050405020304" pitchFamily="18" charset="0"/>
                        </a:rPr>
                        <a:t>28459</a:t>
                      </a:r>
                      <a:endParaRPr lang="en-US" altLang="zh-CN"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636394432"/>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bbc</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v7988</a:t>
                      </a:r>
                      <a:endParaRPr lang="en-US" sz="1100" b="1" i="0" u="none" strike="noStrike">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865142695"/>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pss</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5470</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709999919"/>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ps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5391</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yes</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265116526"/>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pisd</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v109033</a:t>
                      </a:r>
                      <a:endParaRPr lang="en-US" sz="1100" b="1" i="0" u="none" strike="noStrike">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no</a:t>
                      </a:r>
                    </a:p>
                  </a:txBody>
                  <a:tcPr marL="6350" marR="6350" marT="6350" marB="0" anchor="ctr"/>
                </a:tc>
                <a:extLst>
                  <a:ext uri="{0D108BD9-81ED-4DB2-BD59-A6C34878D82A}">
                    <a16:rowId xmlns:a16="http://schemas.microsoft.com/office/drawing/2014/main" val="1238196699"/>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pisd</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25483</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281564063"/>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Pi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684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932912339"/>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Pi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v11852</a:t>
                      </a:r>
                      <a:endParaRPr lang="en-US" sz="1100" b="1" i="0" u="none" strike="noStrike">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911785760"/>
                  </a:ext>
                </a:extLst>
              </a:tr>
              <a:tr h="177800">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CLS</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839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997996985"/>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L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674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298850233"/>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ea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5204</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81966579"/>
                  </a:ext>
                </a:extLst>
              </a:tr>
              <a:tr h="177800">
                <a:tc>
                  <a:txBody>
                    <a:bodyPr/>
                    <a:lstStyle/>
                    <a:p>
                      <a:pPr algn="ctr" fontAlgn="ctr"/>
                      <a:r>
                        <a:rPr lang="en-US" sz="1100" b="1" u="none" strike="noStrike" dirty="0" err="1">
                          <a:effectLst/>
                          <a:latin typeface="Times New Roman" panose="02020603050405020304" pitchFamily="18" charset="0"/>
                          <a:cs typeface="Times New Roman" panose="02020603050405020304" pitchFamily="18" charset="0"/>
                        </a:rPr>
                        <a:t>ea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3784</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236199357"/>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3209</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441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038450277"/>
                  </a:ext>
                </a:extLst>
              </a:tr>
            </a:tbl>
          </a:graphicData>
        </a:graphic>
      </p:graphicFrame>
      <p:sp>
        <p:nvSpPr>
          <p:cNvPr id="5" name="文本框 4">
            <a:extLst>
              <a:ext uri="{FF2B5EF4-FFF2-40B4-BE49-F238E27FC236}">
                <a16:creationId xmlns:a16="http://schemas.microsoft.com/office/drawing/2014/main" id="{0B814FC8-3AF0-F29A-CAB4-5AE09B63166A}"/>
              </a:ext>
            </a:extLst>
          </p:cNvPr>
          <p:cNvSpPr txBox="1"/>
          <p:nvPr/>
        </p:nvSpPr>
        <p:spPr>
          <a:xfrm>
            <a:off x="665630" y="196247"/>
            <a:ext cx="5681382" cy="430887"/>
          </a:xfrm>
          <a:prstGeom prst="rect">
            <a:avLst/>
          </a:prstGeom>
          <a:noFill/>
        </p:spPr>
        <p:txBody>
          <a:bodyPr wrap="square">
            <a:spAutoFit/>
          </a:bodyPr>
          <a:lstStyle/>
          <a:p>
            <a:r>
              <a:rPr lang="en-US" altLang="zh-CN" sz="1100" b="1" kern="100" dirty="0">
                <a:solidFill>
                  <a:srgbClr val="000000"/>
                </a:solidFill>
                <a:effectLst/>
                <a:latin typeface="Times New Roman" panose="02020603050405020304" pitchFamily="18" charset="0"/>
                <a:ea typeface="宋体" panose="02010600030101010101" pitchFamily="2" charset="-122"/>
              </a:rPr>
              <a:t>Supplementary Table S1. </a:t>
            </a:r>
            <a:r>
              <a:rPr lang="en-US" altLang="zh-CN" sz="1100" b="1" kern="100" dirty="0">
                <a:solidFill>
                  <a:srgbClr val="000000"/>
                </a:solidFill>
                <a:latin typeface="Times New Roman" panose="02020603050405020304" pitchFamily="18" charset="0"/>
                <a:ea typeface="宋体" panose="02010600030101010101" pitchFamily="2" charset="-122"/>
              </a:rPr>
              <a:t>(continued)</a:t>
            </a:r>
            <a:r>
              <a:rPr lang="en-US" altLang="zh-CN" sz="1100" b="1" kern="100" dirty="0">
                <a:solidFill>
                  <a:srgbClr val="000000"/>
                </a:solidFill>
                <a:effectLst/>
                <a:latin typeface="Times New Roman" panose="02020603050405020304" pitchFamily="18" charset="0"/>
                <a:ea typeface="宋体" panose="02010600030101010101" pitchFamily="2" charset="-122"/>
              </a:rPr>
              <a:t> Screen for acyl-CoA metabolism related genes involved in gut lipid homeastasis.</a:t>
            </a:r>
            <a:endParaRPr lang="zh-CN" altLang="en-US" sz="1100" dirty="0"/>
          </a:p>
        </p:txBody>
      </p:sp>
      <p:graphicFrame>
        <p:nvGraphicFramePr>
          <p:cNvPr id="2" name="表格 5">
            <a:extLst>
              <a:ext uri="{FF2B5EF4-FFF2-40B4-BE49-F238E27FC236}">
                <a16:creationId xmlns:a16="http://schemas.microsoft.com/office/drawing/2014/main" id="{FD47944B-9DEF-9915-24A4-17AB42F73819}"/>
              </a:ext>
            </a:extLst>
          </p:cNvPr>
          <p:cNvGraphicFramePr>
            <a:graphicFrameLocks noGrp="1"/>
          </p:cNvGraphicFramePr>
          <p:nvPr>
            <p:extLst>
              <p:ext uri="{D42A27DB-BD31-4B8C-83A1-F6EECF244321}">
                <p14:modId xmlns:p14="http://schemas.microsoft.com/office/powerpoint/2010/main" val="1826658167"/>
              </p:ext>
            </p:extLst>
          </p:nvPr>
        </p:nvGraphicFramePr>
        <p:xfrm>
          <a:off x="63500" y="6556618"/>
          <a:ext cx="6731000" cy="1352606"/>
        </p:xfrm>
        <a:graphic>
          <a:graphicData uri="http://schemas.openxmlformats.org/drawingml/2006/table">
            <a:tbl>
              <a:tblPr firstRow="1" bandRow="1">
                <a:tableStyleId>{9D7B26C5-4107-4FEC-AEDC-1716B250A1EF}</a:tableStyleId>
              </a:tblPr>
              <a:tblGrid>
                <a:gridCol w="1066056">
                  <a:extLst>
                    <a:ext uri="{9D8B030D-6E8A-4147-A177-3AD203B41FA5}">
                      <a16:colId xmlns:a16="http://schemas.microsoft.com/office/drawing/2014/main" val="3518635481"/>
                    </a:ext>
                  </a:extLst>
                </a:gridCol>
                <a:gridCol w="1364876">
                  <a:extLst>
                    <a:ext uri="{9D8B030D-6E8A-4147-A177-3AD203B41FA5}">
                      <a16:colId xmlns:a16="http://schemas.microsoft.com/office/drawing/2014/main" val="2607161882"/>
                    </a:ext>
                  </a:extLst>
                </a:gridCol>
                <a:gridCol w="1519518">
                  <a:extLst>
                    <a:ext uri="{9D8B030D-6E8A-4147-A177-3AD203B41FA5}">
                      <a16:colId xmlns:a16="http://schemas.microsoft.com/office/drawing/2014/main" val="698876063"/>
                    </a:ext>
                  </a:extLst>
                </a:gridCol>
                <a:gridCol w="1434350">
                  <a:extLst>
                    <a:ext uri="{9D8B030D-6E8A-4147-A177-3AD203B41FA5}">
                      <a16:colId xmlns:a16="http://schemas.microsoft.com/office/drawing/2014/main" val="216328611"/>
                    </a:ext>
                  </a:extLst>
                </a:gridCol>
                <a:gridCol w="1346200">
                  <a:extLst>
                    <a:ext uri="{9D8B030D-6E8A-4147-A177-3AD203B41FA5}">
                      <a16:colId xmlns:a16="http://schemas.microsoft.com/office/drawing/2014/main" val="2122965941"/>
                    </a:ext>
                  </a:extLst>
                </a:gridCol>
              </a:tblGrid>
              <a:tr h="287650">
                <a:tc>
                  <a:txBody>
                    <a:bodyPr/>
                    <a:lstStyle/>
                    <a:p>
                      <a:pPr algn="ct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b="1" i="1" dirty="0">
                          <a:latin typeface="Times New Roman" panose="02020603050405020304" pitchFamily="18" charset="0"/>
                          <a:cs typeface="Times New Roman" panose="02020603050405020304" pitchFamily="18" charset="0"/>
                        </a:rPr>
                        <a:t>white</a:t>
                      </a:r>
                      <a:r>
                        <a:rPr lang="en-US" altLang="zh-CN" sz="1050" b="1" dirty="0">
                          <a:latin typeface="Times New Roman" panose="02020603050405020304" pitchFamily="18" charset="0"/>
                          <a:cs typeface="Times New Roman" panose="02020603050405020304" pitchFamily="18" charset="0"/>
                        </a:rPr>
                        <a:t> RNAi (PSMs)</a:t>
                      </a:r>
                      <a:endParaRPr lang="zh-CN" altLang="en-US" sz="1050" b="1"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b="1" i="1" dirty="0">
                          <a:latin typeface="Times New Roman" panose="02020603050405020304" pitchFamily="18" charset="0"/>
                          <a:cs typeface="Times New Roman" panose="02020603050405020304" pitchFamily="18" charset="0"/>
                        </a:rPr>
                        <a:t>dAcsl</a:t>
                      </a:r>
                      <a:r>
                        <a:rPr lang="en-US" altLang="zh-CN" sz="1050" b="1" dirty="0">
                          <a:latin typeface="Times New Roman" panose="02020603050405020304" pitchFamily="18" charset="0"/>
                          <a:cs typeface="Times New Roman" panose="02020603050405020304" pitchFamily="18" charset="0"/>
                        </a:rPr>
                        <a:t> RNAi -1(PSMs)</a:t>
                      </a:r>
                      <a:endParaRPr lang="zh-CN" altLang="en-US" sz="1050" b="1" dirty="0">
                        <a:latin typeface="Times New Roman" panose="02020603050405020304" pitchFamily="18" charset="0"/>
                        <a:cs typeface="Times New Roman" panose="02020603050405020304" pitchFamily="18" charset="0"/>
                      </a:endParaRPr>
                    </a:p>
                  </a:txBody>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US" altLang="zh-CN" sz="1050" b="1" i="1"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dAcsl</a:t>
                      </a:r>
                      <a:r>
                        <a:rPr kumimoji="0" lang="en-US" altLang="zh-CN" sz="10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RNAi -2(PSMs)</a:t>
                      </a:r>
                      <a:endParaRPr kumimoji="0" lang="zh-CN" altLang="en-US" sz="10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txBody>
                  <a:tcPr/>
                </a:tc>
                <a:tc>
                  <a:txBody>
                    <a:bodyPr/>
                    <a:lstStyle/>
                    <a:p>
                      <a:pPr algn="ctr"/>
                      <a:r>
                        <a:rPr lang="en-US" altLang="zh-CN" sz="1050" b="1" dirty="0">
                          <a:latin typeface="Times New Roman" panose="02020603050405020304" pitchFamily="18" charset="0"/>
                          <a:cs typeface="Times New Roman" panose="02020603050405020304" pitchFamily="18" charset="0"/>
                        </a:rPr>
                        <a:t>MW (kDa)</a:t>
                      </a:r>
                      <a:endParaRPr lang="zh-CN" altLang="en-US" sz="1050" b="1"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3928781849"/>
                  </a:ext>
                </a:extLst>
              </a:tr>
              <a:tr h="254217">
                <a:tc>
                  <a:txBody>
                    <a:bodyPr/>
                    <a:lstStyle/>
                    <a:p>
                      <a:pPr algn="ctr"/>
                      <a:r>
                        <a:rPr lang="en-US" altLang="zh-CN" sz="1050" b="1" dirty="0">
                          <a:latin typeface="Times New Roman" panose="02020603050405020304" pitchFamily="18" charset="0"/>
                          <a:cs typeface="Times New Roman" panose="02020603050405020304" pitchFamily="18" charset="0"/>
                        </a:rPr>
                        <a:t>apoLpp</a:t>
                      </a:r>
                      <a:endParaRPr lang="zh-CN" altLang="en-US" sz="1050" b="1"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601</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466</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234</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250</a:t>
                      </a:r>
                      <a:endParaRPr lang="zh-CN" altLang="en-US" sz="105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1821249461"/>
                  </a:ext>
                </a:extLst>
              </a:tr>
              <a:tr h="296333">
                <a:tc>
                  <a:txBody>
                    <a:bodyPr/>
                    <a:lstStyle/>
                    <a:p>
                      <a:pPr algn="ctr"/>
                      <a:r>
                        <a:rPr lang="en-US" altLang="zh-CN" sz="1050" b="1" dirty="0">
                          <a:latin typeface="Times New Roman" panose="02020603050405020304" pitchFamily="18" charset="0"/>
                          <a:cs typeface="Times New Roman" panose="02020603050405020304" pitchFamily="18" charset="0"/>
                        </a:rPr>
                        <a:t>TIG</a:t>
                      </a:r>
                      <a:endParaRPr lang="zh-CN" altLang="en-US" sz="1050" b="1"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167</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177</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12</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257</a:t>
                      </a:r>
                      <a:endParaRPr lang="zh-CN" altLang="en-US" sz="105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2230865612"/>
                  </a:ext>
                </a:extLst>
              </a:tr>
              <a:tr h="262467">
                <a:tc>
                  <a:txBody>
                    <a:bodyPr/>
                    <a:lstStyle/>
                    <a:p>
                      <a:pPr algn="ctr"/>
                      <a:r>
                        <a:rPr lang="en-US" altLang="zh-CN" sz="1050" b="1" dirty="0">
                          <a:latin typeface="Times New Roman" panose="02020603050405020304" pitchFamily="18" charset="0"/>
                          <a:cs typeface="Times New Roman" panose="02020603050405020304" pitchFamily="18" charset="0"/>
                        </a:rPr>
                        <a:t>FASN1</a:t>
                      </a:r>
                      <a:endParaRPr lang="zh-CN" altLang="en-US" sz="1050" b="1"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42</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62</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15</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266.28</a:t>
                      </a:r>
                      <a:endParaRPr lang="zh-CN" altLang="en-US" sz="105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1754955145"/>
                  </a:ext>
                </a:extLst>
              </a:tr>
              <a:tr h="251939">
                <a:tc>
                  <a:txBody>
                    <a:bodyPr/>
                    <a:lstStyle/>
                    <a:p>
                      <a:pPr algn="ctr"/>
                      <a:r>
                        <a:rPr lang="en-US" altLang="zh-CN" sz="1050" b="1" dirty="0">
                          <a:latin typeface="Times New Roman" panose="02020603050405020304" pitchFamily="18" charset="0"/>
                          <a:cs typeface="Times New Roman" panose="02020603050405020304" pitchFamily="18" charset="0"/>
                        </a:rPr>
                        <a:t>TAQUILA</a:t>
                      </a:r>
                      <a:endParaRPr lang="zh-CN" altLang="en-US" sz="1050" b="1"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19</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20</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4</a:t>
                      </a:r>
                      <a:endParaRPr lang="zh-CN" altLang="en-US" sz="1050" dirty="0">
                        <a:latin typeface="Times New Roman" panose="02020603050405020304" pitchFamily="18" charset="0"/>
                        <a:cs typeface="Times New Roman" panose="02020603050405020304" pitchFamily="18" charset="0"/>
                      </a:endParaRPr>
                    </a:p>
                  </a:txBody>
                  <a:tcPr/>
                </a:tc>
                <a:tc>
                  <a:txBody>
                    <a:bodyPr/>
                    <a:lstStyle/>
                    <a:p>
                      <a:pPr algn="ctr"/>
                      <a:r>
                        <a:rPr lang="en-US" altLang="zh-CN" sz="1050" dirty="0">
                          <a:latin typeface="Times New Roman" panose="02020603050405020304" pitchFamily="18" charset="0"/>
                          <a:cs typeface="Times New Roman" panose="02020603050405020304" pitchFamily="18" charset="0"/>
                        </a:rPr>
                        <a:t>308.2</a:t>
                      </a:r>
                      <a:endParaRPr lang="zh-CN" altLang="en-US" sz="105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2375042174"/>
                  </a:ext>
                </a:extLst>
              </a:tr>
            </a:tbl>
          </a:graphicData>
        </a:graphic>
      </p:graphicFrame>
      <p:sp>
        <p:nvSpPr>
          <p:cNvPr id="3" name="文本框 2">
            <a:extLst>
              <a:ext uri="{FF2B5EF4-FFF2-40B4-BE49-F238E27FC236}">
                <a16:creationId xmlns:a16="http://schemas.microsoft.com/office/drawing/2014/main" id="{FC564056-E46F-344F-7AC9-437A1D48C6C4}"/>
              </a:ext>
            </a:extLst>
          </p:cNvPr>
          <p:cNvSpPr txBox="1"/>
          <p:nvPr/>
        </p:nvSpPr>
        <p:spPr>
          <a:xfrm>
            <a:off x="786554" y="5681058"/>
            <a:ext cx="5284894" cy="275396"/>
          </a:xfrm>
          <a:prstGeom prst="rect">
            <a:avLst/>
          </a:prstGeom>
          <a:noFill/>
        </p:spPr>
        <p:txBody>
          <a:bodyPr wrap="square">
            <a:spAutoFit/>
          </a:bodyPr>
          <a:lstStyle/>
          <a:p>
            <a:pPr algn="ctr">
              <a:lnSpc>
                <a:spcPct val="125000"/>
              </a:lnSpc>
              <a:spcAft>
                <a:spcPts val="600"/>
              </a:spcAft>
            </a:pPr>
            <a:r>
              <a:rPr lang="en-US" altLang="zh-CN" sz="1050" b="1" kern="100" dirty="0">
                <a:solidFill>
                  <a:srgbClr val="000000"/>
                </a:solidFill>
                <a:effectLst/>
                <a:latin typeface="Times New Roman" panose="02020603050405020304" pitchFamily="18" charset="0"/>
                <a:ea typeface="宋体" panose="02010600030101010101" pitchFamily="2" charset="-122"/>
              </a:rPr>
              <a:t>Supplementary Table S2. </a:t>
            </a:r>
            <a:r>
              <a:rPr lang="en-US" altLang="zh-CN" sz="1050" b="1" dirty="0">
                <a:solidFill>
                  <a:srgbClr val="000000"/>
                </a:solidFill>
                <a:effectLst/>
                <a:latin typeface="Times New Roman" panose="02020603050405020304" pitchFamily="18" charset="0"/>
                <a:ea typeface="宋体" panose="02010600030101010101" pitchFamily="2" charset="-122"/>
              </a:rPr>
              <a:t>Decreased Lpp content of hemolymph in </a:t>
            </a:r>
            <a:r>
              <a:rPr lang="en-US" altLang="zh-CN" sz="1050" b="1" i="1" dirty="0">
                <a:solidFill>
                  <a:srgbClr val="000000"/>
                </a:solidFill>
                <a:effectLst/>
                <a:latin typeface="Times New Roman" panose="02020603050405020304" pitchFamily="18" charset="0"/>
                <a:ea typeface="宋体" panose="02010600030101010101" pitchFamily="2" charset="-122"/>
              </a:rPr>
              <a:t>dAcsl</a:t>
            </a:r>
            <a:r>
              <a:rPr lang="en-US" altLang="zh-CN" sz="1050" b="1" dirty="0">
                <a:solidFill>
                  <a:srgbClr val="000000"/>
                </a:solidFill>
                <a:effectLst/>
                <a:latin typeface="Times New Roman" panose="02020603050405020304" pitchFamily="18" charset="0"/>
                <a:ea typeface="宋体" panose="02010600030101010101" pitchFamily="2" charset="-122"/>
              </a:rPr>
              <a:t> RNAi</a:t>
            </a:r>
            <a:endParaRPr lang="zh-CN" altLang="zh-CN" sz="1050" b="1" kern="100" dirty="0">
              <a:effectLst/>
              <a:latin typeface="Times New Roman" panose="02020603050405020304" pitchFamily="18" charset="0"/>
              <a:ea typeface="宋体" panose="02010600030101010101" pitchFamily="2" charset="-122"/>
            </a:endParaRPr>
          </a:p>
        </p:txBody>
      </p:sp>
      <p:sp>
        <p:nvSpPr>
          <p:cNvPr id="6" name="文本框 5">
            <a:extLst>
              <a:ext uri="{FF2B5EF4-FFF2-40B4-BE49-F238E27FC236}">
                <a16:creationId xmlns:a16="http://schemas.microsoft.com/office/drawing/2014/main" id="{9D775C0F-3044-28A8-BFB3-1AF39327FE6C}"/>
              </a:ext>
            </a:extLst>
          </p:cNvPr>
          <p:cNvSpPr txBox="1"/>
          <p:nvPr/>
        </p:nvSpPr>
        <p:spPr>
          <a:xfrm>
            <a:off x="347587" y="5956454"/>
            <a:ext cx="6162826" cy="600164"/>
          </a:xfrm>
          <a:prstGeom prst="rect">
            <a:avLst/>
          </a:prstGeom>
          <a:noFill/>
        </p:spPr>
        <p:txBody>
          <a:bodyPr wrap="square">
            <a:spAutoFit/>
          </a:bodyPr>
          <a:lstStyle/>
          <a:p>
            <a:pPr algn="just"/>
            <a:r>
              <a:rPr lang="en-US" altLang="zh-CN" sz="1100" dirty="0">
                <a:latin typeface="Times New Roman" panose="02020603050405020304" pitchFamily="18" charset="0"/>
                <a:cs typeface="Times New Roman" panose="02020603050405020304" pitchFamily="18" charset="0"/>
              </a:rPr>
              <a:t>After gel </a:t>
            </a:r>
            <a:r>
              <a:rPr kumimoji="0" lang="en-US" altLang="zh-CN" sz="1100" b="0" i="0" u="none" strike="noStrike" kern="12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running and </a:t>
            </a:r>
            <a:r>
              <a:rPr kumimoji="0" lang="en-US" altLang="zh-CN" sz="1100" b="0" i="0" u="none" strike="noStrike" kern="1200" cap="none" spc="0" normalizeH="0" baseline="0" noProof="0" dirty="0">
                <a:ln>
                  <a:noFill/>
                </a:ln>
                <a:uLnTx/>
                <a:uFillTx/>
                <a:latin typeface="Times New Roman" panose="02020603050405020304" pitchFamily="18" charset="0"/>
                <a:ea typeface="等线" panose="02010600030101010101" pitchFamily="2" charset="-122"/>
                <a:cs typeface="Times New Roman" panose="02020603050405020304" pitchFamily="18" charset="0"/>
              </a:rPr>
              <a:t>c</a:t>
            </a:r>
            <a:r>
              <a:rPr lang="en-US" altLang="zh-CN" sz="1100" dirty="0" err="1">
                <a:effectLst/>
                <a:latin typeface="Times New Roman" panose="02020603050405020304" pitchFamily="18" charset="0"/>
                <a:ea typeface="等线" panose="02010600030101010101" pitchFamily="2" charset="-122"/>
              </a:rPr>
              <a:t>oomassie</a:t>
            </a:r>
            <a:r>
              <a:rPr lang="en-US" altLang="zh-CN" sz="1100" dirty="0">
                <a:effectLst/>
                <a:latin typeface="Times New Roman" panose="02020603050405020304" pitchFamily="18" charset="0"/>
                <a:ea typeface="等线" panose="02010600030101010101" pitchFamily="2" charset="-122"/>
              </a:rPr>
              <a:t> blue</a:t>
            </a:r>
            <a:r>
              <a:rPr lang="en-US" altLang="zh-CN" sz="1100" b="0" i="0" dirty="0">
                <a:effectLst/>
                <a:latin typeface="Times New Roman" panose="02020603050405020304" pitchFamily="18" charset="0"/>
                <a:cs typeface="Times New Roman" panose="02020603050405020304" pitchFamily="18" charset="0"/>
              </a:rPr>
              <a:t> staining (Supplementary Fig. S5a) </a:t>
            </a:r>
            <a:r>
              <a:rPr lang="en-US" altLang="zh-CN" sz="1100" dirty="0">
                <a:latin typeface="Times New Roman" panose="02020603050405020304" pitchFamily="18" charset="0"/>
                <a:cs typeface="Times New Roman" panose="02020603050405020304" pitchFamily="18" charset="0"/>
              </a:rPr>
              <a:t>of hemolymph samples, 250kDa bands were collected and pool three biological replicates of dAcsl </a:t>
            </a:r>
            <a:r>
              <a:rPr lang="en-US" altLang="zh-CN" sz="1100" i="1" dirty="0">
                <a:latin typeface="Times New Roman" panose="02020603050405020304" pitchFamily="18" charset="0"/>
                <a:cs typeface="Times New Roman" panose="02020603050405020304" pitchFamily="18" charset="0"/>
              </a:rPr>
              <a:t>RNAi</a:t>
            </a:r>
            <a:r>
              <a:rPr lang="en-US" altLang="zh-CN" sz="1100" dirty="0">
                <a:latin typeface="Times New Roman" panose="02020603050405020304" pitchFamily="18" charset="0"/>
                <a:cs typeface="Times New Roman" panose="02020603050405020304" pitchFamily="18" charset="0"/>
              </a:rPr>
              <a:t> -1, dAcsl </a:t>
            </a:r>
            <a:r>
              <a:rPr lang="en-US" altLang="zh-CN" sz="1100" i="1" dirty="0">
                <a:latin typeface="Times New Roman" panose="02020603050405020304" pitchFamily="18" charset="0"/>
                <a:cs typeface="Times New Roman" panose="02020603050405020304" pitchFamily="18" charset="0"/>
              </a:rPr>
              <a:t>RNAi</a:t>
            </a:r>
            <a:r>
              <a:rPr lang="en-US" altLang="zh-CN" sz="1100" dirty="0">
                <a:latin typeface="Times New Roman" panose="02020603050405020304" pitchFamily="18" charset="0"/>
                <a:cs typeface="Times New Roman" panose="02020603050405020304" pitchFamily="18" charset="0"/>
              </a:rPr>
              <a:t> -2 and control group to one sample for protein MS profiling. Table showed top 4 highest content proteins.</a:t>
            </a:r>
            <a:endParaRPr lang="zh-CN" alt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950987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内容占位符 3">
            <a:extLst>
              <a:ext uri="{FF2B5EF4-FFF2-40B4-BE49-F238E27FC236}">
                <a16:creationId xmlns:a16="http://schemas.microsoft.com/office/drawing/2014/main" id="{659F5C68-EDF0-5D0D-1B16-C576F4D9912D}"/>
              </a:ext>
            </a:extLst>
          </p:cNvPr>
          <p:cNvGraphicFramePr>
            <a:graphicFrameLocks noGrp="1"/>
          </p:cNvGraphicFramePr>
          <p:nvPr>
            <p:ph idx="1"/>
            <p:extLst>
              <p:ext uri="{D42A27DB-BD31-4B8C-83A1-F6EECF244321}">
                <p14:modId xmlns:p14="http://schemas.microsoft.com/office/powerpoint/2010/main" val="908404150"/>
              </p:ext>
            </p:extLst>
          </p:nvPr>
        </p:nvGraphicFramePr>
        <p:xfrm>
          <a:off x="1062850" y="1909316"/>
          <a:ext cx="4592272" cy="6219190"/>
        </p:xfrm>
        <a:graphic>
          <a:graphicData uri="http://schemas.openxmlformats.org/drawingml/2006/table">
            <a:tbl>
              <a:tblPr>
                <a:tableStyleId>{0505E3EF-67EA-436B-97B2-0124C06EBD24}</a:tableStyleId>
              </a:tblPr>
              <a:tblGrid>
                <a:gridCol w="995184">
                  <a:extLst>
                    <a:ext uri="{9D8B030D-6E8A-4147-A177-3AD203B41FA5}">
                      <a16:colId xmlns:a16="http://schemas.microsoft.com/office/drawing/2014/main" val="2002896734"/>
                    </a:ext>
                  </a:extLst>
                </a:gridCol>
                <a:gridCol w="1385046">
                  <a:extLst>
                    <a:ext uri="{9D8B030D-6E8A-4147-A177-3AD203B41FA5}">
                      <a16:colId xmlns:a16="http://schemas.microsoft.com/office/drawing/2014/main" val="362866773"/>
                    </a:ext>
                  </a:extLst>
                </a:gridCol>
                <a:gridCol w="2212042">
                  <a:extLst>
                    <a:ext uri="{9D8B030D-6E8A-4147-A177-3AD203B41FA5}">
                      <a16:colId xmlns:a16="http://schemas.microsoft.com/office/drawing/2014/main" val="3974792897"/>
                    </a:ext>
                  </a:extLst>
                </a:gridCol>
              </a:tblGrid>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Gene</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Stock number</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Obvious gut lipids accumulatio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98873223"/>
                  </a:ext>
                </a:extLst>
              </a:tr>
              <a:tr h="102164">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682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407.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69940972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682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591.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85821102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8983</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127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701478829"/>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6988</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287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353334841"/>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7830</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1322</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965803226"/>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7013</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3210.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074348433"/>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6668</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1825</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614683569"/>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2918</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5124</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347469380"/>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200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073.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368609415"/>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2002</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075.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431263654"/>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9035</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221.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457762926"/>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9035</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895.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027582889"/>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460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4863.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912689681"/>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4147</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483.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999272086"/>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4147</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084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00205297"/>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5520</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U372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800230261"/>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0688</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39715</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202921615"/>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3310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6523</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173294926"/>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3310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v108005</a:t>
                      </a:r>
                      <a:endParaRPr lang="en-US" sz="1100" b="1" i="0" u="none" strike="noStrike"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a:effectLst/>
                          <a:latin typeface="Times New Roman" panose="02020603050405020304" pitchFamily="18" charset="0"/>
                          <a:cs typeface="Times New Roman" panose="02020603050405020304" pitchFamily="18" charset="0"/>
                        </a:rPr>
                        <a:t>no</a:t>
                      </a:r>
                      <a:endParaRPr lang="en-US" sz="11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4005429862"/>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3199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5016.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965827211"/>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203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1733.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613618952"/>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203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432.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708176369"/>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9232</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TH02749.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329944646"/>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9232</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434.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052333982"/>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5341</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2636</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043535577"/>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6159</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2645</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065088729"/>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884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268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50546926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858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02592.N</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405332227"/>
                  </a:ext>
                </a:extLst>
              </a:tr>
              <a:tr h="177800">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CG1013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201500823.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370940593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1250</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081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yes</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333218406"/>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677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0913</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1032538852"/>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8266</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1068</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609997510"/>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7359</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1476</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98630508"/>
                  </a:ext>
                </a:extLst>
              </a:tr>
              <a:tr h="177800">
                <a:tc>
                  <a:txBody>
                    <a:bodyPr/>
                    <a:lstStyle/>
                    <a:p>
                      <a:pPr algn="ctr" fontAlgn="t"/>
                      <a:r>
                        <a:rPr lang="en-US" sz="1100" b="1" u="none" strike="noStrike" dirty="0">
                          <a:effectLst/>
                          <a:latin typeface="Times New Roman" panose="02020603050405020304" pitchFamily="18" charset="0"/>
                          <a:cs typeface="Times New Roman" panose="02020603050405020304" pitchFamily="18" charset="0"/>
                        </a:rPr>
                        <a:t>CG9539</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THU1687</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tc>
                  <a:txBody>
                    <a:bodyPr/>
                    <a:lstStyle/>
                    <a:p>
                      <a:pPr algn="ctr" fontAlgn="ctr"/>
                      <a:r>
                        <a:rPr lang="en-US" sz="1100" b="1" u="none" strike="noStrike" dirty="0">
                          <a:effectLst/>
                          <a:latin typeface="Times New Roman" panose="02020603050405020304" pitchFamily="18" charset="0"/>
                          <a:cs typeface="Times New Roman" panose="02020603050405020304" pitchFamily="18" charset="0"/>
                        </a:rPr>
                        <a:t>no</a:t>
                      </a:r>
                      <a:endParaRPr lang="en-US" sz="11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350" marR="6350" marT="6350" marB="0" anchor="ctr"/>
                </a:tc>
                <a:extLst>
                  <a:ext uri="{0D108BD9-81ED-4DB2-BD59-A6C34878D82A}">
                    <a16:rowId xmlns:a16="http://schemas.microsoft.com/office/drawing/2014/main" val="262581835"/>
                  </a:ext>
                </a:extLst>
              </a:tr>
            </a:tbl>
          </a:graphicData>
        </a:graphic>
      </p:graphicFrame>
      <p:sp>
        <p:nvSpPr>
          <p:cNvPr id="3" name="文本框 2">
            <a:extLst>
              <a:ext uri="{FF2B5EF4-FFF2-40B4-BE49-F238E27FC236}">
                <a16:creationId xmlns:a16="http://schemas.microsoft.com/office/drawing/2014/main" id="{173B37FC-F4B4-9EA1-D79D-12D7A81FFC26}"/>
              </a:ext>
            </a:extLst>
          </p:cNvPr>
          <p:cNvSpPr txBox="1"/>
          <p:nvPr/>
        </p:nvSpPr>
        <p:spPr>
          <a:xfrm>
            <a:off x="455544" y="623527"/>
            <a:ext cx="5946911" cy="430887"/>
          </a:xfrm>
          <a:prstGeom prst="rect">
            <a:avLst/>
          </a:prstGeom>
          <a:noFill/>
        </p:spPr>
        <p:txBody>
          <a:bodyPr wrap="square">
            <a:spAutoFit/>
          </a:bodyPr>
          <a:lstStyle/>
          <a:p>
            <a:pPr algn="ctr">
              <a:spcAft>
                <a:spcPts val="600"/>
              </a:spcAft>
            </a:pPr>
            <a:r>
              <a:rPr lang="en-US" altLang="zh-CN" sz="1100" b="1" kern="100" dirty="0">
                <a:solidFill>
                  <a:srgbClr val="000000"/>
                </a:solidFill>
                <a:effectLst/>
                <a:latin typeface="Times New Roman" panose="02020603050405020304" pitchFamily="18" charset="0"/>
                <a:ea typeface="宋体" panose="02010600030101010101" pitchFamily="2" charset="-122"/>
              </a:rPr>
              <a:t>Supplementary Table S3. Screen for lipoprotein glycosylation, </a:t>
            </a:r>
            <a:r>
              <a:rPr lang="en-US" altLang="zh-CN" sz="1100" b="1" kern="100" dirty="0">
                <a:solidFill>
                  <a:srgbClr val="000000"/>
                </a:solidFill>
                <a:latin typeface="Times New Roman" panose="02020603050405020304" pitchFamily="18" charset="0"/>
                <a:ea typeface="宋体" panose="02010600030101010101" pitchFamily="2" charset="-122"/>
              </a:rPr>
              <a:t>secretion </a:t>
            </a:r>
            <a:r>
              <a:rPr lang="en-US" altLang="zh-CN" sz="1100" b="1" kern="100" dirty="0">
                <a:solidFill>
                  <a:srgbClr val="000000"/>
                </a:solidFill>
                <a:effectLst/>
                <a:latin typeface="Times New Roman" panose="02020603050405020304" pitchFamily="18" charset="0"/>
                <a:ea typeface="宋体" panose="02010600030101010101" pitchFamily="2" charset="-122"/>
              </a:rPr>
              <a:t>and ER related genes involved in gut lipid homeastasis.</a:t>
            </a:r>
            <a:endParaRPr lang="zh-CN" altLang="zh-CN" sz="1100" b="1" kern="100" dirty="0">
              <a:effectLst/>
              <a:latin typeface="Times New Roman" panose="02020603050405020304" pitchFamily="18" charset="0"/>
              <a:ea typeface="宋体" panose="02010600030101010101" pitchFamily="2" charset="-122"/>
            </a:endParaRPr>
          </a:p>
        </p:txBody>
      </p:sp>
      <p:sp>
        <p:nvSpPr>
          <p:cNvPr id="5" name="文本框 4">
            <a:extLst>
              <a:ext uri="{FF2B5EF4-FFF2-40B4-BE49-F238E27FC236}">
                <a16:creationId xmlns:a16="http://schemas.microsoft.com/office/drawing/2014/main" id="{19E9C591-8393-00F5-CDE5-497C6381C90C}"/>
              </a:ext>
            </a:extLst>
          </p:cNvPr>
          <p:cNvSpPr txBox="1"/>
          <p:nvPr/>
        </p:nvSpPr>
        <p:spPr>
          <a:xfrm>
            <a:off x="265578" y="1000044"/>
            <a:ext cx="6326839" cy="769441"/>
          </a:xfrm>
          <a:prstGeom prst="rect">
            <a:avLst/>
          </a:prstGeom>
          <a:noFill/>
        </p:spPr>
        <p:txBody>
          <a:bodyPr wrap="square">
            <a:spAutoFit/>
          </a:bodyPr>
          <a:lstStyle/>
          <a:p>
            <a:pPr algn="just"/>
            <a:r>
              <a:rPr lang="en-US" altLang="zh-CN" sz="1100" i="0" u="none" strike="noStrike" baseline="0" dirty="0">
                <a:latin typeface="Times New Roman" panose="02020603050405020304" pitchFamily="18" charset="0"/>
                <a:cs typeface="Times New Roman" panose="02020603050405020304" pitchFamily="18" charset="0"/>
              </a:rPr>
              <a:t>List of genes examined in lipoprotein glycosylation, secretion and ER related genes screen. Genes are listed and the stock number in the screen is indicated as is the VDRC or </a:t>
            </a:r>
            <a:r>
              <a:rPr lang="en-US" altLang="zh-CN" sz="1100" dirty="0">
                <a:solidFill>
                  <a:srgbClr val="000000"/>
                </a:solidFill>
                <a:effectLst/>
                <a:latin typeface="Times New Roman" panose="02020603050405020304" pitchFamily="18" charset="0"/>
                <a:ea typeface="宋体" panose="02010600030101010101" pitchFamily="2" charset="-122"/>
              </a:rPr>
              <a:t>Tsinghua Fly Center </a:t>
            </a:r>
            <a:r>
              <a:rPr lang="en-US" altLang="zh-CN" sz="1100" i="0" u="none" strike="noStrike" baseline="0" dirty="0">
                <a:latin typeface="Times New Roman" panose="02020603050405020304" pitchFamily="18" charset="0"/>
                <a:cs typeface="Times New Roman" panose="02020603050405020304" pitchFamily="18" charset="0"/>
              </a:rPr>
              <a:t>stock number. The third column of results showed whether a phenotype of intestinal lipid accumulation was observed during the screening process.</a:t>
            </a:r>
            <a:endParaRPr lang="zh-CN" alt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010553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D7C73909-B581-3CB2-32D9-3D0205B0868C}"/>
              </a:ext>
            </a:extLst>
          </p:cNvPr>
          <p:cNvSpPr txBox="1"/>
          <p:nvPr/>
        </p:nvSpPr>
        <p:spPr>
          <a:xfrm>
            <a:off x="455544" y="202735"/>
            <a:ext cx="5946911" cy="261610"/>
          </a:xfrm>
          <a:prstGeom prst="rect">
            <a:avLst/>
          </a:prstGeom>
          <a:noFill/>
        </p:spPr>
        <p:txBody>
          <a:bodyPr wrap="square">
            <a:spAutoFit/>
          </a:bodyPr>
          <a:lstStyle/>
          <a:p>
            <a:pPr algn="ctr">
              <a:spcAft>
                <a:spcPts val="600"/>
              </a:spcAft>
            </a:pPr>
            <a:r>
              <a:rPr lang="en-US" altLang="zh-CN" sz="1100" b="1" kern="100" dirty="0">
                <a:solidFill>
                  <a:srgbClr val="000000"/>
                </a:solidFill>
                <a:effectLst/>
                <a:latin typeface="Times New Roman" panose="02020603050405020304" pitchFamily="18" charset="0"/>
                <a:ea typeface="宋体" panose="02010600030101010101" pitchFamily="2" charset="-122"/>
              </a:rPr>
              <a:t>Supplementary Table S4. </a:t>
            </a:r>
            <a:r>
              <a:rPr lang="en-US" altLang="zh-CN" sz="1100" b="1" i="1" kern="100" dirty="0">
                <a:solidFill>
                  <a:srgbClr val="000000"/>
                </a:solidFill>
                <a:latin typeface="Times New Roman" panose="02020603050405020304" pitchFamily="18" charset="0"/>
                <a:ea typeface="宋体" panose="02010600030101010101" pitchFamily="2" charset="-122"/>
              </a:rPr>
              <a:t>Drosophila</a:t>
            </a:r>
            <a:r>
              <a:rPr lang="en-US" altLang="zh-CN" sz="1100" b="1" kern="100" dirty="0">
                <a:solidFill>
                  <a:srgbClr val="000000"/>
                </a:solidFill>
                <a:latin typeface="Times New Roman" panose="02020603050405020304" pitchFamily="18" charset="0"/>
                <a:ea typeface="宋体" panose="02010600030101010101" pitchFamily="2" charset="-122"/>
              </a:rPr>
              <a:t> </a:t>
            </a:r>
            <a:r>
              <a:rPr lang="en-US" altLang="zh-CN" sz="1100" b="1" kern="100" dirty="0">
                <a:solidFill>
                  <a:srgbClr val="000000"/>
                </a:solidFill>
                <a:effectLst/>
                <a:latin typeface="Times New Roman" panose="02020603050405020304" pitchFamily="18" charset="0"/>
                <a:ea typeface="宋体" panose="02010600030101010101" pitchFamily="2" charset="-122"/>
              </a:rPr>
              <a:t>strains used in this study.</a:t>
            </a:r>
            <a:endParaRPr lang="zh-CN" altLang="zh-CN" sz="1100" b="1" kern="100" dirty="0">
              <a:effectLst/>
              <a:latin typeface="Times New Roman" panose="02020603050405020304" pitchFamily="18" charset="0"/>
              <a:ea typeface="宋体" panose="02010600030101010101" pitchFamily="2" charset="-122"/>
            </a:endParaRPr>
          </a:p>
        </p:txBody>
      </p:sp>
      <p:graphicFrame>
        <p:nvGraphicFramePr>
          <p:cNvPr id="6" name="表格 5">
            <a:extLst>
              <a:ext uri="{FF2B5EF4-FFF2-40B4-BE49-F238E27FC236}">
                <a16:creationId xmlns:a16="http://schemas.microsoft.com/office/drawing/2014/main" id="{6E18D2FA-DB6D-5C3A-BA86-AAE32006D614}"/>
              </a:ext>
            </a:extLst>
          </p:cNvPr>
          <p:cNvGraphicFramePr>
            <a:graphicFrameLocks noGrp="1"/>
          </p:cNvGraphicFramePr>
          <p:nvPr>
            <p:extLst>
              <p:ext uri="{D42A27DB-BD31-4B8C-83A1-F6EECF244321}">
                <p14:modId xmlns:p14="http://schemas.microsoft.com/office/powerpoint/2010/main" val="4215502044"/>
              </p:ext>
            </p:extLst>
          </p:nvPr>
        </p:nvGraphicFramePr>
        <p:xfrm>
          <a:off x="702211" y="579592"/>
          <a:ext cx="5278658" cy="3688080"/>
        </p:xfrm>
        <a:graphic>
          <a:graphicData uri="http://schemas.openxmlformats.org/drawingml/2006/table">
            <a:tbl>
              <a:tblPr firstRow="1" firstCol="1" bandRow="1">
                <a:tableStyleId>{5C22544A-7EE6-4342-B048-85BDC9FD1C3A}</a:tableStyleId>
              </a:tblPr>
              <a:tblGrid>
                <a:gridCol w="2424918">
                  <a:extLst>
                    <a:ext uri="{9D8B030D-6E8A-4147-A177-3AD203B41FA5}">
                      <a16:colId xmlns:a16="http://schemas.microsoft.com/office/drawing/2014/main" val="3462380899"/>
                    </a:ext>
                  </a:extLst>
                </a:gridCol>
                <a:gridCol w="1608821">
                  <a:extLst>
                    <a:ext uri="{9D8B030D-6E8A-4147-A177-3AD203B41FA5}">
                      <a16:colId xmlns:a16="http://schemas.microsoft.com/office/drawing/2014/main" val="3383866492"/>
                    </a:ext>
                  </a:extLst>
                </a:gridCol>
                <a:gridCol w="1244919">
                  <a:extLst>
                    <a:ext uri="{9D8B030D-6E8A-4147-A177-3AD203B41FA5}">
                      <a16:colId xmlns:a16="http://schemas.microsoft.com/office/drawing/2014/main" val="2848247517"/>
                    </a:ext>
                  </a:extLst>
                </a:gridCol>
              </a:tblGrid>
              <a:tr h="0">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Gene</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Source</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Strain</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988534735"/>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white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0583</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289253395"/>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dAcsl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2816</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381756150"/>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dAcsl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0583</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909172346"/>
                  </a:ext>
                </a:extLst>
              </a:tr>
              <a:tr h="0">
                <a:tc>
                  <a:txBody>
                    <a:bodyPr/>
                    <a:lstStyle/>
                    <a:p>
                      <a:pPr>
                        <a:lnSpc>
                          <a:spcPct val="100000"/>
                        </a:lnSpc>
                        <a:spcAft>
                          <a:spcPts val="800"/>
                        </a:spcAft>
                      </a:pPr>
                      <a:r>
                        <a:rPr lang="en-US" sz="1100" i="1" kern="100">
                          <a:solidFill>
                            <a:schemeClr val="tx1"/>
                          </a:solidFill>
                          <a:effectLst/>
                          <a:latin typeface="Times New Roman" panose="02020603050405020304" pitchFamily="18" charset="0"/>
                          <a:cs typeface="Times New Roman" panose="02020603050405020304" pitchFamily="18" charset="0"/>
                        </a:rPr>
                        <a:t>cg-Gal4</a:t>
                      </a:r>
                      <a:endParaRPr lang="zh-CN" sz="1100" i="1"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BDS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BL7011</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34665599"/>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UAS-GFP</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BDS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BL6874</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689296141"/>
                  </a:ext>
                </a:extLst>
              </a:tr>
              <a:tr h="0">
                <a:tc>
                  <a:txBody>
                    <a:bodyPr/>
                    <a:lstStyle/>
                    <a:p>
                      <a:pPr>
                        <a:lnSpc>
                          <a:spcPct val="100000"/>
                        </a:lnSpc>
                        <a:spcAft>
                          <a:spcPts val="800"/>
                        </a:spcAft>
                      </a:pPr>
                      <a:r>
                        <a:rPr lang="en-US" sz="1100" i="1" kern="100">
                          <a:solidFill>
                            <a:schemeClr val="tx1"/>
                          </a:solidFill>
                          <a:effectLst/>
                          <a:latin typeface="Times New Roman" panose="02020603050405020304" pitchFamily="18" charset="0"/>
                          <a:cs typeface="Times New Roman" panose="02020603050405020304" pitchFamily="18" charset="0"/>
                        </a:rPr>
                        <a:t>UAS-ACC</a:t>
                      </a:r>
                      <a:endParaRPr lang="zh-CN" sz="1100" i="1"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Huang Xun lab</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N/A</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329287348"/>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UAS- mCD8--ChRFP</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BDS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27391</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964253517"/>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PSS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VDR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v5391</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146876889"/>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CLS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VDR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v6742</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618563065"/>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MTP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201500600.S</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950291578"/>
                  </a:ext>
                </a:extLst>
              </a:tr>
              <a:tr h="0">
                <a:tc>
                  <a:txBody>
                    <a:bodyPr/>
                    <a:lstStyle/>
                    <a:p>
                      <a:pPr>
                        <a:lnSpc>
                          <a:spcPct val="100000"/>
                        </a:lnSpc>
                        <a:spcAft>
                          <a:spcPts val="800"/>
                        </a:spcAft>
                      </a:pPr>
                      <a:r>
                        <a:rPr lang="en-US" sz="1100" i="1" kern="100">
                          <a:solidFill>
                            <a:schemeClr val="tx1"/>
                          </a:solidFill>
                          <a:effectLst/>
                          <a:latin typeface="Times New Roman" panose="02020603050405020304" pitchFamily="18" charset="0"/>
                          <a:cs typeface="Times New Roman" panose="02020603050405020304" pitchFamily="18" charset="0"/>
                        </a:rPr>
                        <a:t>MTP RNAi</a:t>
                      </a:r>
                      <a:endParaRPr lang="zh-CN" sz="1100" i="1"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1062</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31361400"/>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apoLTP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01881.N</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448070110"/>
                  </a:ext>
                </a:extLst>
              </a:tr>
              <a:tr h="0">
                <a:tc>
                  <a:txBody>
                    <a:bodyPr/>
                    <a:lstStyle/>
                    <a:p>
                      <a:pPr>
                        <a:lnSpc>
                          <a:spcPct val="100000"/>
                        </a:lnSpc>
                        <a:spcAft>
                          <a:spcPts val="800"/>
                        </a:spcAft>
                      </a:pPr>
                      <a:r>
                        <a:rPr lang="en-US" sz="1100" i="1" kern="100">
                          <a:solidFill>
                            <a:schemeClr val="tx1"/>
                          </a:solidFill>
                          <a:effectLst/>
                          <a:latin typeface="Times New Roman" panose="02020603050405020304" pitchFamily="18" charset="0"/>
                          <a:cs typeface="Times New Roman" panose="02020603050405020304" pitchFamily="18" charset="0"/>
                        </a:rPr>
                        <a:t>apoLpp OE</a:t>
                      </a:r>
                      <a:endParaRPr lang="zh-CN" sz="1100" i="1"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VDR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dirty="0">
                          <a:solidFill>
                            <a:schemeClr val="tx1"/>
                          </a:solidFill>
                          <a:effectLst/>
                          <a:latin typeface="Times New Roman" panose="02020603050405020304" pitchFamily="18" charset="0"/>
                          <a:cs typeface="Times New Roman" panose="02020603050405020304" pitchFamily="18" charset="0"/>
                        </a:rPr>
                        <a:t>v318255</a:t>
                      </a:r>
                      <a:endParaRPr lang="zh-CN" sz="110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599621501"/>
                  </a:ext>
                </a:extLst>
              </a:tr>
              <a:tr h="0">
                <a:tc>
                  <a:txBody>
                    <a:bodyPr/>
                    <a:lstStyle/>
                    <a:p>
                      <a:pPr>
                        <a:lnSpc>
                          <a:spcPct val="100000"/>
                        </a:lnSpc>
                        <a:spcAft>
                          <a:spcPts val="800"/>
                        </a:spcAft>
                      </a:pPr>
                      <a:r>
                        <a:rPr lang="en-US" sz="1100" i="1" kern="100">
                          <a:solidFill>
                            <a:schemeClr val="tx1"/>
                          </a:solidFill>
                          <a:effectLst/>
                          <a:latin typeface="Times New Roman" panose="02020603050405020304" pitchFamily="18" charset="0"/>
                          <a:cs typeface="Times New Roman" panose="02020603050405020304" pitchFamily="18" charset="0"/>
                        </a:rPr>
                        <a:t>UAS-KDEL-RFP</a:t>
                      </a:r>
                      <a:endParaRPr lang="zh-CN" sz="1100" i="1"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BDS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27392</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700455415"/>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UAS-Xbp1-EGFP</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BDS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dirty="0">
                          <a:solidFill>
                            <a:schemeClr val="tx1"/>
                          </a:solidFill>
                          <a:effectLst/>
                          <a:latin typeface="Times New Roman" panose="02020603050405020304" pitchFamily="18" charset="0"/>
                          <a:cs typeface="Times New Roman" panose="02020603050405020304" pitchFamily="18" charset="0"/>
                        </a:rPr>
                        <a:t>60731</a:t>
                      </a:r>
                      <a:endParaRPr lang="zh-CN" sz="110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901014863"/>
                  </a:ext>
                </a:extLst>
              </a:tr>
              <a:tr h="0">
                <a:tc>
                  <a:txBody>
                    <a:bodyPr/>
                    <a:lstStyle/>
                    <a:p>
                      <a:pPr>
                        <a:lnSpc>
                          <a:spcPct val="100000"/>
                        </a:lnSpc>
                        <a:spcAft>
                          <a:spcPts val="800"/>
                        </a:spcAft>
                      </a:pPr>
                      <a:r>
                        <a:rPr lang="en-US" sz="1100" i="1" kern="100">
                          <a:solidFill>
                            <a:schemeClr val="tx1"/>
                          </a:solidFill>
                          <a:effectLst/>
                          <a:latin typeface="Times New Roman" panose="02020603050405020304" pitchFamily="18" charset="0"/>
                          <a:cs typeface="Times New Roman" panose="02020603050405020304" pitchFamily="18" charset="0"/>
                        </a:rPr>
                        <a:t>apoLpp RNAi</a:t>
                      </a:r>
                      <a:endParaRPr lang="zh-CN" sz="1100" i="1"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0476</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409476824"/>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apoLpp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3553</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115913254"/>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ACC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U1468</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613752579"/>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CG9035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201500895.S</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690412928"/>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CG10075 RNAi</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a:solidFill>
                            <a:schemeClr val="tx1"/>
                          </a:solidFill>
                          <a:effectLst/>
                          <a:latin typeface="Times New Roman" panose="02020603050405020304" pitchFamily="18" charset="0"/>
                          <a:cs typeface="Times New Roman" panose="02020603050405020304" pitchFamily="18" charset="0"/>
                        </a:rPr>
                        <a:t>THFC</a:t>
                      </a:r>
                      <a:endParaRPr lang="zh-CN" altLang="en-US" sz="110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a:solidFill>
                            <a:schemeClr val="tx1"/>
                          </a:solidFill>
                          <a:effectLst/>
                          <a:latin typeface="Times New Roman" panose="02020603050405020304" pitchFamily="18" charset="0"/>
                          <a:cs typeface="Times New Roman" panose="02020603050405020304" pitchFamily="18" charset="0"/>
                        </a:rPr>
                        <a:t>TH201500113.S</a:t>
                      </a:r>
                      <a:endParaRPr lang="zh-CN" sz="110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686715440"/>
                  </a:ext>
                </a:extLst>
              </a:tr>
              <a:tr h="0">
                <a:tc>
                  <a:txBody>
                    <a:bodyPr/>
                    <a:lstStyle/>
                    <a:p>
                      <a:pPr>
                        <a:lnSpc>
                          <a:spcPct val="100000"/>
                        </a:lnSpc>
                        <a:spcAft>
                          <a:spcPts val="800"/>
                        </a:spcAft>
                      </a:pPr>
                      <a:r>
                        <a:rPr lang="en-US" sz="1100" i="1" kern="100" dirty="0">
                          <a:solidFill>
                            <a:schemeClr val="tx1"/>
                          </a:solidFill>
                          <a:effectLst/>
                          <a:latin typeface="Times New Roman" panose="02020603050405020304" pitchFamily="18" charset="0"/>
                          <a:cs typeface="Times New Roman" panose="02020603050405020304" pitchFamily="18" charset="0"/>
                        </a:rPr>
                        <a:t>CG9035 OE</a:t>
                      </a:r>
                      <a:endParaRPr lang="zh-CN" sz="1100" i="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pPr>
                      <a:r>
                        <a:rPr lang="en-US" sz="1100" kern="100" dirty="0">
                          <a:solidFill>
                            <a:schemeClr val="tx1"/>
                          </a:solidFill>
                          <a:effectLst/>
                          <a:latin typeface="Times New Roman" panose="02020603050405020304" pitchFamily="18" charset="0"/>
                          <a:cs typeface="Times New Roman" panose="02020603050405020304" pitchFamily="18" charset="0"/>
                        </a:rPr>
                        <a:t>BDSC</a:t>
                      </a:r>
                      <a:endParaRPr lang="zh-CN" altLang="en-US" sz="1100" dirty="0">
                        <a:solidFill>
                          <a:schemeClr val="tx1"/>
                        </a:solidFill>
                        <a:latin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nSpc>
                          <a:spcPct val="100000"/>
                        </a:lnSpc>
                        <a:spcAft>
                          <a:spcPts val="800"/>
                        </a:spcAft>
                      </a:pPr>
                      <a:r>
                        <a:rPr lang="en-US" sz="1100" kern="100" dirty="0">
                          <a:solidFill>
                            <a:schemeClr val="tx1"/>
                          </a:solidFill>
                          <a:effectLst/>
                          <a:latin typeface="Times New Roman" panose="02020603050405020304" pitchFamily="18" charset="0"/>
                          <a:cs typeface="Times New Roman" panose="02020603050405020304" pitchFamily="18" charset="0"/>
                        </a:rPr>
                        <a:t>15871</a:t>
                      </a:r>
                      <a:endParaRPr lang="zh-CN" sz="110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830361698"/>
                  </a:ext>
                </a:extLst>
              </a:tr>
            </a:tbl>
          </a:graphicData>
        </a:graphic>
      </p:graphicFrame>
      <p:graphicFrame>
        <p:nvGraphicFramePr>
          <p:cNvPr id="7" name="表格 6">
            <a:extLst>
              <a:ext uri="{FF2B5EF4-FFF2-40B4-BE49-F238E27FC236}">
                <a16:creationId xmlns:a16="http://schemas.microsoft.com/office/drawing/2014/main" id="{936F1CF9-7F89-E255-95A4-26548FEB51EC}"/>
              </a:ext>
            </a:extLst>
          </p:cNvPr>
          <p:cNvGraphicFramePr>
            <a:graphicFrameLocks noGrp="1"/>
          </p:cNvGraphicFramePr>
          <p:nvPr>
            <p:extLst>
              <p:ext uri="{D42A27DB-BD31-4B8C-83A1-F6EECF244321}">
                <p14:modId xmlns:p14="http://schemas.microsoft.com/office/powerpoint/2010/main" val="4001925296"/>
              </p:ext>
            </p:extLst>
          </p:nvPr>
        </p:nvGraphicFramePr>
        <p:xfrm>
          <a:off x="1760731" y="5199741"/>
          <a:ext cx="3336534" cy="3138710"/>
        </p:xfrm>
        <a:graphic>
          <a:graphicData uri="http://schemas.openxmlformats.org/drawingml/2006/table">
            <a:tbl>
              <a:tblPr firstRow="1" firstCol="1" bandRow="1">
                <a:tableStyleId>{5C22544A-7EE6-4342-B048-85BDC9FD1C3A}</a:tableStyleId>
              </a:tblPr>
              <a:tblGrid>
                <a:gridCol w="3336534">
                  <a:extLst>
                    <a:ext uri="{9D8B030D-6E8A-4147-A177-3AD203B41FA5}">
                      <a16:colId xmlns:a16="http://schemas.microsoft.com/office/drawing/2014/main" val="1844931089"/>
                    </a:ext>
                  </a:extLst>
                </a:gridCol>
              </a:tblGrid>
              <a:tr h="184630">
                <a:tc>
                  <a:txBody>
                    <a:bodyPr/>
                    <a:lstStyle/>
                    <a:p>
                      <a:pPr>
                        <a:lnSpc>
                          <a:spcPct val="106000"/>
                        </a:lnSpc>
                        <a:spcAft>
                          <a:spcPts val="800"/>
                        </a:spcAft>
                      </a:pPr>
                      <a:r>
                        <a:rPr lang="en-US" sz="1100" b="0" kern="100">
                          <a:solidFill>
                            <a:schemeClr val="tx1"/>
                          </a:solidFill>
                          <a:effectLst/>
                          <a:latin typeface="Times New Roman" panose="02020603050405020304" pitchFamily="18" charset="0"/>
                          <a:cs typeface="Times New Roman" panose="02020603050405020304" pitchFamily="18" charset="0"/>
                        </a:rPr>
                        <a:t>Oligonucleotides</a:t>
                      </a:r>
                      <a:endParaRPr lang="zh-CN" sz="11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68687950"/>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rp49</a:t>
                      </a:r>
                      <a:r>
                        <a:rPr lang="en-US" sz="1100" b="0" kern="100" dirty="0">
                          <a:solidFill>
                            <a:schemeClr val="tx1"/>
                          </a:solidFill>
                          <a:effectLst/>
                          <a:latin typeface="Times New Roman" panose="02020603050405020304" pitchFamily="18" charset="0"/>
                          <a:cs typeface="Times New Roman" panose="02020603050405020304" pitchFamily="18" charset="0"/>
                        </a:rPr>
                        <a:t> FW: CGCTTCAAGGGACAGTATCTG</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166299884"/>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rp49</a:t>
                      </a:r>
                      <a:r>
                        <a:rPr lang="en-US" sz="1100" b="0" kern="100" dirty="0">
                          <a:solidFill>
                            <a:schemeClr val="tx1"/>
                          </a:solidFill>
                          <a:effectLst/>
                          <a:latin typeface="Times New Roman" panose="02020603050405020304" pitchFamily="18" charset="0"/>
                          <a:cs typeface="Times New Roman" panose="02020603050405020304" pitchFamily="18" charset="0"/>
                        </a:rPr>
                        <a:t> RV: AAACGCGGTTCTGCATGA</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057803135"/>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dAcsl</a:t>
                      </a:r>
                      <a:r>
                        <a:rPr lang="en-US" sz="1100" b="0" kern="100" dirty="0">
                          <a:solidFill>
                            <a:schemeClr val="tx1"/>
                          </a:solidFill>
                          <a:effectLst/>
                          <a:latin typeface="Times New Roman" panose="02020603050405020304" pitchFamily="18" charset="0"/>
                          <a:cs typeface="Times New Roman" panose="02020603050405020304" pitchFamily="18" charset="0"/>
                        </a:rPr>
                        <a:t> FW: ATGTTCATCGAAGACGATGC</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254284393"/>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dAcsl</a:t>
                      </a:r>
                      <a:r>
                        <a:rPr lang="en-US" sz="1100" b="0" kern="100" dirty="0">
                          <a:solidFill>
                            <a:schemeClr val="tx1"/>
                          </a:solidFill>
                          <a:effectLst/>
                          <a:latin typeface="Times New Roman" panose="02020603050405020304" pitchFamily="18" charset="0"/>
                          <a:cs typeface="Times New Roman" panose="02020603050405020304" pitchFamily="18" charset="0"/>
                        </a:rPr>
                        <a:t> RW: CCAATTCCCTATTCAGAGTTC</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926128367"/>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xbp1-</a:t>
                      </a:r>
                      <a:r>
                        <a:rPr lang="en-US" sz="1100" b="0" kern="100" dirty="0">
                          <a:solidFill>
                            <a:schemeClr val="tx1"/>
                          </a:solidFill>
                          <a:effectLst/>
                          <a:latin typeface="Times New Roman" panose="02020603050405020304" pitchFamily="18" charset="0"/>
                          <a:cs typeface="Times New Roman" panose="02020603050405020304" pitchFamily="18" charset="0"/>
                        </a:rPr>
                        <a:t>(u) FW: TCTGCAGCATCCAAAGCTGAC</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4127604223"/>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xbp1-</a:t>
                      </a:r>
                      <a:r>
                        <a:rPr lang="en-US" sz="1100" b="0" kern="100" dirty="0">
                          <a:solidFill>
                            <a:schemeClr val="tx1"/>
                          </a:solidFill>
                          <a:effectLst/>
                          <a:latin typeface="Times New Roman" panose="02020603050405020304" pitchFamily="18" charset="0"/>
                          <a:cs typeface="Times New Roman" panose="02020603050405020304" pitchFamily="18" charset="0"/>
                        </a:rPr>
                        <a:t>(u) RW: GCGCTTGACGTCGAACTCTT</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501607599"/>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xbp1-</a:t>
                      </a:r>
                      <a:r>
                        <a:rPr lang="en-US" sz="1100" b="0" kern="100" dirty="0">
                          <a:solidFill>
                            <a:schemeClr val="tx1"/>
                          </a:solidFill>
                          <a:effectLst/>
                          <a:latin typeface="Times New Roman" panose="02020603050405020304" pitchFamily="18" charset="0"/>
                          <a:cs typeface="Times New Roman" panose="02020603050405020304" pitchFamily="18" charset="0"/>
                        </a:rPr>
                        <a:t>(s) FW: AGAAGGCACGCATGGAGG</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479477764"/>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xbp1-</a:t>
                      </a:r>
                      <a:r>
                        <a:rPr lang="en-US" sz="1100" b="0" kern="100" dirty="0">
                          <a:solidFill>
                            <a:schemeClr val="tx1"/>
                          </a:solidFill>
                          <a:effectLst/>
                          <a:latin typeface="Times New Roman" panose="02020603050405020304" pitchFamily="18" charset="0"/>
                          <a:cs typeface="Times New Roman" panose="02020603050405020304" pitchFamily="18" charset="0"/>
                        </a:rPr>
                        <a:t>(s) RW: AGCAGTGACTCGTTGATGGC</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978262913"/>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ACC</a:t>
                      </a:r>
                      <a:r>
                        <a:rPr lang="en-US" sz="1100" b="0" kern="100" dirty="0">
                          <a:solidFill>
                            <a:schemeClr val="tx1"/>
                          </a:solidFill>
                          <a:effectLst/>
                          <a:latin typeface="Times New Roman" panose="02020603050405020304" pitchFamily="18" charset="0"/>
                          <a:cs typeface="Times New Roman" panose="02020603050405020304" pitchFamily="18" charset="0"/>
                        </a:rPr>
                        <a:t> FW: TTCGCTCGATCATCCGTCA</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4133863742"/>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ACC</a:t>
                      </a:r>
                      <a:r>
                        <a:rPr lang="en-US" sz="1100" b="0" kern="100" dirty="0">
                          <a:solidFill>
                            <a:schemeClr val="tx1"/>
                          </a:solidFill>
                          <a:effectLst/>
                          <a:latin typeface="Times New Roman" panose="02020603050405020304" pitchFamily="18" charset="0"/>
                          <a:cs typeface="Times New Roman" panose="02020603050405020304" pitchFamily="18" charset="0"/>
                        </a:rPr>
                        <a:t> RW: AATGCCACCTCCAGCTCAT</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3061334"/>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ACS</a:t>
                      </a:r>
                      <a:r>
                        <a:rPr lang="en-US" sz="1100" b="0" kern="100" dirty="0">
                          <a:solidFill>
                            <a:schemeClr val="tx1"/>
                          </a:solidFill>
                          <a:effectLst/>
                          <a:latin typeface="Times New Roman" panose="02020603050405020304" pitchFamily="18" charset="0"/>
                          <a:cs typeface="Times New Roman" panose="02020603050405020304" pitchFamily="18" charset="0"/>
                        </a:rPr>
                        <a:t> FW: CCAAAACTCGTTCCGGCAA</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107888544"/>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ACS</a:t>
                      </a:r>
                      <a:r>
                        <a:rPr lang="en-US" sz="1100" b="0" kern="100" dirty="0">
                          <a:solidFill>
                            <a:schemeClr val="tx1"/>
                          </a:solidFill>
                          <a:effectLst/>
                          <a:latin typeface="Times New Roman" panose="02020603050405020304" pitchFamily="18" charset="0"/>
                          <a:cs typeface="Times New Roman" panose="02020603050405020304" pitchFamily="18" charset="0"/>
                        </a:rPr>
                        <a:t> RW: GCGAACAGTTGCTCCACAA</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066686117"/>
                  </a:ext>
                </a:extLst>
              </a:tr>
              <a:tr h="184630">
                <a:tc>
                  <a:txBody>
                    <a:bodyPr/>
                    <a:lstStyle/>
                    <a:p>
                      <a:pPr>
                        <a:lnSpc>
                          <a:spcPct val="106000"/>
                        </a:lnSpc>
                        <a:spcAft>
                          <a:spcPts val="800"/>
                        </a:spcAft>
                      </a:pPr>
                      <a:r>
                        <a:rPr lang="en-US" sz="1100" b="0" i="1" kern="100" dirty="0" err="1">
                          <a:solidFill>
                            <a:schemeClr val="tx1"/>
                          </a:solidFill>
                          <a:effectLst/>
                          <a:latin typeface="Times New Roman" panose="02020603050405020304" pitchFamily="18" charset="0"/>
                          <a:cs typeface="Times New Roman" panose="02020603050405020304" pitchFamily="18" charset="0"/>
                        </a:rPr>
                        <a:t>mdy</a:t>
                      </a:r>
                      <a:r>
                        <a:rPr lang="en-US" sz="1100" b="0" kern="100" dirty="0">
                          <a:solidFill>
                            <a:schemeClr val="tx1"/>
                          </a:solidFill>
                          <a:effectLst/>
                          <a:latin typeface="Times New Roman" panose="02020603050405020304" pitchFamily="18" charset="0"/>
                          <a:cs typeface="Times New Roman" panose="02020603050405020304" pitchFamily="18" charset="0"/>
                        </a:rPr>
                        <a:t> FW: AGCCACTGAGCGACTTCTT</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951218865"/>
                  </a:ext>
                </a:extLst>
              </a:tr>
              <a:tr h="184630">
                <a:tc>
                  <a:txBody>
                    <a:bodyPr/>
                    <a:lstStyle/>
                    <a:p>
                      <a:pPr>
                        <a:lnSpc>
                          <a:spcPct val="106000"/>
                        </a:lnSpc>
                        <a:spcAft>
                          <a:spcPts val="800"/>
                        </a:spcAft>
                      </a:pPr>
                      <a:r>
                        <a:rPr lang="en-US" sz="1100" b="0" i="1" kern="100" dirty="0" err="1">
                          <a:solidFill>
                            <a:schemeClr val="tx1"/>
                          </a:solidFill>
                          <a:effectLst/>
                          <a:latin typeface="Times New Roman" panose="02020603050405020304" pitchFamily="18" charset="0"/>
                          <a:cs typeface="Times New Roman" panose="02020603050405020304" pitchFamily="18" charset="0"/>
                        </a:rPr>
                        <a:t>mdy</a:t>
                      </a:r>
                      <a:r>
                        <a:rPr lang="en-US" sz="1100" b="0" kern="100" dirty="0">
                          <a:solidFill>
                            <a:schemeClr val="tx1"/>
                          </a:solidFill>
                          <a:effectLst/>
                          <a:latin typeface="Times New Roman" panose="02020603050405020304" pitchFamily="18" charset="0"/>
                          <a:cs typeface="Times New Roman" panose="02020603050405020304" pitchFamily="18" charset="0"/>
                        </a:rPr>
                        <a:t> RW: AATTCAGCAGTTCGCCGAC</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766569085"/>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Dgat2</a:t>
                      </a:r>
                      <a:r>
                        <a:rPr lang="en-US" sz="1100" b="0" kern="100" dirty="0">
                          <a:solidFill>
                            <a:schemeClr val="tx1"/>
                          </a:solidFill>
                          <a:effectLst/>
                          <a:latin typeface="Times New Roman" panose="02020603050405020304" pitchFamily="18" charset="0"/>
                          <a:cs typeface="Times New Roman" panose="02020603050405020304" pitchFamily="18" charset="0"/>
                        </a:rPr>
                        <a:t> FW: ACGCACCAACCTTTTGCAT</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670042149"/>
                  </a:ext>
                </a:extLst>
              </a:tr>
              <a:tr h="184630">
                <a:tc>
                  <a:txBody>
                    <a:bodyPr/>
                    <a:lstStyle/>
                    <a:p>
                      <a:pPr>
                        <a:lnSpc>
                          <a:spcPct val="106000"/>
                        </a:lnSpc>
                        <a:spcAft>
                          <a:spcPts val="800"/>
                        </a:spcAft>
                      </a:pPr>
                      <a:r>
                        <a:rPr lang="en-US" sz="1100" b="0" i="1" kern="100" dirty="0">
                          <a:solidFill>
                            <a:schemeClr val="tx1"/>
                          </a:solidFill>
                          <a:effectLst/>
                          <a:latin typeface="Times New Roman" panose="02020603050405020304" pitchFamily="18" charset="0"/>
                          <a:cs typeface="Times New Roman" panose="02020603050405020304" pitchFamily="18" charset="0"/>
                        </a:rPr>
                        <a:t>Dgat2</a:t>
                      </a:r>
                      <a:r>
                        <a:rPr lang="en-US" sz="1100" b="0" kern="100" dirty="0">
                          <a:solidFill>
                            <a:schemeClr val="tx1"/>
                          </a:solidFill>
                          <a:effectLst/>
                          <a:latin typeface="Times New Roman" panose="02020603050405020304" pitchFamily="18" charset="0"/>
                          <a:cs typeface="Times New Roman" panose="02020603050405020304" pitchFamily="18" charset="0"/>
                        </a:rPr>
                        <a:t> RW: TAATGCCAATGCCTGTGCC</a:t>
                      </a:r>
                      <a:endParaRPr lang="zh-CN" sz="11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490191614"/>
                  </a:ext>
                </a:extLst>
              </a:tr>
            </a:tbl>
          </a:graphicData>
        </a:graphic>
      </p:graphicFrame>
      <p:sp>
        <p:nvSpPr>
          <p:cNvPr id="8" name="文本框 7">
            <a:extLst>
              <a:ext uri="{FF2B5EF4-FFF2-40B4-BE49-F238E27FC236}">
                <a16:creationId xmlns:a16="http://schemas.microsoft.com/office/drawing/2014/main" id="{699947CD-3AB6-67E0-2852-D9E0739DBB1B}"/>
              </a:ext>
            </a:extLst>
          </p:cNvPr>
          <p:cNvSpPr txBox="1"/>
          <p:nvPr/>
        </p:nvSpPr>
        <p:spPr>
          <a:xfrm>
            <a:off x="455543" y="4822195"/>
            <a:ext cx="5946911" cy="261610"/>
          </a:xfrm>
          <a:prstGeom prst="rect">
            <a:avLst/>
          </a:prstGeom>
          <a:noFill/>
        </p:spPr>
        <p:txBody>
          <a:bodyPr wrap="square">
            <a:spAutoFit/>
          </a:bodyPr>
          <a:lstStyle/>
          <a:p>
            <a:pPr algn="ctr">
              <a:spcAft>
                <a:spcPts val="600"/>
              </a:spcAft>
            </a:pPr>
            <a:r>
              <a:rPr lang="en-US" altLang="zh-CN" sz="1100" b="1" kern="100" dirty="0">
                <a:solidFill>
                  <a:srgbClr val="000000"/>
                </a:solidFill>
                <a:effectLst/>
                <a:latin typeface="Times New Roman" panose="02020603050405020304" pitchFamily="18" charset="0"/>
                <a:ea typeface="宋体" panose="02010600030101010101" pitchFamily="2" charset="-122"/>
              </a:rPr>
              <a:t>Supplementary Table S5. </a:t>
            </a:r>
            <a:r>
              <a:rPr lang="en-US" altLang="zh-CN" sz="1100" b="1" kern="100" dirty="0">
                <a:solidFill>
                  <a:srgbClr val="000000"/>
                </a:solidFill>
                <a:latin typeface="Times New Roman" panose="02020603050405020304" pitchFamily="18" charset="0"/>
                <a:ea typeface="宋体" panose="02010600030101010101" pitchFamily="2" charset="-122"/>
              </a:rPr>
              <a:t>All primers used in this study</a:t>
            </a:r>
            <a:r>
              <a:rPr lang="en-US" altLang="zh-CN" sz="1100" b="1" kern="100" dirty="0">
                <a:solidFill>
                  <a:srgbClr val="000000"/>
                </a:solidFill>
                <a:effectLst/>
                <a:latin typeface="Times New Roman" panose="02020603050405020304" pitchFamily="18" charset="0"/>
                <a:ea typeface="宋体" panose="02010600030101010101" pitchFamily="2" charset="-122"/>
              </a:rPr>
              <a:t>.</a:t>
            </a:r>
            <a:endParaRPr lang="zh-CN" altLang="zh-CN" sz="1100" b="1" kern="100" dirty="0">
              <a:effectLst/>
              <a:latin typeface="Times New Roman" panose="02020603050405020304" pitchFamily="18" charset="0"/>
              <a:ea typeface="宋体" panose="02010600030101010101" pitchFamily="2" charset="-122"/>
            </a:endParaRPr>
          </a:p>
        </p:txBody>
      </p:sp>
    </p:spTree>
    <p:extLst>
      <p:ext uri="{BB962C8B-B14F-4D97-AF65-F5344CB8AC3E}">
        <p14:creationId xmlns:p14="http://schemas.microsoft.com/office/powerpoint/2010/main" val="338253223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516</TotalTime>
  <Words>1915</Words>
  <Application>Microsoft Office PowerPoint</Application>
  <PresentationFormat>A4 纸张(210x297 毫米)</PresentationFormat>
  <Paragraphs>496</Paragraphs>
  <Slides>9</Slides>
  <Notes>0</Notes>
  <HiddenSlides>0</HiddenSlides>
  <MMClips>0</MMClips>
  <ScaleCrop>false</ScaleCrop>
  <HeadingPairs>
    <vt:vector size="8" baseType="variant">
      <vt:variant>
        <vt:lpstr>已用的字体</vt:lpstr>
      </vt:variant>
      <vt:variant>
        <vt:i4>6</vt:i4>
      </vt:variant>
      <vt:variant>
        <vt:lpstr>主题</vt:lpstr>
      </vt:variant>
      <vt:variant>
        <vt:i4>1</vt:i4>
      </vt:variant>
      <vt:variant>
        <vt:lpstr>嵌入 OLE 服务器</vt:lpstr>
      </vt:variant>
      <vt:variant>
        <vt:i4>2</vt:i4>
      </vt:variant>
      <vt:variant>
        <vt:lpstr>幻灯片标题</vt:lpstr>
      </vt:variant>
      <vt:variant>
        <vt:i4>9</vt:i4>
      </vt:variant>
    </vt:vector>
  </HeadingPairs>
  <TitlesOfParts>
    <vt:vector size="18" baseType="lpstr">
      <vt:lpstr>等线</vt:lpstr>
      <vt:lpstr>宋体</vt:lpstr>
      <vt:lpstr>Arial</vt:lpstr>
      <vt:lpstr>Calibri</vt:lpstr>
      <vt:lpstr>Calibri Light</vt:lpstr>
      <vt:lpstr>Times New Roman</vt:lpstr>
      <vt:lpstr>Office 主题​​</vt:lpstr>
      <vt:lpstr>Prism 9</vt:lpstr>
      <vt:lpstr>Prism 8</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i Jie</dc:creator>
  <cp:lastModifiedBy>月 董</cp:lastModifiedBy>
  <cp:revision>212</cp:revision>
  <dcterms:created xsi:type="dcterms:W3CDTF">2022-09-15T05:27:27Z</dcterms:created>
  <dcterms:modified xsi:type="dcterms:W3CDTF">2024-01-15T03:15:57Z</dcterms:modified>
</cp:coreProperties>
</file>